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  <p:sldId id="26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6F07"/>
    <a:srgbClr val="FFCCFF"/>
    <a:srgbClr val="FF9999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53" autoAdjust="0"/>
    <p:restoredTop sz="94660"/>
  </p:normalViewPr>
  <p:slideViewPr>
    <p:cSldViewPr snapToGrid="0">
      <p:cViewPr>
        <p:scale>
          <a:sx n="70" d="100"/>
          <a:sy n="70" d="100"/>
        </p:scale>
        <p:origin x="2707" y="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324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443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990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755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819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5441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409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641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251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6759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8503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738D2-C86D-490C-9556-F4CBA627DE75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CEA8D-B1EB-444E-B19F-F48D667F98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1400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2342507" y="4572846"/>
            <a:ext cx="2732025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b="1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Time after spider </a:t>
            </a:r>
            <a:r>
              <a:rPr lang="en-US" sz="1200" b="1" dirty="0" smtClean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mite </a:t>
            </a:r>
            <a:r>
              <a:rPr lang="en-US" sz="1200" b="1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infestation (hour)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4689518" y="4572846"/>
            <a:ext cx="352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GB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 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437990" y="4275184"/>
            <a:ext cx="109179" cy="923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" name="Freeform 5"/>
          <p:cNvSpPr>
            <a:spLocks noEditPoints="1"/>
          </p:cNvSpPr>
          <p:nvPr/>
        </p:nvSpPr>
        <p:spPr bwMode="auto">
          <a:xfrm>
            <a:off x="1433411" y="4271144"/>
            <a:ext cx="118332" cy="17306"/>
          </a:xfrm>
          <a:custGeom>
            <a:avLst/>
            <a:gdLst>
              <a:gd name="T0" fmla="*/ 0 w 1248"/>
              <a:gd name="T1" fmla="*/ 48 h 208"/>
              <a:gd name="T2" fmla="*/ 48 w 1248"/>
              <a:gd name="T3" fmla="*/ 0 h 208"/>
              <a:gd name="T4" fmla="*/ 1200 w 1248"/>
              <a:gd name="T5" fmla="*/ 0 h 208"/>
              <a:gd name="T6" fmla="*/ 1248 w 1248"/>
              <a:gd name="T7" fmla="*/ 48 h 208"/>
              <a:gd name="T8" fmla="*/ 1248 w 1248"/>
              <a:gd name="T9" fmla="*/ 160 h 208"/>
              <a:gd name="T10" fmla="*/ 1200 w 1248"/>
              <a:gd name="T11" fmla="*/ 208 h 208"/>
              <a:gd name="T12" fmla="*/ 48 w 1248"/>
              <a:gd name="T13" fmla="*/ 208 h 208"/>
              <a:gd name="T14" fmla="*/ 0 w 1248"/>
              <a:gd name="T15" fmla="*/ 160 h 208"/>
              <a:gd name="T16" fmla="*/ 0 w 1248"/>
              <a:gd name="T17" fmla="*/ 48 h 208"/>
              <a:gd name="T18" fmla="*/ 96 w 1248"/>
              <a:gd name="T19" fmla="*/ 160 h 208"/>
              <a:gd name="T20" fmla="*/ 48 w 1248"/>
              <a:gd name="T21" fmla="*/ 112 h 208"/>
              <a:gd name="T22" fmla="*/ 1200 w 1248"/>
              <a:gd name="T23" fmla="*/ 112 h 208"/>
              <a:gd name="T24" fmla="*/ 1152 w 1248"/>
              <a:gd name="T25" fmla="*/ 160 h 208"/>
              <a:gd name="T26" fmla="*/ 1152 w 1248"/>
              <a:gd name="T27" fmla="*/ 48 h 208"/>
              <a:gd name="T28" fmla="*/ 1200 w 1248"/>
              <a:gd name="T29" fmla="*/ 96 h 208"/>
              <a:gd name="T30" fmla="*/ 48 w 1248"/>
              <a:gd name="T31" fmla="*/ 96 h 208"/>
              <a:gd name="T32" fmla="*/ 96 w 1248"/>
              <a:gd name="T33" fmla="*/ 48 h 208"/>
              <a:gd name="T34" fmla="*/ 96 w 1248"/>
              <a:gd name="T35" fmla="*/ 160 h 2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20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160"/>
                </a:lnTo>
                <a:cubicBezTo>
                  <a:pt x="1248" y="187"/>
                  <a:pt x="1227" y="208"/>
                  <a:pt x="1200" y="208"/>
                </a:cubicBezTo>
                <a:lnTo>
                  <a:pt x="48" y="208"/>
                </a:lnTo>
                <a:cubicBezTo>
                  <a:pt x="22" y="208"/>
                  <a:pt x="0" y="187"/>
                  <a:pt x="0" y="160"/>
                </a:cubicBezTo>
                <a:lnTo>
                  <a:pt x="0" y="48"/>
                </a:lnTo>
                <a:close/>
                <a:moveTo>
                  <a:pt x="96" y="160"/>
                </a:moveTo>
                <a:lnTo>
                  <a:pt x="48" y="112"/>
                </a:lnTo>
                <a:lnTo>
                  <a:pt x="1200" y="112"/>
                </a:lnTo>
                <a:lnTo>
                  <a:pt x="1152" y="160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16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1817832" y="4281528"/>
            <a:ext cx="109179" cy="288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8" name="Freeform 7"/>
          <p:cNvSpPr>
            <a:spLocks noEditPoints="1"/>
          </p:cNvSpPr>
          <p:nvPr/>
        </p:nvSpPr>
        <p:spPr bwMode="auto">
          <a:xfrm>
            <a:off x="1813254" y="4277491"/>
            <a:ext cx="118332" cy="10960"/>
          </a:xfrm>
          <a:custGeom>
            <a:avLst/>
            <a:gdLst>
              <a:gd name="T0" fmla="*/ 0 w 1248"/>
              <a:gd name="T1" fmla="*/ 48 h 128"/>
              <a:gd name="T2" fmla="*/ 48 w 1248"/>
              <a:gd name="T3" fmla="*/ 0 h 128"/>
              <a:gd name="T4" fmla="*/ 1200 w 1248"/>
              <a:gd name="T5" fmla="*/ 0 h 128"/>
              <a:gd name="T6" fmla="*/ 1248 w 1248"/>
              <a:gd name="T7" fmla="*/ 48 h 128"/>
              <a:gd name="T8" fmla="*/ 1248 w 1248"/>
              <a:gd name="T9" fmla="*/ 80 h 128"/>
              <a:gd name="T10" fmla="*/ 1200 w 1248"/>
              <a:gd name="T11" fmla="*/ 128 h 128"/>
              <a:gd name="T12" fmla="*/ 48 w 1248"/>
              <a:gd name="T13" fmla="*/ 128 h 128"/>
              <a:gd name="T14" fmla="*/ 0 w 1248"/>
              <a:gd name="T15" fmla="*/ 80 h 128"/>
              <a:gd name="T16" fmla="*/ 0 w 1248"/>
              <a:gd name="T17" fmla="*/ 48 h 128"/>
              <a:gd name="T18" fmla="*/ 96 w 1248"/>
              <a:gd name="T19" fmla="*/ 80 h 128"/>
              <a:gd name="T20" fmla="*/ 48 w 1248"/>
              <a:gd name="T21" fmla="*/ 32 h 128"/>
              <a:gd name="T22" fmla="*/ 1200 w 1248"/>
              <a:gd name="T23" fmla="*/ 32 h 128"/>
              <a:gd name="T24" fmla="*/ 1152 w 1248"/>
              <a:gd name="T25" fmla="*/ 80 h 128"/>
              <a:gd name="T26" fmla="*/ 1152 w 1248"/>
              <a:gd name="T27" fmla="*/ 48 h 128"/>
              <a:gd name="T28" fmla="*/ 1200 w 1248"/>
              <a:gd name="T29" fmla="*/ 96 h 128"/>
              <a:gd name="T30" fmla="*/ 48 w 1248"/>
              <a:gd name="T31" fmla="*/ 96 h 128"/>
              <a:gd name="T32" fmla="*/ 96 w 1248"/>
              <a:gd name="T33" fmla="*/ 48 h 128"/>
              <a:gd name="T34" fmla="*/ 96 w 1248"/>
              <a:gd name="T35" fmla="*/ 80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12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80"/>
                </a:lnTo>
                <a:cubicBezTo>
                  <a:pt x="1248" y="107"/>
                  <a:pt x="1227" y="128"/>
                  <a:pt x="1200" y="128"/>
                </a:cubicBezTo>
                <a:lnTo>
                  <a:pt x="48" y="128"/>
                </a:lnTo>
                <a:cubicBezTo>
                  <a:pt x="22" y="128"/>
                  <a:pt x="0" y="107"/>
                  <a:pt x="0" y="80"/>
                </a:cubicBezTo>
                <a:lnTo>
                  <a:pt x="0" y="48"/>
                </a:lnTo>
                <a:close/>
                <a:moveTo>
                  <a:pt x="96" y="80"/>
                </a:moveTo>
                <a:lnTo>
                  <a:pt x="48" y="32"/>
                </a:lnTo>
                <a:lnTo>
                  <a:pt x="1200" y="32"/>
                </a:lnTo>
                <a:lnTo>
                  <a:pt x="1152" y="80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8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2199636" y="4268261"/>
            <a:ext cx="109179" cy="1615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0" name="Freeform 9"/>
          <p:cNvSpPr>
            <a:spLocks noEditPoints="1"/>
          </p:cNvSpPr>
          <p:nvPr/>
        </p:nvSpPr>
        <p:spPr bwMode="auto">
          <a:xfrm>
            <a:off x="2195057" y="4264222"/>
            <a:ext cx="118332" cy="24229"/>
          </a:xfrm>
          <a:custGeom>
            <a:avLst/>
            <a:gdLst>
              <a:gd name="T0" fmla="*/ 0 w 1248"/>
              <a:gd name="T1" fmla="*/ 48 h 288"/>
              <a:gd name="T2" fmla="*/ 48 w 1248"/>
              <a:gd name="T3" fmla="*/ 0 h 288"/>
              <a:gd name="T4" fmla="*/ 1200 w 1248"/>
              <a:gd name="T5" fmla="*/ 0 h 288"/>
              <a:gd name="T6" fmla="*/ 1248 w 1248"/>
              <a:gd name="T7" fmla="*/ 48 h 288"/>
              <a:gd name="T8" fmla="*/ 1248 w 1248"/>
              <a:gd name="T9" fmla="*/ 240 h 288"/>
              <a:gd name="T10" fmla="*/ 1200 w 1248"/>
              <a:gd name="T11" fmla="*/ 288 h 288"/>
              <a:gd name="T12" fmla="*/ 48 w 1248"/>
              <a:gd name="T13" fmla="*/ 288 h 288"/>
              <a:gd name="T14" fmla="*/ 0 w 1248"/>
              <a:gd name="T15" fmla="*/ 240 h 288"/>
              <a:gd name="T16" fmla="*/ 0 w 1248"/>
              <a:gd name="T17" fmla="*/ 48 h 288"/>
              <a:gd name="T18" fmla="*/ 96 w 1248"/>
              <a:gd name="T19" fmla="*/ 240 h 288"/>
              <a:gd name="T20" fmla="*/ 48 w 1248"/>
              <a:gd name="T21" fmla="*/ 192 h 288"/>
              <a:gd name="T22" fmla="*/ 1200 w 1248"/>
              <a:gd name="T23" fmla="*/ 192 h 288"/>
              <a:gd name="T24" fmla="*/ 1152 w 1248"/>
              <a:gd name="T25" fmla="*/ 240 h 288"/>
              <a:gd name="T26" fmla="*/ 1152 w 1248"/>
              <a:gd name="T27" fmla="*/ 48 h 288"/>
              <a:gd name="T28" fmla="*/ 1200 w 1248"/>
              <a:gd name="T29" fmla="*/ 96 h 288"/>
              <a:gd name="T30" fmla="*/ 48 w 1248"/>
              <a:gd name="T31" fmla="*/ 96 h 288"/>
              <a:gd name="T32" fmla="*/ 96 w 1248"/>
              <a:gd name="T33" fmla="*/ 48 h 288"/>
              <a:gd name="T34" fmla="*/ 96 w 1248"/>
              <a:gd name="T35" fmla="*/ 240 h 2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288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240"/>
                </a:lnTo>
                <a:cubicBezTo>
                  <a:pt x="1248" y="267"/>
                  <a:pt x="1227" y="288"/>
                  <a:pt x="1200" y="288"/>
                </a:cubicBezTo>
                <a:lnTo>
                  <a:pt x="48" y="288"/>
                </a:lnTo>
                <a:cubicBezTo>
                  <a:pt x="22" y="288"/>
                  <a:pt x="0" y="267"/>
                  <a:pt x="0" y="240"/>
                </a:cubicBezTo>
                <a:lnTo>
                  <a:pt x="0" y="48"/>
                </a:lnTo>
                <a:close/>
                <a:moveTo>
                  <a:pt x="96" y="240"/>
                </a:moveTo>
                <a:lnTo>
                  <a:pt x="48" y="192"/>
                </a:lnTo>
                <a:lnTo>
                  <a:pt x="1200" y="192"/>
                </a:lnTo>
                <a:lnTo>
                  <a:pt x="1152" y="240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24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>
            <a:spLocks noChangeArrowheads="1"/>
          </p:cNvSpPr>
          <p:nvPr/>
        </p:nvSpPr>
        <p:spPr bwMode="auto">
          <a:xfrm>
            <a:off x="2581440" y="4279222"/>
            <a:ext cx="109179" cy="519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2" name="Freeform 11"/>
          <p:cNvSpPr>
            <a:spLocks noEditPoints="1"/>
          </p:cNvSpPr>
          <p:nvPr/>
        </p:nvSpPr>
        <p:spPr bwMode="auto">
          <a:xfrm>
            <a:off x="2576861" y="4275183"/>
            <a:ext cx="118332" cy="13268"/>
          </a:xfrm>
          <a:custGeom>
            <a:avLst/>
            <a:gdLst>
              <a:gd name="T0" fmla="*/ 0 w 1248"/>
              <a:gd name="T1" fmla="*/ 48 h 160"/>
              <a:gd name="T2" fmla="*/ 48 w 1248"/>
              <a:gd name="T3" fmla="*/ 0 h 160"/>
              <a:gd name="T4" fmla="*/ 1200 w 1248"/>
              <a:gd name="T5" fmla="*/ 0 h 160"/>
              <a:gd name="T6" fmla="*/ 1248 w 1248"/>
              <a:gd name="T7" fmla="*/ 48 h 160"/>
              <a:gd name="T8" fmla="*/ 1248 w 1248"/>
              <a:gd name="T9" fmla="*/ 112 h 160"/>
              <a:gd name="T10" fmla="*/ 1200 w 1248"/>
              <a:gd name="T11" fmla="*/ 160 h 160"/>
              <a:gd name="T12" fmla="*/ 48 w 1248"/>
              <a:gd name="T13" fmla="*/ 160 h 160"/>
              <a:gd name="T14" fmla="*/ 0 w 1248"/>
              <a:gd name="T15" fmla="*/ 112 h 160"/>
              <a:gd name="T16" fmla="*/ 0 w 1248"/>
              <a:gd name="T17" fmla="*/ 48 h 160"/>
              <a:gd name="T18" fmla="*/ 96 w 1248"/>
              <a:gd name="T19" fmla="*/ 112 h 160"/>
              <a:gd name="T20" fmla="*/ 48 w 1248"/>
              <a:gd name="T21" fmla="*/ 64 h 160"/>
              <a:gd name="T22" fmla="*/ 1200 w 1248"/>
              <a:gd name="T23" fmla="*/ 64 h 160"/>
              <a:gd name="T24" fmla="*/ 1152 w 1248"/>
              <a:gd name="T25" fmla="*/ 112 h 160"/>
              <a:gd name="T26" fmla="*/ 1152 w 1248"/>
              <a:gd name="T27" fmla="*/ 48 h 160"/>
              <a:gd name="T28" fmla="*/ 1200 w 1248"/>
              <a:gd name="T29" fmla="*/ 96 h 160"/>
              <a:gd name="T30" fmla="*/ 48 w 1248"/>
              <a:gd name="T31" fmla="*/ 96 h 160"/>
              <a:gd name="T32" fmla="*/ 96 w 1248"/>
              <a:gd name="T33" fmla="*/ 48 h 160"/>
              <a:gd name="T34" fmla="*/ 96 w 1248"/>
              <a:gd name="T35" fmla="*/ 112 h 1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16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112"/>
                </a:lnTo>
                <a:cubicBezTo>
                  <a:pt x="1248" y="139"/>
                  <a:pt x="1227" y="160"/>
                  <a:pt x="1200" y="160"/>
                </a:cubicBezTo>
                <a:lnTo>
                  <a:pt x="48" y="160"/>
                </a:lnTo>
                <a:cubicBezTo>
                  <a:pt x="22" y="160"/>
                  <a:pt x="0" y="139"/>
                  <a:pt x="0" y="112"/>
                </a:cubicBezTo>
                <a:lnTo>
                  <a:pt x="0" y="48"/>
                </a:lnTo>
                <a:close/>
                <a:moveTo>
                  <a:pt x="96" y="112"/>
                </a:moveTo>
                <a:lnTo>
                  <a:pt x="48" y="64"/>
                </a:lnTo>
                <a:lnTo>
                  <a:pt x="1200" y="64"/>
                </a:lnTo>
                <a:lnTo>
                  <a:pt x="1152" y="112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11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2961283" y="4279222"/>
            <a:ext cx="109179" cy="519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4" name="Freeform 13"/>
          <p:cNvSpPr>
            <a:spLocks noEditPoints="1"/>
          </p:cNvSpPr>
          <p:nvPr/>
        </p:nvSpPr>
        <p:spPr bwMode="auto">
          <a:xfrm>
            <a:off x="2956704" y="4275183"/>
            <a:ext cx="118332" cy="13268"/>
          </a:xfrm>
          <a:custGeom>
            <a:avLst/>
            <a:gdLst>
              <a:gd name="T0" fmla="*/ 0 w 1248"/>
              <a:gd name="T1" fmla="*/ 48 h 160"/>
              <a:gd name="T2" fmla="*/ 48 w 1248"/>
              <a:gd name="T3" fmla="*/ 0 h 160"/>
              <a:gd name="T4" fmla="*/ 1200 w 1248"/>
              <a:gd name="T5" fmla="*/ 0 h 160"/>
              <a:gd name="T6" fmla="*/ 1248 w 1248"/>
              <a:gd name="T7" fmla="*/ 48 h 160"/>
              <a:gd name="T8" fmla="*/ 1248 w 1248"/>
              <a:gd name="T9" fmla="*/ 112 h 160"/>
              <a:gd name="T10" fmla="*/ 1200 w 1248"/>
              <a:gd name="T11" fmla="*/ 160 h 160"/>
              <a:gd name="T12" fmla="*/ 48 w 1248"/>
              <a:gd name="T13" fmla="*/ 160 h 160"/>
              <a:gd name="T14" fmla="*/ 0 w 1248"/>
              <a:gd name="T15" fmla="*/ 112 h 160"/>
              <a:gd name="T16" fmla="*/ 0 w 1248"/>
              <a:gd name="T17" fmla="*/ 48 h 160"/>
              <a:gd name="T18" fmla="*/ 96 w 1248"/>
              <a:gd name="T19" fmla="*/ 112 h 160"/>
              <a:gd name="T20" fmla="*/ 48 w 1248"/>
              <a:gd name="T21" fmla="*/ 64 h 160"/>
              <a:gd name="T22" fmla="*/ 1200 w 1248"/>
              <a:gd name="T23" fmla="*/ 64 h 160"/>
              <a:gd name="T24" fmla="*/ 1152 w 1248"/>
              <a:gd name="T25" fmla="*/ 112 h 160"/>
              <a:gd name="T26" fmla="*/ 1152 w 1248"/>
              <a:gd name="T27" fmla="*/ 48 h 160"/>
              <a:gd name="T28" fmla="*/ 1200 w 1248"/>
              <a:gd name="T29" fmla="*/ 96 h 160"/>
              <a:gd name="T30" fmla="*/ 48 w 1248"/>
              <a:gd name="T31" fmla="*/ 96 h 160"/>
              <a:gd name="T32" fmla="*/ 96 w 1248"/>
              <a:gd name="T33" fmla="*/ 48 h 160"/>
              <a:gd name="T34" fmla="*/ 96 w 1248"/>
              <a:gd name="T35" fmla="*/ 112 h 1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16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112"/>
                </a:lnTo>
                <a:cubicBezTo>
                  <a:pt x="1248" y="139"/>
                  <a:pt x="1227" y="160"/>
                  <a:pt x="1200" y="160"/>
                </a:cubicBezTo>
                <a:lnTo>
                  <a:pt x="48" y="160"/>
                </a:lnTo>
                <a:cubicBezTo>
                  <a:pt x="22" y="160"/>
                  <a:pt x="0" y="139"/>
                  <a:pt x="0" y="112"/>
                </a:cubicBezTo>
                <a:lnTo>
                  <a:pt x="0" y="48"/>
                </a:lnTo>
                <a:close/>
                <a:moveTo>
                  <a:pt x="96" y="112"/>
                </a:moveTo>
                <a:lnTo>
                  <a:pt x="48" y="64"/>
                </a:lnTo>
                <a:lnTo>
                  <a:pt x="1200" y="64"/>
                </a:lnTo>
                <a:lnTo>
                  <a:pt x="1152" y="112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11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>
            <a:spLocks noChangeArrowheads="1"/>
          </p:cNvSpPr>
          <p:nvPr/>
        </p:nvSpPr>
        <p:spPr bwMode="auto">
          <a:xfrm>
            <a:off x="3343087" y="4276336"/>
            <a:ext cx="109179" cy="807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6" name="Freeform 15"/>
          <p:cNvSpPr>
            <a:spLocks noEditPoints="1"/>
          </p:cNvSpPr>
          <p:nvPr/>
        </p:nvSpPr>
        <p:spPr bwMode="auto">
          <a:xfrm>
            <a:off x="3338507" y="4272298"/>
            <a:ext cx="118332" cy="16152"/>
          </a:xfrm>
          <a:custGeom>
            <a:avLst/>
            <a:gdLst>
              <a:gd name="T0" fmla="*/ 0 w 624"/>
              <a:gd name="T1" fmla="*/ 24 h 96"/>
              <a:gd name="T2" fmla="*/ 24 w 624"/>
              <a:gd name="T3" fmla="*/ 0 h 96"/>
              <a:gd name="T4" fmla="*/ 600 w 624"/>
              <a:gd name="T5" fmla="*/ 0 h 96"/>
              <a:gd name="T6" fmla="*/ 624 w 624"/>
              <a:gd name="T7" fmla="*/ 24 h 96"/>
              <a:gd name="T8" fmla="*/ 624 w 624"/>
              <a:gd name="T9" fmla="*/ 72 h 96"/>
              <a:gd name="T10" fmla="*/ 600 w 624"/>
              <a:gd name="T11" fmla="*/ 96 h 96"/>
              <a:gd name="T12" fmla="*/ 24 w 624"/>
              <a:gd name="T13" fmla="*/ 96 h 96"/>
              <a:gd name="T14" fmla="*/ 0 w 624"/>
              <a:gd name="T15" fmla="*/ 72 h 96"/>
              <a:gd name="T16" fmla="*/ 0 w 624"/>
              <a:gd name="T17" fmla="*/ 24 h 96"/>
              <a:gd name="T18" fmla="*/ 48 w 624"/>
              <a:gd name="T19" fmla="*/ 72 h 96"/>
              <a:gd name="T20" fmla="*/ 24 w 624"/>
              <a:gd name="T21" fmla="*/ 48 h 96"/>
              <a:gd name="T22" fmla="*/ 600 w 624"/>
              <a:gd name="T23" fmla="*/ 48 h 96"/>
              <a:gd name="T24" fmla="*/ 576 w 624"/>
              <a:gd name="T25" fmla="*/ 72 h 96"/>
              <a:gd name="T26" fmla="*/ 576 w 624"/>
              <a:gd name="T27" fmla="*/ 24 h 96"/>
              <a:gd name="T28" fmla="*/ 600 w 624"/>
              <a:gd name="T29" fmla="*/ 48 h 96"/>
              <a:gd name="T30" fmla="*/ 24 w 624"/>
              <a:gd name="T31" fmla="*/ 48 h 96"/>
              <a:gd name="T32" fmla="*/ 48 w 624"/>
              <a:gd name="T33" fmla="*/ 24 h 96"/>
              <a:gd name="T34" fmla="*/ 48 w 624"/>
              <a:gd name="T35" fmla="*/ 72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9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72"/>
                </a:lnTo>
                <a:cubicBezTo>
                  <a:pt x="624" y="86"/>
                  <a:pt x="614" y="96"/>
                  <a:pt x="600" y="96"/>
                </a:cubicBezTo>
                <a:lnTo>
                  <a:pt x="24" y="96"/>
                </a:lnTo>
                <a:cubicBezTo>
                  <a:pt x="11" y="96"/>
                  <a:pt x="0" y="86"/>
                  <a:pt x="0" y="72"/>
                </a:cubicBezTo>
                <a:lnTo>
                  <a:pt x="0" y="24"/>
                </a:lnTo>
                <a:close/>
                <a:moveTo>
                  <a:pt x="48" y="72"/>
                </a:moveTo>
                <a:lnTo>
                  <a:pt x="24" y="48"/>
                </a:lnTo>
                <a:lnTo>
                  <a:pt x="600" y="48"/>
                </a:lnTo>
                <a:lnTo>
                  <a:pt x="576" y="72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7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>
            <a:spLocks noChangeArrowheads="1"/>
          </p:cNvSpPr>
          <p:nvPr/>
        </p:nvSpPr>
        <p:spPr bwMode="auto">
          <a:xfrm>
            <a:off x="3724887" y="4279222"/>
            <a:ext cx="109179" cy="519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8" name="Freeform 17"/>
          <p:cNvSpPr>
            <a:spLocks noEditPoints="1"/>
          </p:cNvSpPr>
          <p:nvPr/>
        </p:nvSpPr>
        <p:spPr bwMode="auto">
          <a:xfrm>
            <a:off x="3720311" y="4275183"/>
            <a:ext cx="118332" cy="13268"/>
          </a:xfrm>
          <a:custGeom>
            <a:avLst/>
            <a:gdLst>
              <a:gd name="T0" fmla="*/ 0 w 624"/>
              <a:gd name="T1" fmla="*/ 24 h 80"/>
              <a:gd name="T2" fmla="*/ 24 w 624"/>
              <a:gd name="T3" fmla="*/ 0 h 80"/>
              <a:gd name="T4" fmla="*/ 600 w 624"/>
              <a:gd name="T5" fmla="*/ 0 h 80"/>
              <a:gd name="T6" fmla="*/ 624 w 624"/>
              <a:gd name="T7" fmla="*/ 24 h 80"/>
              <a:gd name="T8" fmla="*/ 624 w 624"/>
              <a:gd name="T9" fmla="*/ 56 h 80"/>
              <a:gd name="T10" fmla="*/ 600 w 624"/>
              <a:gd name="T11" fmla="*/ 80 h 80"/>
              <a:gd name="T12" fmla="*/ 24 w 624"/>
              <a:gd name="T13" fmla="*/ 80 h 80"/>
              <a:gd name="T14" fmla="*/ 0 w 624"/>
              <a:gd name="T15" fmla="*/ 56 h 80"/>
              <a:gd name="T16" fmla="*/ 0 w 624"/>
              <a:gd name="T17" fmla="*/ 24 h 80"/>
              <a:gd name="T18" fmla="*/ 48 w 624"/>
              <a:gd name="T19" fmla="*/ 56 h 80"/>
              <a:gd name="T20" fmla="*/ 24 w 624"/>
              <a:gd name="T21" fmla="*/ 32 h 80"/>
              <a:gd name="T22" fmla="*/ 600 w 624"/>
              <a:gd name="T23" fmla="*/ 32 h 80"/>
              <a:gd name="T24" fmla="*/ 576 w 624"/>
              <a:gd name="T25" fmla="*/ 56 h 80"/>
              <a:gd name="T26" fmla="*/ 576 w 624"/>
              <a:gd name="T27" fmla="*/ 24 h 80"/>
              <a:gd name="T28" fmla="*/ 600 w 624"/>
              <a:gd name="T29" fmla="*/ 48 h 80"/>
              <a:gd name="T30" fmla="*/ 24 w 624"/>
              <a:gd name="T31" fmla="*/ 48 h 80"/>
              <a:gd name="T32" fmla="*/ 48 w 624"/>
              <a:gd name="T33" fmla="*/ 24 h 80"/>
              <a:gd name="T34" fmla="*/ 48 w 624"/>
              <a:gd name="T35" fmla="*/ 56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8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56"/>
                </a:lnTo>
                <a:cubicBezTo>
                  <a:pt x="624" y="70"/>
                  <a:pt x="614" y="80"/>
                  <a:pt x="600" y="80"/>
                </a:cubicBezTo>
                <a:lnTo>
                  <a:pt x="24" y="80"/>
                </a:lnTo>
                <a:cubicBezTo>
                  <a:pt x="11" y="80"/>
                  <a:pt x="0" y="70"/>
                  <a:pt x="0" y="56"/>
                </a:cubicBezTo>
                <a:lnTo>
                  <a:pt x="0" y="24"/>
                </a:lnTo>
                <a:close/>
                <a:moveTo>
                  <a:pt x="48" y="56"/>
                </a:moveTo>
                <a:lnTo>
                  <a:pt x="24" y="32"/>
                </a:lnTo>
                <a:lnTo>
                  <a:pt x="600" y="32"/>
                </a:lnTo>
                <a:lnTo>
                  <a:pt x="576" y="56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56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19" name="Rectangle 18"/>
          <p:cNvSpPr>
            <a:spLocks noChangeArrowheads="1"/>
          </p:cNvSpPr>
          <p:nvPr/>
        </p:nvSpPr>
        <p:spPr bwMode="auto">
          <a:xfrm>
            <a:off x="4104730" y="4280376"/>
            <a:ext cx="109179" cy="40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0" name="Freeform 19"/>
          <p:cNvSpPr>
            <a:spLocks noEditPoints="1"/>
          </p:cNvSpPr>
          <p:nvPr/>
        </p:nvSpPr>
        <p:spPr bwMode="auto">
          <a:xfrm>
            <a:off x="4100153" y="4276337"/>
            <a:ext cx="118332" cy="12114"/>
          </a:xfrm>
          <a:custGeom>
            <a:avLst/>
            <a:gdLst>
              <a:gd name="T0" fmla="*/ 0 w 624"/>
              <a:gd name="T1" fmla="*/ 24 h 72"/>
              <a:gd name="T2" fmla="*/ 24 w 624"/>
              <a:gd name="T3" fmla="*/ 0 h 72"/>
              <a:gd name="T4" fmla="*/ 600 w 624"/>
              <a:gd name="T5" fmla="*/ 0 h 72"/>
              <a:gd name="T6" fmla="*/ 624 w 624"/>
              <a:gd name="T7" fmla="*/ 24 h 72"/>
              <a:gd name="T8" fmla="*/ 624 w 624"/>
              <a:gd name="T9" fmla="*/ 48 h 72"/>
              <a:gd name="T10" fmla="*/ 600 w 624"/>
              <a:gd name="T11" fmla="*/ 72 h 72"/>
              <a:gd name="T12" fmla="*/ 24 w 624"/>
              <a:gd name="T13" fmla="*/ 72 h 72"/>
              <a:gd name="T14" fmla="*/ 0 w 624"/>
              <a:gd name="T15" fmla="*/ 48 h 72"/>
              <a:gd name="T16" fmla="*/ 0 w 624"/>
              <a:gd name="T17" fmla="*/ 24 h 72"/>
              <a:gd name="T18" fmla="*/ 48 w 624"/>
              <a:gd name="T19" fmla="*/ 48 h 72"/>
              <a:gd name="T20" fmla="*/ 24 w 624"/>
              <a:gd name="T21" fmla="*/ 24 h 72"/>
              <a:gd name="T22" fmla="*/ 600 w 624"/>
              <a:gd name="T23" fmla="*/ 24 h 72"/>
              <a:gd name="T24" fmla="*/ 576 w 624"/>
              <a:gd name="T25" fmla="*/ 48 h 72"/>
              <a:gd name="T26" fmla="*/ 576 w 624"/>
              <a:gd name="T27" fmla="*/ 24 h 72"/>
              <a:gd name="T28" fmla="*/ 600 w 624"/>
              <a:gd name="T29" fmla="*/ 48 h 72"/>
              <a:gd name="T30" fmla="*/ 24 w 624"/>
              <a:gd name="T31" fmla="*/ 48 h 72"/>
              <a:gd name="T32" fmla="*/ 48 w 624"/>
              <a:gd name="T33" fmla="*/ 24 h 72"/>
              <a:gd name="T34" fmla="*/ 48 w 624"/>
              <a:gd name="T35" fmla="*/ 48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72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48"/>
                </a:lnTo>
                <a:cubicBezTo>
                  <a:pt x="624" y="62"/>
                  <a:pt x="614" y="72"/>
                  <a:pt x="600" y="72"/>
                </a:cubicBezTo>
                <a:lnTo>
                  <a:pt x="24" y="72"/>
                </a:lnTo>
                <a:cubicBezTo>
                  <a:pt x="11" y="72"/>
                  <a:pt x="0" y="62"/>
                  <a:pt x="0" y="48"/>
                </a:cubicBezTo>
                <a:lnTo>
                  <a:pt x="0" y="24"/>
                </a:lnTo>
                <a:close/>
                <a:moveTo>
                  <a:pt x="48" y="48"/>
                </a:moveTo>
                <a:lnTo>
                  <a:pt x="24" y="24"/>
                </a:lnTo>
                <a:lnTo>
                  <a:pt x="600" y="24"/>
                </a:lnTo>
                <a:lnTo>
                  <a:pt x="576" y="48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48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4486536" y="4275184"/>
            <a:ext cx="109179" cy="923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2" name="Freeform 21"/>
          <p:cNvSpPr>
            <a:spLocks noEditPoints="1"/>
          </p:cNvSpPr>
          <p:nvPr/>
        </p:nvSpPr>
        <p:spPr bwMode="auto">
          <a:xfrm>
            <a:off x="4481957" y="4271144"/>
            <a:ext cx="118332" cy="17306"/>
          </a:xfrm>
          <a:custGeom>
            <a:avLst/>
            <a:gdLst>
              <a:gd name="T0" fmla="*/ 0 w 624"/>
              <a:gd name="T1" fmla="*/ 24 h 104"/>
              <a:gd name="T2" fmla="*/ 24 w 624"/>
              <a:gd name="T3" fmla="*/ 0 h 104"/>
              <a:gd name="T4" fmla="*/ 600 w 624"/>
              <a:gd name="T5" fmla="*/ 0 h 104"/>
              <a:gd name="T6" fmla="*/ 624 w 624"/>
              <a:gd name="T7" fmla="*/ 24 h 104"/>
              <a:gd name="T8" fmla="*/ 624 w 624"/>
              <a:gd name="T9" fmla="*/ 80 h 104"/>
              <a:gd name="T10" fmla="*/ 600 w 624"/>
              <a:gd name="T11" fmla="*/ 104 h 104"/>
              <a:gd name="T12" fmla="*/ 24 w 624"/>
              <a:gd name="T13" fmla="*/ 104 h 104"/>
              <a:gd name="T14" fmla="*/ 0 w 624"/>
              <a:gd name="T15" fmla="*/ 80 h 104"/>
              <a:gd name="T16" fmla="*/ 0 w 624"/>
              <a:gd name="T17" fmla="*/ 24 h 104"/>
              <a:gd name="T18" fmla="*/ 48 w 624"/>
              <a:gd name="T19" fmla="*/ 80 h 104"/>
              <a:gd name="T20" fmla="*/ 24 w 624"/>
              <a:gd name="T21" fmla="*/ 56 h 104"/>
              <a:gd name="T22" fmla="*/ 600 w 624"/>
              <a:gd name="T23" fmla="*/ 56 h 104"/>
              <a:gd name="T24" fmla="*/ 576 w 624"/>
              <a:gd name="T25" fmla="*/ 80 h 104"/>
              <a:gd name="T26" fmla="*/ 576 w 624"/>
              <a:gd name="T27" fmla="*/ 24 h 104"/>
              <a:gd name="T28" fmla="*/ 600 w 624"/>
              <a:gd name="T29" fmla="*/ 48 h 104"/>
              <a:gd name="T30" fmla="*/ 24 w 624"/>
              <a:gd name="T31" fmla="*/ 48 h 104"/>
              <a:gd name="T32" fmla="*/ 48 w 624"/>
              <a:gd name="T33" fmla="*/ 24 h 104"/>
              <a:gd name="T34" fmla="*/ 48 w 624"/>
              <a:gd name="T35" fmla="*/ 80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10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80"/>
                </a:lnTo>
                <a:cubicBezTo>
                  <a:pt x="624" y="94"/>
                  <a:pt x="614" y="104"/>
                  <a:pt x="600" y="104"/>
                </a:cubicBezTo>
                <a:lnTo>
                  <a:pt x="24" y="104"/>
                </a:lnTo>
                <a:cubicBezTo>
                  <a:pt x="11" y="104"/>
                  <a:pt x="0" y="94"/>
                  <a:pt x="0" y="80"/>
                </a:cubicBezTo>
                <a:lnTo>
                  <a:pt x="0" y="24"/>
                </a:lnTo>
                <a:close/>
                <a:moveTo>
                  <a:pt x="48" y="80"/>
                </a:moveTo>
                <a:lnTo>
                  <a:pt x="24" y="56"/>
                </a:lnTo>
                <a:lnTo>
                  <a:pt x="600" y="56"/>
                </a:lnTo>
                <a:lnTo>
                  <a:pt x="576" y="80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8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3" name="Rectangle 22"/>
          <p:cNvSpPr>
            <a:spLocks noChangeArrowheads="1"/>
          </p:cNvSpPr>
          <p:nvPr/>
        </p:nvSpPr>
        <p:spPr bwMode="auto">
          <a:xfrm>
            <a:off x="4868340" y="4277490"/>
            <a:ext cx="109179" cy="692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4" name="Freeform 23"/>
          <p:cNvSpPr>
            <a:spLocks noEditPoints="1"/>
          </p:cNvSpPr>
          <p:nvPr/>
        </p:nvSpPr>
        <p:spPr bwMode="auto">
          <a:xfrm>
            <a:off x="4863761" y="4273452"/>
            <a:ext cx="118332" cy="14999"/>
          </a:xfrm>
          <a:custGeom>
            <a:avLst/>
            <a:gdLst>
              <a:gd name="T0" fmla="*/ 0 w 624"/>
              <a:gd name="T1" fmla="*/ 24 h 88"/>
              <a:gd name="T2" fmla="*/ 24 w 624"/>
              <a:gd name="T3" fmla="*/ 0 h 88"/>
              <a:gd name="T4" fmla="*/ 600 w 624"/>
              <a:gd name="T5" fmla="*/ 0 h 88"/>
              <a:gd name="T6" fmla="*/ 624 w 624"/>
              <a:gd name="T7" fmla="*/ 24 h 88"/>
              <a:gd name="T8" fmla="*/ 624 w 624"/>
              <a:gd name="T9" fmla="*/ 64 h 88"/>
              <a:gd name="T10" fmla="*/ 600 w 624"/>
              <a:gd name="T11" fmla="*/ 88 h 88"/>
              <a:gd name="T12" fmla="*/ 24 w 624"/>
              <a:gd name="T13" fmla="*/ 88 h 88"/>
              <a:gd name="T14" fmla="*/ 0 w 624"/>
              <a:gd name="T15" fmla="*/ 64 h 88"/>
              <a:gd name="T16" fmla="*/ 0 w 624"/>
              <a:gd name="T17" fmla="*/ 24 h 88"/>
              <a:gd name="T18" fmla="*/ 48 w 624"/>
              <a:gd name="T19" fmla="*/ 64 h 88"/>
              <a:gd name="T20" fmla="*/ 24 w 624"/>
              <a:gd name="T21" fmla="*/ 40 h 88"/>
              <a:gd name="T22" fmla="*/ 600 w 624"/>
              <a:gd name="T23" fmla="*/ 40 h 88"/>
              <a:gd name="T24" fmla="*/ 576 w 624"/>
              <a:gd name="T25" fmla="*/ 64 h 88"/>
              <a:gd name="T26" fmla="*/ 576 w 624"/>
              <a:gd name="T27" fmla="*/ 24 h 88"/>
              <a:gd name="T28" fmla="*/ 600 w 624"/>
              <a:gd name="T29" fmla="*/ 48 h 88"/>
              <a:gd name="T30" fmla="*/ 24 w 624"/>
              <a:gd name="T31" fmla="*/ 48 h 88"/>
              <a:gd name="T32" fmla="*/ 48 w 624"/>
              <a:gd name="T33" fmla="*/ 24 h 88"/>
              <a:gd name="T34" fmla="*/ 48 w 624"/>
              <a:gd name="T35" fmla="*/ 64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88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64"/>
                </a:lnTo>
                <a:cubicBezTo>
                  <a:pt x="624" y="78"/>
                  <a:pt x="614" y="88"/>
                  <a:pt x="600" y="88"/>
                </a:cubicBezTo>
                <a:lnTo>
                  <a:pt x="24" y="88"/>
                </a:lnTo>
                <a:cubicBezTo>
                  <a:pt x="11" y="88"/>
                  <a:pt x="0" y="78"/>
                  <a:pt x="0" y="64"/>
                </a:cubicBezTo>
                <a:lnTo>
                  <a:pt x="0" y="24"/>
                </a:lnTo>
                <a:close/>
                <a:moveTo>
                  <a:pt x="48" y="64"/>
                </a:moveTo>
                <a:lnTo>
                  <a:pt x="24" y="40"/>
                </a:lnTo>
                <a:lnTo>
                  <a:pt x="600" y="40"/>
                </a:lnTo>
                <a:lnTo>
                  <a:pt x="576" y="64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64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5" name="Rectangle 24"/>
          <p:cNvSpPr>
            <a:spLocks noChangeArrowheads="1"/>
          </p:cNvSpPr>
          <p:nvPr/>
        </p:nvSpPr>
        <p:spPr bwMode="auto">
          <a:xfrm>
            <a:off x="5248182" y="4276336"/>
            <a:ext cx="109179" cy="807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6" name="Freeform 25"/>
          <p:cNvSpPr>
            <a:spLocks noEditPoints="1"/>
          </p:cNvSpPr>
          <p:nvPr/>
        </p:nvSpPr>
        <p:spPr bwMode="auto">
          <a:xfrm>
            <a:off x="5244260" y="4272298"/>
            <a:ext cx="117679" cy="16152"/>
          </a:xfrm>
          <a:custGeom>
            <a:avLst/>
            <a:gdLst>
              <a:gd name="T0" fmla="*/ 0 w 624"/>
              <a:gd name="T1" fmla="*/ 24 h 96"/>
              <a:gd name="T2" fmla="*/ 24 w 624"/>
              <a:gd name="T3" fmla="*/ 0 h 96"/>
              <a:gd name="T4" fmla="*/ 600 w 624"/>
              <a:gd name="T5" fmla="*/ 0 h 96"/>
              <a:gd name="T6" fmla="*/ 624 w 624"/>
              <a:gd name="T7" fmla="*/ 24 h 96"/>
              <a:gd name="T8" fmla="*/ 624 w 624"/>
              <a:gd name="T9" fmla="*/ 72 h 96"/>
              <a:gd name="T10" fmla="*/ 600 w 624"/>
              <a:gd name="T11" fmla="*/ 96 h 96"/>
              <a:gd name="T12" fmla="*/ 24 w 624"/>
              <a:gd name="T13" fmla="*/ 96 h 96"/>
              <a:gd name="T14" fmla="*/ 0 w 624"/>
              <a:gd name="T15" fmla="*/ 72 h 96"/>
              <a:gd name="T16" fmla="*/ 0 w 624"/>
              <a:gd name="T17" fmla="*/ 24 h 96"/>
              <a:gd name="T18" fmla="*/ 48 w 624"/>
              <a:gd name="T19" fmla="*/ 72 h 96"/>
              <a:gd name="T20" fmla="*/ 24 w 624"/>
              <a:gd name="T21" fmla="*/ 48 h 96"/>
              <a:gd name="T22" fmla="*/ 600 w 624"/>
              <a:gd name="T23" fmla="*/ 48 h 96"/>
              <a:gd name="T24" fmla="*/ 576 w 624"/>
              <a:gd name="T25" fmla="*/ 72 h 96"/>
              <a:gd name="T26" fmla="*/ 576 w 624"/>
              <a:gd name="T27" fmla="*/ 24 h 96"/>
              <a:gd name="T28" fmla="*/ 600 w 624"/>
              <a:gd name="T29" fmla="*/ 48 h 96"/>
              <a:gd name="T30" fmla="*/ 24 w 624"/>
              <a:gd name="T31" fmla="*/ 48 h 96"/>
              <a:gd name="T32" fmla="*/ 48 w 624"/>
              <a:gd name="T33" fmla="*/ 24 h 96"/>
              <a:gd name="T34" fmla="*/ 48 w 624"/>
              <a:gd name="T35" fmla="*/ 72 h 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9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72"/>
                </a:lnTo>
                <a:cubicBezTo>
                  <a:pt x="624" y="86"/>
                  <a:pt x="614" y="96"/>
                  <a:pt x="600" y="96"/>
                </a:cubicBezTo>
                <a:lnTo>
                  <a:pt x="24" y="96"/>
                </a:lnTo>
                <a:cubicBezTo>
                  <a:pt x="11" y="96"/>
                  <a:pt x="0" y="86"/>
                  <a:pt x="0" y="72"/>
                </a:cubicBezTo>
                <a:lnTo>
                  <a:pt x="0" y="24"/>
                </a:lnTo>
                <a:close/>
                <a:moveTo>
                  <a:pt x="48" y="72"/>
                </a:moveTo>
                <a:lnTo>
                  <a:pt x="24" y="48"/>
                </a:lnTo>
                <a:lnTo>
                  <a:pt x="600" y="48"/>
                </a:lnTo>
                <a:lnTo>
                  <a:pt x="576" y="72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7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7" name="Rectangle 26"/>
          <p:cNvSpPr>
            <a:spLocks noChangeArrowheads="1"/>
          </p:cNvSpPr>
          <p:nvPr/>
        </p:nvSpPr>
        <p:spPr bwMode="auto">
          <a:xfrm>
            <a:off x="5629987" y="4075585"/>
            <a:ext cx="109179" cy="20882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8" name="Freeform 27"/>
          <p:cNvSpPr>
            <a:spLocks noEditPoints="1"/>
          </p:cNvSpPr>
          <p:nvPr/>
        </p:nvSpPr>
        <p:spPr bwMode="auto">
          <a:xfrm>
            <a:off x="5625406" y="4071548"/>
            <a:ext cx="118332" cy="216904"/>
          </a:xfrm>
          <a:custGeom>
            <a:avLst/>
            <a:gdLst>
              <a:gd name="T0" fmla="*/ 0 w 624"/>
              <a:gd name="T1" fmla="*/ 24 h 1296"/>
              <a:gd name="T2" fmla="*/ 24 w 624"/>
              <a:gd name="T3" fmla="*/ 0 h 1296"/>
              <a:gd name="T4" fmla="*/ 600 w 624"/>
              <a:gd name="T5" fmla="*/ 0 h 1296"/>
              <a:gd name="T6" fmla="*/ 624 w 624"/>
              <a:gd name="T7" fmla="*/ 24 h 1296"/>
              <a:gd name="T8" fmla="*/ 624 w 624"/>
              <a:gd name="T9" fmla="*/ 1272 h 1296"/>
              <a:gd name="T10" fmla="*/ 600 w 624"/>
              <a:gd name="T11" fmla="*/ 1296 h 1296"/>
              <a:gd name="T12" fmla="*/ 24 w 624"/>
              <a:gd name="T13" fmla="*/ 1296 h 1296"/>
              <a:gd name="T14" fmla="*/ 0 w 624"/>
              <a:gd name="T15" fmla="*/ 1272 h 1296"/>
              <a:gd name="T16" fmla="*/ 0 w 624"/>
              <a:gd name="T17" fmla="*/ 24 h 1296"/>
              <a:gd name="T18" fmla="*/ 48 w 624"/>
              <a:gd name="T19" fmla="*/ 1272 h 1296"/>
              <a:gd name="T20" fmla="*/ 24 w 624"/>
              <a:gd name="T21" fmla="*/ 1248 h 1296"/>
              <a:gd name="T22" fmla="*/ 600 w 624"/>
              <a:gd name="T23" fmla="*/ 1248 h 1296"/>
              <a:gd name="T24" fmla="*/ 576 w 624"/>
              <a:gd name="T25" fmla="*/ 1272 h 1296"/>
              <a:gd name="T26" fmla="*/ 576 w 624"/>
              <a:gd name="T27" fmla="*/ 24 h 1296"/>
              <a:gd name="T28" fmla="*/ 600 w 624"/>
              <a:gd name="T29" fmla="*/ 48 h 1296"/>
              <a:gd name="T30" fmla="*/ 24 w 624"/>
              <a:gd name="T31" fmla="*/ 48 h 1296"/>
              <a:gd name="T32" fmla="*/ 48 w 624"/>
              <a:gd name="T33" fmla="*/ 24 h 1296"/>
              <a:gd name="T34" fmla="*/ 48 w 624"/>
              <a:gd name="T35" fmla="*/ 1272 h 12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129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1272"/>
                </a:lnTo>
                <a:cubicBezTo>
                  <a:pt x="624" y="1286"/>
                  <a:pt x="614" y="1296"/>
                  <a:pt x="600" y="1296"/>
                </a:cubicBezTo>
                <a:lnTo>
                  <a:pt x="24" y="1296"/>
                </a:lnTo>
                <a:cubicBezTo>
                  <a:pt x="11" y="1296"/>
                  <a:pt x="0" y="1286"/>
                  <a:pt x="0" y="1272"/>
                </a:cubicBezTo>
                <a:lnTo>
                  <a:pt x="0" y="24"/>
                </a:lnTo>
                <a:close/>
                <a:moveTo>
                  <a:pt x="48" y="1272"/>
                </a:moveTo>
                <a:lnTo>
                  <a:pt x="24" y="1248"/>
                </a:lnTo>
                <a:lnTo>
                  <a:pt x="600" y="1248"/>
                </a:lnTo>
                <a:lnTo>
                  <a:pt x="576" y="1272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127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29" name="Freeform 28"/>
          <p:cNvSpPr>
            <a:spLocks noEditPoints="1"/>
          </p:cNvSpPr>
          <p:nvPr/>
        </p:nvSpPr>
        <p:spPr bwMode="auto">
          <a:xfrm>
            <a:off x="1542595" y="4193267"/>
            <a:ext cx="117679" cy="95184"/>
          </a:xfrm>
          <a:custGeom>
            <a:avLst/>
            <a:gdLst>
              <a:gd name="T0" fmla="*/ 0 w 1248"/>
              <a:gd name="T1" fmla="*/ 48 h 1136"/>
              <a:gd name="T2" fmla="*/ 48 w 1248"/>
              <a:gd name="T3" fmla="*/ 0 h 1136"/>
              <a:gd name="T4" fmla="*/ 1200 w 1248"/>
              <a:gd name="T5" fmla="*/ 0 h 1136"/>
              <a:gd name="T6" fmla="*/ 1248 w 1248"/>
              <a:gd name="T7" fmla="*/ 48 h 1136"/>
              <a:gd name="T8" fmla="*/ 1248 w 1248"/>
              <a:gd name="T9" fmla="*/ 1088 h 1136"/>
              <a:gd name="T10" fmla="*/ 1200 w 1248"/>
              <a:gd name="T11" fmla="*/ 1136 h 1136"/>
              <a:gd name="T12" fmla="*/ 48 w 1248"/>
              <a:gd name="T13" fmla="*/ 1136 h 1136"/>
              <a:gd name="T14" fmla="*/ 0 w 1248"/>
              <a:gd name="T15" fmla="*/ 1088 h 1136"/>
              <a:gd name="T16" fmla="*/ 0 w 1248"/>
              <a:gd name="T17" fmla="*/ 48 h 1136"/>
              <a:gd name="T18" fmla="*/ 96 w 1248"/>
              <a:gd name="T19" fmla="*/ 1088 h 1136"/>
              <a:gd name="T20" fmla="*/ 48 w 1248"/>
              <a:gd name="T21" fmla="*/ 1040 h 1136"/>
              <a:gd name="T22" fmla="*/ 1200 w 1248"/>
              <a:gd name="T23" fmla="*/ 1040 h 1136"/>
              <a:gd name="T24" fmla="*/ 1152 w 1248"/>
              <a:gd name="T25" fmla="*/ 1088 h 1136"/>
              <a:gd name="T26" fmla="*/ 1152 w 1248"/>
              <a:gd name="T27" fmla="*/ 48 h 1136"/>
              <a:gd name="T28" fmla="*/ 1200 w 1248"/>
              <a:gd name="T29" fmla="*/ 96 h 1136"/>
              <a:gd name="T30" fmla="*/ 48 w 1248"/>
              <a:gd name="T31" fmla="*/ 96 h 1136"/>
              <a:gd name="T32" fmla="*/ 96 w 1248"/>
              <a:gd name="T33" fmla="*/ 48 h 1136"/>
              <a:gd name="T34" fmla="*/ 96 w 1248"/>
              <a:gd name="T35" fmla="*/ 1088 h 1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1136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1088"/>
                </a:lnTo>
                <a:cubicBezTo>
                  <a:pt x="1248" y="1115"/>
                  <a:pt x="1227" y="1136"/>
                  <a:pt x="1200" y="1136"/>
                </a:cubicBezTo>
                <a:lnTo>
                  <a:pt x="48" y="1136"/>
                </a:lnTo>
                <a:cubicBezTo>
                  <a:pt x="22" y="1136"/>
                  <a:pt x="0" y="1115"/>
                  <a:pt x="0" y="1088"/>
                </a:cubicBezTo>
                <a:lnTo>
                  <a:pt x="0" y="48"/>
                </a:lnTo>
                <a:close/>
                <a:moveTo>
                  <a:pt x="96" y="1088"/>
                </a:moveTo>
                <a:lnTo>
                  <a:pt x="48" y="1040"/>
                </a:lnTo>
                <a:lnTo>
                  <a:pt x="1200" y="1040"/>
                </a:lnTo>
                <a:lnTo>
                  <a:pt x="1152" y="1088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1088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0" name="Freeform 29"/>
          <p:cNvSpPr>
            <a:spLocks noEditPoints="1"/>
          </p:cNvSpPr>
          <p:nvPr/>
        </p:nvSpPr>
        <p:spPr bwMode="auto">
          <a:xfrm>
            <a:off x="1922434" y="4235956"/>
            <a:ext cx="118332" cy="52495"/>
          </a:xfrm>
          <a:custGeom>
            <a:avLst/>
            <a:gdLst>
              <a:gd name="T0" fmla="*/ 0 w 1248"/>
              <a:gd name="T1" fmla="*/ 48 h 624"/>
              <a:gd name="T2" fmla="*/ 48 w 1248"/>
              <a:gd name="T3" fmla="*/ 0 h 624"/>
              <a:gd name="T4" fmla="*/ 1200 w 1248"/>
              <a:gd name="T5" fmla="*/ 0 h 624"/>
              <a:gd name="T6" fmla="*/ 1248 w 1248"/>
              <a:gd name="T7" fmla="*/ 48 h 624"/>
              <a:gd name="T8" fmla="*/ 1248 w 1248"/>
              <a:gd name="T9" fmla="*/ 576 h 624"/>
              <a:gd name="T10" fmla="*/ 1200 w 1248"/>
              <a:gd name="T11" fmla="*/ 624 h 624"/>
              <a:gd name="T12" fmla="*/ 48 w 1248"/>
              <a:gd name="T13" fmla="*/ 624 h 624"/>
              <a:gd name="T14" fmla="*/ 0 w 1248"/>
              <a:gd name="T15" fmla="*/ 576 h 624"/>
              <a:gd name="T16" fmla="*/ 0 w 1248"/>
              <a:gd name="T17" fmla="*/ 48 h 624"/>
              <a:gd name="T18" fmla="*/ 96 w 1248"/>
              <a:gd name="T19" fmla="*/ 576 h 624"/>
              <a:gd name="T20" fmla="*/ 48 w 1248"/>
              <a:gd name="T21" fmla="*/ 528 h 624"/>
              <a:gd name="T22" fmla="*/ 1200 w 1248"/>
              <a:gd name="T23" fmla="*/ 528 h 624"/>
              <a:gd name="T24" fmla="*/ 1152 w 1248"/>
              <a:gd name="T25" fmla="*/ 576 h 624"/>
              <a:gd name="T26" fmla="*/ 1152 w 1248"/>
              <a:gd name="T27" fmla="*/ 48 h 624"/>
              <a:gd name="T28" fmla="*/ 1200 w 1248"/>
              <a:gd name="T29" fmla="*/ 96 h 624"/>
              <a:gd name="T30" fmla="*/ 48 w 1248"/>
              <a:gd name="T31" fmla="*/ 96 h 624"/>
              <a:gd name="T32" fmla="*/ 96 w 1248"/>
              <a:gd name="T33" fmla="*/ 48 h 624"/>
              <a:gd name="T34" fmla="*/ 96 w 1248"/>
              <a:gd name="T35" fmla="*/ 576 h 6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624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576"/>
                </a:lnTo>
                <a:cubicBezTo>
                  <a:pt x="1248" y="603"/>
                  <a:pt x="1227" y="624"/>
                  <a:pt x="1200" y="624"/>
                </a:cubicBezTo>
                <a:lnTo>
                  <a:pt x="48" y="624"/>
                </a:lnTo>
                <a:cubicBezTo>
                  <a:pt x="22" y="624"/>
                  <a:pt x="0" y="603"/>
                  <a:pt x="0" y="576"/>
                </a:cubicBezTo>
                <a:lnTo>
                  <a:pt x="0" y="48"/>
                </a:lnTo>
                <a:close/>
                <a:moveTo>
                  <a:pt x="96" y="576"/>
                </a:moveTo>
                <a:lnTo>
                  <a:pt x="48" y="528"/>
                </a:lnTo>
                <a:lnTo>
                  <a:pt x="1200" y="528"/>
                </a:lnTo>
                <a:lnTo>
                  <a:pt x="1152" y="576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576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1" name="Freeform 30"/>
          <p:cNvSpPr>
            <a:spLocks noEditPoints="1"/>
          </p:cNvSpPr>
          <p:nvPr/>
        </p:nvSpPr>
        <p:spPr bwMode="auto">
          <a:xfrm>
            <a:off x="2304236" y="4228457"/>
            <a:ext cx="118332" cy="59995"/>
          </a:xfrm>
          <a:custGeom>
            <a:avLst/>
            <a:gdLst>
              <a:gd name="T0" fmla="*/ 0 w 1248"/>
              <a:gd name="T1" fmla="*/ 48 h 720"/>
              <a:gd name="T2" fmla="*/ 48 w 1248"/>
              <a:gd name="T3" fmla="*/ 0 h 720"/>
              <a:gd name="T4" fmla="*/ 1200 w 1248"/>
              <a:gd name="T5" fmla="*/ 0 h 720"/>
              <a:gd name="T6" fmla="*/ 1248 w 1248"/>
              <a:gd name="T7" fmla="*/ 48 h 720"/>
              <a:gd name="T8" fmla="*/ 1248 w 1248"/>
              <a:gd name="T9" fmla="*/ 672 h 720"/>
              <a:gd name="T10" fmla="*/ 1200 w 1248"/>
              <a:gd name="T11" fmla="*/ 720 h 720"/>
              <a:gd name="T12" fmla="*/ 48 w 1248"/>
              <a:gd name="T13" fmla="*/ 720 h 720"/>
              <a:gd name="T14" fmla="*/ 0 w 1248"/>
              <a:gd name="T15" fmla="*/ 672 h 720"/>
              <a:gd name="T16" fmla="*/ 0 w 1248"/>
              <a:gd name="T17" fmla="*/ 48 h 720"/>
              <a:gd name="T18" fmla="*/ 96 w 1248"/>
              <a:gd name="T19" fmla="*/ 672 h 720"/>
              <a:gd name="T20" fmla="*/ 48 w 1248"/>
              <a:gd name="T21" fmla="*/ 624 h 720"/>
              <a:gd name="T22" fmla="*/ 1200 w 1248"/>
              <a:gd name="T23" fmla="*/ 624 h 720"/>
              <a:gd name="T24" fmla="*/ 1152 w 1248"/>
              <a:gd name="T25" fmla="*/ 672 h 720"/>
              <a:gd name="T26" fmla="*/ 1152 w 1248"/>
              <a:gd name="T27" fmla="*/ 48 h 720"/>
              <a:gd name="T28" fmla="*/ 1200 w 1248"/>
              <a:gd name="T29" fmla="*/ 96 h 720"/>
              <a:gd name="T30" fmla="*/ 48 w 1248"/>
              <a:gd name="T31" fmla="*/ 96 h 720"/>
              <a:gd name="T32" fmla="*/ 96 w 1248"/>
              <a:gd name="T33" fmla="*/ 48 h 720"/>
              <a:gd name="T34" fmla="*/ 96 w 1248"/>
              <a:gd name="T35" fmla="*/ 672 h 7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72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672"/>
                </a:lnTo>
                <a:cubicBezTo>
                  <a:pt x="1248" y="699"/>
                  <a:pt x="1227" y="720"/>
                  <a:pt x="1200" y="720"/>
                </a:cubicBezTo>
                <a:lnTo>
                  <a:pt x="48" y="720"/>
                </a:lnTo>
                <a:cubicBezTo>
                  <a:pt x="22" y="720"/>
                  <a:pt x="0" y="699"/>
                  <a:pt x="0" y="672"/>
                </a:cubicBezTo>
                <a:lnTo>
                  <a:pt x="0" y="48"/>
                </a:lnTo>
                <a:close/>
                <a:moveTo>
                  <a:pt x="96" y="672"/>
                </a:moveTo>
                <a:lnTo>
                  <a:pt x="48" y="624"/>
                </a:lnTo>
                <a:lnTo>
                  <a:pt x="1200" y="624"/>
                </a:lnTo>
                <a:lnTo>
                  <a:pt x="1152" y="672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67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2" name="Freeform 31"/>
          <p:cNvSpPr>
            <a:spLocks noEditPoints="1"/>
          </p:cNvSpPr>
          <p:nvPr/>
        </p:nvSpPr>
        <p:spPr bwMode="auto">
          <a:xfrm>
            <a:off x="2686045" y="4241726"/>
            <a:ext cx="117679" cy="46726"/>
          </a:xfrm>
          <a:custGeom>
            <a:avLst/>
            <a:gdLst>
              <a:gd name="T0" fmla="*/ 0 w 1248"/>
              <a:gd name="T1" fmla="*/ 48 h 560"/>
              <a:gd name="T2" fmla="*/ 48 w 1248"/>
              <a:gd name="T3" fmla="*/ 0 h 560"/>
              <a:gd name="T4" fmla="*/ 1200 w 1248"/>
              <a:gd name="T5" fmla="*/ 0 h 560"/>
              <a:gd name="T6" fmla="*/ 1248 w 1248"/>
              <a:gd name="T7" fmla="*/ 48 h 560"/>
              <a:gd name="T8" fmla="*/ 1248 w 1248"/>
              <a:gd name="T9" fmla="*/ 512 h 560"/>
              <a:gd name="T10" fmla="*/ 1200 w 1248"/>
              <a:gd name="T11" fmla="*/ 560 h 560"/>
              <a:gd name="T12" fmla="*/ 48 w 1248"/>
              <a:gd name="T13" fmla="*/ 560 h 560"/>
              <a:gd name="T14" fmla="*/ 0 w 1248"/>
              <a:gd name="T15" fmla="*/ 512 h 560"/>
              <a:gd name="T16" fmla="*/ 0 w 1248"/>
              <a:gd name="T17" fmla="*/ 48 h 560"/>
              <a:gd name="T18" fmla="*/ 96 w 1248"/>
              <a:gd name="T19" fmla="*/ 512 h 560"/>
              <a:gd name="T20" fmla="*/ 48 w 1248"/>
              <a:gd name="T21" fmla="*/ 464 h 560"/>
              <a:gd name="T22" fmla="*/ 1200 w 1248"/>
              <a:gd name="T23" fmla="*/ 464 h 560"/>
              <a:gd name="T24" fmla="*/ 1152 w 1248"/>
              <a:gd name="T25" fmla="*/ 512 h 560"/>
              <a:gd name="T26" fmla="*/ 1152 w 1248"/>
              <a:gd name="T27" fmla="*/ 48 h 560"/>
              <a:gd name="T28" fmla="*/ 1200 w 1248"/>
              <a:gd name="T29" fmla="*/ 96 h 560"/>
              <a:gd name="T30" fmla="*/ 48 w 1248"/>
              <a:gd name="T31" fmla="*/ 96 h 560"/>
              <a:gd name="T32" fmla="*/ 96 w 1248"/>
              <a:gd name="T33" fmla="*/ 48 h 560"/>
              <a:gd name="T34" fmla="*/ 96 w 1248"/>
              <a:gd name="T35" fmla="*/ 512 h 5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560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512"/>
                </a:lnTo>
                <a:cubicBezTo>
                  <a:pt x="1248" y="539"/>
                  <a:pt x="1227" y="560"/>
                  <a:pt x="1200" y="560"/>
                </a:cubicBezTo>
                <a:lnTo>
                  <a:pt x="48" y="560"/>
                </a:lnTo>
                <a:cubicBezTo>
                  <a:pt x="22" y="560"/>
                  <a:pt x="0" y="539"/>
                  <a:pt x="0" y="512"/>
                </a:cubicBezTo>
                <a:lnTo>
                  <a:pt x="0" y="48"/>
                </a:lnTo>
                <a:close/>
                <a:moveTo>
                  <a:pt x="96" y="512"/>
                </a:moveTo>
                <a:lnTo>
                  <a:pt x="48" y="464"/>
                </a:lnTo>
                <a:lnTo>
                  <a:pt x="1200" y="464"/>
                </a:lnTo>
                <a:lnTo>
                  <a:pt x="1152" y="512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51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3" name="Freeform 32"/>
          <p:cNvSpPr>
            <a:spLocks noEditPoints="1"/>
          </p:cNvSpPr>
          <p:nvPr/>
        </p:nvSpPr>
        <p:spPr bwMode="auto">
          <a:xfrm>
            <a:off x="3065883" y="4216343"/>
            <a:ext cx="118332" cy="72109"/>
          </a:xfrm>
          <a:custGeom>
            <a:avLst/>
            <a:gdLst>
              <a:gd name="T0" fmla="*/ 0 w 1248"/>
              <a:gd name="T1" fmla="*/ 48 h 864"/>
              <a:gd name="T2" fmla="*/ 48 w 1248"/>
              <a:gd name="T3" fmla="*/ 0 h 864"/>
              <a:gd name="T4" fmla="*/ 1200 w 1248"/>
              <a:gd name="T5" fmla="*/ 0 h 864"/>
              <a:gd name="T6" fmla="*/ 1248 w 1248"/>
              <a:gd name="T7" fmla="*/ 48 h 864"/>
              <a:gd name="T8" fmla="*/ 1248 w 1248"/>
              <a:gd name="T9" fmla="*/ 816 h 864"/>
              <a:gd name="T10" fmla="*/ 1200 w 1248"/>
              <a:gd name="T11" fmla="*/ 864 h 864"/>
              <a:gd name="T12" fmla="*/ 48 w 1248"/>
              <a:gd name="T13" fmla="*/ 864 h 864"/>
              <a:gd name="T14" fmla="*/ 0 w 1248"/>
              <a:gd name="T15" fmla="*/ 816 h 864"/>
              <a:gd name="T16" fmla="*/ 0 w 1248"/>
              <a:gd name="T17" fmla="*/ 48 h 864"/>
              <a:gd name="T18" fmla="*/ 96 w 1248"/>
              <a:gd name="T19" fmla="*/ 816 h 864"/>
              <a:gd name="T20" fmla="*/ 48 w 1248"/>
              <a:gd name="T21" fmla="*/ 768 h 864"/>
              <a:gd name="T22" fmla="*/ 1200 w 1248"/>
              <a:gd name="T23" fmla="*/ 768 h 864"/>
              <a:gd name="T24" fmla="*/ 1152 w 1248"/>
              <a:gd name="T25" fmla="*/ 816 h 864"/>
              <a:gd name="T26" fmla="*/ 1152 w 1248"/>
              <a:gd name="T27" fmla="*/ 48 h 864"/>
              <a:gd name="T28" fmla="*/ 1200 w 1248"/>
              <a:gd name="T29" fmla="*/ 96 h 864"/>
              <a:gd name="T30" fmla="*/ 48 w 1248"/>
              <a:gd name="T31" fmla="*/ 96 h 864"/>
              <a:gd name="T32" fmla="*/ 96 w 1248"/>
              <a:gd name="T33" fmla="*/ 48 h 864"/>
              <a:gd name="T34" fmla="*/ 96 w 1248"/>
              <a:gd name="T35" fmla="*/ 816 h 8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1248" h="864">
                <a:moveTo>
                  <a:pt x="0" y="48"/>
                </a:moveTo>
                <a:cubicBezTo>
                  <a:pt x="0" y="22"/>
                  <a:pt x="22" y="0"/>
                  <a:pt x="48" y="0"/>
                </a:cubicBezTo>
                <a:lnTo>
                  <a:pt x="1200" y="0"/>
                </a:lnTo>
                <a:cubicBezTo>
                  <a:pt x="1227" y="0"/>
                  <a:pt x="1248" y="22"/>
                  <a:pt x="1248" y="48"/>
                </a:cubicBezTo>
                <a:lnTo>
                  <a:pt x="1248" y="816"/>
                </a:lnTo>
                <a:cubicBezTo>
                  <a:pt x="1248" y="843"/>
                  <a:pt x="1227" y="864"/>
                  <a:pt x="1200" y="864"/>
                </a:cubicBezTo>
                <a:lnTo>
                  <a:pt x="48" y="864"/>
                </a:lnTo>
                <a:cubicBezTo>
                  <a:pt x="22" y="864"/>
                  <a:pt x="0" y="843"/>
                  <a:pt x="0" y="816"/>
                </a:cubicBezTo>
                <a:lnTo>
                  <a:pt x="0" y="48"/>
                </a:lnTo>
                <a:close/>
                <a:moveTo>
                  <a:pt x="96" y="816"/>
                </a:moveTo>
                <a:lnTo>
                  <a:pt x="48" y="768"/>
                </a:lnTo>
                <a:lnTo>
                  <a:pt x="1200" y="768"/>
                </a:lnTo>
                <a:lnTo>
                  <a:pt x="1152" y="816"/>
                </a:lnTo>
                <a:lnTo>
                  <a:pt x="1152" y="48"/>
                </a:lnTo>
                <a:lnTo>
                  <a:pt x="1200" y="96"/>
                </a:lnTo>
                <a:lnTo>
                  <a:pt x="48" y="96"/>
                </a:lnTo>
                <a:lnTo>
                  <a:pt x="96" y="48"/>
                </a:lnTo>
                <a:lnTo>
                  <a:pt x="96" y="816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4" name="Freeform 33"/>
          <p:cNvSpPr>
            <a:spLocks noEditPoints="1"/>
          </p:cNvSpPr>
          <p:nvPr/>
        </p:nvSpPr>
        <p:spPr bwMode="auto">
          <a:xfrm>
            <a:off x="3447687" y="4204228"/>
            <a:ext cx="118332" cy="84224"/>
          </a:xfrm>
          <a:custGeom>
            <a:avLst/>
            <a:gdLst>
              <a:gd name="T0" fmla="*/ 0 w 624"/>
              <a:gd name="T1" fmla="*/ 24 h 504"/>
              <a:gd name="T2" fmla="*/ 24 w 624"/>
              <a:gd name="T3" fmla="*/ 0 h 504"/>
              <a:gd name="T4" fmla="*/ 600 w 624"/>
              <a:gd name="T5" fmla="*/ 0 h 504"/>
              <a:gd name="T6" fmla="*/ 624 w 624"/>
              <a:gd name="T7" fmla="*/ 24 h 504"/>
              <a:gd name="T8" fmla="*/ 624 w 624"/>
              <a:gd name="T9" fmla="*/ 480 h 504"/>
              <a:gd name="T10" fmla="*/ 600 w 624"/>
              <a:gd name="T11" fmla="*/ 504 h 504"/>
              <a:gd name="T12" fmla="*/ 24 w 624"/>
              <a:gd name="T13" fmla="*/ 504 h 504"/>
              <a:gd name="T14" fmla="*/ 0 w 624"/>
              <a:gd name="T15" fmla="*/ 480 h 504"/>
              <a:gd name="T16" fmla="*/ 0 w 624"/>
              <a:gd name="T17" fmla="*/ 24 h 504"/>
              <a:gd name="T18" fmla="*/ 48 w 624"/>
              <a:gd name="T19" fmla="*/ 480 h 504"/>
              <a:gd name="T20" fmla="*/ 24 w 624"/>
              <a:gd name="T21" fmla="*/ 456 h 504"/>
              <a:gd name="T22" fmla="*/ 600 w 624"/>
              <a:gd name="T23" fmla="*/ 456 h 504"/>
              <a:gd name="T24" fmla="*/ 576 w 624"/>
              <a:gd name="T25" fmla="*/ 480 h 504"/>
              <a:gd name="T26" fmla="*/ 576 w 624"/>
              <a:gd name="T27" fmla="*/ 24 h 504"/>
              <a:gd name="T28" fmla="*/ 600 w 624"/>
              <a:gd name="T29" fmla="*/ 48 h 504"/>
              <a:gd name="T30" fmla="*/ 24 w 624"/>
              <a:gd name="T31" fmla="*/ 48 h 504"/>
              <a:gd name="T32" fmla="*/ 48 w 624"/>
              <a:gd name="T33" fmla="*/ 24 h 504"/>
              <a:gd name="T34" fmla="*/ 48 w 624"/>
              <a:gd name="T35" fmla="*/ 480 h 5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50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480"/>
                </a:lnTo>
                <a:cubicBezTo>
                  <a:pt x="624" y="494"/>
                  <a:pt x="614" y="504"/>
                  <a:pt x="600" y="504"/>
                </a:cubicBezTo>
                <a:lnTo>
                  <a:pt x="24" y="504"/>
                </a:lnTo>
                <a:cubicBezTo>
                  <a:pt x="11" y="504"/>
                  <a:pt x="0" y="494"/>
                  <a:pt x="0" y="480"/>
                </a:cubicBezTo>
                <a:lnTo>
                  <a:pt x="0" y="24"/>
                </a:lnTo>
                <a:close/>
                <a:moveTo>
                  <a:pt x="48" y="480"/>
                </a:moveTo>
                <a:lnTo>
                  <a:pt x="24" y="456"/>
                </a:lnTo>
                <a:lnTo>
                  <a:pt x="600" y="456"/>
                </a:lnTo>
                <a:lnTo>
                  <a:pt x="576" y="480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48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5" name="Freeform 34"/>
          <p:cNvSpPr>
            <a:spLocks noEditPoints="1"/>
          </p:cNvSpPr>
          <p:nvPr/>
        </p:nvSpPr>
        <p:spPr bwMode="auto">
          <a:xfrm>
            <a:off x="3829494" y="4252108"/>
            <a:ext cx="117679" cy="36343"/>
          </a:xfrm>
          <a:custGeom>
            <a:avLst/>
            <a:gdLst>
              <a:gd name="T0" fmla="*/ 0 w 624"/>
              <a:gd name="T1" fmla="*/ 24 h 216"/>
              <a:gd name="T2" fmla="*/ 24 w 624"/>
              <a:gd name="T3" fmla="*/ 0 h 216"/>
              <a:gd name="T4" fmla="*/ 600 w 624"/>
              <a:gd name="T5" fmla="*/ 0 h 216"/>
              <a:gd name="T6" fmla="*/ 624 w 624"/>
              <a:gd name="T7" fmla="*/ 24 h 216"/>
              <a:gd name="T8" fmla="*/ 624 w 624"/>
              <a:gd name="T9" fmla="*/ 192 h 216"/>
              <a:gd name="T10" fmla="*/ 600 w 624"/>
              <a:gd name="T11" fmla="*/ 216 h 216"/>
              <a:gd name="T12" fmla="*/ 24 w 624"/>
              <a:gd name="T13" fmla="*/ 216 h 216"/>
              <a:gd name="T14" fmla="*/ 0 w 624"/>
              <a:gd name="T15" fmla="*/ 192 h 216"/>
              <a:gd name="T16" fmla="*/ 0 w 624"/>
              <a:gd name="T17" fmla="*/ 24 h 216"/>
              <a:gd name="T18" fmla="*/ 48 w 624"/>
              <a:gd name="T19" fmla="*/ 192 h 216"/>
              <a:gd name="T20" fmla="*/ 24 w 624"/>
              <a:gd name="T21" fmla="*/ 168 h 216"/>
              <a:gd name="T22" fmla="*/ 600 w 624"/>
              <a:gd name="T23" fmla="*/ 168 h 216"/>
              <a:gd name="T24" fmla="*/ 576 w 624"/>
              <a:gd name="T25" fmla="*/ 192 h 216"/>
              <a:gd name="T26" fmla="*/ 576 w 624"/>
              <a:gd name="T27" fmla="*/ 24 h 216"/>
              <a:gd name="T28" fmla="*/ 600 w 624"/>
              <a:gd name="T29" fmla="*/ 48 h 216"/>
              <a:gd name="T30" fmla="*/ 24 w 624"/>
              <a:gd name="T31" fmla="*/ 48 h 216"/>
              <a:gd name="T32" fmla="*/ 48 w 624"/>
              <a:gd name="T33" fmla="*/ 24 h 216"/>
              <a:gd name="T34" fmla="*/ 48 w 624"/>
              <a:gd name="T35" fmla="*/ 192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21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192"/>
                </a:lnTo>
                <a:cubicBezTo>
                  <a:pt x="624" y="206"/>
                  <a:pt x="614" y="216"/>
                  <a:pt x="600" y="216"/>
                </a:cubicBezTo>
                <a:lnTo>
                  <a:pt x="24" y="216"/>
                </a:lnTo>
                <a:cubicBezTo>
                  <a:pt x="11" y="216"/>
                  <a:pt x="0" y="206"/>
                  <a:pt x="0" y="192"/>
                </a:cubicBezTo>
                <a:lnTo>
                  <a:pt x="0" y="24"/>
                </a:lnTo>
                <a:close/>
                <a:moveTo>
                  <a:pt x="48" y="192"/>
                </a:moveTo>
                <a:lnTo>
                  <a:pt x="24" y="168"/>
                </a:lnTo>
                <a:lnTo>
                  <a:pt x="600" y="168"/>
                </a:lnTo>
                <a:lnTo>
                  <a:pt x="576" y="192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19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6" name="Freeform 35"/>
          <p:cNvSpPr>
            <a:spLocks noEditPoints="1"/>
          </p:cNvSpPr>
          <p:nvPr/>
        </p:nvSpPr>
        <p:spPr bwMode="auto">
          <a:xfrm>
            <a:off x="4209333" y="4248070"/>
            <a:ext cx="118332" cy="40381"/>
          </a:xfrm>
          <a:custGeom>
            <a:avLst/>
            <a:gdLst>
              <a:gd name="T0" fmla="*/ 0 w 624"/>
              <a:gd name="T1" fmla="*/ 24 h 240"/>
              <a:gd name="T2" fmla="*/ 24 w 624"/>
              <a:gd name="T3" fmla="*/ 0 h 240"/>
              <a:gd name="T4" fmla="*/ 600 w 624"/>
              <a:gd name="T5" fmla="*/ 0 h 240"/>
              <a:gd name="T6" fmla="*/ 624 w 624"/>
              <a:gd name="T7" fmla="*/ 24 h 240"/>
              <a:gd name="T8" fmla="*/ 624 w 624"/>
              <a:gd name="T9" fmla="*/ 216 h 240"/>
              <a:gd name="T10" fmla="*/ 600 w 624"/>
              <a:gd name="T11" fmla="*/ 240 h 240"/>
              <a:gd name="T12" fmla="*/ 24 w 624"/>
              <a:gd name="T13" fmla="*/ 240 h 240"/>
              <a:gd name="T14" fmla="*/ 0 w 624"/>
              <a:gd name="T15" fmla="*/ 216 h 240"/>
              <a:gd name="T16" fmla="*/ 0 w 624"/>
              <a:gd name="T17" fmla="*/ 24 h 240"/>
              <a:gd name="T18" fmla="*/ 48 w 624"/>
              <a:gd name="T19" fmla="*/ 216 h 240"/>
              <a:gd name="T20" fmla="*/ 24 w 624"/>
              <a:gd name="T21" fmla="*/ 192 h 240"/>
              <a:gd name="T22" fmla="*/ 600 w 624"/>
              <a:gd name="T23" fmla="*/ 192 h 240"/>
              <a:gd name="T24" fmla="*/ 576 w 624"/>
              <a:gd name="T25" fmla="*/ 216 h 240"/>
              <a:gd name="T26" fmla="*/ 576 w 624"/>
              <a:gd name="T27" fmla="*/ 24 h 240"/>
              <a:gd name="T28" fmla="*/ 600 w 624"/>
              <a:gd name="T29" fmla="*/ 48 h 240"/>
              <a:gd name="T30" fmla="*/ 24 w 624"/>
              <a:gd name="T31" fmla="*/ 48 h 240"/>
              <a:gd name="T32" fmla="*/ 48 w 624"/>
              <a:gd name="T33" fmla="*/ 24 h 240"/>
              <a:gd name="T34" fmla="*/ 48 w 624"/>
              <a:gd name="T35" fmla="*/ 216 h 2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240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216"/>
                </a:lnTo>
                <a:cubicBezTo>
                  <a:pt x="624" y="230"/>
                  <a:pt x="614" y="240"/>
                  <a:pt x="600" y="240"/>
                </a:cubicBezTo>
                <a:lnTo>
                  <a:pt x="24" y="240"/>
                </a:lnTo>
                <a:cubicBezTo>
                  <a:pt x="11" y="240"/>
                  <a:pt x="0" y="230"/>
                  <a:pt x="0" y="216"/>
                </a:cubicBezTo>
                <a:lnTo>
                  <a:pt x="0" y="24"/>
                </a:lnTo>
                <a:close/>
                <a:moveTo>
                  <a:pt x="48" y="216"/>
                </a:moveTo>
                <a:lnTo>
                  <a:pt x="24" y="192"/>
                </a:lnTo>
                <a:lnTo>
                  <a:pt x="600" y="192"/>
                </a:lnTo>
                <a:lnTo>
                  <a:pt x="576" y="216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216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7" name="Freeform 36"/>
          <p:cNvSpPr>
            <a:spLocks noEditPoints="1"/>
          </p:cNvSpPr>
          <p:nvPr/>
        </p:nvSpPr>
        <p:spPr bwMode="auto">
          <a:xfrm>
            <a:off x="4591136" y="4250956"/>
            <a:ext cx="118332" cy="37497"/>
          </a:xfrm>
          <a:custGeom>
            <a:avLst/>
            <a:gdLst>
              <a:gd name="T0" fmla="*/ 0 w 624"/>
              <a:gd name="T1" fmla="*/ 24 h 224"/>
              <a:gd name="T2" fmla="*/ 24 w 624"/>
              <a:gd name="T3" fmla="*/ 0 h 224"/>
              <a:gd name="T4" fmla="*/ 600 w 624"/>
              <a:gd name="T5" fmla="*/ 0 h 224"/>
              <a:gd name="T6" fmla="*/ 624 w 624"/>
              <a:gd name="T7" fmla="*/ 24 h 224"/>
              <a:gd name="T8" fmla="*/ 624 w 624"/>
              <a:gd name="T9" fmla="*/ 200 h 224"/>
              <a:gd name="T10" fmla="*/ 600 w 624"/>
              <a:gd name="T11" fmla="*/ 224 h 224"/>
              <a:gd name="T12" fmla="*/ 24 w 624"/>
              <a:gd name="T13" fmla="*/ 224 h 224"/>
              <a:gd name="T14" fmla="*/ 0 w 624"/>
              <a:gd name="T15" fmla="*/ 200 h 224"/>
              <a:gd name="T16" fmla="*/ 0 w 624"/>
              <a:gd name="T17" fmla="*/ 24 h 224"/>
              <a:gd name="T18" fmla="*/ 48 w 624"/>
              <a:gd name="T19" fmla="*/ 200 h 224"/>
              <a:gd name="T20" fmla="*/ 24 w 624"/>
              <a:gd name="T21" fmla="*/ 176 h 224"/>
              <a:gd name="T22" fmla="*/ 600 w 624"/>
              <a:gd name="T23" fmla="*/ 176 h 224"/>
              <a:gd name="T24" fmla="*/ 576 w 624"/>
              <a:gd name="T25" fmla="*/ 200 h 224"/>
              <a:gd name="T26" fmla="*/ 576 w 624"/>
              <a:gd name="T27" fmla="*/ 24 h 224"/>
              <a:gd name="T28" fmla="*/ 600 w 624"/>
              <a:gd name="T29" fmla="*/ 48 h 224"/>
              <a:gd name="T30" fmla="*/ 24 w 624"/>
              <a:gd name="T31" fmla="*/ 48 h 224"/>
              <a:gd name="T32" fmla="*/ 48 w 624"/>
              <a:gd name="T33" fmla="*/ 24 h 224"/>
              <a:gd name="T34" fmla="*/ 48 w 624"/>
              <a:gd name="T35" fmla="*/ 200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22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200"/>
                </a:lnTo>
                <a:cubicBezTo>
                  <a:pt x="624" y="214"/>
                  <a:pt x="614" y="224"/>
                  <a:pt x="600" y="224"/>
                </a:cubicBezTo>
                <a:lnTo>
                  <a:pt x="24" y="224"/>
                </a:lnTo>
                <a:cubicBezTo>
                  <a:pt x="11" y="224"/>
                  <a:pt x="0" y="214"/>
                  <a:pt x="0" y="200"/>
                </a:cubicBezTo>
                <a:lnTo>
                  <a:pt x="0" y="24"/>
                </a:lnTo>
                <a:close/>
                <a:moveTo>
                  <a:pt x="48" y="200"/>
                </a:moveTo>
                <a:lnTo>
                  <a:pt x="24" y="176"/>
                </a:lnTo>
                <a:lnTo>
                  <a:pt x="600" y="176"/>
                </a:lnTo>
                <a:lnTo>
                  <a:pt x="576" y="200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20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8" name="Freeform 37"/>
          <p:cNvSpPr>
            <a:spLocks noEditPoints="1"/>
          </p:cNvSpPr>
          <p:nvPr/>
        </p:nvSpPr>
        <p:spPr bwMode="auto">
          <a:xfrm>
            <a:off x="4972941" y="3657355"/>
            <a:ext cx="118332" cy="631097"/>
          </a:xfrm>
          <a:custGeom>
            <a:avLst/>
            <a:gdLst>
              <a:gd name="T0" fmla="*/ 0 w 624"/>
              <a:gd name="T1" fmla="*/ 24 h 3776"/>
              <a:gd name="T2" fmla="*/ 24 w 624"/>
              <a:gd name="T3" fmla="*/ 0 h 3776"/>
              <a:gd name="T4" fmla="*/ 600 w 624"/>
              <a:gd name="T5" fmla="*/ 0 h 3776"/>
              <a:gd name="T6" fmla="*/ 624 w 624"/>
              <a:gd name="T7" fmla="*/ 24 h 3776"/>
              <a:gd name="T8" fmla="*/ 624 w 624"/>
              <a:gd name="T9" fmla="*/ 3752 h 3776"/>
              <a:gd name="T10" fmla="*/ 600 w 624"/>
              <a:gd name="T11" fmla="*/ 3776 h 3776"/>
              <a:gd name="T12" fmla="*/ 24 w 624"/>
              <a:gd name="T13" fmla="*/ 3776 h 3776"/>
              <a:gd name="T14" fmla="*/ 0 w 624"/>
              <a:gd name="T15" fmla="*/ 3752 h 3776"/>
              <a:gd name="T16" fmla="*/ 0 w 624"/>
              <a:gd name="T17" fmla="*/ 24 h 3776"/>
              <a:gd name="T18" fmla="*/ 48 w 624"/>
              <a:gd name="T19" fmla="*/ 3752 h 3776"/>
              <a:gd name="T20" fmla="*/ 24 w 624"/>
              <a:gd name="T21" fmla="*/ 3728 h 3776"/>
              <a:gd name="T22" fmla="*/ 600 w 624"/>
              <a:gd name="T23" fmla="*/ 3728 h 3776"/>
              <a:gd name="T24" fmla="*/ 576 w 624"/>
              <a:gd name="T25" fmla="*/ 3752 h 3776"/>
              <a:gd name="T26" fmla="*/ 576 w 624"/>
              <a:gd name="T27" fmla="*/ 24 h 3776"/>
              <a:gd name="T28" fmla="*/ 600 w 624"/>
              <a:gd name="T29" fmla="*/ 48 h 3776"/>
              <a:gd name="T30" fmla="*/ 24 w 624"/>
              <a:gd name="T31" fmla="*/ 48 h 3776"/>
              <a:gd name="T32" fmla="*/ 48 w 624"/>
              <a:gd name="T33" fmla="*/ 24 h 3776"/>
              <a:gd name="T34" fmla="*/ 48 w 624"/>
              <a:gd name="T35" fmla="*/ 3752 h 37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3776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3752"/>
                </a:lnTo>
                <a:cubicBezTo>
                  <a:pt x="624" y="3766"/>
                  <a:pt x="614" y="3776"/>
                  <a:pt x="600" y="3776"/>
                </a:cubicBezTo>
                <a:lnTo>
                  <a:pt x="24" y="3776"/>
                </a:lnTo>
                <a:cubicBezTo>
                  <a:pt x="11" y="3776"/>
                  <a:pt x="0" y="3766"/>
                  <a:pt x="0" y="3752"/>
                </a:cubicBezTo>
                <a:lnTo>
                  <a:pt x="0" y="24"/>
                </a:lnTo>
                <a:close/>
                <a:moveTo>
                  <a:pt x="48" y="3752"/>
                </a:moveTo>
                <a:lnTo>
                  <a:pt x="24" y="3728"/>
                </a:lnTo>
                <a:lnTo>
                  <a:pt x="600" y="3728"/>
                </a:lnTo>
                <a:lnTo>
                  <a:pt x="576" y="3752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3752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39" name="Freeform 38"/>
          <p:cNvSpPr>
            <a:spLocks noEditPoints="1"/>
          </p:cNvSpPr>
          <p:nvPr/>
        </p:nvSpPr>
        <p:spPr bwMode="auto">
          <a:xfrm>
            <a:off x="5352783" y="4057127"/>
            <a:ext cx="118332" cy="231325"/>
          </a:xfrm>
          <a:custGeom>
            <a:avLst/>
            <a:gdLst>
              <a:gd name="T0" fmla="*/ 0 w 624"/>
              <a:gd name="T1" fmla="*/ 24 h 1384"/>
              <a:gd name="T2" fmla="*/ 24 w 624"/>
              <a:gd name="T3" fmla="*/ 0 h 1384"/>
              <a:gd name="T4" fmla="*/ 600 w 624"/>
              <a:gd name="T5" fmla="*/ 0 h 1384"/>
              <a:gd name="T6" fmla="*/ 624 w 624"/>
              <a:gd name="T7" fmla="*/ 24 h 1384"/>
              <a:gd name="T8" fmla="*/ 624 w 624"/>
              <a:gd name="T9" fmla="*/ 1360 h 1384"/>
              <a:gd name="T10" fmla="*/ 600 w 624"/>
              <a:gd name="T11" fmla="*/ 1384 h 1384"/>
              <a:gd name="T12" fmla="*/ 24 w 624"/>
              <a:gd name="T13" fmla="*/ 1384 h 1384"/>
              <a:gd name="T14" fmla="*/ 0 w 624"/>
              <a:gd name="T15" fmla="*/ 1360 h 1384"/>
              <a:gd name="T16" fmla="*/ 0 w 624"/>
              <a:gd name="T17" fmla="*/ 24 h 1384"/>
              <a:gd name="T18" fmla="*/ 48 w 624"/>
              <a:gd name="T19" fmla="*/ 1360 h 1384"/>
              <a:gd name="T20" fmla="*/ 24 w 624"/>
              <a:gd name="T21" fmla="*/ 1336 h 1384"/>
              <a:gd name="T22" fmla="*/ 600 w 624"/>
              <a:gd name="T23" fmla="*/ 1336 h 1384"/>
              <a:gd name="T24" fmla="*/ 576 w 624"/>
              <a:gd name="T25" fmla="*/ 1360 h 1384"/>
              <a:gd name="T26" fmla="*/ 576 w 624"/>
              <a:gd name="T27" fmla="*/ 24 h 1384"/>
              <a:gd name="T28" fmla="*/ 600 w 624"/>
              <a:gd name="T29" fmla="*/ 48 h 1384"/>
              <a:gd name="T30" fmla="*/ 24 w 624"/>
              <a:gd name="T31" fmla="*/ 48 h 1384"/>
              <a:gd name="T32" fmla="*/ 48 w 624"/>
              <a:gd name="T33" fmla="*/ 24 h 1384"/>
              <a:gd name="T34" fmla="*/ 48 w 624"/>
              <a:gd name="T35" fmla="*/ 1360 h 13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138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1360"/>
                </a:lnTo>
                <a:cubicBezTo>
                  <a:pt x="624" y="1374"/>
                  <a:pt x="614" y="1384"/>
                  <a:pt x="600" y="1384"/>
                </a:cubicBezTo>
                <a:lnTo>
                  <a:pt x="24" y="1384"/>
                </a:lnTo>
                <a:cubicBezTo>
                  <a:pt x="11" y="1384"/>
                  <a:pt x="0" y="1374"/>
                  <a:pt x="0" y="1360"/>
                </a:cubicBezTo>
                <a:lnTo>
                  <a:pt x="0" y="24"/>
                </a:lnTo>
                <a:close/>
                <a:moveTo>
                  <a:pt x="48" y="1360"/>
                </a:moveTo>
                <a:lnTo>
                  <a:pt x="24" y="1336"/>
                </a:lnTo>
                <a:lnTo>
                  <a:pt x="600" y="1336"/>
                </a:lnTo>
                <a:lnTo>
                  <a:pt x="576" y="1360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136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0" name="Freeform 39"/>
          <p:cNvSpPr>
            <a:spLocks noEditPoints="1"/>
          </p:cNvSpPr>
          <p:nvPr/>
        </p:nvSpPr>
        <p:spPr bwMode="auto">
          <a:xfrm>
            <a:off x="5734586" y="3295079"/>
            <a:ext cx="118332" cy="993372"/>
          </a:xfrm>
          <a:custGeom>
            <a:avLst/>
            <a:gdLst>
              <a:gd name="T0" fmla="*/ 0 w 624"/>
              <a:gd name="T1" fmla="*/ 24 h 5944"/>
              <a:gd name="T2" fmla="*/ 24 w 624"/>
              <a:gd name="T3" fmla="*/ 0 h 5944"/>
              <a:gd name="T4" fmla="*/ 600 w 624"/>
              <a:gd name="T5" fmla="*/ 0 h 5944"/>
              <a:gd name="T6" fmla="*/ 624 w 624"/>
              <a:gd name="T7" fmla="*/ 24 h 5944"/>
              <a:gd name="T8" fmla="*/ 624 w 624"/>
              <a:gd name="T9" fmla="*/ 5920 h 5944"/>
              <a:gd name="T10" fmla="*/ 600 w 624"/>
              <a:gd name="T11" fmla="*/ 5944 h 5944"/>
              <a:gd name="T12" fmla="*/ 24 w 624"/>
              <a:gd name="T13" fmla="*/ 5944 h 5944"/>
              <a:gd name="T14" fmla="*/ 0 w 624"/>
              <a:gd name="T15" fmla="*/ 5920 h 5944"/>
              <a:gd name="T16" fmla="*/ 0 w 624"/>
              <a:gd name="T17" fmla="*/ 24 h 5944"/>
              <a:gd name="T18" fmla="*/ 48 w 624"/>
              <a:gd name="T19" fmla="*/ 5920 h 5944"/>
              <a:gd name="T20" fmla="*/ 24 w 624"/>
              <a:gd name="T21" fmla="*/ 5896 h 5944"/>
              <a:gd name="T22" fmla="*/ 600 w 624"/>
              <a:gd name="T23" fmla="*/ 5896 h 5944"/>
              <a:gd name="T24" fmla="*/ 576 w 624"/>
              <a:gd name="T25" fmla="*/ 5920 h 5944"/>
              <a:gd name="T26" fmla="*/ 576 w 624"/>
              <a:gd name="T27" fmla="*/ 24 h 5944"/>
              <a:gd name="T28" fmla="*/ 600 w 624"/>
              <a:gd name="T29" fmla="*/ 48 h 5944"/>
              <a:gd name="T30" fmla="*/ 24 w 624"/>
              <a:gd name="T31" fmla="*/ 48 h 5944"/>
              <a:gd name="T32" fmla="*/ 48 w 624"/>
              <a:gd name="T33" fmla="*/ 24 h 5944"/>
              <a:gd name="T34" fmla="*/ 48 w 624"/>
              <a:gd name="T35" fmla="*/ 5920 h 59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624" h="5944">
                <a:moveTo>
                  <a:pt x="0" y="24"/>
                </a:moveTo>
                <a:cubicBezTo>
                  <a:pt x="0" y="11"/>
                  <a:pt x="11" y="0"/>
                  <a:pt x="24" y="0"/>
                </a:cubicBezTo>
                <a:lnTo>
                  <a:pt x="600" y="0"/>
                </a:lnTo>
                <a:cubicBezTo>
                  <a:pt x="614" y="0"/>
                  <a:pt x="624" y="11"/>
                  <a:pt x="624" y="24"/>
                </a:cubicBezTo>
                <a:lnTo>
                  <a:pt x="624" y="5920"/>
                </a:lnTo>
                <a:cubicBezTo>
                  <a:pt x="624" y="5934"/>
                  <a:pt x="614" y="5944"/>
                  <a:pt x="600" y="5944"/>
                </a:cubicBezTo>
                <a:lnTo>
                  <a:pt x="24" y="5944"/>
                </a:lnTo>
                <a:cubicBezTo>
                  <a:pt x="11" y="5944"/>
                  <a:pt x="0" y="5934"/>
                  <a:pt x="0" y="5920"/>
                </a:cubicBezTo>
                <a:lnTo>
                  <a:pt x="0" y="24"/>
                </a:lnTo>
                <a:close/>
                <a:moveTo>
                  <a:pt x="48" y="5920"/>
                </a:moveTo>
                <a:lnTo>
                  <a:pt x="24" y="5896"/>
                </a:lnTo>
                <a:lnTo>
                  <a:pt x="600" y="5896"/>
                </a:lnTo>
                <a:lnTo>
                  <a:pt x="576" y="5920"/>
                </a:lnTo>
                <a:lnTo>
                  <a:pt x="576" y="24"/>
                </a:lnTo>
                <a:lnTo>
                  <a:pt x="600" y="48"/>
                </a:lnTo>
                <a:lnTo>
                  <a:pt x="24" y="48"/>
                </a:lnTo>
                <a:lnTo>
                  <a:pt x="48" y="24"/>
                </a:lnTo>
                <a:lnTo>
                  <a:pt x="48" y="592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1" name="Freeform 40"/>
          <p:cNvSpPr>
            <a:spLocks noEditPoints="1"/>
          </p:cNvSpPr>
          <p:nvPr/>
        </p:nvSpPr>
        <p:spPr bwMode="auto">
          <a:xfrm>
            <a:off x="1463487" y="4267107"/>
            <a:ext cx="56225" cy="17306"/>
          </a:xfrm>
          <a:custGeom>
            <a:avLst/>
            <a:gdLst>
              <a:gd name="T0" fmla="*/ 37 w 86"/>
              <a:gd name="T1" fmla="*/ 23 h 30"/>
              <a:gd name="T2" fmla="*/ 37 w 86"/>
              <a:gd name="T3" fmla="*/ 14 h 30"/>
              <a:gd name="T4" fmla="*/ 37 w 86"/>
              <a:gd name="T5" fmla="*/ 7 h 30"/>
              <a:gd name="T6" fmla="*/ 51 w 86"/>
              <a:gd name="T7" fmla="*/ 7 h 30"/>
              <a:gd name="T8" fmla="*/ 51 w 86"/>
              <a:gd name="T9" fmla="*/ 14 h 30"/>
              <a:gd name="T10" fmla="*/ 51 w 86"/>
              <a:gd name="T11" fmla="*/ 23 h 30"/>
              <a:gd name="T12" fmla="*/ 37 w 86"/>
              <a:gd name="T13" fmla="*/ 23 h 30"/>
              <a:gd name="T14" fmla="*/ 0 w 86"/>
              <a:gd name="T15" fmla="*/ 16 h 30"/>
              <a:gd name="T16" fmla="*/ 86 w 86"/>
              <a:gd name="T17" fmla="*/ 16 h 30"/>
              <a:gd name="T18" fmla="*/ 86 w 86"/>
              <a:gd name="T19" fmla="*/ 30 h 30"/>
              <a:gd name="T20" fmla="*/ 0 w 86"/>
              <a:gd name="T21" fmla="*/ 30 h 30"/>
              <a:gd name="T22" fmla="*/ 0 w 86"/>
              <a:gd name="T23" fmla="*/ 16 h 30"/>
              <a:gd name="T24" fmla="*/ 0 w 86"/>
              <a:gd name="T25" fmla="*/ 0 h 30"/>
              <a:gd name="T26" fmla="*/ 86 w 86"/>
              <a:gd name="T27" fmla="*/ 0 h 30"/>
              <a:gd name="T28" fmla="*/ 86 w 86"/>
              <a:gd name="T29" fmla="*/ 14 h 30"/>
              <a:gd name="T30" fmla="*/ 0 w 86"/>
              <a:gd name="T31" fmla="*/ 14 h 30"/>
              <a:gd name="T32" fmla="*/ 0 w 86"/>
              <a:gd name="T33" fmla="*/ 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30">
                <a:moveTo>
                  <a:pt x="37" y="23"/>
                </a:moveTo>
                <a:lnTo>
                  <a:pt x="37" y="14"/>
                </a:lnTo>
                <a:lnTo>
                  <a:pt x="37" y="7"/>
                </a:lnTo>
                <a:lnTo>
                  <a:pt x="51" y="7"/>
                </a:lnTo>
                <a:lnTo>
                  <a:pt x="51" y="14"/>
                </a:lnTo>
                <a:lnTo>
                  <a:pt x="51" y="23"/>
                </a:lnTo>
                <a:lnTo>
                  <a:pt x="37" y="23"/>
                </a:lnTo>
                <a:close/>
                <a:moveTo>
                  <a:pt x="0" y="16"/>
                </a:moveTo>
                <a:lnTo>
                  <a:pt x="86" y="16"/>
                </a:lnTo>
                <a:lnTo>
                  <a:pt x="86" y="30"/>
                </a:lnTo>
                <a:lnTo>
                  <a:pt x="0" y="30"/>
                </a:lnTo>
                <a:lnTo>
                  <a:pt x="0" y="16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2" name="Freeform 41"/>
          <p:cNvSpPr>
            <a:spLocks noEditPoints="1"/>
          </p:cNvSpPr>
          <p:nvPr/>
        </p:nvSpPr>
        <p:spPr bwMode="auto">
          <a:xfrm>
            <a:off x="1845291" y="4276336"/>
            <a:ext cx="56225" cy="9230"/>
          </a:xfrm>
          <a:custGeom>
            <a:avLst/>
            <a:gdLst>
              <a:gd name="T0" fmla="*/ 35 w 86"/>
              <a:gd name="T1" fmla="*/ 9 h 16"/>
              <a:gd name="T2" fmla="*/ 35 w 86"/>
              <a:gd name="T3" fmla="*/ 7 h 16"/>
              <a:gd name="T4" fmla="*/ 49 w 86"/>
              <a:gd name="T5" fmla="*/ 7 h 16"/>
              <a:gd name="T6" fmla="*/ 49 w 86"/>
              <a:gd name="T7" fmla="*/ 9 h 16"/>
              <a:gd name="T8" fmla="*/ 35 w 86"/>
              <a:gd name="T9" fmla="*/ 9 h 16"/>
              <a:gd name="T10" fmla="*/ 0 w 86"/>
              <a:gd name="T11" fmla="*/ 2 h 16"/>
              <a:gd name="T12" fmla="*/ 86 w 86"/>
              <a:gd name="T13" fmla="*/ 2 h 16"/>
              <a:gd name="T14" fmla="*/ 86 w 86"/>
              <a:gd name="T15" fmla="*/ 16 h 16"/>
              <a:gd name="T16" fmla="*/ 0 w 86"/>
              <a:gd name="T17" fmla="*/ 16 h 16"/>
              <a:gd name="T18" fmla="*/ 0 w 86"/>
              <a:gd name="T19" fmla="*/ 2 h 16"/>
              <a:gd name="T20" fmla="*/ 0 w 86"/>
              <a:gd name="T21" fmla="*/ 0 h 16"/>
              <a:gd name="T22" fmla="*/ 86 w 86"/>
              <a:gd name="T23" fmla="*/ 0 h 16"/>
              <a:gd name="T24" fmla="*/ 86 w 86"/>
              <a:gd name="T25" fmla="*/ 14 h 16"/>
              <a:gd name="T26" fmla="*/ 0 w 86"/>
              <a:gd name="T27" fmla="*/ 14 h 16"/>
              <a:gd name="T28" fmla="*/ 0 w 86"/>
              <a:gd name="T29" fmla="*/ 0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6" h="16">
                <a:moveTo>
                  <a:pt x="35" y="9"/>
                </a:moveTo>
                <a:lnTo>
                  <a:pt x="35" y="7"/>
                </a:lnTo>
                <a:lnTo>
                  <a:pt x="49" y="7"/>
                </a:lnTo>
                <a:lnTo>
                  <a:pt x="49" y="9"/>
                </a:lnTo>
                <a:lnTo>
                  <a:pt x="35" y="9"/>
                </a:lnTo>
                <a:close/>
                <a:moveTo>
                  <a:pt x="0" y="2"/>
                </a:moveTo>
                <a:lnTo>
                  <a:pt x="86" y="2"/>
                </a:lnTo>
                <a:lnTo>
                  <a:pt x="86" y="16"/>
                </a:lnTo>
                <a:lnTo>
                  <a:pt x="0" y="16"/>
                </a:lnTo>
                <a:lnTo>
                  <a:pt x="0" y="2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3" name="Freeform 42"/>
          <p:cNvSpPr>
            <a:spLocks noEditPoints="1"/>
          </p:cNvSpPr>
          <p:nvPr/>
        </p:nvSpPr>
        <p:spPr bwMode="auto">
          <a:xfrm>
            <a:off x="2225134" y="4261915"/>
            <a:ext cx="57531" cy="13268"/>
          </a:xfrm>
          <a:custGeom>
            <a:avLst/>
            <a:gdLst>
              <a:gd name="T0" fmla="*/ 37 w 88"/>
              <a:gd name="T1" fmla="*/ 16 h 23"/>
              <a:gd name="T2" fmla="*/ 37 w 88"/>
              <a:gd name="T3" fmla="*/ 11 h 23"/>
              <a:gd name="T4" fmla="*/ 37 w 88"/>
              <a:gd name="T5" fmla="*/ 6 h 23"/>
              <a:gd name="T6" fmla="*/ 51 w 88"/>
              <a:gd name="T7" fmla="*/ 6 h 23"/>
              <a:gd name="T8" fmla="*/ 51 w 88"/>
              <a:gd name="T9" fmla="*/ 11 h 23"/>
              <a:gd name="T10" fmla="*/ 51 w 88"/>
              <a:gd name="T11" fmla="*/ 16 h 23"/>
              <a:gd name="T12" fmla="*/ 37 w 88"/>
              <a:gd name="T13" fmla="*/ 16 h 23"/>
              <a:gd name="T14" fmla="*/ 0 w 88"/>
              <a:gd name="T15" fmla="*/ 9 h 23"/>
              <a:gd name="T16" fmla="*/ 88 w 88"/>
              <a:gd name="T17" fmla="*/ 9 h 23"/>
              <a:gd name="T18" fmla="*/ 88 w 88"/>
              <a:gd name="T19" fmla="*/ 23 h 23"/>
              <a:gd name="T20" fmla="*/ 0 w 88"/>
              <a:gd name="T21" fmla="*/ 23 h 23"/>
              <a:gd name="T22" fmla="*/ 0 w 88"/>
              <a:gd name="T23" fmla="*/ 9 h 23"/>
              <a:gd name="T24" fmla="*/ 0 w 88"/>
              <a:gd name="T25" fmla="*/ 0 h 23"/>
              <a:gd name="T26" fmla="*/ 88 w 88"/>
              <a:gd name="T27" fmla="*/ 0 h 23"/>
              <a:gd name="T28" fmla="*/ 88 w 88"/>
              <a:gd name="T29" fmla="*/ 13 h 23"/>
              <a:gd name="T30" fmla="*/ 0 w 88"/>
              <a:gd name="T31" fmla="*/ 13 h 23"/>
              <a:gd name="T32" fmla="*/ 0 w 88"/>
              <a:gd name="T33" fmla="*/ 0 h 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23">
                <a:moveTo>
                  <a:pt x="37" y="16"/>
                </a:moveTo>
                <a:lnTo>
                  <a:pt x="37" y="11"/>
                </a:lnTo>
                <a:lnTo>
                  <a:pt x="37" y="6"/>
                </a:lnTo>
                <a:lnTo>
                  <a:pt x="51" y="6"/>
                </a:lnTo>
                <a:lnTo>
                  <a:pt x="51" y="11"/>
                </a:lnTo>
                <a:lnTo>
                  <a:pt x="51" y="16"/>
                </a:lnTo>
                <a:lnTo>
                  <a:pt x="37" y="16"/>
                </a:lnTo>
                <a:close/>
                <a:moveTo>
                  <a:pt x="0" y="9"/>
                </a:moveTo>
                <a:lnTo>
                  <a:pt x="88" y="9"/>
                </a:lnTo>
                <a:lnTo>
                  <a:pt x="88" y="23"/>
                </a:lnTo>
                <a:lnTo>
                  <a:pt x="0" y="23"/>
                </a:lnTo>
                <a:lnTo>
                  <a:pt x="0" y="9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3"/>
                </a:lnTo>
                <a:lnTo>
                  <a:pt x="0" y="1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4" name="Freeform 43"/>
          <p:cNvSpPr>
            <a:spLocks noEditPoints="1"/>
          </p:cNvSpPr>
          <p:nvPr/>
        </p:nvSpPr>
        <p:spPr bwMode="auto">
          <a:xfrm>
            <a:off x="2606937" y="4275184"/>
            <a:ext cx="56225" cy="9230"/>
          </a:xfrm>
          <a:custGeom>
            <a:avLst/>
            <a:gdLst>
              <a:gd name="T0" fmla="*/ 37 w 86"/>
              <a:gd name="T1" fmla="*/ 9 h 16"/>
              <a:gd name="T2" fmla="*/ 37 w 86"/>
              <a:gd name="T3" fmla="*/ 7 h 16"/>
              <a:gd name="T4" fmla="*/ 51 w 86"/>
              <a:gd name="T5" fmla="*/ 7 h 16"/>
              <a:gd name="T6" fmla="*/ 51 w 86"/>
              <a:gd name="T7" fmla="*/ 9 h 16"/>
              <a:gd name="T8" fmla="*/ 37 w 86"/>
              <a:gd name="T9" fmla="*/ 9 h 16"/>
              <a:gd name="T10" fmla="*/ 0 w 86"/>
              <a:gd name="T11" fmla="*/ 2 h 16"/>
              <a:gd name="T12" fmla="*/ 86 w 86"/>
              <a:gd name="T13" fmla="*/ 2 h 16"/>
              <a:gd name="T14" fmla="*/ 86 w 86"/>
              <a:gd name="T15" fmla="*/ 16 h 16"/>
              <a:gd name="T16" fmla="*/ 0 w 86"/>
              <a:gd name="T17" fmla="*/ 16 h 16"/>
              <a:gd name="T18" fmla="*/ 0 w 86"/>
              <a:gd name="T19" fmla="*/ 2 h 16"/>
              <a:gd name="T20" fmla="*/ 0 w 86"/>
              <a:gd name="T21" fmla="*/ 0 h 16"/>
              <a:gd name="T22" fmla="*/ 86 w 86"/>
              <a:gd name="T23" fmla="*/ 0 h 16"/>
              <a:gd name="T24" fmla="*/ 86 w 86"/>
              <a:gd name="T25" fmla="*/ 14 h 16"/>
              <a:gd name="T26" fmla="*/ 0 w 86"/>
              <a:gd name="T27" fmla="*/ 14 h 16"/>
              <a:gd name="T28" fmla="*/ 0 w 86"/>
              <a:gd name="T29" fmla="*/ 0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6" h="16">
                <a:moveTo>
                  <a:pt x="37" y="9"/>
                </a:moveTo>
                <a:lnTo>
                  <a:pt x="37" y="7"/>
                </a:lnTo>
                <a:lnTo>
                  <a:pt x="51" y="7"/>
                </a:lnTo>
                <a:lnTo>
                  <a:pt x="51" y="9"/>
                </a:lnTo>
                <a:lnTo>
                  <a:pt x="37" y="9"/>
                </a:lnTo>
                <a:close/>
                <a:moveTo>
                  <a:pt x="0" y="2"/>
                </a:moveTo>
                <a:lnTo>
                  <a:pt x="86" y="2"/>
                </a:lnTo>
                <a:lnTo>
                  <a:pt x="86" y="16"/>
                </a:lnTo>
                <a:lnTo>
                  <a:pt x="0" y="16"/>
                </a:lnTo>
                <a:lnTo>
                  <a:pt x="0" y="2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5" name="Freeform 44"/>
          <p:cNvSpPr>
            <a:spLocks noEditPoints="1"/>
          </p:cNvSpPr>
          <p:nvPr/>
        </p:nvSpPr>
        <p:spPr bwMode="auto">
          <a:xfrm>
            <a:off x="2988742" y="4275184"/>
            <a:ext cx="56225" cy="9230"/>
          </a:xfrm>
          <a:custGeom>
            <a:avLst/>
            <a:gdLst>
              <a:gd name="T0" fmla="*/ 35 w 86"/>
              <a:gd name="T1" fmla="*/ 9 h 16"/>
              <a:gd name="T2" fmla="*/ 35 w 86"/>
              <a:gd name="T3" fmla="*/ 7 h 16"/>
              <a:gd name="T4" fmla="*/ 49 w 86"/>
              <a:gd name="T5" fmla="*/ 7 h 16"/>
              <a:gd name="T6" fmla="*/ 49 w 86"/>
              <a:gd name="T7" fmla="*/ 9 h 16"/>
              <a:gd name="T8" fmla="*/ 35 w 86"/>
              <a:gd name="T9" fmla="*/ 9 h 16"/>
              <a:gd name="T10" fmla="*/ 0 w 86"/>
              <a:gd name="T11" fmla="*/ 2 h 16"/>
              <a:gd name="T12" fmla="*/ 86 w 86"/>
              <a:gd name="T13" fmla="*/ 2 h 16"/>
              <a:gd name="T14" fmla="*/ 86 w 86"/>
              <a:gd name="T15" fmla="*/ 16 h 16"/>
              <a:gd name="T16" fmla="*/ 0 w 86"/>
              <a:gd name="T17" fmla="*/ 16 h 16"/>
              <a:gd name="T18" fmla="*/ 0 w 86"/>
              <a:gd name="T19" fmla="*/ 2 h 16"/>
              <a:gd name="T20" fmla="*/ 0 w 86"/>
              <a:gd name="T21" fmla="*/ 0 h 16"/>
              <a:gd name="T22" fmla="*/ 86 w 86"/>
              <a:gd name="T23" fmla="*/ 0 h 16"/>
              <a:gd name="T24" fmla="*/ 86 w 86"/>
              <a:gd name="T25" fmla="*/ 14 h 16"/>
              <a:gd name="T26" fmla="*/ 0 w 86"/>
              <a:gd name="T27" fmla="*/ 14 h 16"/>
              <a:gd name="T28" fmla="*/ 0 w 86"/>
              <a:gd name="T29" fmla="*/ 0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6" h="16">
                <a:moveTo>
                  <a:pt x="35" y="9"/>
                </a:moveTo>
                <a:lnTo>
                  <a:pt x="35" y="7"/>
                </a:lnTo>
                <a:lnTo>
                  <a:pt x="49" y="7"/>
                </a:lnTo>
                <a:lnTo>
                  <a:pt x="49" y="9"/>
                </a:lnTo>
                <a:lnTo>
                  <a:pt x="35" y="9"/>
                </a:lnTo>
                <a:close/>
                <a:moveTo>
                  <a:pt x="0" y="2"/>
                </a:moveTo>
                <a:lnTo>
                  <a:pt x="86" y="2"/>
                </a:lnTo>
                <a:lnTo>
                  <a:pt x="86" y="16"/>
                </a:lnTo>
                <a:lnTo>
                  <a:pt x="0" y="16"/>
                </a:lnTo>
                <a:lnTo>
                  <a:pt x="0" y="2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6" name="Rectangle 45"/>
          <p:cNvSpPr>
            <a:spLocks noChangeArrowheads="1"/>
          </p:cNvSpPr>
          <p:nvPr/>
        </p:nvSpPr>
        <p:spPr bwMode="auto">
          <a:xfrm>
            <a:off x="3369238" y="4272298"/>
            <a:ext cx="57531" cy="8077"/>
          </a:xfrm>
          <a:prstGeom prst="rect">
            <a:avLst/>
          </a:pr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7" name="Freeform 46"/>
          <p:cNvSpPr>
            <a:spLocks noEditPoints="1"/>
          </p:cNvSpPr>
          <p:nvPr/>
        </p:nvSpPr>
        <p:spPr bwMode="auto">
          <a:xfrm>
            <a:off x="3750387" y="4273454"/>
            <a:ext cx="56225" cy="10960"/>
          </a:xfrm>
          <a:custGeom>
            <a:avLst/>
            <a:gdLst>
              <a:gd name="T0" fmla="*/ 37 w 86"/>
              <a:gd name="T1" fmla="*/ 12 h 19"/>
              <a:gd name="T2" fmla="*/ 37 w 86"/>
              <a:gd name="T3" fmla="*/ 10 h 19"/>
              <a:gd name="T4" fmla="*/ 37 w 86"/>
              <a:gd name="T5" fmla="*/ 7 h 19"/>
              <a:gd name="T6" fmla="*/ 51 w 86"/>
              <a:gd name="T7" fmla="*/ 7 h 19"/>
              <a:gd name="T8" fmla="*/ 51 w 86"/>
              <a:gd name="T9" fmla="*/ 10 h 19"/>
              <a:gd name="T10" fmla="*/ 51 w 86"/>
              <a:gd name="T11" fmla="*/ 12 h 19"/>
              <a:gd name="T12" fmla="*/ 37 w 86"/>
              <a:gd name="T13" fmla="*/ 12 h 19"/>
              <a:gd name="T14" fmla="*/ 0 w 86"/>
              <a:gd name="T15" fmla="*/ 5 h 19"/>
              <a:gd name="T16" fmla="*/ 86 w 86"/>
              <a:gd name="T17" fmla="*/ 5 h 19"/>
              <a:gd name="T18" fmla="*/ 86 w 86"/>
              <a:gd name="T19" fmla="*/ 19 h 19"/>
              <a:gd name="T20" fmla="*/ 0 w 86"/>
              <a:gd name="T21" fmla="*/ 19 h 19"/>
              <a:gd name="T22" fmla="*/ 0 w 86"/>
              <a:gd name="T23" fmla="*/ 5 h 19"/>
              <a:gd name="T24" fmla="*/ 0 w 86"/>
              <a:gd name="T25" fmla="*/ 0 h 19"/>
              <a:gd name="T26" fmla="*/ 86 w 86"/>
              <a:gd name="T27" fmla="*/ 0 h 19"/>
              <a:gd name="T28" fmla="*/ 86 w 86"/>
              <a:gd name="T29" fmla="*/ 14 h 19"/>
              <a:gd name="T30" fmla="*/ 0 w 86"/>
              <a:gd name="T31" fmla="*/ 14 h 19"/>
              <a:gd name="T32" fmla="*/ 0 w 86"/>
              <a:gd name="T33" fmla="*/ 0 h 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19">
                <a:moveTo>
                  <a:pt x="37" y="12"/>
                </a:moveTo>
                <a:lnTo>
                  <a:pt x="37" y="10"/>
                </a:lnTo>
                <a:lnTo>
                  <a:pt x="37" y="7"/>
                </a:lnTo>
                <a:lnTo>
                  <a:pt x="51" y="7"/>
                </a:lnTo>
                <a:lnTo>
                  <a:pt x="51" y="10"/>
                </a:lnTo>
                <a:lnTo>
                  <a:pt x="51" y="12"/>
                </a:lnTo>
                <a:lnTo>
                  <a:pt x="37" y="12"/>
                </a:lnTo>
                <a:close/>
                <a:moveTo>
                  <a:pt x="0" y="5"/>
                </a:moveTo>
                <a:lnTo>
                  <a:pt x="86" y="5"/>
                </a:lnTo>
                <a:lnTo>
                  <a:pt x="86" y="19"/>
                </a:lnTo>
                <a:lnTo>
                  <a:pt x="0" y="19"/>
                </a:lnTo>
                <a:lnTo>
                  <a:pt x="0" y="5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8" name="Freeform 47"/>
          <p:cNvSpPr>
            <a:spLocks noEditPoints="1"/>
          </p:cNvSpPr>
          <p:nvPr/>
        </p:nvSpPr>
        <p:spPr bwMode="auto">
          <a:xfrm>
            <a:off x="4132191" y="4276336"/>
            <a:ext cx="56225" cy="9230"/>
          </a:xfrm>
          <a:custGeom>
            <a:avLst/>
            <a:gdLst>
              <a:gd name="T0" fmla="*/ 35 w 86"/>
              <a:gd name="T1" fmla="*/ 9 h 16"/>
              <a:gd name="T2" fmla="*/ 35 w 86"/>
              <a:gd name="T3" fmla="*/ 7 h 16"/>
              <a:gd name="T4" fmla="*/ 49 w 86"/>
              <a:gd name="T5" fmla="*/ 7 h 16"/>
              <a:gd name="T6" fmla="*/ 49 w 86"/>
              <a:gd name="T7" fmla="*/ 9 h 16"/>
              <a:gd name="T8" fmla="*/ 35 w 86"/>
              <a:gd name="T9" fmla="*/ 9 h 16"/>
              <a:gd name="T10" fmla="*/ 0 w 86"/>
              <a:gd name="T11" fmla="*/ 2 h 16"/>
              <a:gd name="T12" fmla="*/ 86 w 86"/>
              <a:gd name="T13" fmla="*/ 2 h 16"/>
              <a:gd name="T14" fmla="*/ 86 w 86"/>
              <a:gd name="T15" fmla="*/ 16 h 16"/>
              <a:gd name="T16" fmla="*/ 0 w 86"/>
              <a:gd name="T17" fmla="*/ 16 h 16"/>
              <a:gd name="T18" fmla="*/ 0 w 86"/>
              <a:gd name="T19" fmla="*/ 2 h 16"/>
              <a:gd name="T20" fmla="*/ 0 w 86"/>
              <a:gd name="T21" fmla="*/ 0 h 16"/>
              <a:gd name="T22" fmla="*/ 86 w 86"/>
              <a:gd name="T23" fmla="*/ 0 h 16"/>
              <a:gd name="T24" fmla="*/ 86 w 86"/>
              <a:gd name="T25" fmla="*/ 14 h 16"/>
              <a:gd name="T26" fmla="*/ 0 w 86"/>
              <a:gd name="T27" fmla="*/ 14 h 16"/>
              <a:gd name="T28" fmla="*/ 0 w 86"/>
              <a:gd name="T29" fmla="*/ 0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6" h="16">
                <a:moveTo>
                  <a:pt x="35" y="9"/>
                </a:moveTo>
                <a:lnTo>
                  <a:pt x="35" y="7"/>
                </a:lnTo>
                <a:lnTo>
                  <a:pt x="49" y="7"/>
                </a:lnTo>
                <a:lnTo>
                  <a:pt x="49" y="9"/>
                </a:lnTo>
                <a:lnTo>
                  <a:pt x="35" y="9"/>
                </a:lnTo>
                <a:close/>
                <a:moveTo>
                  <a:pt x="0" y="2"/>
                </a:moveTo>
                <a:lnTo>
                  <a:pt x="86" y="2"/>
                </a:lnTo>
                <a:lnTo>
                  <a:pt x="86" y="16"/>
                </a:lnTo>
                <a:lnTo>
                  <a:pt x="0" y="16"/>
                </a:lnTo>
                <a:lnTo>
                  <a:pt x="0" y="2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49" name="Freeform 48"/>
          <p:cNvSpPr>
            <a:spLocks noEditPoints="1"/>
          </p:cNvSpPr>
          <p:nvPr/>
        </p:nvSpPr>
        <p:spPr bwMode="auto">
          <a:xfrm>
            <a:off x="4512687" y="4267107"/>
            <a:ext cx="57531" cy="14422"/>
          </a:xfrm>
          <a:custGeom>
            <a:avLst/>
            <a:gdLst>
              <a:gd name="T0" fmla="*/ 37 w 88"/>
              <a:gd name="T1" fmla="*/ 18 h 25"/>
              <a:gd name="T2" fmla="*/ 37 w 88"/>
              <a:gd name="T3" fmla="*/ 14 h 25"/>
              <a:gd name="T4" fmla="*/ 37 w 88"/>
              <a:gd name="T5" fmla="*/ 7 h 25"/>
              <a:gd name="T6" fmla="*/ 51 w 88"/>
              <a:gd name="T7" fmla="*/ 7 h 25"/>
              <a:gd name="T8" fmla="*/ 51 w 88"/>
              <a:gd name="T9" fmla="*/ 14 h 25"/>
              <a:gd name="T10" fmla="*/ 51 w 88"/>
              <a:gd name="T11" fmla="*/ 18 h 25"/>
              <a:gd name="T12" fmla="*/ 37 w 88"/>
              <a:gd name="T13" fmla="*/ 18 h 25"/>
              <a:gd name="T14" fmla="*/ 0 w 88"/>
              <a:gd name="T15" fmla="*/ 11 h 25"/>
              <a:gd name="T16" fmla="*/ 88 w 88"/>
              <a:gd name="T17" fmla="*/ 11 h 25"/>
              <a:gd name="T18" fmla="*/ 88 w 88"/>
              <a:gd name="T19" fmla="*/ 25 h 25"/>
              <a:gd name="T20" fmla="*/ 0 w 88"/>
              <a:gd name="T21" fmla="*/ 25 h 25"/>
              <a:gd name="T22" fmla="*/ 0 w 88"/>
              <a:gd name="T23" fmla="*/ 11 h 25"/>
              <a:gd name="T24" fmla="*/ 0 w 88"/>
              <a:gd name="T25" fmla="*/ 0 h 25"/>
              <a:gd name="T26" fmla="*/ 88 w 88"/>
              <a:gd name="T27" fmla="*/ 0 h 25"/>
              <a:gd name="T28" fmla="*/ 88 w 88"/>
              <a:gd name="T29" fmla="*/ 14 h 25"/>
              <a:gd name="T30" fmla="*/ 0 w 88"/>
              <a:gd name="T31" fmla="*/ 14 h 25"/>
              <a:gd name="T32" fmla="*/ 0 w 88"/>
              <a:gd name="T33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25">
                <a:moveTo>
                  <a:pt x="37" y="18"/>
                </a:moveTo>
                <a:lnTo>
                  <a:pt x="37" y="14"/>
                </a:lnTo>
                <a:lnTo>
                  <a:pt x="37" y="7"/>
                </a:lnTo>
                <a:lnTo>
                  <a:pt x="51" y="7"/>
                </a:lnTo>
                <a:lnTo>
                  <a:pt x="51" y="14"/>
                </a:lnTo>
                <a:lnTo>
                  <a:pt x="51" y="18"/>
                </a:lnTo>
                <a:lnTo>
                  <a:pt x="37" y="18"/>
                </a:lnTo>
                <a:close/>
                <a:moveTo>
                  <a:pt x="0" y="11"/>
                </a:moveTo>
                <a:lnTo>
                  <a:pt x="88" y="11"/>
                </a:lnTo>
                <a:lnTo>
                  <a:pt x="88" y="25"/>
                </a:lnTo>
                <a:lnTo>
                  <a:pt x="0" y="25"/>
                </a:lnTo>
                <a:lnTo>
                  <a:pt x="0" y="11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0" name="Freeform 49"/>
          <p:cNvSpPr>
            <a:spLocks noEditPoints="1"/>
          </p:cNvSpPr>
          <p:nvPr/>
        </p:nvSpPr>
        <p:spPr bwMode="auto">
          <a:xfrm>
            <a:off x="4893837" y="4272300"/>
            <a:ext cx="56225" cy="10960"/>
          </a:xfrm>
          <a:custGeom>
            <a:avLst/>
            <a:gdLst>
              <a:gd name="T0" fmla="*/ 37 w 86"/>
              <a:gd name="T1" fmla="*/ 12 h 19"/>
              <a:gd name="T2" fmla="*/ 37 w 86"/>
              <a:gd name="T3" fmla="*/ 9 h 19"/>
              <a:gd name="T4" fmla="*/ 37 w 86"/>
              <a:gd name="T5" fmla="*/ 7 h 19"/>
              <a:gd name="T6" fmla="*/ 51 w 86"/>
              <a:gd name="T7" fmla="*/ 7 h 19"/>
              <a:gd name="T8" fmla="*/ 51 w 86"/>
              <a:gd name="T9" fmla="*/ 9 h 19"/>
              <a:gd name="T10" fmla="*/ 51 w 86"/>
              <a:gd name="T11" fmla="*/ 12 h 19"/>
              <a:gd name="T12" fmla="*/ 37 w 86"/>
              <a:gd name="T13" fmla="*/ 12 h 19"/>
              <a:gd name="T14" fmla="*/ 0 w 86"/>
              <a:gd name="T15" fmla="*/ 5 h 19"/>
              <a:gd name="T16" fmla="*/ 86 w 86"/>
              <a:gd name="T17" fmla="*/ 5 h 19"/>
              <a:gd name="T18" fmla="*/ 86 w 86"/>
              <a:gd name="T19" fmla="*/ 19 h 19"/>
              <a:gd name="T20" fmla="*/ 0 w 86"/>
              <a:gd name="T21" fmla="*/ 19 h 19"/>
              <a:gd name="T22" fmla="*/ 0 w 86"/>
              <a:gd name="T23" fmla="*/ 5 h 19"/>
              <a:gd name="T24" fmla="*/ 0 w 86"/>
              <a:gd name="T25" fmla="*/ 0 h 19"/>
              <a:gd name="T26" fmla="*/ 86 w 86"/>
              <a:gd name="T27" fmla="*/ 0 h 19"/>
              <a:gd name="T28" fmla="*/ 86 w 86"/>
              <a:gd name="T29" fmla="*/ 14 h 19"/>
              <a:gd name="T30" fmla="*/ 0 w 86"/>
              <a:gd name="T31" fmla="*/ 14 h 19"/>
              <a:gd name="T32" fmla="*/ 0 w 86"/>
              <a:gd name="T33" fmla="*/ 0 h 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19">
                <a:moveTo>
                  <a:pt x="37" y="12"/>
                </a:moveTo>
                <a:lnTo>
                  <a:pt x="37" y="9"/>
                </a:lnTo>
                <a:lnTo>
                  <a:pt x="37" y="7"/>
                </a:lnTo>
                <a:lnTo>
                  <a:pt x="51" y="7"/>
                </a:lnTo>
                <a:lnTo>
                  <a:pt x="51" y="9"/>
                </a:lnTo>
                <a:lnTo>
                  <a:pt x="51" y="12"/>
                </a:lnTo>
                <a:lnTo>
                  <a:pt x="37" y="12"/>
                </a:lnTo>
                <a:close/>
                <a:moveTo>
                  <a:pt x="0" y="5"/>
                </a:moveTo>
                <a:lnTo>
                  <a:pt x="86" y="5"/>
                </a:lnTo>
                <a:lnTo>
                  <a:pt x="86" y="19"/>
                </a:lnTo>
                <a:lnTo>
                  <a:pt x="0" y="19"/>
                </a:lnTo>
                <a:lnTo>
                  <a:pt x="0" y="5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1" name="Freeform 50"/>
          <p:cNvSpPr>
            <a:spLocks noEditPoints="1"/>
          </p:cNvSpPr>
          <p:nvPr/>
        </p:nvSpPr>
        <p:spPr bwMode="auto">
          <a:xfrm>
            <a:off x="5275641" y="4269414"/>
            <a:ext cx="56225" cy="12114"/>
          </a:xfrm>
          <a:custGeom>
            <a:avLst/>
            <a:gdLst>
              <a:gd name="T0" fmla="*/ 35 w 86"/>
              <a:gd name="T1" fmla="*/ 14 h 21"/>
              <a:gd name="T2" fmla="*/ 35 w 86"/>
              <a:gd name="T3" fmla="*/ 12 h 21"/>
              <a:gd name="T4" fmla="*/ 35 w 86"/>
              <a:gd name="T5" fmla="*/ 7 h 21"/>
              <a:gd name="T6" fmla="*/ 49 w 86"/>
              <a:gd name="T7" fmla="*/ 7 h 21"/>
              <a:gd name="T8" fmla="*/ 49 w 86"/>
              <a:gd name="T9" fmla="*/ 12 h 21"/>
              <a:gd name="T10" fmla="*/ 49 w 86"/>
              <a:gd name="T11" fmla="*/ 14 h 21"/>
              <a:gd name="T12" fmla="*/ 35 w 86"/>
              <a:gd name="T13" fmla="*/ 14 h 21"/>
              <a:gd name="T14" fmla="*/ 0 w 86"/>
              <a:gd name="T15" fmla="*/ 7 h 21"/>
              <a:gd name="T16" fmla="*/ 86 w 86"/>
              <a:gd name="T17" fmla="*/ 7 h 21"/>
              <a:gd name="T18" fmla="*/ 86 w 86"/>
              <a:gd name="T19" fmla="*/ 21 h 21"/>
              <a:gd name="T20" fmla="*/ 0 w 86"/>
              <a:gd name="T21" fmla="*/ 21 h 21"/>
              <a:gd name="T22" fmla="*/ 0 w 86"/>
              <a:gd name="T23" fmla="*/ 7 h 21"/>
              <a:gd name="T24" fmla="*/ 0 w 86"/>
              <a:gd name="T25" fmla="*/ 0 h 21"/>
              <a:gd name="T26" fmla="*/ 86 w 86"/>
              <a:gd name="T27" fmla="*/ 0 h 21"/>
              <a:gd name="T28" fmla="*/ 86 w 86"/>
              <a:gd name="T29" fmla="*/ 14 h 21"/>
              <a:gd name="T30" fmla="*/ 0 w 86"/>
              <a:gd name="T31" fmla="*/ 14 h 21"/>
              <a:gd name="T32" fmla="*/ 0 w 86"/>
              <a:gd name="T33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21">
                <a:moveTo>
                  <a:pt x="35" y="14"/>
                </a:moveTo>
                <a:lnTo>
                  <a:pt x="35" y="12"/>
                </a:lnTo>
                <a:lnTo>
                  <a:pt x="35" y="7"/>
                </a:lnTo>
                <a:lnTo>
                  <a:pt x="49" y="7"/>
                </a:lnTo>
                <a:lnTo>
                  <a:pt x="49" y="12"/>
                </a:lnTo>
                <a:lnTo>
                  <a:pt x="49" y="14"/>
                </a:lnTo>
                <a:lnTo>
                  <a:pt x="35" y="14"/>
                </a:lnTo>
                <a:close/>
                <a:moveTo>
                  <a:pt x="0" y="7"/>
                </a:moveTo>
                <a:lnTo>
                  <a:pt x="86" y="7"/>
                </a:lnTo>
                <a:lnTo>
                  <a:pt x="86" y="21"/>
                </a:lnTo>
                <a:lnTo>
                  <a:pt x="0" y="21"/>
                </a:lnTo>
                <a:lnTo>
                  <a:pt x="0" y="7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2" name="Freeform 51"/>
          <p:cNvSpPr>
            <a:spLocks noEditPoints="1"/>
          </p:cNvSpPr>
          <p:nvPr/>
        </p:nvSpPr>
        <p:spPr bwMode="auto">
          <a:xfrm>
            <a:off x="5656137" y="4031745"/>
            <a:ext cx="57531" cy="87107"/>
          </a:xfrm>
          <a:custGeom>
            <a:avLst/>
            <a:gdLst>
              <a:gd name="T0" fmla="*/ 37 w 88"/>
              <a:gd name="T1" fmla="*/ 144 h 151"/>
              <a:gd name="T2" fmla="*/ 37 w 88"/>
              <a:gd name="T3" fmla="*/ 76 h 151"/>
              <a:gd name="T4" fmla="*/ 37 w 88"/>
              <a:gd name="T5" fmla="*/ 7 h 151"/>
              <a:gd name="T6" fmla="*/ 51 w 88"/>
              <a:gd name="T7" fmla="*/ 7 h 151"/>
              <a:gd name="T8" fmla="*/ 51 w 88"/>
              <a:gd name="T9" fmla="*/ 76 h 151"/>
              <a:gd name="T10" fmla="*/ 51 w 88"/>
              <a:gd name="T11" fmla="*/ 144 h 151"/>
              <a:gd name="T12" fmla="*/ 37 w 88"/>
              <a:gd name="T13" fmla="*/ 144 h 151"/>
              <a:gd name="T14" fmla="*/ 0 w 88"/>
              <a:gd name="T15" fmla="*/ 137 h 151"/>
              <a:gd name="T16" fmla="*/ 88 w 88"/>
              <a:gd name="T17" fmla="*/ 137 h 151"/>
              <a:gd name="T18" fmla="*/ 88 w 88"/>
              <a:gd name="T19" fmla="*/ 151 h 151"/>
              <a:gd name="T20" fmla="*/ 0 w 88"/>
              <a:gd name="T21" fmla="*/ 151 h 151"/>
              <a:gd name="T22" fmla="*/ 0 w 88"/>
              <a:gd name="T23" fmla="*/ 137 h 151"/>
              <a:gd name="T24" fmla="*/ 0 w 88"/>
              <a:gd name="T25" fmla="*/ 0 h 151"/>
              <a:gd name="T26" fmla="*/ 88 w 88"/>
              <a:gd name="T27" fmla="*/ 0 h 151"/>
              <a:gd name="T28" fmla="*/ 88 w 88"/>
              <a:gd name="T29" fmla="*/ 14 h 151"/>
              <a:gd name="T30" fmla="*/ 0 w 88"/>
              <a:gd name="T31" fmla="*/ 14 h 151"/>
              <a:gd name="T32" fmla="*/ 0 w 88"/>
              <a:gd name="T33" fmla="*/ 0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151">
                <a:moveTo>
                  <a:pt x="37" y="144"/>
                </a:moveTo>
                <a:lnTo>
                  <a:pt x="37" y="76"/>
                </a:lnTo>
                <a:lnTo>
                  <a:pt x="37" y="7"/>
                </a:lnTo>
                <a:lnTo>
                  <a:pt x="51" y="7"/>
                </a:lnTo>
                <a:lnTo>
                  <a:pt x="51" y="76"/>
                </a:lnTo>
                <a:lnTo>
                  <a:pt x="51" y="144"/>
                </a:lnTo>
                <a:lnTo>
                  <a:pt x="37" y="144"/>
                </a:lnTo>
                <a:close/>
                <a:moveTo>
                  <a:pt x="0" y="137"/>
                </a:moveTo>
                <a:lnTo>
                  <a:pt x="88" y="137"/>
                </a:lnTo>
                <a:lnTo>
                  <a:pt x="88" y="151"/>
                </a:lnTo>
                <a:lnTo>
                  <a:pt x="0" y="151"/>
                </a:lnTo>
                <a:lnTo>
                  <a:pt x="0" y="137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3" name="Freeform 52"/>
          <p:cNvSpPr>
            <a:spLocks noEditPoints="1"/>
          </p:cNvSpPr>
          <p:nvPr/>
        </p:nvSpPr>
        <p:spPr bwMode="auto">
          <a:xfrm>
            <a:off x="1572668" y="4141348"/>
            <a:ext cx="56225" cy="112490"/>
          </a:xfrm>
          <a:custGeom>
            <a:avLst/>
            <a:gdLst>
              <a:gd name="T0" fmla="*/ 37 w 86"/>
              <a:gd name="T1" fmla="*/ 188 h 195"/>
              <a:gd name="T2" fmla="*/ 37 w 86"/>
              <a:gd name="T3" fmla="*/ 97 h 195"/>
              <a:gd name="T4" fmla="*/ 37 w 86"/>
              <a:gd name="T5" fmla="*/ 7 h 195"/>
              <a:gd name="T6" fmla="*/ 51 w 86"/>
              <a:gd name="T7" fmla="*/ 7 h 195"/>
              <a:gd name="T8" fmla="*/ 51 w 86"/>
              <a:gd name="T9" fmla="*/ 97 h 195"/>
              <a:gd name="T10" fmla="*/ 51 w 86"/>
              <a:gd name="T11" fmla="*/ 188 h 195"/>
              <a:gd name="T12" fmla="*/ 37 w 86"/>
              <a:gd name="T13" fmla="*/ 188 h 195"/>
              <a:gd name="T14" fmla="*/ 0 w 86"/>
              <a:gd name="T15" fmla="*/ 181 h 195"/>
              <a:gd name="T16" fmla="*/ 86 w 86"/>
              <a:gd name="T17" fmla="*/ 181 h 195"/>
              <a:gd name="T18" fmla="*/ 86 w 86"/>
              <a:gd name="T19" fmla="*/ 195 h 195"/>
              <a:gd name="T20" fmla="*/ 0 w 86"/>
              <a:gd name="T21" fmla="*/ 195 h 195"/>
              <a:gd name="T22" fmla="*/ 0 w 86"/>
              <a:gd name="T23" fmla="*/ 181 h 195"/>
              <a:gd name="T24" fmla="*/ 0 w 86"/>
              <a:gd name="T25" fmla="*/ 0 h 195"/>
              <a:gd name="T26" fmla="*/ 86 w 86"/>
              <a:gd name="T27" fmla="*/ 0 h 195"/>
              <a:gd name="T28" fmla="*/ 86 w 86"/>
              <a:gd name="T29" fmla="*/ 14 h 195"/>
              <a:gd name="T30" fmla="*/ 0 w 86"/>
              <a:gd name="T31" fmla="*/ 14 h 195"/>
              <a:gd name="T32" fmla="*/ 0 w 86"/>
              <a:gd name="T33" fmla="*/ 0 h 1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195">
                <a:moveTo>
                  <a:pt x="37" y="188"/>
                </a:moveTo>
                <a:lnTo>
                  <a:pt x="37" y="97"/>
                </a:lnTo>
                <a:lnTo>
                  <a:pt x="37" y="7"/>
                </a:lnTo>
                <a:lnTo>
                  <a:pt x="51" y="7"/>
                </a:lnTo>
                <a:lnTo>
                  <a:pt x="51" y="97"/>
                </a:lnTo>
                <a:lnTo>
                  <a:pt x="51" y="188"/>
                </a:lnTo>
                <a:lnTo>
                  <a:pt x="37" y="188"/>
                </a:lnTo>
                <a:close/>
                <a:moveTo>
                  <a:pt x="0" y="181"/>
                </a:moveTo>
                <a:lnTo>
                  <a:pt x="86" y="181"/>
                </a:lnTo>
                <a:lnTo>
                  <a:pt x="86" y="195"/>
                </a:lnTo>
                <a:lnTo>
                  <a:pt x="0" y="195"/>
                </a:lnTo>
                <a:lnTo>
                  <a:pt x="0" y="181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4" name="Freeform 53"/>
          <p:cNvSpPr>
            <a:spLocks noEditPoints="1"/>
          </p:cNvSpPr>
          <p:nvPr/>
        </p:nvSpPr>
        <p:spPr bwMode="auto">
          <a:xfrm>
            <a:off x="1952510" y="4225572"/>
            <a:ext cx="57531" cy="29421"/>
          </a:xfrm>
          <a:custGeom>
            <a:avLst/>
            <a:gdLst>
              <a:gd name="T0" fmla="*/ 37 w 88"/>
              <a:gd name="T1" fmla="*/ 44 h 51"/>
              <a:gd name="T2" fmla="*/ 37 w 88"/>
              <a:gd name="T3" fmla="*/ 25 h 51"/>
              <a:gd name="T4" fmla="*/ 37 w 88"/>
              <a:gd name="T5" fmla="*/ 7 h 51"/>
              <a:gd name="T6" fmla="*/ 51 w 88"/>
              <a:gd name="T7" fmla="*/ 7 h 51"/>
              <a:gd name="T8" fmla="*/ 51 w 88"/>
              <a:gd name="T9" fmla="*/ 25 h 51"/>
              <a:gd name="T10" fmla="*/ 51 w 88"/>
              <a:gd name="T11" fmla="*/ 44 h 51"/>
              <a:gd name="T12" fmla="*/ 37 w 88"/>
              <a:gd name="T13" fmla="*/ 44 h 51"/>
              <a:gd name="T14" fmla="*/ 0 w 88"/>
              <a:gd name="T15" fmla="*/ 37 h 51"/>
              <a:gd name="T16" fmla="*/ 88 w 88"/>
              <a:gd name="T17" fmla="*/ 37 h 51"/>
              <a:gd name="T18" fmla="*/ 88 w 88"/>
              <a:gd name="T19" fmla="*/ 51 h 51"/>
              <a:gd name="T20" fmla="*/ 0 w 88"/>
              <a:gd name="T21" fmla="*/ 51 h 51"/>
              <a:gd name="T22" fmla="*/ 0 w 88"/>
              <a:gd name="T23" fmla="*/ 37 h 51"/>
              <a:gd name="T24" fmla="*/ 0 w 88"/>
              <a:gd name="T25" fmla="*/ 0 h 51"/>
              <a:gd name="T26" fmla="*/ 88 w 88"/>
              <a:gd name="T27" fmla="*/ 0 h 51"/>
              <a:gd name="T28" fmla="*/ 88 w 88"/>
              <a:gd name="T29" fmla="*/ 14 h 51"/>
              <a:gd name="T30" fmla="*/ 0 w 88"/>
              <a:gd name="T31" fmla="*/ 14 h 51"/>
              <a:gd name="T32" fmla="*/ 0 w 88"/>
              <a:gd name="T33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51">
                <a:moveTo>
                  <a:pt x="37" y="44"/>
                </a:moveTo>
                <a:lnTo>
                  <a:pt x="37" y="25"/>
                </a:lnTo>
                <a:lnTo>
                  <a:pt x="37" y="7"/>
                </a:lnTo>
                <a:lnTo>
                  <a:pt x="51" y="7"/>
                </a:lnTo>
                <a:lnTo>
                  <a:pt x="51" y="25"/>
                </a:lnTo>
                <a:lnTo>
                  <a:pt x="51" y="44"/>
                </a:lnTo>
                <a:lnTo>
                  <a:pt x="37" y="44"/>
                </a:lnTo>
                <a:close/>
                <a:moveTo>
                  <a:pt x="0" y="37"/>
                </a:moveTo>
                <a:lnTo>
                  <a:pt x="88" y="37"/>
                </a:lnTo>
                <a:lnTo>
                  <a:pt x="88" y="51"/>
                </a:lnTo>
                <a:lnTo>
                  <a:pt x="0" y="51"/>
                </a:lnTo>
                <a:lnTo>
                  <a:pt x="0" y="37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5" name="Freeform 54"/>
          <p:cNvSpPr>
            <a:spLocks noEditPoints="1"/>
          </p:cNvSpPr>
          <p:nvPr/>
        </p:nvSpPr>
        <p:spPr bwMode="auto">
          <a:xfrm>
            <a:off x="2334315" y="4194999"/>
            <a:ext cx="57531" cy="73262"/>
          </a:xfrm>
          <a:custGeom>
            <a:avLst/>
            <a:gdLst>
              <a:gd name="T0" fmla="*/ 37 w 88"/>
              <a:gd name="T1" fmla="*/ 120 h 127"/>
              <a:gd name="T2" fmla="*/ 37 w 88"/>
              <a:gd name="T3" fmla="*/ 65 h 127"/>
              <a:gd name="T4" fmla="*/ 37 w 88"/>
              <a:gd name="T5" fmla="*/ 7 h 127"/>
              <a:gd name="T6" fmla="*/ 51 w 88"/>
              <a:gd name="T7" fmla="*/ 7 h 127"/>
              <a:gd name="T8" fmla="*/ 51 w 88"/>
              <a:gd name="T9" fmla="*/ 65 h 127"/>
              <a:gd name="T10" fmla="*/ 51 w 88"/>
              <a:gd name="T11" fmla="*/ 120 h 127"/>
              <a:gd name="T12" fmla="*/ 37 w 88"/>
              <a:gd name="T13" fmla="*/ 120 h 127"/>
              <a:gd name="T14" fmla="*/ 0 w 88"/>
              <a:gd name="T15" fmla="*/ 113 h 127"/>
              <a:gd name="T16" fmla="*/ 88 w 88"/>
              <a:gd name="T17" fmla="*/ 113 h 127"/>
              <a:gd name="T18" fmla="*/ 88 w 88"/>
              <a:gd name="T19" fmla="*/ 127 h 127"/>
              <a:gd name="T20" fmla="*/ 0 w 88"/>
              <a:gd name="T21" fmla="*/ 127 h 127"/>
              <a:gd name="T22" fmla="*/ 0 w 88"/>
              <a:gd name="T23" fmla="*/ 113 h 127"/>
              <a:gd name="T24" fmla="*/ 0 w 88"/>
              <a:gd name="T25" fmla="*/ 0 h 127"/>
              <a:gd name="T26" fmla="*/ 88 w 88"/>
              <a:gd name="T27" fmla="*/ 0 h 127"/>
              <a:gd name="T28" fmla="*/ 88 w 88"/>
              <a:gd name="T29" fmla="*/ 14 h 127"/>
              <a:gd name="T30" fmla="*/ 0 w 88"/>
              <a:gd name="T31" fmla="*/ 14 h 127"/>
              <a:gd name="T32" fmla="*/ 0 w 88"/>
              <a:gd name="T33" fmla="*/ 0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127">
                <a:moveTo>
                  <a:pt x="37" y="120"/>
                </a:moveTo>
                <a:lnTo>
                  <a:pt x="37" y="65"/>
                </a:lnTo>
                <a:lnTo>
                  <a:pt x="37" y="7"/>
                </a:lnTo>
                <a:lnTo>
                  <a:pt x="51" y="7"/>
                </a:lnTo>
                <a:lnTo>
                  <a:pt x="51" y="65"/>
                </a:lnTo>
                <a:lnTo>
                  <a:pt x="51" y="120"/>
                </a:lnTo>
                <a:lnTo>
                  <a:pt x="37" y="120"/>
                </a:lnTo>
                <a:close/>
                <a:moveTo>
                  <a:pt x="0" y="113"/>
                </a:moveTo>
                <a:lnTo>
                  <a:pt x="88" y="113"/>
                </a:lnTo>
                <a:lnTo>
                  <a:pt x="88" y="127"/>
                </a:lnTo>
                <a:lnTo>
                  <a:pt x="0" y="127"/>
                </a:lnTo>
                <a:lnTo>
                  <a:pt x="0" y="113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6" name="Freeform 55"/>
          <p:cNvSpPr>
            <a:spLocks noEditPoints="1"/>
          </p:cNvSpPr>
          <p:nvPr/>
        </p:nvSpPr>
        <p:spPr bwMode="auto">
          <a:xfrm>
            <a:off x="2716117" y="4230765"/>
            <a:ext cx="56225" cy="29421"/>
          </a:xfrm>
          <a:custGeom>
            <a:avLst/>
            <a:gdLst>
              <a:gd name="T0" fmla="*/ 37 w 86"/>
              <a:gd name="T1" fmla="*/ 44 h 51"/>
              <a:gd name="T2" fmla="*/ 37 w 86"/>
              <a:gd name="T3" fmla="*/ 26 h 51"/>
              <a:gd name="T4" fmla="*/ 37 w 86"/>
              <a:gd name="T5" fmla="*/ 7 h 51"/>
              <a:gd name="T6" fmla="*/ 51 w 86"/>
              <a:gd name="T7" fmla="*/ 7 h 51"/>
              <a:gd name="T8" fmla="*/ 51 w 86"/>
              <a:gd name="T9" fmla="*/ 26 h 51"/>
              <a:gd name="T10" fmla="*/ 51 w 86"/>
              <a:gd name="T11" fmla="*/ 44 h 51"/>
              <a:gd name="T12" fmla="*/ 37 w 86"/>
              <a:gd name="T13" fmla="*/ 44 h 51"/>
              <a:gd name="T14" fmla="*/ 0 w 86"/>
              <a:gd name="T15" fmla="*/ 37 h 51"/>
              <a:gd name="T16" fmla="*/ 86 w 86"/>
              <a:gd name="T17" fmla="*/ 37 h 51"/>
              <a:gd name="T18" fmla="*/ 86 w 86"/>
              <a:gd name="T19" fmla="*/ 51 h 51"/>
              <a:gd name="T20" fmla="*/ 0 w 86"/>
              <a:gd name="T21" fmla="*/ 51 h 51"/>
              <a:gd name="T22" fmla="*/ 0 w 86"/>
              <a:gd name="T23" fmla="*/ 37 h 51"/>
              <a:gd name="T24" fmla="*/ 0 w 86"/>
              <a:gd name="T25" fmla="*/ 0 h 51"/>
              <a:gd name="T26" fmla="*/ 86 w 86"/>
              <a:gd name="T27" fmla="*/ 0 h 51"/>
              <a:gd name="T28" fmla="*/ 86 w 86"/>
              <a:gd name="T29" fmla="*/ 14 h 51"/>
              <a:gd name="T30" fmla="*/ 0 w 86"/>
              <a:gd name="T31" fmla="*/ 14 h 51"/>
              <a:gd name="T32" fmla="*/ 0 w 86"/>
              <a:gd name="T33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51">
                <a:moveTo>
                  <a:pt x="37" y="44"/>
                </a:moveTo>
                <a:lnTo>
                  <a:pt x="37" y="26"/>
                </a:lnTo>
                <a:lnTo>
                  <a:pt x="37" y="7"/>
                </a:lnTo>
                <a:lnTo>
                  <a:pt x="51" y="7"/>
                </a:lnTo>
                <a:lnTo>
                  <a:pt x="51" y="26"/>
                </a:lnTo>
                <a:lnTo>
                  <a:pt x="51" y="44"/>
                </a:lnTo>
                <a:lnTo>
                  <a:pt x="37" y="44"/>
                </a:lnTo>
                <a:close/>
                <a:moveTo>
                  <a:pt x="0" y="37"/>
                </a:moveTo>
                <a:lnTo>
                  <a:pt x="86" y="37"/>
                </a:lnTo>
                <a:lnTo>
                  <a:pt x="86" y="51"/>
                </a:lnTo>
                <a:lnTo>
                  <a:pt x="0" y="51"/>
                </a:lnTo>
                <a:lnTo>
                  <a:pt x="0" y="37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7" name="Freeform 56"/>
          <p:cNvSpPr>
            <a:spLocks noEditPoints="1"/>
          </p:cNvSpPr>
          <p:nvPr/>
        </p:nvSpPr>
        <p:spPr bwMode="auto">
          <a:xfrm>
            <a:off x="3096615" y="4208265"/>
            <a:ext cx="57531" cy="24229"/>
          </a:xfrm>
          <a:custGeom>
            <a:avLst/>
            <a:gdLst>
              <a:gd name="T0" fmla="*/ 37 w 88"/>
              <a:gd name="T1" fmla="*/ 35 h 42"/>
              <a:gd name="T2" fmla="*/ 37 w 88"/>
              <a:gd name="T3" fmla="*/ 21 h 42"/>
              <a:gd name="T4" fmla="*/ 37 w 88"/>
              <a:gd name="T5" fmla="*/ 7 h 42"/>
              <a:gd name="T6" fmla="*/ 50 w 88"/>
              <a:gd name="T7" fmla="*/ 7 h 42"/>
              <a:gd name="T8" fmla="*/ 50 w 88"/>
              <a:gd name="T9" fmla="*/ 21 h 42"/>
              <a:gd name="T10" fmla="*/ 50 w 88"/>
              <a:gd name="T11" fmla="*/ 35 h 42"/>
              <a:gd name="T12" fmla="*/ 37 w 88"/>
              <a:gd name="T13" fmla="*/ 35 h 42"/>
              <a:gd name="T14" fmla="*/ 0 w 88"/>
              <a:gd name="T15" fmla="*/ 28 h 42"/>
              <a:gd name="T16" fmla="*/ 88 w 88"/>
              <a:gd name="T17" fmla="*/ 28 h 42"/>
              <a:gd name="T18" fmla="*/ 88 w 88"/>
              <a:gd name="T19" fmla="*/ 42 h 42"/>
              <a:gd name="T20" fmla="*/ 0 w 88"/>
              <a:gd name="T21" fmla="*/ 42 h 42"/>
              <a:gd name="T22" fmla="*/ 0 w 88"/>
              <a:gd name="T23" fmla="*/ 28 h 42"/>
              <a:gd name="T24" fmla="*/ 0 w 88"/>
              <a:gd name="T25" fmla="*/ 0 h 42"/>
              <a:gd name="T26" fmla="*/ 88 w 88"/>
              <a:gd name="T27" fmla="*/ 0 h 42"/>
              <a:gd name="T28" fmla="*/ 88 w 88"/>
              <a:gd name="T29" fmla="*/ 14 h 42"/>
              <a:gd name="T30" fmla="*/ 0 w 88"/>
              <a:gd name="T31" fmla="*/ 14 h 42"/>
              <a:gd name="T32" fmla="*/ 0 w 88"/>
              <a:gd name="T33" fmla="*/ 0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42">
                <a:moveTo>
                  <a:pt x="37" y="35"/>
                </a:moveTo>
                <a:lnTo>
                  <a:pt x="37" y="21"/>
                </a:lnTo>
                <a:lnTo>
                  <a:pt x="37" y="7"/>
                </a:lnTo>
                <a:lnTo>
                  <a:pt x="50" y="7"/>
                </a:lnTo>
                <a:lnTo>
                  <a:pt x="50" y="21"/>
                </a:lnTo>
                <a:lnTo>
                  <a:pt x="50" y="35"/>
                </a:lnTo>
                <a:lnTo>
                  <a:pt x="37" y="35"/>
                </a:lnTo>
                <a:close/>
                <a:moveTo>
                  <a:pt x="0" y="28"/>
                </a:moveTo>
                <a:lnTo>
                  <a:pt x="88" y="28"/>
                </a:lnTo>
                <a:lnTo>
                  <a:pt x="88" y="42"/>
                </a:lnTo>
                <a:lnTo>
                  <a:pt x="0" y="42"/>
                </a:lnTo>
                <a:lnTo>
                  <a:pt x="0" y="28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8" name="Freeform 57"/>
          <p:cNvSpPr>
            <a:spLocks noEditPoints="1"/>
          </p:cNvSpPr>
          <p:nvPr/>
        </p:nvSpPr>
        <p:spPr bwMode="auto">
          <a:xfrm>
            <a:off x="3477764" y="4182884"/>
            <a:ext cx="57531" cy="50765"/>
          </a:xfrm>
          <a:custGeom>
            <a:avLst/>
            <a:gdLst>
              <a:gd name="T0" fmla="*/ 37 w 88"/>
              <a:gd name="T1" fmla="*/ 81 h 88"/>
              <a:gd name="T2" fmla="*/ 37 w 88"/>
              <a:gd name="T3" fmla="*/ 44 h 88"/>
              <a:gd name="T4" fmla="*/ 37 w 88"/>
              <a:gd name="T5" fmla="*/ 7 h 88"/>
              <a:gd name="T6" fmla="*/ 51 w 88"/>
              <a:gd name="T7" fmla="*/ 7 h 88"/>
              <a:gd name="T8" fmla="*/ 51 w 88"/>
              <a:gd name="T9" fmla="*/ 44 h 88"/>
              <a:gd name="T10" fmla="*/ 51 w 88"/>
              <a:gd name="T11" fmla="*/ 81 h 88"/>
              <a:gd name="T12" fmla="*/ 37 w 88"/>
              <a:gd name="T13" fmla="*/ 81 h 88"/>
              <a:gd name="T14" fmla="*/ 0 w 88"/>
              <a:gd name="T15" fmla="*/ 74 h 88"/>
              <a:gd name="T16" fmla="*/ 88 w 88"/>
              <a:gd name="T17" fmla="*/ 74 h 88"/>
              <a:gd name="T18" fmla="*/ 88 w 88"/>
              <a:gd name="T19" fmla="*/ 88 h 88"/>
              <a:gd name="T20" fmla="*/ 0 w 88"/>
              <a:gd name="T21" fmla="*/ 88 h 88"/>
              <a:gd name="T22" fmla="*/ 0 w 88"/>
              <a:gd name="T23" fmla="*/ 74 h 88"/>
              <a:gd name="T24" fmla="*/ 0 w 88"/>
              <a:gd name="T25" fmla="*/ 0 h 88"/>
              <a:gd name="T26" fmla="*/ 88 w 88"/>
              <a:gd name="T27" fmla="*/ 0 h 88"/>
              <a:gd name="T28" fmla="*/ 88 w 88"/>
              <a:gd name="T29" fmla="*/ 14 h 88"/>
              <a:gd name="T30" fmla="*/ 0 w 88"/>
              <a:gd name="T31" fmla="*/ 14 h 88"/>
              <a:gd name="T32" fmla="*/ 0 w 88"/>
              <a:gd name="T33" fmla="*/ 0 h 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88">
                <a:moveTo>
                  <a:pt x="37" y="81"/>
                </a:moveTo>
                <a:lnTo>
                  <a:pt x="37" y="44"/>
                </a:lnTo>
                <a:lnTo>
                  <a:pt x="37" y="7"/>
                </a:lnTo>
                <a:lnTo>
                  <a:pt x="51" y="7"/>
                </a:lnTo>
                <a:lnTo>
                  <a:pt x="51" y="44"/>
                </a:lnTo>
                <a:lnTo>
                  <a:pt x="51" y="81"/>
                </a:lnTo>
                <a:lnTo>
                  <a:pt x="37" y="81"/>
                </a:lnTo>
                <a:close/>
                <a:moveTo>
                  <a:pt x="0" y="74"/>
                </a:moveTo>
                <a:lnTo>
                  <a:pt x="88" y="74"/>
                </a:lnTo>
                <a:lnTo>
                  <a:pt x="88" y="88"/>
                </a:lnTo>
                <a:lnTo>
                  <a:pt x="0" y="88"/>
                </a:lnTo>
                <a:lnTo>
                  <a:pt x="0" y="74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59" name="Freeform 58"/>
          <p:cNvSpPr>
            <a:spLocks noEditPoints="1"/>
          </p:cNvSpPr>
          <p:nvPr/>
        </p:nvSpPr>
        <p:spPr bwMode="auto">
          <a:xfrm>
            <a:off x="3859568" y="4241724"/>
            <a:ext cx="56225" cy="27690"/>
          </a:xfrm>
          <a:custGeom>
            <a:avLst/>
            <a:gdLst>
              <a:gd name="T0" fmla="*/ 37 w 86"/>
              <a:gd name="T1" fmla="*/ 41 h 48"/>
              <a:gd name="T2" fmla="*/ 37 w 86"/>
              <a:gd name="T3" fmla="*/ 25 h 48"/>
              <a:gd name="T4" fmla="*/ 37 w 86"/>
              <a:gd name="T5" fmla="*/ 7 h 48"/>
              <a:gd name="T6" fmla="*/ 51 w 86"/>
              <a:gd name="T7" fmla="*/ 7 h 48"/>
              <a:gd name="T8" fmla="*/ 51 w 86"/>
              <a:gd name="T9" fmla="*/ 25 h 48"/>
              <a:gd name="T10" fmla="*/ 51 w 86"/>
              <a:gd name="T11" fmla="*/ 41 h 48"/>
              <a:gd name="T12" fmla="*/ 37 w 86"/>
              <a:gd name="T13" fmla="*/ 41 h 48"/>
              <a:gd name="T14" fmla="*/ 0 w 86"/>
              <a:gd name="T15" fmla="*/ 35 h 48"/>
              <a:gd name="T16" fmla="*/ 86 w 86"/>
              <a:gd name="T17" fmla="*/ 35 h 48"/>
              <a:gd name="T18" fmla="*/ 86 w 86"/>
              <a:gd name="T19" fmla="*/ 48 h 48"/>
              <a:gd name="T20" fmla="*/ 0 w 86"/>
              <a:gd name="T21" fmla="*/ 48 h 48"/>
              <a:gd name="T22" fmla="*/ 0 w 86"/>
              <a:gd name="T23" fmla="*/ 35 h 48"/>
              <a:gd name="T24" fmla="*/ 0 w 86"/>
              <a:gd name="T25" fmla="*/ 0 h 48"/>
              <a:gd name="T26" fmla="*/ 86 w 86"/>
              <a:gd name="T27" fmla="*/ 0 h 48"/>
              <a:gd name="T28" fmla="*/ 86 w 86"/>
              <a:gd name="T29" fmla="*/ 14 h 48"/>
              <a:gd name="T30" fmla="*/ 0 w 86"/>
              <a:gd name="T31" fmla="*/ 14 h 48"/>
              <a:gd name="T32" fmla="*/ 0 w 86"/>
              <a:gd name="T33" fmla="*/ 0 h 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48">
                <a:moveTo>
                  <a:pt x="37" y="41"/>
                </a:moveTo>
                <a:lnTo>
                  <a:pt x="37" y="25"/>
                </a:lnTo>
                <a:lnTo>
                  <a:pt x="37" y="7"/>
                </a:lnTo>
                <a:lnTo>
                  <a:pt x="51" y="7"/>
                </a:lnTo>
                <a:lnTo>
                  <a:pt x="51" y="25"/>
                </a:lnTo>
                <a:lnTo>
                  <a:pt x="51" y="41"/>
                </a:lnTo>
                <a:lnTo>
                  <a:pt x="37" y="41"/>
                </a:lnTo>
                <a:close/>
                <a:moveTo>
                  <a:pt x="0" y="35"/>
                </a:moveTo>
                <a:lnTo>
                  <a:pt x="86" y="35"/>
                </a:lnTo>
                <a:lnTo>
                  <a:pt x="86" y="48"/>
                </a:lnTo>
                <a:lnTo>
                  <a:pt x="0" y="48"/>
                </a:lnTo>
                <a:lnTo>
                  <a:pt x="0" y="35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0" name="Freeform 59"/>
          <p:cNvSpPr>
            <a:spLocks noEditPoints="1"/>
          </p:cNvSpPr>
          <p:nvPr/>
        </p:nvSpPr>
        <p:spPr bwMode="auto">
          <a:xfrm>
            <a:off x="4240063" y="4232494"/>
            <a:ext cx="57531" cy="40958"/>
          </a:xfrm>
          <a:custGeom>
            <a:avLst/>
            <a:gdLst>
              <a:gd name="T0" fmla="*/ 37 w 88"/>
              <a:gd name="T1" fmla="*/ 64 h 71"/>
              <a:gd name="T2" fmla="*/ 37 w 88"/>
              <a:gd name="T3" fmla="*/ 34 h 71"/>
              <a:gd name="T4" fmla="*/ 37 w 88"/>
              <a:gd name="T5" fmla="*/ 6 h 71"/>
              <a:gd name="T6" fmla="*/ 51 w 88"/>
              <a:gd name="T7" fmla="*/ 6 h 71"/>
              <a:gd name="T8" fmla="*/ 51 w 88"/>
              <a:gd name="T9" fmla="*/ 34 h 71"/>
              <a:gd name="T10" fmla="*/ 51 w 88"/>
              <a:gd name="T11" fmla="*/ 64 h 71"/>
              <a:gd name="T12" fmla="*/ 37 w 88"/>
              <a:gd name="T13" fmla="*/ 64 h 71"/>
              <a:gd name="T14" fmla="*/ 0 w 88"/>
              <a:gd name="T15" fmla="*/ 57 h 71"/>
              <a:gd name="T16" fmla="*/ 88 w 88"/>
              <a:gd name="T17" fmla="*/ 57 h 71"/>
              <a:gd name="T18" fmla="*/ 88 w 88"/>
              <a:gd name="T19" fmla="*/ 71 h 71"/>
              <a:gd name="T20" fmla="*/ 0 w 88"/>
              <a:gd name="T21" fmla="*/ 71 h 71"/>
              <a:gd name="T22" fmla="*/ 0 w 88"/>
              <a:gd name="T23" fmla="*/ 57 h 71"/>
              <a:gd name="T24" fmla="*/ 0 w 88"/>
              <a:gd name="T25" fmla="*/ 0 h 71"/>
              <a:gd name="T26" fmla="*/ 88 w 88"/>
              <a:gd name="T27" fmla="*/ 0 h 71"/>
              <a:gd name="T28" fmla="*/ 88 w 88"/>
              <a:gd name="T29" fmla="*/ 13 h 71"/>
              <a:gd name="T30" fmla="*/ 0 w 88"/>
              <a:gd name="T31" fmla="*/ 13 h 71"/>
              <a:gd name="T32" fmla="*/ 0 w 88"/>
              <a:gd name="T33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71">
                <a:moveTo>
                  <a:pt x="37" y="64"/>
                </a:moveTo>
                <a:lnTo>
                  <a:pt x="37" y="34"/>
                </a:lnTo>
                <a:lnTo>
                  <a:pt x="37" y="6"/>
                </a:lnTo>
                <a:lnTo>
                  <a:pt x="51" y="6"/>
                </a:lnTo>
                <a:lnTo>
                  <a:pt x="51" y="34"/>
                </a:lnTo>
                <a:lnTo>
                  <a:pt x="51" y="64"/>
                </a:lnTo>
                <a:lnTo>
                  <a:pt x="37" y="64"/>
                </a:lnTo>
                <a:close/>
                <a:moveTo>
                  <a:pt x="0" y="57"/>
                </a:moveTo>
                <a:lnTo>
                  <a:pt x="88" y="57"/>
                </a:lnTo>
                <a:lnTo>
                  <a:pt x="88" y="71"/>
                </a:lnTo>
                <a:lnTo>
                  <a:pt x="0" y="71"/>
                </a:lnTo>
                <a:lnTo>
                  <a:pt x="0" y="57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3"/>
                </a:lnTo>
                <a:lnTo>
                  <a:pt x="0" y="1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1" name="Freeform 60"/>
          <p:cNvSpPr>
            <a:spLocks noEditPoints="1"/>
          </p:cNvSpPr>
          <p:nvPr/>
        </p:nvSpPr>
        <p:spPr bwMode="auto">
          <a:xfrm>
            <a:off x="4621214" y="4244032"/>
            <a:ext cx="57531" cy="23075"/>
          </a:xfrm>
          <a:custGeom>
            <a:avLst/>
            <a:gdLst>
              <a:gd name="T0" fmla="*/ 37 w 88"/>
              <a:gd name="T1" fmla="*/ 33 h 40"/>
              <a:gd name="T2" fmla="*/ 37 w 88"/>
              <a:gd name="T3" fmla="*/ 19 h 40"/>
              <a:gd name="T4" fmla="*/ 37 w 88"/>
              <a:gd name="T5" fmla="*/ 7 h 40"/>
              <a:gd name="T6" fmla="*/ 51 w 88"/>
              <a:gd name="T7" fmla="*/ 7 h 40"/>
              <a:gd name="T8" fmla="*/ 51 w 88"/>
              <a:gd name="T9" fmla="*/ 19 h 40"/>
              <a:gd name="T10" fmla="*/ 51 w 88"/>
              <a:gd name="T11" fmla="*/ 33 h 40"/>
              <a:gd name="T12" fmla="*/ 37 w 88"/>
              <a:gd name="T13" fmla="*/ 33 h 40"/>
              <a:gd name="T14" fmla="*/ 0 w 88"/>
              <a:gd name="T15" fmla="*/ 26 h 40"/>
              <a:gd name="T16" fmla="*/ 88 w 88"/>
              <a:gd name="T17" fmla="*/ 26 h 40"/>
              <a:gd name="T18" fmla="*/ 88 w 88"/>
              <a:gd name="T19" fmla="*/ 40 h 40"/>
              <a:gd name="T20" fmla="*/ 0 w 88"/>
              <a:gd name="T21" fmla="*/ 40 h 40"/>
              <a:gd name="T22" fmla="*/ 0 w 88"/>
              <a:gd name="T23" fmla="*/ 26 h 40"/>
              <a:gd name="T24" fmla="*/ 0 w 88"/>
              <a:gd name="T25" fmla="*/ 0 h 40"/>
              <a:gd name="T26" fmla="*/ 88 w 88"/>
              <a:gd name="T27" fmla="*/ 0 h 40"/>
              <a:gd name="T28" fmla="*/ 88 w 88"/>
              <a:gd name="T29" fmla="*/ 14 h 40"/>
              <a:gd name="T30" fmla="*/ 0 w 88"/>
              <a:gd name="T31" fmla="*/ 14 h 40"/>
              <a:gd name="T32" fmla="*/ 0 w 88"/>
              <a:gd name="T33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40">
                <a:moveTo>
                  <a:pt x="37" y="33"/>
                </a:moveTo>
                <a:lnTo>
                  <a:pt x="37" y="19"/>
                </a:lnTo>
                <a:lnTo>
                  <a:pt x="37" y="7"/>
                </a:lnTo>
                <a:lnTo>
                  <a:pt x="51" y="7"/>
                </a:lnTo>
                <a:lnTo>
                  <a:pt x="51" y="19"/>
                </a:lnTo>
                <a:lnTo>
                  <a:pt x="51" y="33"/>
                </a:lnTo>
                <a:lnTo>
                  <a:pt x="37" y="33"/>
                </a:lnTo>
                <a:close/>
                <a:moveTo>
                  <a:pt x="0" y="26"/>
                </a:moveTo>
                <a:lnTo>
                  <a:pt x="88" y="26"/>
                </a:lnTo>
                <a:lnTo>
                  <a:pt x="88" y="40"/>
                </a:lnTo>
                <a:lnTo>
                  <a:pt x="0" y="40"/>
                </a:lnTo>
                <a:lnTo>
                  <a:pt x="0" y="26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2" name="Freeform 61"/>
          <p:cNvSpPr>
            <a:spLocks noEditPoints="1"/>
          </p:cNvSpPr>
          <p:nvPr/>
        </p:nvSpPr>
        <p:spPr bwMode="auto">
          <a:xfrm>
            <a:off x="5003019" y="3430068"/>
            <a:ext cx="56225" cy="462651"/>
          </a:xfrm>
          <a:custGeom>
            <a:avLst/>
            <a:gdLst>
              <a:gd name="T0" fmla="*/ 37 w 86"/>
              <a:gd name="T1" fmla="*/ 795 h 802"/>
              <a:gd name="T2" fmla="*/ 37 w 86"/>
              <a:gd name="T3" fmla="*/ 401 h 802"/>
              <a:gd name="T4" fmla="*/ 37 w 86"/>
              <a:gd name="T5" fmla="*/ 7 h 802"/>
              <a:gd name="T6" fmla="*/ 51 w 86"/>
              <a:gd name="T7" fmla="*/ 7 h 802"/>
              <a:gd name="T8" fmla="*/ 51 w 86"/>
              <a:gd name="T9" fmla="*/ 401 h 802"/>
              <a:gd name="T10" fmla="*/ 51 w 86"/>
              <a:gd name="T11" fmla="*/ 795 h 802"/>
              <a:gd name="T12" fmla="*/ 37 w 86"/>
              <a:gd name="T13" fmla="*/ 795 h 802"/>
              <a:gd name="T14" fmla="*/ 0 w 86"/>
              <a:gd name="T15" fmla="*/ 788 h 802"/>
              <a:gd name="T16" fmla="*/ 86 w 86"/>
              <a:gd name="T17" fmla="*/ 788 h 802"/>
              <a:gd name="T18" fmla="*/ 86 w 86"/>
              <a:gd name="T19" fmla="*/ 802 h 802"/>
              <a:gd name="T20" fmla="*/ 0 w 86"/>
              <a:gd name="T21" fmla="*/ 802 h 802"/>
              <a:gd name="T22" fmla="*/ 0 w 86"/>
              <a:gd name="T23" fmla="*/ 788 h 802"/>
              <a:gd name="T24" fmla="*/ 0 w 86"/>
              <a:gd name="T25" fmla="*/ 0 h 802"/>
              <a:gd name="T26" fmla="*/ 86 w 86"/>
              <a:gd name="T27" fmla="*/ 0 h 802"/>
              <a:gd name="T28" fmla="*/ 86 w 86"/>
              <a:gd name="T29" fmla="*/ 14 h 802"/>
              <a:gd name="T30" fmla="*/ 0 w 86"/>
              <a:gd name="T31" fmla="*/ 14 h 802"/>
              <a:gd name="T32" fmla="*/ 0 w 86"/>
              <a:gd name="T33" fmla="*/ 0 h 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6" h="802">
                <a:moveTo>
                  <a:pt x="37" y="795"/>
                </a:moveTo>
                <a:lnTo>
                  <a:pt x="37" y="401"/>
                </a:lnTo>
                <a:lnTo>
                  <a:pt x="37" y="7"/>
                </a:lnTo>
                <a:lnTo>
                  <a:pt x="51" y="7"/>
                </a:lnTo>
                <a:lnTo>
                  <a:pt x="51" y="401"/>
                </a:lnTo>
                <a:lnTo>
                  <a:pt x="51" y="795"/>
                </a:lnTo>
                <a:lnTo>
                  <a:pt x="37" y="795"/>
                </a:lnTo>
                <a:close/>
                <a:moveTo>
                  <a:pt x="0" y="788"/>
                </a:moveTo>
                <a:lnTo>
                  <a:pt x="86" y="788"/>
                </a:lnTo>
                <a:lnTo>
                  <a:pt x="86" y="802"/>
                </a:lnTo>
                <a:lnTo>
                  <a:pt x="0" y="802"/>
                </a:lnTo>
                <a:lnTo>
                  <a:pt x="0" y="788"/>
                </a:lnTo>
                <a:close/>
                <a:moveTo>
                  <a:pt x="0" y="0"/>
                </a:moveTo>
                <a:lnTo>
                  <a:pt x="86" y="0"/>
                </a:lnTo>
                <a:lnTo>
                  <a:pt x="86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3" name="Freeform 62"/>
          <p:cNvSpPr>
            <a:spLocks noEditPoints="1"/>
          </p:cNvSpPr>
          <p:nvPr/>
        </p:nvSpPr>
        <p:spPr bwMode="auto">
          <a:xfrm>
            <a:off x="5383515" y="3951558"/>
            <a:ext cx="57531" cy="218058"/>
          </a:xfrm>
          <a:custGeom>
            <a:avLst/>
            <a:gdLst>
              <a:gd name="T0" fmla="*/ 37 w 88"/>
              <a:gd name="T1" fmla="*/ 371 h 378"/>
              <a:gd name="T2" fmla="*/ 37 w 88"/>
              <a:gd name="T3" fmla="*/ 190 h 378"/>
              <a:gd name="T4" fmla="*/ 37 w 88"/>
              <a:gd name="T5" fmla="*/ 7 h 378"/>
              <a:gd name="T6" fmla="*/ 51 w 88"/>
              <a:gd name="T7" fmla="*/ 7 h 378"/>
              <a:gd name="T8" fmla="*/ 51 w 88"/>
              <a:gd name="T9" fmla="*/ 190 h 378"/>
              <a:gd name="T10" fmla="*/ 51 w 88"/>
              <a:gd name="T11" fmla="*/ 371 h 378"/>
              <a:gd name="T12" fmla="*/ 37 w 88"/>
              <a:gd name="T13" fmla="*/ 371 h 378"/>
              <a:gd name="T14" fmla="*/ 0 w 88"/>
              <a:gd name="T15" fmla="*/ 364 h 378"/>
              <a:gd name="T16" fmla="*/ 88 w 88"/>
              <a:gd name="T17" fmla="*/ 364 h 378"/>
              <a:gd name="T18" fmla="*/ 88 w 88"/>
              <a:gd name="T19" fmla="*/ 378 h 378"/>
              <a:gd name="T20" fmla="*/ 0 w 88"/>
              <a:gd name="T21" fmla="*/ 378 h 378"/>
              <a:gd name="T22" fmla="*/ 0 w 88"/>
              <a:gd name="T23" fmla="*/ 364 h 378"/>
              <a:gd name="T24" fmla="*/ 0 w 88"/>
              <a:gd name="T25" fmla="*/ 0 h 378"/>
              <a:gd name="T26" fmla="*/ 88 w 88"/>
              <a:gd name="T27" fmla="*/ 0 h 378"/>
              <a:gd name="T28" fmla="*/ 88 w 88"/>
              <a:gd name="T29" fmla="*/ 14 h 378"/>
              <a:gd name="T30" fmla="*/ 0 w 88"/>
              <a:gd name="T31" fmla="*/ 14 h 378"/>
              <a:gd name="T32" fmla="*/ 0 w 88"/>
              <a:gd name="T33" fmla="*/ 0 h 3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378">
                <a:moveTo>
                  <a:pt x="37" y="371"/>
                </a:moveTo>
                <a:lnTo>
                  <a:pt x="37" y="190"/>
                </a:lnTo>
                <a:lnTo>
                  <a:pt x="37" y="7"/>
                </a:lnTo>
                <a:lnTo>
                  <a:pt x="51" y="7"/>
                </a:lnTo>
                <a:lnTo>
                  <a:pt x="51" y="190"/>
                </a:lnTo>
                <a:lnTo>
                  <a:pt x="51" y="371"/>
                </a:lnTo>
                <a:lnTo>
                  <a:pt x="37" y="371"/>
                </a:lnTo>
                <a:close/>
                <a:moveTo>
                  <a:pt x="0" y="364"/>
                </a:moveTo>
                <a:lnTo>
                  <a:pt x="88" y="364"/>
                </a:lnTo>
                <a:lnTo>
                  <a:pt x="88" y="378"/>
                </a:lnTo>
                <a:lnTo>
                  <a:pt x="0" y="378"/>
                </a:lnTo>
                <a:lnTo>
                  <a:pt x="0" y="364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4" name="Freeform 63"/>
          <p:cNvSpPr>
            <a:spLocks noEditPoints="1"/>
          </p:cNvSpPr>
          <p:nvPr/>
        </p:nvSpPr>
        <p:spPr bwMode="auto">
          <a:xfrm>
            <a:off x="5764664" y="2872234"/>
            <a:ext cx="57531" cy="852038"/>
          </a:xfrm>
          <a:custGeom>
            <a:avLst/>
            <a:gdLst>
              <a:gd name="T0" fmla="*/ 38 w 88"/>
              <a:gd name="T1" fmla="*/ 1470 h 1477"/>
              <a:gd name="T2" fmla="*/ 38 w 88"/>
              <a:gd name="T3" fmla="*/ 740 h 1477"/>
              <a:gd name="T4" fmla="*/ 38 w 88"/>
              <a:gd name="T5" fmla="*/ 7 h 1477"/>
              <a:gd name="T6" fmla="*/ 51 w 88"/>
              <a:gd name="T7" fmla="*/ 7 h 1477"/>
              <a:gd name="T8" fmla="*/ 51 w 88"/>
              <a:gd name="T9" fmla="*/ 740 h 1477"/>
              <a:gd name="T10" fmla="*/ 51 w 88"/>
              <a:gd name="T11" fmla="*/ 1470 h 1477"/>
              <a:gd name="T12" fmla="*/ 38 w 88"/>
              <a:gd name="T13" fmla="*/ 1470 h 1477"/>
              <a:gd name="T14" fmla="*/ 0 w 88"/>
              <a:gd name="T15" fmla="*/ 1463 h 1477"/>
              <a:gd name="T16" fmla="*/ 88 w 88"/>
              <a:gd name="T17" fmla="*/ 1463 h 1477"/>
              <a:gd name="T18" fmla="*/ 88 w 88"/>
              <a:gd name="T19" fmla="*/ 1477 h 1477"/>
              <a:gd name="T20" fmla="*/ 0 w 88"/>
              <a:gd name="T21" fmla="*/ 1477 h 1477"/>
              <a:gd name="T22" fmla="*/ 0 w 88"/>
              <a:gd name="T23" fmla="*/ 1463 h 1477"/>
              <a:gd name="T24" fmla="*/ 0 w 88"/>
              <a:gd name="T25" fmla="*/ 0 h 1477"/>
              <a:gd name="T26" fmla="*/ 88 w 88"/>
              <a:gd name="T27" fmla="*/ 0 h 1477"/>
              <a:gd name="T28" fmla="*/ 88 w 88"/>
              <a:gd name="T29" fmla="*/ 14 h 1477"/>
              <a:gd name="T30" fmla="*/ 0 w 88"/>
              <a:gd name="T31" fmla="*/ 14 h 1477"/>
              <a:gd name="T32" fmla="*/ 0 w 88"/>
              <a:gd name="T33" fmla="*/ 0 h 14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88" h="1477">
                <a:moveTo>
                  <a:pt x="38" y="1470"/>
                </a:moveTo>
                <a:lnTo>
                  <a:pt x="38" y="740"/>
                </a:lnTo>
                <a:lnTo>
                  <a:pt x="38" y="7"/>
                </a:lnTo>
                <a:lnTo>
                  <a:pt x="51" y="7"/>
                </a:lnTo>
                <a:lnTo>
                  <a:pt x="51" y="740"/>
                </a:lnTo>
                <a:lnTo>
                  <a:pt x="51" y="1470"/>
                </a:lnTo>
                <a:lnTo>
                  <a:pt x="38" y="1470"/>
                </a:lnTo>
                <a:close/>
                <a:moveTo>
                  <a:pt x="0" y="1463"/>
                </a:moveTo>
                <a:lnTo>
                  <a:pt x="88" y="1463"/>
                </a:lnTo>
                <a:lnTo>
                  <a:pt x="88" y="1477"/>
                </a:lnTo>
                <a:lnTo>
                  <a:pt x="0" y="1477"/>
                </a:lnTo>
                <a:lnTo>
                  <a:pt x="0" y="1463"/>
                </a:lnTo>
                <a:close/>
                <a:moveTo>
                  <a:pt x="0" y="0"/>
                </a:moveTo>
                <a:lnTo>
                  <a:pt x="88" y="0"/>
                </a:lnTo>
                <a:lnTo>
                  <a:pt x="8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270" cap="flat">
            <a:solidFill>
              <a:srgbClr val="000000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5" name="Rectangle 64"/>
          <p:cNvSpPr>
            <a:spLocks noChangeArrowheads="1"/>
          </p:cNvSpPr>
          <p:nvPr/>
        </p:nvSpPr>
        <p:spPr bwMode="auto">
          <a:xfrm>
            <a:off x="1400969" y="2685326"/>
            <a:ext cx="9153" cy="1599086"/>
          </a:xfrm>
          <a:prstGeom prst="rect">
            <a:avLst/>
          </a:prstGeom>
          <a:solidFill>
            <a:srgbClr val="868686"/>
          </a:solidFill>
          <a:ln w="1270" cap="flat">
            <a:solidFill>
              <a:srgbClr val="868686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6" name="Freeform 65"/>
          <p:cNvSpPr>
            <a:spLocks noEditPoints="1"/>
          </p:cNvSpPr>
          <p:nvPr/>
        </p:nvSpPr>
        <p:spPr bwMode="auto">
          <a:xfrm>
            <a:off x="1366769" y="2681289"/>
            <a:ext cx="37920" cy="1607162"/>
          </a:xfrm>
          <a:custGeom>
            <a:avLst/>
            <a:gdLst>
              <a:gd name="T0" fmla="*/ 0 w 58"/>
              <a:gd name="T1" fmla="*/ 2772 h 2786"/>
              <a:gd name="T2" fmla="*/ 58 w 58"/>
              <a:gd name="T3" fmla="*/ 2772 h 2786"/>
              <a:gd name="T4" fmla="*/ 58 w 58"/>
              <a:gd name="T5" fmla="*/ 2786 h 2786"/>
              <a:gd name="T6" fmla="*/ 0 w 58"/>
              <a:gd name="T7" fmla="*/ 2786 h 2786"/>
              <a:gd name="T8" fmla="*/ 0 w 58"/>
              <a:gd name="T9" fmla="*/ 2772 h 2786"/>
              <a:gd name="T10" fmla="*/ 0 w 58"/>
              <a:gd name="T11" fmla="*/ 2376 h 2786"/>
              <a:gd name="T12" fmla="*/ 58 w 58"/>
              <a:gd name="T13" fmla="*/ 2376 h 2786"/>
              <a:gd name="T14" fmla="*/ 58 w 58"/>
              <a:gd name="T15" fmla="*/ 2390 h 2786"/>
              <a:gd name="T16" fmla="*/ 0 w 58"/>
              <a:gd name="T17" fmla="*/ 2390 h 2786"/>
              <a:gd name="T18" fmla="*/ 0 w 58"/>
              <a:gd name="T19" fmla="*/ 2376 h 2786"/>
              <a:gd name="T20" fmla="*/ 0 w 58"/>
              <a:gd name="T21" fmla="*/ 1979 h 2786"/>
              <a:gd name="T22" fmla="*/ 58 w 58"/>
              <a:gd name="T23" fmla="*/ 1979 h 2786"/>
              <a:gd name="T24" fmla="*/ 58 w 58"/>
              <a:gd name="T25" fmla="*/ 1993 h 2786"/>
              <a:gd name="T26" fmla="*/ 0 w 58"/>
              <a:gd name="T27" fmla="*/ 1993 h 2786"/>
              <a:gd name="T28" fmla="*/ 0 w 58"/>
              <a:gd name="T29" fmla="*/ 1979 h 2786"/>
              <a:gd name="T30" fmla="*/ 0 w 58"/>
              <a:gd name="T31" fmla="*/ 1583 h 2786"/>
              <a:gd name="T32" fmla="*/ 58 w 58"/>
              <a:gd name="T33" fmla="*/ 1583 h 2786"/>
              <a:gd name="T34" fmla="*/ 58 w 58"/>
              <a:gd name="T35" fmla="*/ 1597 h 2786"/>
              <a:gd name="T36" fmla="*/ 0 w 58"/>
              <a:gd name="T37" fmla="*/ 1597 h 2786"/>
              <a:gd name="T38" fmla="*/ 0 w 58"/>
              <a:gd name="T39" fmla="*/ 1583 h 2786"/>
              <a:gd name="T40" fmla="*/ 0 w 58"/>
              <a:gd name="T41" fmla="*/ 1187 h 2786"/>
              <a:gd name="T42" fmla="*/ 58 w 58"/>
              <a:gd name="T43" fmla="*/ 1187 h 2786"/>
              <a:gd name="T44" fmla="*/ 58 w 58"/>
              <a:gd name="T45" fmla="*/ 1201 h 2786"/>
              <a:gd name="T46" fmla="*/ 0 w 58"/>
              <a:gd name="T47" fmla="*/ 1201 h 2786"/>
              <a:gd name="T48" fmla="*/ 0 w 58"/>
              <a:gd name="T49" fmla="*/ 1187 h 2786"/>
              <a:gd name="T50" fmla="*/ 0 w 58"/>
              <a:gd name="T51" fmla="*/ 790 h 2786"/>
              <a:gd name="T52" fmla="*/ 58 w 58"/>
              <a:gd name="T53" fmla="*/ 790 h 2786"/>
              <a:gd name="T54" fmla="*/ 58 w 58"/>
              <a:gd name="T55" fmla="*/ 804 h 2786"/>
              <a:gd name="T56" fmla="*/ 0 w 58"/>
              <a:gd name="T57" fmla="*/ 804 h 2786"/>
              <a:gd name="T58" fmla="*/ 0 w 58"/>
              <a:gd name="T59" fmla="*/ 790 h 2786"/>
              <a:gd name="T60" fmla="*/ 0 w 58"/>
              <a:gd name="T61" fmla="*/ 396 h 2786"/>
              <a:gd name="T62" fmla="*/ 58 w 58"/>
              <a:gd name="T63" fmla="*/ 396 h 2786"/>
              <a:gd name="T64" fmla="*/ 58 w 58"/>
              <a:gd name="T65" fmla="*/ 410 h 2786"/>
              <a:gd name="T66" fmla="*/ 0 w 58"/>
              <a:gd name="T67" fmla="*/ 410 h 2786"/>
              <a:gd name="T68" fmla="*/ 0 w 58"/>
              <a:gd name="T69" fmla="*/ 396 h 2786"/>
              <a:gd name="T70" fmla="*/ 0 w 58"/>
              <a:gd name="T71" fmla="*/ 0 h 2786"/>
              <a:gd name="T72" fmla="*/ 58 w 58"/>
              <a:gd name="T73" fmla="*/ 0 h 2786"/>
              <a:gd name="T74" fmla="*/ 58 w 58"/>
              <a:gd name="T75" fmla="*/ 14 h 2786"/>
              <a:gd name="T76" fmla="*/ 0 w 58"/>
              <a:gd name="T77" fmla="*/ 14 h 2786"/>
              <a:gd name="T78" fmla="*/ 0 w 58"/>
              <a:gd name="T79" fmla="*/ 0 h 27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</a:cxnLst>
            <a:rect l="0" t="0" r="r" b="b"/>
            <a:pathLst>
              <a:path w="58" h="2786">
                <a:moveTo>
                  <a:pt x="0" y="2772"/>
                </a:moveTo>
                <a:lnTo>
                  <a:pt x="58" y="2772"/>
                </a:lnTo>
                <a:lnTo>
                  <a:pt x="58" y="2786"/>
                </a:lnTo>
                <a:lnTo>
                  <a:pt x="0" y="2786"/>
                </a:lnTo>
                <a:lnTo>
                  <a:pt x="0" y="2772"/>
                </a:lnTo>
                <a:close/>
                <a:moveTo>
                  <a:pt x="0" y="2376"/>
                </a:moveTo>
                <a:lnTo>
                  <a:pt x="58" y="2376"/>
                </a:lnTo>
                <a:lnTo>
                  <a:pt x="58" y="2390"/>
                </a:lnTo>
                <a:lnTo>
                  <a:pt x="0" y="2390"/>
                </a:lnTo>
                <a:lnTo>
                  <a:pt x="0" y="2376"/>
                </a:lnTo>
                <a:close/>
                <a:moveTo>
                  <a:pt x="0" y="1979"/>
                </a:moveTo>
                <a:lnTo>
                  <a:pt x="58" y="1979"/>
                </a:lnTo>
                <a:lnTo>
                  <a:pt x="58" y="1993"/>
                </a:lnTo>
                <a:lnTo>
                  <a:pt x="0" y="1993"/>
                </a:lnTo>
                <a:lnTo>
                  <a:pt x="0" y="1979"/>
                </a:lnTo>
                <a:close/>
                <a:moveTo>
                  <a:pt x="0" y="1583"/>
                </a:moveTo>
                <a:lnTo>
                  <a:pt x="58" y="1583"/>
                </a:lnTo>
                <a:lnTo>
                  <a:pt x="58" y="1597"/>
                </a:lnTo>
                <a:lnTo>
                  <a:pt x="0" y="1597"/>
                </a:lnTo>
                <a:lnTo>
                  <a:pt x="0" y="1583"/>
                </a:lnTo>
                <a:close/>
                <a:moveTo>
                  <a:pt x="0" y="1187"/>
                </a:moveTo>
                <a:lnTo>
                  <a:pt x="58" y="1187"/>
                </a:lnTo>
                <a:lnTo>
                  <a:pt x="58" y="1201"/>
                </a:lnTo>
                <a:lnTo>
                  <a:pt x="0" y="1201"/>
                </a:lnTo>
                <a:lnTo>
                  <a:pt x="0" y="1187"/>
                </a:lnTo>
                <a:close/>
                <a:moveTo>
                  <a:pt x="0" y="790"/>
                </a:moveTo>
                <a:lnTo>
                  <a:pt x="58" y="790"/>
                </a:lnTo>
                <a:lnTo>
                  <a:pt x="58" y="804"/>
                </a:lnTo>
                <a:lnTo>
                  <a:pt x="0" y="804"/>
                </a:lnTo>
                <a:lnTo>
                  <a:pt x="0" y="790"/>
                </a:lnTo>
                <a:close/>
                <a:moveTo>
                  <a:pt x="0" y="396"/>
                </a:moveTo>
                <a:lnTo>
                  <a:pt x="58" y="396"/>
                </a:lnTo>
                <a:lnTo>
                  <a:pt x="58" y="410"/>
                </a:lnTo>
                <a:lnTo>
                  <a:pt x="0" y="410"/>
                </a:lnTo>
                <a:lnTo>
                  <a:pt x="0" y="396"/>
                </a:lnTo>
                <a:close/>
                <a:moveTo>
                  <a:pt x="0" y="0"/>
                </a:moveTo>
                <a:lnTo>
                  <a:pt x="58" y="0"/>
                </a:lnTo>
                <a:lnTo>
                  <a:pt x="58" y="14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868686"/>
          </a:solidFill>
          <a:ln w="1270" cap="flat">
            <a:solidFill>
              <a:srgbClr val="868686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7" name="Rectangle 66"/>
          <p:cNvSpPr>
            <a:spLocks noChangeArrowheads="1"/>
          </p:cNvSpPr>
          <p:nvPr/>
        </p:nvSpPr>
        <p:spPr bwMode="auto">
          <a:xfrm>
            <a:off x="1356268" y="4280376"/>
            <a:ext cx="4573799" cy="8077"/>
          </a:xfrm>
          <a:prstGeom prst="rect">
            <a:avLst/>
          </a:prstGeom>
          <a:solidFill>
            <a:srgbClr val="868686"/>
          </a:solidFill>
          <a:ln w="1270" cap="flat">
            <a:solidFill>
              <a:srgbClr val="868686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8" name="Freeform 67"/>
          <p:cNvSpPr>
            <a:spLocks noEditPoints="1"/>
          </p:cNvSpPr>
          <p:nvPr/>
        </p:nvSpPr>
        <p:spPr bwMode="auto">
          <a:xfrm>
            <a:off x="1351689" y="4284412"/>
            <a:ext cx="4582952" cy="32305"/>
          </a:xfrm>
          <a:custGeom>
            <a:avLst/>
            <a:gdLst>
              <a:gd name="T0" fmla="*/ 14 w 7010"/>
              <a:gd name="T1" fmla="*/ 56 h 56"/>
              <a:gd name="T2" fmla="*/ 0 w 7010"/>
              <a:gd name="T3" fmla="*/ 0 h 56"/>
              <a:gd name="T4" fmla="*/ 595 w 7010"/>
              <a:gd name="T5" fmla="*/ 0 h 56"/>
              <a:gd name="T6" fmla="*/ 581 w 7010"/>
              <a:gd name="T7" fmla="*/ 56 h 56"/>
              <a:gd name="T8" fmla="*/ 595 w 7010"/>
              <a:gd name="T9" fmla="*/ 0 h 56"/>
              <a:gd name="T10" fmla="*/ 1179 w 7010"/>
              <a:gd name="T11" fmla="*/ 56 h 56"/>
              <a:gd name="T12" fmla="*/ 1165 w 7010"/>
              <a:gd name="T13" fmla="*/ 0 h 56"/>
              <a:gd name="T14" fmla="*/ 1763 w 7010"/>
              <a:gd name="T15" fmla="*/ 0 h 56"/>
              <a:gd name="T16" fmla="*/ 1749 w 7010"/>
              <a:gd name="T17" fmla="*/ 56 h 56"/>
              <a:gd name="T18" fmla="*/ 1763 w 7010"/>
              <a:gd name="T19" fmla="*/ 0 h 56"/>
              <a:gd name="T20" fmla="*/ 2344 w 7010"/>
              <a:gd name="T21" fmla="*/ 56 h 56"/>
              <a:gd name="T22" fmla="*/ 2330 w 7010"/>
              <a:gd name="T23" fmla="*/ 0 h 56"/>
              <a:gd name="T24" fmla="*/ 2928 w 7010"/>
              <a:gd name="T25" fmla="*/ 0 h 56"/>
              <a:gd name="T26" fmla="*/ 2914 w 7010"/>
              <a:gd name="T27" fmla="*/ 56 h 56"/>
              <a:gd name="T28" fmla="*/ 2928 w 7010"/>
              <a:gd name="T29" fmla="*/ 0 h 56"/>
              <a:gd name="T30" fmla="*/ 3512 w 7010"/>
              <a:gd name="T31" fmla="*/ 56 h 56"/>
              <a:gd name="T32" fmla="*/ 3498 w 7010"/>
              <a:gd name="T33" fmla="*/ 0 h 56"/>
              <a:gd name="T34" fmla="*/ 4093 w 7010"/>
              <a:gd name="T35" fmla="*/ 0 h 56"/>
              <a:gd name="T36" fmla="*/ 4079 w 7010"/>
              <a:gd name="T37" fmla="*/ 56 h 56"/>
              <a:gd name="T38" fmla="*/ 4093 w 7010"/>
              <a:gd name="T39" fmla="*/ 0 h 56"/>
              <a:gd name="T40" fmla="*/ 4677 w 7010"/>
              <a:gd name="T41" fmla="*/ 56 h 56"/>
              <a:gd name="T42" fmla="*/ 4663 w 7010"/>
              <a:gd name="T43" fmla="*/ 0 h 56"/>
              <a:gd name="T44" fmla="*/ 5261 w 7010"/>
              <a:gd name="T45" fmla="*/ 0 h 56"/>
              <a:gd name="T46" fmla="*/ 5247 w 7010"/>
              <a:gd name="T47" fmla="*/ 56 h 56"/>
              <a:gd name="T48" fmla="*/ 5261 w 7010"/>
              <a:gd name="T49" fmla="*/ 0 h 56"/>
              <a:gd name="T50" fmla="*/ 5842 w 7010"/>
              <a:gd name="T51" fmla="*/ 56 h 56"/>
              <a:gd name="T52" fmla="*/ 5828 w 7010"/>
              <a:gd name="T53" fmla="*/ 0 h 56"/>
              <a:gd name="T54" fmla="*/ 6426 w 7010"/>
              <a:gd name="T55" fmla="*/ 0 h 56"/>
              <a:gd name="T56" fmla="*/ 6412 w 7010"/>
              <a:gd name="T57" fmla="*/ 56 h 56"/>
              <a:gd name="T58" fmla="*/ 6426 w 7010"/>
              <a:gd name="T59" fmla="*/ 0 h 56"/>
              <a:gd name="T60" fmla="*/ 7010 w 7010"/>
              <a:gd name="T61" fmla="*/ 56 h 56"/>
              <a:gd name="T62" fmla="*/ 6996 w 7010"/>
              <a:gd name="T63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7010" h="56">
                <a:moveTo>
                  <a:pt x="14" y="0"/>
                </a:moveTo>
                <a:lnTo>
                  <a:pt x="14" y="56"/>
                </a:lnTo>
                <a:lnTo>
                  <a:pt x="0" y="56"/>
                </a:lnTo>
                <a:lnTo>
                  <a:pt x="0" y="0"/>
                </a:lnTo>
                <a:lnTo>
                  <a:pt x="14" y="0"/>
                </a:lnTo>
                <a:close/>
                <a:moveTo>
                  <a:pt x="595" y="0"/>
                </a:moveTo>
                <a:lnTo>
                  <a:pt x="595" y="56"/>
                </a:lnTo>
                <a:lnTo>
                  <a:pt x="581" y="56"/>
                </a:lnTo>
                <a:lnTo>
                  <a:pt x="581" y="0"/>
                </a:lnTo>
                <a:lnTo>
                  <a:pt x="595" y="0"/>
                </a:lnTo>
                <a:close/>
                <a:moveTo>
                  <a:pt x="1179" y="0"/>
                </a:moveTo>
                <a:lnTo>
                  <a:pt x="1179" y="56"/>
                </a:lnTo>
                <a:lnTo>
                  <a:pt x="1165" y="56"/>
                </a:lnTo>
                <a:lnTo>
                  <a:pt x="1165" y="0"/>
                </a:lnTo>
                <a:lnTo>
                  <a:pt x="1179" y="0"/>
                </a:lnTo>
                <a:close/>
                <a:moveTo>
                  <a:pt x="1763" y="0"/>
                </a:moveTo>
                <a:lnTo>
                  <a:pt x="1763" y="56"/>
                </a:lnTo>
                <a:lnTo>
                  <a:pt x="1749" y="56"/>
                </a:lnTo>
                <a:lnTo>
                  <a:pt x="1749" y="0"/>
                </a:lnTo>
                <a:lnTo>
                  <a:pt x="1763" y="0"/>
                </a:lnTo>
                <a:close/>
                <a:moveTo>
                  <a:pt x="2344" y="0"/>
                </a:moveTo>
                <a:lnTo>
                  <a:pt x="2344" y="56"/>
                </a:lnTo>
                <a:lnTo>
                  <a:pt x="2330" y="56"/>
                </a:lnTo>
                <a:lnTo>
                  <a:pt x="2330" y="0"/>
                </a:lnTo>
                <a:lnTo>
                  <a:pt x="2344" y="0"/>
                </a:lnTo>
                <a:close/>
                <a:moveTo>
                  <a:pt x="2928" y="0"/>
                </a:moveTo>
                <a:lnTo>
                  <a:pt x="2928" y="56"/>
                </a:lnTo>
                <a:lnTo>
                  <a:pt x="2914" y="56"/>
                </a:lnTo>
                <a:lnTo>
                  <a:pt x="2914" y="0"/>
                </a:lnTo>
                <a:lnTo>
                  <a:pt x="2928" y="0"/>
                </a:lnTo>
                <a:close/>
                <a:moveTo>
                  <a:pt x="3512" y="0"/>
                </a:moveTo>
                <a:lnTo>
                  <a:pt x="3512" y="56"/>
                </a:lnTo>
                <a:lnTo>
                  <a:pt x="3498" y="56"/>
                </a:lnTo>
                <a:lnTo>
                  <a:pt x="3498" y="0"/>
                </a:lnTo>
                <a:lnTo>
                  <a:pt x="3512" y="0"/>
                </a:lnTo>
                <a:close/>
                <a:moveTo>
                  <a:pt x="4093" y="0"/>
                </a:moveTo>
                <a:lnTo>
                  <a:pt x="4093" y="56"/>
                </a:lnTo>
                <a:lnTo>
                  <a:pt x="4079" y="56"/>
                </a:lnTo>
                <a:lnTo>
                  <a:pt x="4079" y="0"/>
                </a:lnTo>
                <a:lnTo>
                  <a:pt x="4093" y="0"/>
                </a:lnTo>
                <a:close/>
                <a:moveTo>
                  <a:pt x="4677" y="0"/>
                </a:moveTo>
                <a:lnTo>
                  <a:pt x="4677" y="56"/>
                </a:lnTo>
                <a:lnTo>
                  <a:pt x="4663" y="56"/>
                </a:lnTo>
                <a:lnTo>
                  <a:pt x="4663" y="0"/>
                </a:lnTo>
                <a:lnTo>
                  <a:pt x="4677" y="0"/>
                </a:lnTo>
                <a:close/>
                <a:moveTo>
                  <a:pt x="5261" y="0"/>
                </a:moveTo>
                <a:lnTo>
                  <a:pt x="5261" y="56"/>
                </a:lnTo>
                <a:lnTo>
                  <a:pt x="5247" y="56"/>
                </a:lnTo>
                <a:lnTo>
                  <a:pt x="5247" y="0"/>
                </a:lnTo>
                <a:lnTo>
                  <a:pt x="5261" y="0"/>
                </a:lnTo>
                <a:close/>
                <a:moveTo>
                  <a:pt x="5842" y="0"/>
                </a:moveTo>
                <a:lnTo>
                  <a:pt x="5842" y="56"/>
                </a:lnTo>
                <a:lnTo>
                  <a:pt x="5828" y="56"/>
                </a:lnTo>
                <a:lnTo>
                  <a:pt x="5828" y="0"/>
                </a:lnTo>
                <a:lnTo>
                  <a:pt x="5842" y="0"/>
                </a:lnTo>
                <a:close/>
                <a:moveTo>
                  <a:pt x="6426" y="0"/>
                </a:moveTo>
                <a:lnTo>
                  <a:pt x="6426" y="56"/>
                </a:lnTo>
                <a:lnTo>
                  <a:pt x="6412" y="56"/>
                </a:lnTo>
                <a:lnTo>
                  <a:pt x="6412" y="0"/>
                </a:lnTo>
                <a:lnTo>
                  <a:pt x="6426" y="0"/>
                </a:lnTo>
                <a:close/>
                <a:moveTo>
                  <a:pt x="7010" y="0"/>
                </a:moveTo>
                <a:lnTo>
                  <a:pt x="7010" y="56"/>
                </a:lnTo>
                <a:lnTo>
                  <a:pt x="6996" y="56"/>
                </a:lnTo>
                <a:lnTo>
                  <a:pt x="6996" y="0"/>
                </a:lnTo>
                <a:lnTo>
                  <a:pt x="7010" y="0"/>
                </a:lnTo>
                <a:close/>
              </a:path>
            </a:pathLst>
          </a:custGeom>
          <a:solidFill>
            <a:srgbClr val="868686"/>
          </a:solidFill>
          <a:ln w="1270" cap="flat">
            <a:solidFill>
              <a:srgbClr val="868686"/>
            </a:solidFill>
            <a:prstDash val="solid"/>
            <a:bevel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69" name="Rectangle 68"/>
          <p:cNvSpPr>
            <a:spLocks noChangeArrowheads="1"/>
          </p:cNvSpPr>
          <p:nvPr/>
        </p:nvSpPr>
        <p:spPr bwMode="auto">
          <a:xfrm>
            <a:off x="1112342" y="4219804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0" name="Rectangle 69"/>
          <p:cNvSpPr>
            <a:spLocks noChangeArrowheads="1"/>
          </p:cNvSpPr>
          <p:nvPr/>
        </p:nvSpPr>
        <p:spPr bwMode="auto">
          <a:xfrm>
            <a:off x="1063451" y="3762921"/>
            <a:ext cx="1955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.1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1" name="Rectangle 70"/>
          <p:cNvSpPr>
            <a:spLocks noChangeArrowheads="1"/>
          </p:cNvSpPr>
          <p:nvPr/>
        </p:nvSpPr>
        <p:spPr bwMode="auto">
          <a:xfrm>
            <a:off x="1063451" y="3306037"/>
            <a:ext cx="1955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.2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2" name="Rectangle 71"/>
          <p:cNvSpPr>
            <a:spLocks noChangeArrowheads="1"/>
          </p:cNvSpPr>
          <p:nvPr/>
        </p:nvSpPr>
        <p:spPr bwMode="auto">
          <a:xfrm>
            <a:off x="1063451" y="2849158"/>
            <a:ext cx="1955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.3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3" name="Rectangle 72"/>
          <p:cNvSpPr>
            <a:spLocks noChangeArrowheads="1"/>
          </p:cNvSpPr>
          <p:nvPr/>
        </p:nvSpPr>
        <p:spPr bwMode="auto">
          <a:xfrm>
            <a:off x="1435921" y="4350176"/>
            <a:ext cx="27411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.15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4" name="Rectangle 73"/>
          <p:cNvSpPr>
            <a:spLocks noChangeArrowheads="1"/>
          </p:cNvSpPr>
          <p:nvPr/>
        </p:nvSpPr>
        <p:spPr bwMode="auto">
          <a:xfrm>
            <a:off x="1848405" y="4350176"/>
            <a:ext cx="1955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0.3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5" name="Rectangle 74"/>
          <p:cNvSpPr>
            <a:spLocks noChangeArrowheads="1"/>
          </p:cNvSpPr>
          <p:nvPr/>
        </p:nvSpPr>
        <p:spPr bwMode="auto">
          <a:xfrm>
            <a:off x="2277229" y="4350176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1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6" name="Rectangle 75"/>
          <p:cNvSpPr>
            <a:spLocks noChangeArrowheads="1"/>
          </p:cNvSpPr>
          <p:nvPr/>
        </p:nvSpPr>
        <p:spPr bwMode="auto">
          <a:xfrm>
            <a:off x="2658334" y="4350176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2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>
            <a:off x="3039438" y="4350176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4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8" name="Rectangle 77"/>
          <p:cNvSpPr>
            <a:spLocks noChangeArrowheads="1"/>
          </p:cNvSpPr>
          <p:nvPr/>
        </p:nvSpPr>
        <p:spPr bwMode="auto">
          <a:xfrm>
            <a:off x="3420543" y="4350176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6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79" name="Rectangle 78"/>
          <p:cNvSpPr>
            <a:spLocks noChangeArrowheads="1"/>
          </p:cNvSpPr>
          <p:nvPr/>
        </p:nvSpPr>
        <p:spPr bwMode="auto">
          <a:xfrm>
            <a:off x="3801647" y="4350176"/>
            <a:ext cx="78548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8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0" name="Rectangle 79"/>
          <p:cNvSpPr>
            <a:spLocks noChangeArrowheads="1"/>
          </p:cNvSpPr>
          <p:nvPr/>
        </p:nvSpPr>
        <p:spPr bwMode="auto">
          <a:xfrm>
            <a:off x="4151374" y="4350176"/>
            <a:ext cx="15709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10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1" name="Rectangle 80"/>
          <p:cNvSpPr>
            <a:spLocks noChangeArrowheads="1"/>
          </p:cNvSpPr>
          <p:nvPr/>
        </p:nvSpPr>
        <p:spPr bwMode="auto">
          <a:xfrm>
            <a:off x="4532477" y="4350176"/>
            <a:ext cx="15709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15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2" name="Rectangle 81"/>
          <p:cNvSpPr>
            <a:spLocks noChangeArrowheads="1"/>
          </p:cNvSpPr>
          <p:nvPr/>
        </p:nvSpPr>
        <p:spPr bwMode="auto">
          <a:xfrm>
            <a:off x="4913582" y="4350176"/>
            <a:ext cx="15709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 dirty="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24</a:t>
            </a:r>
            <a:endParaRPr lang="en-GB" sz="1200" dirty="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3" name="Rectangle 82"/>
          <p:cNvSpPr>
            <a:spLocks noChangeArrowheads="1"/>
          </p:cNvSpPr>
          <p:nvPr/>
        </p:nvSpPr>
        <p:spPr bwMode="auto">
          <a:xfrm>
            <a:off x="5294687" y="4350176"/>
            <a:ext cx="15709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48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4" name="Rectangle 83"/>
          <p:cNvSpPr>
            <a:spLocks noChangeArrowheads="1"/>
          </p:cNvSpPr>
          <p:nvPr/>
        </p:nvSpPr>
        <p:spPr bwMode="auto">
          <a:xfrm>
            <a:off x="5675791" y="4350176"/>
            <a:ext cx="157094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US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72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5" name="Rectangle 84"/>
          <p:cNvSpPr>
            <a:spLocks noChangeArrowheads="1"/>
          </p:cNvSpPr>
          <p:nvPr/>
        </p:nvSpPr>
        <p:spPr bwMode="auto">
          <a:xfrm>
            <a:off x="607695" y="2729170"/>
            <a:ext cx="399455" cy="144390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defTabSz="914400"/>
            <a:endParaRPr lang="en-GB" sz="120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  <p:sp>
        <p:nvSpPr>
          <p:cNvPr id="86" name="Rectangle 85"/>
          <p:cNvSpPr>
            <a:spLocks noChangeArrowheads="1"/>
          </p:cNvSpPr>
          <p:nvPr/>
        </p:nvSpPr>
        <p:spPr bwMode="auto">
          <a:xfrm>
            <a:off x="825370" y="2898770"/>
            <a:ext cx="35266" cy="2123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0" tIns="0" rIns="0" bIns="0" anchor="t" anchorCtr="0">
            <a:sp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GB" sz="1200">
                <a:solidFill>
                  <a:srgbClr val="000000"/>
                </a:solidFill>
                <a:ea typeface="SimSun"/>
                <a:cs typeface="Times New Roman" panose="02020603050405020304" pitchFamily="18" charset="0"/>
              </a:rPr>
              <a:t> </a:t>
            </a:r>
            <a:endParaRPr lang="en-GB" sz="1200">
              <a:solidFill>
                <a:prstClr val="black"/>
              </a:solidFill>
              <a:ea typeface="SimSun"/>
              <a:cs typeface="Times New Roman" panose="02020603050405020304" pitchFamily="18" charset="0"/>
            </a:endParaRPr>
          </a:p>
        </p:txBody>
      </p:sp>
      <p:sp>
        <p:nvSpPr>
          <p:cNvPr id="87" name="Text Box 2"/>
          <p:cNvSpPr txBox="1"/>
          <p:nvPr/>
        </p:nvSpPr>
        <p:spPr>
          <a:xfrm rot="10800000">
            <a:off x="538227" y="2632454"/>
            <a:ext cx="413838" cy="1668109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defTabSz="914400">
              <a:lnSpc>
                <a:spcPct val="115000"/>
              </a:lnSpc>
              <a:spcAft>
                <a:spcPts val="1047"/>
              </a:spcAft>
            </a:pPr>
            <a:r>
              <a:rPr lang="en-GB" sz="1200" b="1" dirty="0">
                <a:solidFill>
                  <a:prstClr val="black"/>
                </a:solidFill>
                <a:ea typeface="SimSun"/>
                <a:cs typeface="Times New Roman" panose="02020603050405020304" pitchFamily="18" charset="0"/>
              </a:rPr>
              <a:t>Expression relative to </a:t>
            </a:r>
            <a:r>
              <a:rPr lang="en-GB" sz="1200" b="1" i="1" dirty="0">
                <a:solidFill>
                  <a:prstClr val="black"/>
                </a:solidFill>
                <a:ea typeface="SimSun"/>
                <a:cs typeface="Times New Roman" panose="02020603050405020304" pitchFamily="18" charset="0"/>
              </a:rPr>
              <a:t>Actin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293081" y="244018"/>
            <a:ext cx="622963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cs typeface="Times New Roman" panose="02020603050405020304" pitchFamily="18" charset="0"/>
              </a:rPr>
              <a:t>Supplemental Figure S1</a:t>
            </a:r>
          </a:p>
          <a:p>
            <a:endParaRPr lang="en-GB" sz="1600" dirty="0">
              <a:cs typeface="Times New Roman" panose="02020603050405020304" pitchFamily="18" charset="0"/>
            </a:endParaRPr>
          </a:p>
          <a:p>
            <a:r>
              <a:rPr lang="en-GB" sz="1200" dirty="0" smtClean="0">
                <a:cs typeface="Times New Roman" panose="02020603050405020304" pitchFamily="18" charset="0"/>
              </a:rPr>
              <a:t>Expression of </a:t>
            </a:r>
            <a:r>
              <a:rPr lang="en-GB" sz="1200" i="1" dirty="0" smtClean="0">
                <a:cs typeface="Times New Roman" panose="02020603050405020304" pitchFamily="18" charset="0"/>
              </a:rPr>
              <a:t>LIPOXYGENASE</a:t>
            </a:r>
            <a:r>
              <a:rPr lang="en-GB" sz="1200" dirty="0" smtClean="0">
                <a:cs typeface="Times New Roman" panose="02020603050405020304" pitchFamily="18" charset="0"/>
              </a:rPr>
              <a:t> (Csa2M024440) (white bars) and </a:t>
            </a:r>
            <a:r>
              <a:rPr lang="en-GB" sz="1200" i="1" dirty="0" smtClean="0">
                <a:cs typeface="Times New Roman" panose="02020603050405020304" pitchFamily="18" charset="0"/>
              </a:rPr>
              <a:t>(E,E)-</a:t>
            </a:r>
            <a:r>
              <a:rPr lang="el-GR" sz="1200" i="1" dirty="0" smtClean="0">
                <a:cs typeface="Times New Roman" panose="02020603050405020304" pitchFamily="18" charset="0"/>
              </a:rPr>
              <a:t>α</a:t>
            </a:r>
            <a:r>
              <a:rPr lang="nl-NL" sz="1200" i="1" dirty="0" smtClean="0">
                <a:cs typeface="Times New Roman" panose="02020603050405020304" pitchFamily="18" charset="0"/>
              </a:rPr>
              <a:t>-FARNESENE SYNTHASE </a:t>
            </a:r>
            <a:r>
              <a:rPr lang="nl-NL" sz="1200" dirty="0" smtClean="0">
                <a:cs typeface="Times New Roman" panose="02020603050405020304" pitchFamily="18" charset="0"/>
              </a:rPr>
              <a:t>(</a:t>
            </a:r>
            <a:r>
              <a:rPr lang="en-GB" sz="1200" dirty="0" smtClean="0">
                <a:cs typeface="Times New Roman" panose="02020603050405020304" pitchFamily="18" charset="0"/>
              </a:rPr>
              <a:t>Csa3M095040) (black bars) in </a:t>
            </a:r>
            <a:r>
              <a:rPr lang="en-GB" sz="1200" i="1" dirty="0" err="1" smtClean="0">
                <a:cs typeface="Times New Roman" panose="02020603050405020304" pitchFamily="18" charset="0"/>
              </a:rPr>
              <a:t>Cucumis</a:t>
            </a:r>
            <a:r>
              <a:rPr lang="en-GB" sz="1200" i="1" dirty="0" smtClean="0">
                <a:cs typeface="Times New Roman" panose="02020603050405020304" pitchFamily="18" charset="0"/>
              </a:rPr>
              <a:t> </a:t>
            </a:r>
            <a:r>
              <a:rPr lang="en-GB" sz="1200" i="1" dirty="0" err="1" smtClean="0">
                <a:cs typeface="Times New Roman" panose="02020603050405020304" pitchFamily="18" charset="0"/>
              </a:rPr>
              <a:t>sativus</a:t>
            </a:r>
            <a:r>
              <a:rPr lang="en-GB" sz="1200" i="1" dirty="0" smtClean="0"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cs typeface="Times New Roman" panose="02020603050405020304" pitchFamily="18" charset="0"/>
              </a:rPr>
              <a:t>Chinese Long 9930 leaves after different times of infestation with two-spotted spider mites</a:t>
            </a:r>
            <a:r>
              <a:rPr lang="en-GB" sz="1200" dirty="0" smtClean="0">
                <a:cs typeface="Times New Roman" panose="02020603050405020304" pitchFamily="18" charset="0"/>
              </a:rPr>
              <a:t>. Bars represent means ± SD (N=3).</a:t>
            </a:r>
            <a:endParaRPr lang="en-GB" sz="12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3719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" y="1714500"/>
            <a:ext cx="5993130" cy="546735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88"/>
          <p:cNvSpPr txBox="1"/>
          <p:nvPr/>
        </p:nvSpPr>
        <p:spPr>
          <a:xfrm>
            <a:off x="293081" y="244018"/>
            <a:ext cx="6229639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cs typeface="Times New Roman" panose="02020603050405020304" pitchFamily="18" charset="0"/>
              </a:rPr>
              <a:t>Supplemental Figure S2</a:t>
            </a:r>
          </a:p>
          <a:p>
            <a:endParaRPr lang="en-GB" sz="16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Sequencing assessment of reads achieved from RNA-seq. (A) Number of raw reads classified by sequencing quality. (B) Distribution of reads mapped to cucumber chromosome 3; (C) Mapped reads and number of genes expressed. (D) Mapped reads and their relative position in genes.</a:t>
            </a:r>
            <a:endParaRPr lang="en-GB" sz="12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8301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8"/>
          <p:cNvSpPr txBox="1"/>
          <p:nvPr/>
        </p:nvSpPr>
        <p:spPr>
          <a:xfrm>
            <a:off x="195735" y="790628"/>
            <a:ext cx="6553408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cs typeface="Times New Roman" panose="02020603050405020304" pitchFamily="18" charset="0"/>
              </a:rPr>
              <a:t>Supplemental Figure S3</a:t>
            </a:r>
          </a:p>
          <a:p>
            <a:endParaRPr lang="en-GB" sz="16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Validation of RNA-</a:t>
            </a:r>
            <a:r>
              <a:rPr lang="en-US" sz="1200" dirty="0" err="1">
                <a:cs typeface="Times New Roman" panose="02020603050405020304" pitchFamily="18" charset="0"/>
              </a:rPr>
              <a:t>seq</a:t>
            </a:r>
            <a:r>
              <a:rPr lang="en-US" sz="1200" dirty="0">
                <a:cs typeface="Times New Roman" panose="02020603050405020304" pitchFamily="18" charset="0"/>
              </a:rPr>
              <a:t> transcript data of </a:t>
            </a:r>
            <a:r>
              <a:rPr lang="en-US" sz="1200" dirty="0" smtClean="0">
                <a:cs typeface="Times New Roman" panose="02020603050405020304" pitchFamily="18" charset="0"/>
              </a:rPr>
              <a:t>7 </a:t>
            </a:r>
            <a:r>
              <a:rPr lang="en-US" sz="1200" dirty="0">
                <a:cs typeface="Times New Roman" panose="02020603050405020304" pitchFamily="18" charset="0"/>
              </a:rPr>
              <a:t>selected genes by </a:t>
            </a:r>
            <a:r>
              <a:rPr lang="en-US" sz="1200" dirty="0" err="1">
                <a:cs typeface="Times New Roman" panose="02020603050405020304" pitchFamily="18" charset="0"/>
              </a:rPr>
              <a:t>qRT</a:t>
            </a:r>
            <a:r>
              <a:rPr lang="en-US" sz="1200" dirty="0">
                <a:cs typeface="Times New Roman" panose="02020603050405020304" pitchFamily="18" charset="0"/>
              </a:rPr>
              <a:t>-PCR. </a:t>
            </a:r>
            <a:r>
              <a:rPr lang="en-US" sz="1200" dirty="0" smtClean="0">
                <a:cs typeface="Times New Roman" panose="02020603050405020304" pitchFamily="18" charset="0"/>
              </a:rPr>
              <a:t>Light grey bars represent RNA-</a:t>
            </a:r>
            <a:r>
              <a:rPr lang="en-US" sz="1200" dirty="0" err="1" smtClean="0">
                <a:cs typeface="Times New Roman" panose="02020603050405020304" pitchFamily="18" charset="0"/>
              </a:rPr>
              <a:t>seq</a:t>
            </a:r>
            <a:r>
              <a:rPr lang="en-US" sz="1200" dirty="0" smtClean="0">
                <a:cs typeface="Times New Roman" panose="02020603050405020304" pitchFamily="18" charset="0"/>
              </a:rPr>
              <a:t> data, dark grey bars represent </a:t>
            </a:r>
            <a:r>
              <a:rPr lang="en-US" sz="1200" dirty="0" err="1" smtClean="0">
                <a:cs typeface="Times New Roman" panose="02020603050405020304" pitchFamily="18" charset="0"/>
              </a:rPr>
              <a:t>qRT</a:t>
            </a:r>
            <a:r>
              <a:rPr lang="en-US" sz="1200" dirty="0" smtClean="0">
                <a:cs typeface="Times New Roman" panose="02020603050405020304" pitchFamily="18" charset="0"/>
              </a:rPr>
              <a:t>-PCR data (N=3, means± SD). Data represent fold-changes relative to the value analyzed at day 0 for both genotypes. </a:t>
            </a:r>
            <a:r>
              <a:rPr lang="en-US" sz="1200" dirty="0" smtClean="0">
                <a:cs typeface="Times New Roman" panose="02020603050405020304" pitchFamily="18" charset="0"/>
              </a:rPr>
              <a:t> The </a:t>
            </a:r>
            <a:r>
              <a:rPr lang="en-US" sz="1200" dirty="0">
                <a:cs typeface="Times New Roman" panose="02020603050405020304" pitchFamily="18" charset="0"/>
              </a:rPr>
              <a:t>cucumber Actin gene </a:t>
            </a:r>
            <a:r>
              <a:rPr lang="en-GB" sz="1200" dirty="0" smtClean="0">
                <a:cs typeface="Times New Roman" panose="02020603050405020304" pitchFamily="18" charset="0"/>
              </a:rPr>
              <a:t>(</a:t>
            </a:r>
            <a:r>
              <a:rPr lang="en-GB" sz="1200" dirty="0">
                <a:cs typeface="Times New Roman" panose="02020603050405020304" pitchFamily="18" charset="0"/>
              </a:rPr>
              <a:t>forward:5′-TGGACTCTGGTGATGGTGTTA-3′, and reverse:5′-CAATGAGGGATGGTGGAAAA-3′) was used as a normalizer, and the relative expression levels of genes </a:t>
            </a:r>
            <a:r>
              <a:rPr lang="en-GB" sz="1200" dirty="0" smtClean="0">
                <a:cs typeface="Times New Roman" panose="02020603050405020304" pitchFamily="18" charset="0"/>
              </a:rPr>
              <a:t>are presented </a:t>
            </a:r>
            <a:r>
              <a:rPr lang="en-GB" sz="1200" dirty="0">
                <a:cs typeface="Times New Roman" panose="02020603050405020304" pitchFamily="18" charset="0"/>
              </a:rPr>
              <a:t>by 2-ΔΔCT</a:t>
            </a:r>
            <a:r>
              <a:rPr lang="en-GB" sz="1200" dirty="0" smtClean="0">
                <a:cs typeface="Times New Roman" panose="02020603050405020304" pitchFamily="18" charset="0"/>
              </a:rPr>
              <a:t>. 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47647" y="2803850"/>
            <a:ext cx="2857891" cy="1300214"/>
            <a:chOff x="420688" y="644525"/>
            <a:chExt cx="3248026" cy="1736725"/>
          </a:xfrm>
        </p:grpSpPr>
        <p:sp>
          <p:nvSpPr>
            <p:cNvPr id="8" name="Freeform 13"/>
            <p:cNvSpPr>
              <a:spLocks noEditPoints="1"/>
            </p:cNvSpPr>
            <p:nvPr/>
          </p:nvSpPr>
          <p:spPr bwMode="auto">
            <a:xfrm>
              <a:off x="654051" y="1466850"/>
              <a:ext cx="2782888" cy="727075"/>
            </a:xfrm>
            <a:custGeom>
              <a:avLst/>
              <a:gdLst>
                <a:gd name="T0" fmla="*/ 0 w 1753"/>
                <a:gd name="T1" fmla="*/ 230 h 458"/>
                <a:gd name="T2" fmla="*/ 65 w 1753"/>
                <a:gd name="T3" fmla="*/ 230 h 458"/>
                <a:gd name="T4" fmla="*/ 65 w 1753"/>
                <a:gd name="T5" fmla="*/ 458 h 458"/>
                <a:gd name="T6" fmla="*/ 0 w 1753"/>
                <a:gd name="T7" fmla="*/ 458 h 458"/>
                <a:gd name="T8" fmla="*/ 0 w 1753"/>
                <a:gd name="T9" fmla="*/ 230 h 458"/>
                <a:gd name="T10" fmla="*/ 281 w 1753"/>
                <a:gd name="T11" fmla="*/ 263 h 458"/>
                <a:gd name="T12" fmla="*/ 344 w 1753"/>
                <a:gd name="T13" fmla="*/ 263 h 458"/>
                <a:gd name="T14" fmla="*/ 344 w 1753"/>
                <a:gd name="T15" fmla="*/ 458 h 458"/>
                <a:gd name="T16" fmla="*/ 281 w 1753"/>
                <a:gd name="T17" fmla="*/ 458 h 458"/>
                <a:gd name="T18" fmla="*/ 281 w 1753"/>
                <a:gd name="T19" fmla="*/ 263 h 458"/>
                <a:gd name="T20" fmla="*/ 563 w 1753"/>
                <a:gd name="T21" fmla="*/ 344 h 458"/>
                <a:gd name="T22" fmla="*/ 625 w 1753"/>
                <a:gd name="T23" fmla="*/ 344 h 458"/>
                <a:gd name="T24" fmla="*/ 625 w 1753"/>
                <a:gd name="T25" fmla="*/ 458 h 458"/>
                <a:gd name="T26" fmla="*/ 563 w 1753"/>
                <a:gd name="T27" fmla="*/ 458 h 458"/>
                <a:gd name="T28" fmla="*/ 563 w 1753"/>
                <a:gd name="T29" fmla="*/ 344 h 458"/>
                <a:gd name="T30" fmla="*/ 1127 w 1753"/>
                <a:gd name="T31" fmla="*/ 230 h 458"/>
                <a:gd name="T32" fmla="*/ 1189 w 1753"/>
                <a:gd name="T33" fmla="*/ 230 h 458"/>
                <a:gd name="T34" fmla="*/ 1189 w 1753"/>
                <a:gd name="T35" fmla="*/ 458 h 458"/>
                <a:gd name="T36" fmla="*/ 1127 w 1753"/>
                <a:gd name="T37" fmla="*/ 458 h 458"/>
                <a:gd name="T38" fmla="*/ 1127 w 1753"/>
                <a:gd name="T39" fmla="*/ 230 h 458"/>
                <a:gd name="T40" fmla="*/ 1409 w 1753"/>
                <a:gd name="T41" fmla="*/ 0 h 458"/>
                <a:gd name="T42" fmla="*/ 1471 w 1753"/>
                <a:gd name="T43" fmla="*/ 0 h 458"/>
                <a:gd name="T44" fmla="*/ 1471 w 1753"/>
                <a:gd name="T45" fmla="*/ 458 h 458"/>
                <a:gd name="T46" fmla="*/ 1409 w 1753"/>
                <a:gd name="T47" fmla="*/ 458 h 458"/>
                <a:gd name="T48" fmla="*/ 1409 w 1753"/>
                <a:gd name="T49" fmla="*/ 0 h 458"/>
                <a:gd name="T50" fmla="*/ 1687 w 1753"/>
                <a:gd name="T51" fmla="*/ 128 h 458"/>
                <a:gd name="T52" fmla="*/ 1753 w 1753"/>
                <a:gd name="T53" fmla="*/ 128 h 458"/>
                <a:gd name="T54" fmla="*/ 1753 w 1753"/>
                <a:gd name="T55" fmla="*/ 458 h 458"/>
                <a:gd name="T56" fmla="*/ 1687 w 1753"/>
                <a:gd name="T57" fmla="*/ 458 h 458"/>
                <a:gd name="T58" fmla="*/ 1687 w 1753"/>
                <a:gd name="T59" fmla="*/ 12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458">
                  <a:moveTo>
                    <a:pt x="0" y="230"/>
                  </a:moveTo>
                  <a:lnTo>
                    <a:pt x="65" y="230"/>
                  </a:lnTo>
                  <a:lnTo>
                    <a:pt x="65" y="458"/>
                  </a:lnTo>
                  <a:lnTo>
                    <a:pt x="0" y="458"/>
                  </a:lnTo>
                  <a:lnTo>
                    <a:pt x="0" y="230"/>
                  </a:lnTo>
                  <a:close/>
                  <a:moveTo>
                    <a:pt x="281" y="263"/>
                  </a:moveTo>
                  <a:lnTo>
                    <a:pt x="344" y="263"/>
                  </a:lnTo>
                  <a:lnTo>
                    <a:pt x="344" y="458"/>
                  </a:lnTo>
                  <a:lnTo>
                    <a:pt x="281" y="458"/>
                  </a:lnTo>
                  <a:lnTo>
                    <a:pt x="281" y="263"/>
                  </a:lnTo>
                  <a:close/>
                  <a:moveTo>
                    <a:pt x="563" y="344"/>
                  </a:moveTo>
                  <a:lnTo>
                    <a:pt x="625" y="344"/>
                  </a:lnTo>
                  <a:lnTo>
                    <a:pt x="625" y="458"/>
                  </a:lnTo>
                  <a:lnTo>
                    <a:pt x="563" y="458"/>
                  </a:lnTo>
                  <a:lnTo>
                    <a:pt x="563" y="344"/>
                  </a:lnTo>
                  <a:close/>
                  <a:moveTo>
                    <a:pt x="1127" y="230"/>
                  </a:moveTo>
                  <a:lnTo>
                    <a:pt x="1189" y="230"/>
                  </a:lnTo>
                  <a:lnTo>
                    <a:pt x="1189" y="458"/>
                  </a:lnTo>
                  <a:lnTo>
                    <a:pt x="1127" y="458"/>
                  </a:lnTo>
                  <a:lnTo>
                    <a:pt x="1127" y="230"/>
                  </a:lnTo>
                  <a:close/>
                  <a:moveTo>
                    <a:pt x="1409" y="0"/>
                  </a:moveTo>
                  <a:lnTo>
                    <a:pt x="1471" y="0"/>
                  </a:lnTo>
                  <a:lnTo>
                    <a:pt x="1471" y="458"/>
                  </a:lnTo>
                  <a:lnTo>
                    <a:pt x="1409" y="458"/>
                  </a:lnTo>
                  <a:lnTo>
                    <a:pt x="1409" y="0"/>
                  </a:lnTo>
                  <a:close/>
                  <a:moveTo>
                    <a:pt x="1687" y="128"/>
                  </a:moveTo>
                  <a:lnTo>
                    <a:pt x="1753" y="128"/>
                  </a:lnTo>
                  <a:lnTo>
                    <a:pt x="1753" y="458"/>
                  </a:lnTo>
                  <a:lnTo>
                    <a:pt x="1687" y="458"/>
                  </a:lnTo>
                  <a:lnTo>
                    <a:pt x="1687" y="128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Freeform 14"/>
            <p:cNvSpPr>
              <a:spLocks noEditPoints="1"/>
            </p:cNvSpPr>
            <p:nvPr/>
          </p:nvSpPr>
          <p:spPr bwMode="auto">
            <a:xfrm>
              <a:off x="781051" y="1111250"/>
              <a:ext cx="2782888" cy="1082675"/>
            </a:xfrm>
            <a:custGeom>
              <a:avLst/>
              <a:gdLst>
                <a:gd name="T0" fmla="*/ 0 w 1753"/>
                <a:gd name="T1" fmla="*/ 454 h 682"/>
                <a:gd name="T2" fmla="*/ 62 w 1753"/>
                <a:gd name="T3" fmla="*/ 454 h 682"/>
                <a:gd name="T4" fmla="*/ 62 w 1753"/>
                <a:gd name="T5" fmla="*/ 682 h 682"/>
                <a:gd name="T6" fmla="*/ 0 w 1753"/>
                <a:gd name="T7" fmla="*/ 682 h 682"/>
                <a:gd name="T8" fmla="*/ 0 w 1753"/>
                <a:gd name="T9" fmla="*/ 454 h 682"/>
                <a:gd name="T10" fmla="*/ 282 w 1753"/>
                <a:gd name="T11" fmla="*/ 502 h 682"/>
                <a:gd name="T12" fmla="*/ 344 w 1753"/>
                <a:gd name="T13" fmla="*/ 502 h 682"/>
                <a:gd name="T14" fmla="*/ 344 w 1753"/>
                <a:gd name="T15" fmla="*/ 682 h 682"/>
                <a:gd name="T16" fmla="*/ 282 w 1753"/>
                <a:gd name="T17" fmla="*/ 682 h 682"/>
                <a:gd name="T18" fmla="*/ 282 w 1753"/>
                <a:gd name="T19" fmla="*/ 502 h 682"/>
                <a:gd name="T20" fmla="*/ 564 w 1753"/>
                <a:gd name="T21" fmla="*/ 638 h 682"/>
                <a:gd name="T22" fmla="*/ 626 w 1753"/>
                <a:gd name="T23" fmla="*/ 638 h 682"/>
                <a:gd name="T24" fmla="*/ 626 w 1753"/>
                <a:gd name="T25" fmla="*/ 682 h 682"/>
                <a:gd name="T26" fmla="*/ 564 w 1753"/>
                <a:gd name="T27" fmla="*/ 682 h 682"/>
                <a:gd name="T28" fmla="*/ 564 w 1753"/>
                <a:gd name="T29" fmla="*/ 638 h 682"/>
                <a:gd name="T30" fmla="*/ 1127 w 1753"/>
                <a:gd name="T31" fmla="*/ 454 h 682"/>
                <a:gd name="T32" fmla="*/ 1190 w 1753"/>
                <a:gd name="T33" fmla="*/ 454 h 682"/>
                <a:gd name="T34" fmla="*/ 1190 w 1753"/>
                <a:gd name="T35" fmla="*/ 682 h 682"/>
                <a:gd name="T36" fmla="*/ 1127 w 1753"/>
                <a:gd name="T37" fmla="*/ 682 h 682"/>
                <a:gd name="T38" fmla="*/ 1127 w 1753"/>
                <a:gd name="T39" fmla="*/ 454 h 682"/>
                <a:gd name="T40" fmla="*/ 1406 w 1753"/>
                <a:gd name="T41" fmla="*/ 0 h 682"/>
                <a:gd name="T42" fmla="*/ 1471 w 1753"/>
                <a:gd name="T43" fmla="*/ 0 h 682"/>
                <a:gd name="T44" fmla="*/ 1471 w 1753"/>
                <a:gd name="T45" fmla="*/ 682 h 682"/>
                <a:gd name="T46" fmla="*/ 1406 w 1753"/>
                <a:gd name="T47" fmla="*/ 682 h 682"/>
                <a:gd name="T48" fmla="*/ 1406 w 1753"/>
                <a:gd name="T49" fmla="*/ 0 h 682"/>
                <a:gd name="T50" fmla="*/ 1687 w 1753"/>
                <a:gd name="T51" fmla="*/ 227 h 682"/>
                <a:gd name="T52" fmla="*/ 1753 w 1753"/>
                <a:gd name="T53" fmla="*/ 227 h 682"/>
                <a:gd name="T54" fmla="*/ 1753 w 1753"/>
                <a:gd name="T55" fmla="*/ 682 h 682"/>
                <a:gd name="T56" fmla="*/ 1687 w 1753"/>
                <a:gd name="T57" fmla="*/ 682 h 682"/>
                <a:gd name="T58" fmla="*/ 1687 w 1753"/>
                <a:gd name="T59" fmla="*/ 227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682">
                  <a:moveTo>
                    <a:pt x="0" y="454"/>
                  </a:moveTo>
                  <a:lnTo>
                    <a:pt x="62" y="454"/>
                  </a:lnTo>
                  <a:lnTo>
                    <a:pt x="62" y="682"/>
                  </a:lnTo>
                  <a:lnTo>
                    <a:pt x="0" y="682"/>
                  </a:lnTo>
                  <a:lnTo>
                    <a:pt x="0" y="454"/>
                  </a:lnTo>
                  <a:close/>
                  <a:moveTo>
                    <a:pt x="282" y="502"/>
                  </a:moveTo>
                  <a:lnTo>
                    <a:pt x="344" y="502"/>
                  </a:lnTo>
                  <a:lnTo>
                    <a:pt x="344" y="682"/>
                  </a:lnTo>
                  <a:lnTo>
                    <a:pt x="282" y="682"/>
                  </a:lnTo>
                  <a:lnTo>
                    <a:pt x="282" y="502"/>
                  </a:lnTo>
                  <a:close/>
                  <a:moveTo>
                    <a:pt x="564" y="638"/>
                  </a:moveTo>
                  <a:lnTo>
                    <a:pt x="626" y="638"/>
                  </a:lnTo>
                  <a:lnTo>
                    <a:pt x="626" y="682"/>
                  </a:lnTo>
                  <a:lnTo>
                    <a:pt x="564" y="682"/>
                  </a:lnTo>
                  <a:lnTo>
                    <a:pt x="564" y="638"/>
                  </a:lnTo>
                  <a:close/>
                  <a:moveTo>
                    <a:pt x="1127" y="454"/>
                  </a:moveTo>
                  <a:lnTo>
                    <a:pt x="1190" y="454"/>
                  </a:lnTo>
                  <a:lnTo>
                    <a:pt x="1190" y="682"/>
                  </a:lnTo>
                  <a:lnTo>
                    <a:pt x="1127" y="682"/>
                  </a:lnTo>
                  <a:lnTo>
                    <a:pt x="1127" y="454"/>
                  </a:lnTo>
                  <a:close/>
                  <a:moveTo>
                    <a:pt x="1406" y="0"/>
                  </a:moveTo>
                  <a:lnTo>
                    <a:pt x="1471" y="0"/>
                  </a:lnTo>
                  <a:lnTo>
                    <a:pt x="1471" y="682"/>
                  </a:lnTo>
                  <a:lnTo>
                    <a:pt x="1406" y="682"/>
                  </a:lnTo>
                  <a:lnTo>
                    <a:pt x="1406" y="0"/>
                  </a:lnTo>
                  <a:close/>
                  <a:moveTo>
                    <a:pt x="1687" y="227"/>
                  </a:moveTo>
                  <a:lnTo>
                    <a:pt x="1753" y="227"/>
                  </a:lnTo>
                  <a:lnTo>
                    <a:pt x="1753" y="682"/>
                  </a:lnTo>
                  <a:lnTo>
                    <a:pt x="1687" y="682"/>
                  </a:lnTo>
                  <a:lnTo>
                    <a:pt x="1687" y="227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Line 15"/>
            <p:cNvSpPr>
              <a:spLocks noChangeShapeType="1"/>
            </p:cNvSpPr>
            <p:nvPr/>
          </p:nvSpPr>
          <p:spPr bwMode="auto">
            <a:xfrm>
              <a:off x="1274763" y="1901825"/>
              <a:ext cx="0" cy="1746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Line 16"/>
            <p:cNvSpPr>
              <a:spLocks noChangeShapeType="1"/>
            </p:cNvSpPr>
            <p:nvPr/>
          </p:nvSpPr>
          <p:spPr bwMode="auto">
            <a:xfrm flipV="1">
              <a:off x="1274763" y="1890713"/>
              <a:ext cx="0" cy="1111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Line 17"/>
            <p:cNvSpPr>
              <a:spLocks noChangeShapeType="1"/>
            </p:cNvSpPr>
            <p:nvPr/>
          </p:nvSpPr>
          <p:spPr bwMode="auto">
            <a:xfrm>
              <a:off x="1252538" y="1919288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Line 18"/>
            <p:cNvSpPr>
              <a:spLocks noChangeShapeType="1"/>
            </p:cNvSpPr>
            <p:nvPr/>
          </p:nvSpPr>
          <p:spPr bwMode="auto">
            <a:xfrm>
              <a:off x="1252538" y="189071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Line 19"/>
            <p:cNvSpPr>
              <a:spLocks noChangeShapeType="1"/>
            </p:cNvSpPr>
            <p:nvPr/>
          </p:nvSpPr>
          <p:spPr bwMode="auto">
            <a:xfrm>
              <a:off x="1722438" y="2124075"/>
              <a:ext cx="0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Line 20"/>
            <p:cNvSpPr>
              <a:spLocks noChangeShapeType="1"/>
            </p:cNvSpPr>
            <p:nvPr/>
          </p:nvSpPr>
          <p:spPr bwMode="auto">
            <a:xfrm flipV="1">
              <a:off x="1722438" y="2117725"/>
              <a:ext cx="0" cy="635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Line 21"/>
            <p:cNvSpPr>
              <a:spLocks noChangeShapeType="1"/>
            </p:cNvSpPr>
            <p:nvPr/>
          </p:nvSpPr>
          <p:spPr bwMode="auto">
            <a:xfrm>
              <a:off x="1698626" y="212407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Line 22"/>
            <p:cNvSpPr>
              <a:spLocks noChangeShapeType="1"/>
            </p:cNvSpPr>
            <p:nvPr/>
          </p:nvSpPr>
          <p:spPr bwMode="auto">
            <a:xfrm>
              <a:off x="1698626" y="211772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Line 23"/>
            <p:cNvSpPr>
              <a:spLocks noChangeShapeType="1"/>
            </p:cNvSpPr>
            <p:nvPr/>
          </p:nvSpPr>
          <p:spPr bwMode="auto">
            <a:xfrm>
              <a:off x="2617788" y="1831975"/>
              <a:ext cx="0" cy="1746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Line 24"/>
            <p:cNvSpPr>
              <a:spLocks noChangeShapeType="1"/>
            </p:cNvSpPr>
            <p:nvPr/>
          </p:nvSpPr>
          <p:spPr bwMode="auto">
            <a:xfrm flipV="1">
              <a:off x="2617788" y="1814513"/>
              <a:ext cx="0" cy="1746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Line 25"/>
            <p:cNvSpPr>
              <a:spLocks noChangeShapeType="1"/>
            </p:cNvSpPr>
            <p:nvPr/>
          </p:nvSpPr>
          <p:spPr bwMode="auto">
            <a:xfrm>
              <a:off x="2593976" y="1849438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Line 26"/>
            <p:cNvSpPr>
              <a:spLocks noChangeShapeType="1"/>
            </p:cNvSpPr>
            <p:nvPr/>
          </p:nvSpPr>
          <p:spPr bwMode="auto">
            <a:xfrm>
              <a:off x="2593976" y="181451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Line 27"/>
            <p:cNvSpPr>
              <a:spLocks noChangeShapeType="1"/>
            </p:cNvSpPr>
            <p:nvPr/>
          </p:nvSpPr>
          <p:spPr bwMode="auto">
            <a:xfrm>
              <a:off x="3063876" y="1104900"/>
              <a:ext cx="0" cy="5873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Line 28"/>
            <p:cNvSpPr>
              <a:spLocks noChangeShapeType="1"/>
            </p:cNvSpPr>
            <p:nvPr/>
          </p:nvSpPr>
          <p:spPr bwMode="auto">
            <a:xfrm flipV="1">
              <a:off x="3063876" y="1052513"/>
              <a:ext cx="0" cy="5238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Line 29"/>
            <p:cNvSpPr>
              <a:spLocks noChangeShapeType="1"/>
            </p:cNvSpPr>
            <p:nvPr/>
          </p:nvSpPr>
          <p:spPr bwMode="auto">
            <a:xfrm>
              <a:off x="3041651" y="116363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Line 30"/>
            <p:cNvSpPr>
              <a:spLocks noChangeShapeType="1"/>
            </p:cNvSpPr>
            <p:nvPr/>
          </p:nvSpPr>
          <p:spPr bwMode="auto">
            <a:xfrm>
              <a:off x="3041651" y="1052513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Line 31"/>
            <p:cNvSpPr>
              <a:spLocks noChangeShapeType="1"/>
            </p:cNvSpPr>
            <p:nvPr/>
          </p:nvSpPr>
          <p:spPr bwMode="auto">
            <a:xfrm>
              <a:off x="3506788" y="1471613"/>
              <a:ext cx="0" cy="349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Line 32"/>
            <p:cNvSpPr>
              <a:spLocks noChangeShapeType="1"/>
            </p:cNvSpPr>
            <p:nvPr/>
          </p:nvSpPr>
          <p:spPr bwMode="auto">
            <a:xfrm flipV="1">
              <a:off x="3506788" y="1431925"/>
              <a:ext cx="0" cy="3968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Line 33"/>
            <p:cNvSpPr>
              <a:spLocks noChangeShapeType="1"/>
            </p:cNvSpPr>
            <p:nvPr/>
          </p:nvSpPr>
          <p:spPr bwMode="auto">
            <a:xfrm>
              <a:off x="3489326" y="150653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" name="Line 34"/>
            <p:cNvSpPr>
              <a:spLocks noChangeShapeType="1"/>
            </p:cNvSpPr>
            <p:nvPr/>
          </p:nvSpPr>
          <p:spPr bwMode="auto">
            <a:xfrm>
              <a:off x="3489326" y="14319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Line 35"/>
            <p:cNvSpPr>
              <a:spLocks noChangeShapeType="1"/>
            </p:cNvSpPr>
            <p:nvPr/>
          </p:nvSpPr>
          <p:spPr bwMode="auto">
            <a:xfrm>
              <a:off x="542926" y="2193925"/>
              <a:ext cx="3125788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" name="Rectangle 36"/>
            <p:cNvSpPr>
              <a:spLocks noChangeArrowheads="1"/>
            </p:cNvSpPr>
            <p:nvPr/>
          </p:nvSpPr>
          <p:spPr bwMode="auto">
            <a:xfrm>
              <a:off x="420688" y="2135188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38"/>
            <p:cNvSpPr>
              <a:spLocks noChangeArrowheads="1"/>
            </p:cNvSpPr>
            <p:nvPr/>
          </p:nvSpPr>
          <p:spPr bwMode="auto">
            <a:xfrm>
              <a:off x="420688" y="1774825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40"/>
            <p:cNvSpPr>
              <a:spLocks noChangeArrowheads="1"/>
            </p:cNvSpPr>
            <p:nvPr/>
          </p:nvSpPr>
          <p:spPr bwMode="auto">
            <a:xfrm>
              <a:off x="420688" y="1414463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42"/>
            <p:cNvSpPr>
              <a:spLocks noChangeArrowheads="1"/>
            </p:cNvSpPr>
            <p:nvPr/>
          </p:nvSpPr>
          <p:spPr bwMode="auto">
            <a:xfrm>
              <a:off x="420688" y="1054100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44"/>
            <p:cNvSpPr>
              <a:spLocks noChangeArrowheads="1"/>
            </p:cNvSpPr>
            <p:nvPr/>
          </p:nvSpPr>
          <p:spPr bwMode="auto">
            <a:xfrm>
              <a:off x="671513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45"/>
            <p:cNvSpPr>
              <a:spLocks noChangeArrowheads="1"/>
            </p:cNvSpPr>
            <p:nvPr/>
          </p:nvSpPr>
          <p:spPr bwMode="auto">
            <a:xfrm>
              <a:off x="1117601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46"/>
            <p:cNvSpPr>
              <a:spLocks noChangeArrowheads="1"/>
            </p:cNvSpPr>
            <p:nvPr/>
          </p:nvSpPr>
          <p:spPr bwMode="auto">
            <a:xfrm>
              <a:off x="1565276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47"/>
            <p:cNvSpPr>
              <a:spLocks noChangeArrowheads="1"/>
            </p:cNvSpPr>
            <p:nvPr/>
          </p:nvSpPr>
          <p:spPr bwMode="auto">
            <a:xfrm>
              <a:off x="2454276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48"/>
            <p:cNvSpPr>
              <a:spLocks noChangeArrowheads="1"/>
            </p:cNvSpPr>
            <p:nvPr/>
          </p:nvSpPr>
          <p:spPr bwMode="auto">
            <a:xfrm>
              <a:off x="2901951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49"/>
            <p:cNvSpPr>
              <a:spLocks noChangeArrowheads="1"/>
            </p:cNvSpPr>
            <p:nvPr/>
          </p:nvSpPr>
          <p:spPr bwMode="auto">
            <a:xfrm>
              <a:off x="3349626" y="225266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50"/>
            <p:cNvSpPr>
              <a:spLocks noChangeArrowheads="1"/>
            </p:cNvSpPr>
            <p:nvPr/>
          </p:nvSpPr>
          <p:spPr bwMode="auto">
            <a:xfrm>
              <a:off x="1751013" y="644525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 smtClean="0">
                  <a:solidFill>
                    <a:srgbClr val="595959"/>
                  </a:solidFill>
                  <a:latin typeface="Calibri" panose="020F0502020204030204" pitchFamily="34" charset="0"/>
                </a:rPr>
                <a:t>Csa</a:t>
              </a: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M05174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547647" y="4445259"/>
            <a:ext cx="2913763" cy="1300214"/>
            <a:chOff x="-317500" y="2894013"/>
            <a:chExt cx="3311525" cy="1736725"/>
          </a:xfrm>
        </p:grpSpPr>
        <p:sp>
          <p:nvSpPr>
            <p:cNvPr id="45" name="Freeform 122"/>
            <p:cNvSpPr>
              <a:spLocks noEditPoints="1"/>
            </p:cNvSpPr>
            <p:nvPr/>
          </p:nvSpPr>
          <p:spPr bwMode="auto">
            <a:xfrm>
              <a:off x="-38100" y="3343275"/>
              <a:ext cx="2794000" cy="1100138"/>
            </a:xfrm>
            <a:custGeom>
              <a:avLst/>
              <a:gdLst>
                <a:gd name="T0" fmla="*/ 0 w 1760"/>
                <a:gd name="T1" fmla="*/ 685 h 693"/>
                <a:gd name="T2" fmla="*/ 62 w 1760"/>
                <a:gd name="T3" fmla="*/ 685 h 693"/>
                <a:gd name="T4" fmla="*/ 62 w 1760"/>
                <a:gd name="T5" fmla="*/ 693 h 693"/>
                <a:gd name="T6" fmla="*/ 0 w 1760"/>
                <a:gd name="T7" fmla="*/ 693 h 693"/>
                <a:gd name="T8" fmla="*/ 0 w 1760"/>
                <a:gd name="T9" fmla="*/ 685 h 693"/>
                <a:gd name="T10" fmla="*/ 281 w 1760"/>
                <a:gd name="T11" fmla="*/ 0 h 693"/>
                <a:gd name="T12" fmla="*/ 344 w 1760"/>
                <a:gd name="T13" fmla="*/ 0 h 693"/>
                <a:gd name="T14" fmla="*/ 344 w 1760"/>
                <a:gd name="T15" fmla="*/ 693 h 693"/>
                <a:gd name="T16" fmla="*/ 281 w 1760"/>
                <a:gd name="T17" fmla="*/ 693 h 693"/>
                <a:gd name="T18" fmla="*/ 281 w 1760"/>
                <a:gd name="T19" fmla="*/ 0 h 693"/>
                <a:gd name="T20" fmla="*/ 563 w 1760"/>
                <a:gd name="T21" fmla="*/ 403 h 693"/>
                <a:gd name="T22" fmla="*/ 629 w 1760"/>
                <a:gd name="T23" fmla="*/ 403 h 693"/>
                <a:gd name="T24" fmla="*/ 629 w 1760"/>
                <a:gd name="T25" fmla="*/ 693 h 693"/>
                <a:gd name="T26" fmla="*/ 563 w 1760"/>
                <a:gd name="T27" fmla="*/ 693 h 693"/>
                <a:gd name="T28" fmla="*/ 563 w 1760"/>
                <a:gd name="T29" fmla="*/ 403 h 693"/>
                <a:gd name="T30" fmla="*/ 1131 w 1760"/>
                <a:gd name="T31" fmla="*/ 685 h 693"/>
                <a:gd name="T32" fmla="*/ 1196 w 1760"/>
                <a:gd name="T33" fmla="*/ 685 h 693"/>
                <a:gd name="T34" fmla="*/ 1196 w 1760"/>
                <a:gd name="T35" fmla="*/ 693 h 693"/>
                <a:gd name="T36" fmla="*/ 1131 w 1760"/>
                <a:gd name="T37" fmla="*/ 693 h 693"/>
                <a:gd name="T38" fmla="*/ 1131 w 1760"/>
                <a:gd name="T39" fmla="*/ 685 h 693"/>
                <a:gd name="T40" fmla="*/ 1416 w 1760"/>
                <a:gd name="T41" fmla="*/ 630 h 693"/>
                <a:gd name="T42" fmla="*/ 1478 w 1760"/>
                <a:gd name="T43" fmla="*/ 630 h 693"/>
                <a:gd name="T44" fmla="*/ 1478 w 1760"/>
                <a:gd name="T45" fmla="*/ 693 h 693"/>
                <a:gd name="T46" fmla="*/ 1416 w 1760"/>
                <a:gd name="T47" fmla="*/ 693 h 693"/>
                <a:gd name="T48" fmla="*/ 1416 w 1760"/>
                <a:gd name="T49" fmla="*/ 630 h 693"/>
                <a:gd name="T50" fmla="*/ 1698 w 1760"/>
                <a:gd name="T51" fmla="*/ 663 h 693"/>
                <a:gd name="T52" fmla="*/ 1760 w 1760"/>
                <a:gd name="T53" fmla="*/ 663 h 693"/>
                <a:gd name="T54" fmla="*/ 1760 w 1760"/>
                <a:gd name="T55" fmla="*/ 693 h 693"/>
                <a:gd name="T56" fmla="*/ 1698 w 1760"/>
                <a:gd name="T57" fmla="*/ 693 h 693"/>
                <a:gd name="T58" fmla="*/ 1698 w 1760"/>
                <a:gd name="T59" fmla="*/ 663 h 6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60" h="693">
                  <a:moveTo>
                    <a:pt x="0" y="685"/>
                  </a:moveTo>
                  <a:lnTo>
                    <a:pt x="62" y="685"/>
                  </a:lnTo>
                  <a:lnTo>
                    <a:pt x="62" y="693"/>
                  </a:lnTo>
                  <a:lnTo>
                    <a:pt x="0" y="693"/>
                  </a:lnTo>
                  <a:lnTo>
                    <a:pt x="0" y="685"/>
                  </a:lnTo>
                  <a:close/>
                  <a:moveTo>
                    <a:pt x="281" y="0"/>
                  </a:moveTo>
                  <a:lnTo>
                    <a:pt x="344" y="0"/>
                  </a:lnTo>
                  <a:lnTo>
                    <a:pt x="344" y="693"/>
                  </a:lnTo>
                  <a:lnTo>
                    <a:pt x="281" y="693"/>
                  </a:lnTo>
                  <a:lnTo>
                    <a:pt x="281" y="0"/>
                  </a:lnTo>
                  <a:close/>
                  <a:moveTo>
                    <a:pt x="563" y="403"/>
                  </a:moveTo>
                  <a:lnTo>
                    <a:pt x="629" y="403"/>
                  </a:lnTo>
                  <a:lnTo>
                    <a:pt x="629" y="693"/>
                  </a:lnTo>
                  <a:lnTo>
                    <a:pt x="563" y="693"/>
                  </a:lnTo>
                  <a:lnTo>
                    <a:pt x="563" y="403"/>
                  </a:lnTo>
                  <a:close/>
                  <a:moveTo>
                    <a:pt x="1131" y="685"/>
                  </a:moveTo>
                  <a:lnTo>
                    <a:pt x="1196" y="685"/>
                  </a:lnTo>
                  <a:lnTo>
                    <a:pt x="1196" y="693"/>
                  </a:lnTo>
                  <a:lnTo>
                    <a:pt x="1131" y="693"/>
                  </a:lnTo>
                  <a:lnTo>
                    <a:pt x="1131" y="685"/>
                  </a:lnTo>
                  <a:close/>
                  <a:moveTo>
                    <a:pt x="1416" y="630"/>
                  </a:moveTo>
                  <a:lnTo>
                    <a:pt x="1478" y="630"/>
                  </a:lnTo>
                  <a:lnTo>
                    <a:pt x="1478" y="693"/>
                  </a:lnTo>
                  <a:lnTo>
                    <a:pt x="1416" y="693"/>
                  </a:lnTo>
                  <a:lnTo>
                    <a:pt x="1416" y="630"/>
                  </a:lnTo>
                  <a:close/>
                  <a:moveTo>
                    <a:pt x="1698" y="663"/>
                  </a:moveTo>
                  <a:lnTo>
                    <a:pt x="1760" y="663"/>
                  </a:lnTo>
                  <a:lnTo>
                    <a:pt x="1760" y="693"/>
                  </a:lnTo>
                  <a:lnTo>
                    <a:pt x="1698" y="693"/>
                  </a:lnTo>
                  <a:lnTo>
                    <a:pt x="1698" y="663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Freeform 123"/>
            <p:cNvSpPr>
              <a:spLocks noEditPoints="1"/>
            </p:cNvSpPr>
            <p:nvPr/>
          </p:nvSpPr>
          <p:spPr bwMode="auto">
            <a:xfrm>
              <a:off x="88900" y="3640138"/>
              <a:ext cx="2795588" cy="803275"/>
            </a:xfrm>
            <a:custGeom>
              <a:avLst/>
              <a:gdLst>
                <a:gd name="T0" fmla="*/ 0 w 1761"/>
                <a:gd name="T1" fmla="*/ 498 h 506"/>
                <a:gd name="T2" fmla="*/ 62 w 1761"/>
                <a:gd name="T3" fmla="*/ 498 h 506"/>
                <a:gd name="T4" fmla="*/ 62 w 1761"/>
                <a:gd name="T5" fmla="*/ 506 h 506"/>
                <a:gd name="T6" fmla="*/ 0 w 1761"/>
                <a:gd name="T7" fmla="*/ 506 h 506"/>
                <a:gd name="T8" fmla="*/ 0 w 1761"/>
                <a:gd name="T9" fmla="*/ 498 h 506"/>
                <a:gd name="T10" fmla="*/ 282 w 1761"/>
                <a:gd name="T11" fmla="*/ 0 h 506"/>
                <a:gd name="T12" fmla="*/ 344 w 1761"/>
                <a:gd name="T13" fmla="*/ 0 h 506"/>
                <a:gd name="T14" fmla="*/ 344 w 1761"/>
                <a:gd name="T15" fmla="*/ 506 h 506"/>
                <a:gd name="T16" fmla="*/ 282 w 1761"/>
                <a:gd name="T17" fmla="*/ 506 h 506"/>
                <a:gd name="T18" fmla="*/ 282 w 1761"/>
                <a:gd name="T19" fmla="*/ 0 h 506"/>
                <a:gd name="T20" fmla="*/ 567 w 1761"/>
                <a:gd name="T21" fmla="*/ 326 h 506"/>
                <a:gd name="T22" fmla="*/ 630 w 1761"/>
                <a:gd name="T23" fmla="*/ 326 h 506"/>
                <a:gd name="T24" fmla="*/ 630 w 1761"/>
                <a:gd name="T25" fmla="*/ 506 h 506"/>
                <a:gd name="T26" fmla="*/ 567 w 1761"/>
                <a:gd name="T27" fmla="*/ 506 h 506"/>
                <a:gd name="T28" fmla="*/ 567 w 1761"/>
                <a:gd name="T29" fmla="*/ 326 h 506"/>
                <a:gd name="T30" fmla="*/ 1131 w 1761"/>
                <a:gd name="T31" fmla="*/ 498 h 506"/>
                <a:gd name="T32" fmla="*/ 1197 w 1761"/>
                <a:gd name="T33" fmla="*/ 498 h 506"/>
                <a:gd name="T34" fmla="*/ 1197 w 1761"/>
                <a:gd name="T35" fmla="*/ 506 h 506"/>
                <a:gd name="T36" fmla="*/ 1131 w 1761"/>
                <a:gd name="T37" fmla="*/ 506 h 506"/>
                <a:gd name="T38" fmla="*/ 1131 w 1761"/>
                <a:gd name="T39" fmla="*/ 498 h 506"/>
                <a:gd name="T40" fmla="*/ 1417 w 1761"/>
                <a:gd name="T41" fmla="*/ 436 h 506"/>
                <a:gd name="T42" fmla="*/ 1479 w 1761"/>
                <a:gd name="T43" fmla="*/ 436 h 506"/>
                <a:gd name="T44" fmla="*/ 1479 w 1761"/>
                <a:gd name="T45" fmla="*/ 506 h 506"/>
                <a:gd name="T46" fmla="*/ 1417 w 1761"/>
                <a:gd name="T47" fmla="*/ 506 h 506"/>
                <a:gd name="T48" fmla="*/ 1417 w 1761"/>
                <a:gd name="T49" fmla="*/ 436 h 506"/>
                <a:gd name="T50" fmla="*/ 1698 w 1761"/>
                <a:gd name="T51" fmla="*/ 476 h 506"/>
                <a:gd name="T52" fmla="*/ 1761 w 1761"/>
                <a:gd name="T53" fmla="*/ 476 h 506"/>
                <a:gd name="T54" fmla="*/ 1761 w 1761"/>
                <a:gd name="T55" fmla="*/ 506 h 506"/>
                <a:gd name="T56" fmla="*/ 1698 w 1761"/>
                <a:gd name="T57" fmla="*/ 506 h 506"/>
                <a:gd name="T58" fmla="*/ 1698 w 1761"/>
                <a:gd name="T59" fmla="*/ 476 h 5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61" h="506">
                  <a:moveTo>
                    <a:pt x="0" y="498"/>
                  </a:moveTo>
                  <a:lnTo>
                    <a:pt x="62" y="498"/>
                  </a:lnTo>
                  <a:lnTo>
                    <a:pt x="62" y="506"/>
                  </a:lnTo>
                  <a:lnTo>
                    <a:pt x="0" y="506"/>
                  </a:lnTo>
                  <a:lnTo>
                    <a:pt x="0" y="498"/>
                  </a:lnTo>
                  <a:close/>
                  <a:moveTo>
                    <a:pt x="282" y="0"/>
                  </a:moveTo>
                  <a:lnTo>
                    <a:pt x="344" y="0"/>
                  </a:lnTo>
                  <a:lnTo>
                    <a:pt x="344" y="506"/>
                  </a:lnTo>
                  <a:lnTo>
                    <a:pt x="282" y="506"/>
                  </a:lnTo>
                  <a:lnTo>
                    <a:pt x="282" y="0"/>
                  </a:lnTo>
                  <a:close/>
                  <a:moveTo>
                    <a:pt x="567" y="326"/>
                  </a:moveTo>
                  <a:lnTo>
                    <a:pt x="630" y="326"/>
                  </a:lnTo>
                  <a:lnTo>
                    <a:pt x="630" y="506"/>
                  </a:lnTo>
                  <a:lnTo>
                    <a:pt x="567" y="506"/>
                  </a:lnTo>
                  <a:lnTo>
                    <a:pt x="567" y="326"/>
                  </a:lnTo>
                  <a:close/>
                  <a:moveTo>
                    <a:pt x="1131" y="498"/>
                  </a:moveTo>
                  <a:lnTo>
                    <a:pt x="1197" y="498"/>
                  </a:lnTo>
                  <a:lnTo>
                    <a:pt x="1197" y="506"/>
                  </a:lnTo>
                  <a:lnTo>
                    <a:pt x="1131" y="506"/>
                  </a:lnTo>
                  <a:lnTo>
                    <a:pt x="1131" y="498"/>
                  </a:lnTo>
                  <a:close/>
                  <a:moveTo>
                    <a:pt x="1417" y="436"/>
                  </a:moveTo>
                  <a:lnTo>
                    <a:pt x="1479" y="436"/>
                  </a:lnTo>
                  <a:lnTo>
                    <a:pt x="1479" y="506"/>
                  </a:lnTo>
                  <a:lnTo>
                    <a:pt x="1417" y="506"/>
                  </a:lnTo>
                  <a:lnTo>
                    <a:pt x="1417" y="436"/>
                  </a:lnTo>
                  <a:close/>
                  <a:moveTo>
                    <a:pt x="1698" y="476"/>
                  </a:moveTo>
                  <a:lnTo>
                    <a:pt x="1761" y="476"/>
                  </a:lnTo>
                  <a:lnTo>
                    <a:pt x="1761" y="506"/>
                  </a:lnTo>
                  <a:lnTo>
                    <a:pt x="1698" y="506"/>
                  </a:lnTo>
                  <a:lnTo>
                    <a:pt x="1698" y="476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" name="Line 124"/>
            <p:cNvSpPr>
              <a:spLocks noChangeShapeType="1"/>
            </p:cNvSpPr>
            <p:nvPr/>
          </p:nvSpPr>
          <p:spPr bwMode="auto">
            <a:xfrm>
              <a:off x="134938" y="4425950"/>
              <a:ext cx="0" cy="174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" name="Line 125"/>
            <p:cNvSpPr>
              <a:spLocks noChangeShapeType="1"/>
            </p:cNvSpPr>
            <p:nvPr/>
          </p:nvSpPr>
          <p:spPr bwMode="auto">
            <a:xfrm flipV="1">
              <a:off x="134938" y="4413250"/>
              <a:ext cx="0" cy="127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" name="Line 126"/>
            <p:cNvSpPr>
              <a:spLocks noChangeShapeType="1"/>
            </p:cNvSpPr>
            <p:nvPr/>
          </p:nvSpPr>
          <p:spPr bwMode="auto">
            <a:xfrm>
              <a:off x="112713" y="444341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" name="Line 127"/>
            <p:cNvSpPr>
              <a:spLocks noChangeShapeType="1"/>
            </p:cNvSpPr>
            <p:nvPr/>
          </p:nvSpPr>
          <p:spPr bwMode="auto">
            <a:xfrm>
              <a:off x="112713" y="4413250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" name="Line 128"/>
            <p:cNvSpPr>
              <a:spLocks noChangeShapeType="1"/>
            </p:cNvSpPr>
            <p:nvPr/>
          </p:nvSpPr>
          <p:spPr bwMode="auto">
            <a:xfrm>
              <a:off x="582613" y="3633788"/>
              <a:ext cx="0" cy="1111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" name="Line 129"/>
            <p:cNvSpPr>
              <a:spLocks noChangeShapeType="1"/>
            </p:cNvSpPr>
            <p:nvPr/>
          </p:nvSpPr>
          <p:spPr bwMode="auto">
            <a:xfrm flipV="1">
              <a:off x="582613" y="3524250"/>
              <a:ext cx="0" cy="10953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" name="Line 130"/>
            <p:cNvSpPr>
              <a:spLocks noChangeShapeType="1"/>
            </p:cNvSpPr>
            <p:nvPr/>
          </p:nvSpPr>
          <p:spPr bwMode="auto">
            <a:xfrm>
              <a:off x="565150" y="374491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4" name="Line 131"/>
            <p:cNvSpPr>
              <a:spLocks noChangeShapeType="1"/>
            </p:cNvSpPr>
            <p:nvPr/>
          </p:nvSpPr>
          <p:spPr bwMode="auto">
            <a:xfrm>
              <a:off x="565150" y="352425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Line 132"/>
            <p:cNvSpPr>
              <a:spLocks noChangeShapeType="1"/>
            </p:cNvSpPr>
            <p:nvPr/>
          </p:nvSpPr>
          <p:spPr bwMode="auto">
            <a:xfrm>
              <a:off x="1036638" y="4157663"/>
              <a:ext cx="0" cy="809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6" name="Line 133"/>
            <p:cNvSpPr>
              <a:spLocks noChangeShapeType="1"/>
            </p:cNvSpPr>
            <p:nvPr/>
          </p:nvSpPr>
          <p:spPr bwMode="auto">
            <a:xfrm flipV="1">
              <a:off x="1036638" y="4076700"/>
              <a:ext cx="0" cy="809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" name="Line 134"/>
            <p:cNvSpPr>
              <a:spLocks noChangeShapeType="1"/>
            </p:cNvSpPr>
            <p:nvPr/>
          </p:nvSpPr>
          <p:spPr bwMode="auto">
            <a:xfrm>
              <a:off x="1012825" y="4238625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8" name="Line 135"/>
            <p:cNvSpPr>
              <a:spLocks noChangeShapeType="1"/>
            </p:cNvSpPr>
            <p:nvPr/>
          </p:nvSpPr>
          <p:spPr bwMode="auto">
            <a:xfrm>
              <a:off x="1012825" y="40767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Line 136"/>
            <p:cNvSpPr>
              <a:spLocks noChangeShapeType="1"/>
            </p:cNvSpPr>
            <p:nvPr/>
          </p:nvSpPr>
          <p:spPr bwMode="auto">
            <a:xfrm>
              <a:off x="1930400" y="4425950"/>
              <a:ext cx="0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0" name="Line 137"/>
            <p:cNvSpPr>
              <a:spLocks noChangeShapeType="1"/>
            </p:cNvSpPr>
            <p:nvPr/>
          </p:nvSpPr>
          <p:spPr bwMode="auto">
            <a:xfrm>
              <a:off x="1930400" y="4425950"/>
              <a:ext cx="0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Line 138"/>
            <p:cNvSpPr>
              <a:spLocks noChangeShapeType="1"/>
            </p:cNvSpPr>
            <p:nvPr/>
          </p:nvSpPr>
          <p:spPr bwMode="auto">
            <a:xfrm>
              <a:off x="1912938" y="442595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" name="Line 139"/>
            <p:cNvSpPr>
              <a:spLocks noChangeShapeType="1"/>
            </p:cNvSpPr>
            <p:nvPr/>
          </p:nvSpPr>
          <p:spPr bwMode="auto">
            <a:xfrm>
              <a:off x="1912938" y="442595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" name="Line 140"/>
            <p:cNvSpPr>
              <a:spLocks noChangeShapeType="1"/>
            </p:cNvSpPr>
            <p:nvPr/>
          </p:nvSpPr>
          <p:spPr bwMode="auto">
            <a:xfrm>
              <a:off x="2384425" y="4332288"/>
              <a:ext cx="0" cy="4603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" name="Line 141"/>
            <p:cNvSpPr>
              <a:spLocks noChangeShapeType="1"/>
            </p:cNvSpPr>
            <p:nvPr/>
          </p:nvSpPr>
          <p:spPr bwMode="auto">
            <a:xfrm flipV="1">
              <a:off x="2384425" y="4286250"/>
              <a:ext cx="0" cy="4603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5" name="Line 142"/>
            <p:cNvSpPr>
              <a:spLocks noChangeShapeType="1"/>
            </p:cNvSpPr>
            <p:nvPr/>
          </p:nvSpPr>
          <p:spPr bwMode="auto">
            <a:xfrm>
              <a:off x="2360613" y="4378325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6" name="Line 143"/>
            <p:cNvSpPr>
              <a:spLocks noChangeShapeType="1"/>
            </p:cNvSpPr>
            <p:nvPr/>
          </p:nvSpPr>
          <p:spPr bwMode="auto">
            <a:xfrm>
              <a:off x="2360613" y="4286250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" name="Line 144"/>
            <p:cNvSpPr>
              <a:spLocks noChangeShapeType="1"/>
            </p:cNvSpPr>
            <p:nvPr/>
          </p:nvSpPr>
          <p:spPr bwMode="auto">
            <a:xfrm>
              <a:off x="2832100" y="4395788"/>
              <a:ext cx="0" cy="301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8" name="Line 145"/>
            <p:cNvSpPr>
              <a:spLocks noChangeShapeType="1"/>
            </p:cNvSpPr>
            <p:nvPr/>
          </p:nvSpPr>
          <p:spPr bwMode="auto">
            <a:xfrm flipV="1">
              <a:off x="2832100" y="4360863"/>
              <a:ext cx="0" cy="349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9" name="Line 146"/>
            <p:cNvSpPr>
              <a:spLocks noChangeShapeType="1"/>
            </p:cNvSpPr>
            <p:nvPr/>
          </p:nvSpPr>
          <p:spPr bwMode="auto">
            <a:xfrm>
              <a:off x="2808288" y="4425950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0" name="Line 147"/>
            <p:cNvSpPr>
              <a:spLocks noChangeShapeType="1"/>
            </p:cNvSpPr>
            <p:nvPr/>
          </p:nvSpPr>
          <p:spPr bwMode="auto">
            <a:xfrm>
              <a:off x="2808288" y="436086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" name="Line 148"/>
            <p:cNvSpPr>
              <a:spLocks noChangeShapeType="1"/>
            </p:cNvSpPr>
            <p:nvPr/>
          </p:nvSpPr>
          <p:spPr bwMode="auto">
            <a:xfrm>
              <a:off x="-155575" y="4443413"/>
              <a:ext cx="3149600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2" name="Rectangle 149"/>
            <p:cNvSpPr>
              <a:spLocks noChangeArrowheads="1"/>
            </p:cNvSpPr>
            <p:nvPr/>
          </p:nvSpPr>
          <p:spPr bwMode="auto">
            <a:xfrm>
              <a:off x="-276225" y="4384675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151"/>
            <p:cNvSpPr>
              <a:spLocks noChangeArrowheads="1"/>
            </p:cNvSpPr>
            <p:nvPr/>
          </p:nvSpPr>
          <p:spPr bwMode="auto">
            <a:xfrm>
              <a:off x="-317500" y="4070350"/>
              <a:ext cx="128588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153"/>
            <p:cNvSpPr>
              <a:spLocks noChangeArrowheads="1"/>
            </p:cNvSpPr>
            <p:nvPr/>
          </p:nvSpPr>
          <p:spPr bwMode="auto">
            <a:xfrm>
              <a:off x="-317500" y="3757613"/>
              <a:ext cx="128588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155"/>
            <p:cNvSpPr>
              <a:spLocks noChangeArrowheads="1"/>
            </p:cNvSpPr>
            <p:nvPr/>
          </p:nvSpPr>
          <p:spPr bwMode="auto">
            <a:xfrm>
              <a:off x="-317500" y="3436938"/>
              <a:ext cx="128588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157"/>
            <p:cNvSpPr>
              <a:spLocks noChangeArrowheads="1"/>
            </p:cNvSpPr>
            <p:nvPr/>
          </p:nvSpPr>
          <p:spPr bwMode="auto">
            <a:xfrm>
              <a:off x="-317500" y="3122613"/>
              <a:ext cx="128588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8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158"/>
            <p:cNvSpPr>
              <a:spLocks noChangeArrowheads="1"/>
            </p:cNvSpPr>
            <p:nvPr/>
          </p:nvSpPr>
          <p:spPr bwMode="auto">
            <a:xfrm>
              <a:off x="-26988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159"/>
            <p:cNvSpPr>
              <a:spLocks noChangeArrowheads="1"/>
            </p:cNvSpPr>
            <p:nvPr/>
          </p:nvSpPr>
          <p:spPr bwMode="auto">
            <a:xfrm>
              <a:off x="425450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160"/>
            <p:cNvSpPr>
              <a:spLocks noChangeArrowheads="1"/>
            </p:cNvSpPr>
            <p:nvPr/>
          </p:nvSpPr>
          <p:spPr bwMode="auto">
            <a:xfrm>
              <a:off x="873125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161"/>
            <p:cNvSpPr>
              <a:spLocks noChangeArrowheads="1"/>
            </p:cNvSpPr>
            <p:nvPr/>
          </p:nvSpPr>
          <p:spPr bwMode="auto">
            <a:xfrm>
              <a:off x="1774825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162"/>
            <p:cNvSpPr>
              <a:spLocks noChangeArrowheads="1"/>
            </p:cNvSpPr>
            <p:nvPr/>
          </p:nvSpPr>
          <p:spPr bwMode="auto">
            <a:xfrm>
              <a:off x="2220913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163"/>
            <p:cNvSpPr>
              <a:spLocks noChangeArrowheads="1"/>
            </p:cNvSpPr>
            <p:nvPr/>
          </p:nvSpPr>
          <p:spPr bwMode="auto">
            <a:xfrm>
              <a:off x="2674938" y="45021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164"/>
            <p:cNvSpPr>
              <a:spLocks noChangeArrowheads="1"/>
            </p:cNvSpPr>
            <p:nvPr/>
          </p:nvSpPr>
          <p:spPr bwMode="auto">
            <a:xfrm>
              <a:off x="1076325" y="2894013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Csa2M02444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85" name="Group 84"/>
          <p:cNvGrpSpPr/>
          <p:nvPr/>
        </p:nvGrpSpPr>
        <p:grpSpPr>
          <a:xfrm>
            <a:off x="547647" y="6225769"/>
            <a:ext cx="2857890" cy="1301402"/>
            <a:chOff x="-222250" y="5081588"/>
            <a:chExt cx="3248025" cy="1738312"/>
          </a:xfrm>
        </p:grpSpPr>
        <p:sp>
          <p:nvSpPr>
            <p:cNvPr id="87" name="Freeform 231"/>
            <p:cNvSpPr>
              <a:spLocks noEditPoints="1"/>
            </p:cNvSpPr>
            <p:nvPr/>
          </p:nvSpPr>
          <p:spPr bwMode="auto">
            <a:xfrm>
              <a:off x="7938" y="5926138"/>
              <a:ext cx="2782888" cy="704850"/>
            </a:xfrm>
            <a:custGeom>
              <a:avLst/>
              <a:gdLst>
                <a:gd name="T0" fmla="*/ 0 w 1753"/>
                <a:gd name="T1" fmla="*/ 246 h 444"/>
                <a:gd name="T2" fmla="*/ 66 w 1753"/>
                <a:gd name="T3" fmla="*/ 246 h 444"/>
                <a:gd name="T4" fmla="*/ 66 w 1753"/>
                <a:gd name="T5" fmla="*/ 444 h 444"/>
                <a:gd name="T6" fmla="*/ 0 w 1753"/>
                <a:gd name="T7" fmla="*/ 444 h 444"/>
                <a:gd name="T8" fmla="*/ 0 w 1753"/>
                <a:gd name="T9" fmla="*/ 246 h 444"/>
                <a:gd name="T10" fmla="*/ 282 w 1753"/>
                <a:gd name="T11" fmla="*/ 107 h 444"/>
                <a:gd name="T12" fmla="*/ 344 w 1753"/>
                <a:gd name="T13" fmla="*/ 107 h 444"/>
                <a:gd name="T14" fmla="*/ 344 w 1753"/>
                <a:gd name="T15" fmla="*/ 444 h 444"/>
                <a:gd name="T16" fmla="*/ 282 w 1753"/>
                <a:gd name="T17" fmla="*/ 444 h 444"/>
                <a:gd name="T18" fmla="*/ 282 w 1753"/>
                <a:gd name="T19" fmla="*/ 107 h 444"/>
                <a:gd name="T20" fmla="*/ 563 w 1753"/>
                <a:gd name="T21" fmla="*/ 30 h 444"/>
                <a:gd name="T22" fmla="*/ 626 w 1753"/>
                <a:gd name="T23" fmla="*/ 30 h 444"/>
                <a:gd name="T24" fmla="*/ 626 w 1753"/>
                <a:gd name="T25" fmla="*/ 444 h 444"/>
                <a:gd name="T26" fmla="*/ 563 w 1753"/>
                <a:gd name="T27" fmla="*/ 444 h 444"/>
                <a:gd name="T28" fmla="*/ 563 w 1753"/>
                <a:gd name="T29" fmla="*/ 30 h 444"/>
                <a:gd name="T30" fmla="*/ 1127 w 1753"/>
                <a:gd name="T31" fmla="*/ 246 h 444"/>
                <a:gd name="T32" fmla="*/ 1189 w 1753"/>
                <a:gd name="T33" fmla="*/ 246 h 444"/>
                <a:gd name="T34" fmla="*/ 1189 w 1753"/>
                <a:gd name="T35" fmla="*/ 444 h 444"/>
                <a:gd name="T36" fmla="*/ 1127 w 1753"/>
                <a:gd name="T37" fmla="*/ 444 h 444"/>
                <a:gd name="T38" fmla="*/ 1127 w 1753"/>
                <a:gd name="T39" fmla="*/ 246 h 444"/>
                <a:gd name="T40" fmla="*/ 1409 w 1753"/>
                <a:gd name="T41" fmla="*/ 0 h 444"/>
                <a:gd name="T42" fmla="*/ 1471 w 1753"/>
                <a:gd name="T43" fmla="*/ 0 h 444"/>
                <a:gd name="T44" fmla="*/ 1471 w 1753"/>
                <a:gd name="T45" fmla="*/ 444 h 444"/>
                <a:gd name="T46" fmla="*/ 1409 w 1753"/>
                <a:gd name="T47" fmla="*/ 444 h 444"/>
                <a:gd name="T48" fmla="*/ 1409 w 1753"/>
                <a:gd name="T49" fmla="*/ 0 h 444"/>
                <a:gd name="T50" fmla="*/ 1687 w 1753"/>
                <a:gd name="T51" fmla="*/ 59 h 444"/>
                <a:gd name="T52" fmla="*/ 1753 w 1753"/>
                <a:gd name="T53" fmla="*/ 59 h 444"/>
                <a:gd name="T54" fmla="*/ 1753 w 1753"/>
                <a:gd name="T55" fmla="*/ 444 h 444"/>
                <a:gd name="T56" fmla="*/ 1687 w 1753"/>
                <a:gd name="T57" fmla="*/ 444 h 444"/>
                <a:gd name="T58" fmla="*/ 1687 w 1753"/>
                <a:gd name="T59" fmla="*/ 59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444">
                  <a:moveTo>
                    <a:pt x="0" y="246"/>
                  </a:moveTo>
                  <a:lnTo>
                    <a:pt x="66" y="246"/>
                  </a:lnTo>
                  <a:lnTo>
                    <a:pt x="66" y="444"/>
                  </a:lnTo>
                  <a:lnTo>
                    <a:pt x="0" y="444"/>
                  </a:lnTo>
                  <a:lnTo>
                    <a:pt x="0" y="246"/>
                  </a:lnTo>
                  <a:close/>
                  <a:moveTo>
                    <a:pt x="282" y="107"/>
                  </a:moveTo>
                  <a:lnTo>
                    <a:pt x="344" y="107"/>
                  </a:lnTo>
                  <a:lnTo>
                    <a:pt x="344" y="444"/>
                  </a:lnTo>
                  <a:lnTo>
                    <a:pt x="282" y="444"/>
                  </a:lnTo>
                  <a:lnTo>
                    <a:pt x="282" y="107"/>
                  </a:lnTo>
                  <a:close/>
                  <a:moveTo>
                    <a:pt x="563" y="30"/>
                  </a:moveTo>
                  <a:lnTo>
                    <a:pt x="626" y="30"/>
                  </a:lnTo>
                  <a:lnTo>
                    <a:pt x="626" y="444"/>
                  </a:lnTo>
                  <a:lnTo>
                    <a:pt x="563" y="444"/>
                  </a:lnTo>
                  <a:lnTo>
                    <a:pt x="563" y="30"/>
                  </a:lnTo>
                  <a:close/>
                  <a:moveTo>
                    <a:pt x="1127" y="246"/>
                  </a:moveTo>
                  <a:lnTo>
                    <a:pt x="1189" y="246"/>
                  </a:lnTo>
                  <a:lnTo>
                    <a:pt x="1189" y="444"/>
                  </a:lnTo>
                  <a:lnTo>
                    <a:pt x="1127" y="444"/>
                  </a:lnTo>
                  <a:lnTo>
                    <a:pt x="1127" y="246"/>
                  </a:lnTo>
                  <a:close/>
                  <a:moveTo>
                    <a:pt x="1409" y="0"/>
                  </a:moveTo>
                  <a:lnTo>
                    <a:pt x="1471" y="0"/>
                  </a:lnTo>
                  <a:lnTo>
                    <a:pt x="1471" y="444"/>
                  </a:lnTo>
                  <a:lnTo>
                    <a:pt x="1409" y="444"/>
                  </a:lnTo>
                  <a:lnTo>
                    <a:pt x="1409" y="0"/>
                  </a:lnTo>
                  <a:close/>
                  <a:moveTo>
                    <a:pt x="1687" y="59"/>
                  </a:moveTo>
                  <a:lnTo>
                    <a:pt x="1753" y="59"/>
                  </a:lnTo>
                  <a:lnTo>
                    <a:pt x="1753" y="444"/>
                  </a:lnTo>
                  <a:lnTo>
                    <a:pt x="1687" y="444"/>
                  </a:lnTo>
                  <a:lnTo>
                    <a:pt x="1687" y="59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8" name="Freeform 232"/>
            <p:cNvSpPr>
              <a:spLocks noEditPoints="1"/>
            </p:cNvSpPr>
            <p:nvPr/>
          </p:nvSpPr>
          <p:spPr bwMode="auto">
            <a:xfrm>
              <a:off x="134938" y="5681663"/>
              <a:ext cx="2782888" cy="949325"/>
            </a:xfrm>
            <a:custGeom>
              <a:avLst/>
              <a:gdLst>
                <a:gd name="T0" fmla="*/ 0 w 1753"/>
                <a:gd name="T1" fmla="*/ 400 h 598"/>
                <a:gd name="T2" fmla="*/ 62 w 1753"/>
                <a:gd name="T3" fmla="*/ 400 h 598"/>
                <a:gd name="T4" fmla="*/ 62 w 1753"/>
                <a:gd name="T5" fmla="*/ 598 h 598"/>
                <a:gd name="T6" fmla="*/ 0 w 1753"/>
                <a:gd name="T7" fmla="*/ 598 h 598"/>
                <a:gd name="T8" fmla="*/ 0 w 1753"/>
                <a:gd name="T9" fmla="*/ 400 h 598"/>
                <a:gd name="T10" fmla="*/ 282 w 1753"/>
                <a:gd name="T11" fmla="*/ 202 h 598"/>
                <a:gd name="T12" fmla="*/ 344 w 1753"/>
                <a:gd name="T13" fmla="*/ 202 h 598"/>
                <a:gd name="T14" fmla="*/ 344 w 1753"/>
                <a:gd name="T15" fmla="*/ 598 h 598"/>
                <a:gd name="T16" fmla="*/ 282 w 1753"/>
                <a:gd name="T17" fmla="*/ 598 h 598"/>
                <a:gd name="T18" fmla="*/ 282 w 1753"/>
                <a:gd name="T19" fmla="*/ 202 h 598"/>
                <a:gd name="T20" fmla="*/ 564 w 1753"/>
                <a:gd name="T21" fmla="*/ 0 h 598"/>
                <a:gd name="T22" fmla="*/ 626 w 1753"/>
                <a:gd name="T23" fmla="*/ 0 h 598"/>
                <a:gd name="T24" fmla="*/ 626 w 1753"/>
                <a:gd name="T25" fmla="*/ 598 h 598"/>
                <a:gd name="T26" fmla="*/ 564 w 1753"/>
                <a:gd name="T27" fmla="*/ 598 h 598"/>
                <a:gd name="T28" fmla="*/ 564 w 1753"/>
                <a:gd name="T29" fmla="*/ 0 h 598"/>
                <a:gd name="T30" fmla="*/ 1128 w 1753"/>
                <a:gd name="T31" fmla="*/ 400 h 598"/>
                <a:gd name="T32" fmla="*/ 1190 w 1753"/>
                <a:gd name="T33" fmla="*/ 400 h 598"/>
                <a:gd name="T34" fmla="*/ 1190 w 1753"/>
                <a:gd name="T35" fmla="*/ 598 h 598"/>
                <a:gd name="T36" fmla="*/ 1128 w 1753"/>
                <a:gd name="T37" fmla="*/ 598 h 598"/>
                <a:gd name="T38" fmla="*/ 1128 w 1753"/>
                <a:gd name="T39" fmla="*/ 400 h 598"/>
                <a:gd name="T40" fmla="*/ 1406 w 1753"/>
                <a:gd name="T41" fmla="*/ 202 h 598"/>
                <a:gd name="T42" fmla="*/ 1472 w 1753"/>
                <a:gd name="T43" fmla="*/ 202 h 598"/>
                <a:gd name="T44" fmla="*/ 1472 w 1753"/>
                <a:gd name="T45" fmla="*/ 598 h 598"/>
                <a:gd name="T46" fmla="*/ 1406 w 1753"/>
                <a:gd name="T47" fmla="*/ 598 h 598"/>
                <a:gd name="T48" fmla="*/ 1406 w 1753"/>
                <a:gd name="T49" fmla="*/ 202 h 598"/>
                <a:gd name="T50" fmla="*/ 1688 w 1753"/>
                <a:gd name="T51" fmla="*/ 162 h 598"/>
                <a:gd name="T52" fmla="*/ 1753 w 1753"/>
                <a:gd name="T53" fmla="*/ 162 h 598"/>
                <a:gd name="T54" fmla="*/ 1753 w 1753"/>
                <a:gd name="T55" fmla="*/ 598 h 598"/>
                <a:gd name="T56" fmla="*/ 1688 w 1753"/>
                <a:gd name="T57" fmla="*/ 598 h 598"/>
                <a:gd name="T58" fmla="*/ 1688 w 1753"/>
                <a:gd name="T59" fmla="*/ 162 h 5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598">
                  <a:moveTo>
                    <a:pt x="0" y="400"/>
                  </a:moveTo>
                  <a:lnTo>
                    <a:pt x="62" y="400"/>
                  </a:lnTo>
                  <a:lnTo>
                    <a:pt x="62" y="598"/>
                  </a:lnTo>
                  <a:lnTo>
                    <a:pt x="0" y="598"/>
                  </a:lnTo>
                  <a:lnTo>
                    <a:pt x="0" y="400"/>
                  </a:lnTo>
                  <a:close/>
                  <a:moveTo>
                    <a:pt x="282" y="202"/>
                  </a:moveTo>
                  <a:lnTo>
                    <a:pt x="344" y="202"/>
                  </a:lnTo>
                  <a:lnTo>
                    <a:pt x="344" y="598"/>
                  </a:lnTo>
                  <a:lnTo>
                    <a:pt x="282" y="598"/>
                  </a:lnTo>
                  <a:lnTo>
                    <a:pt x="282" y="202"/>
                  </a:lnTo>
                  <a:close/>
                  <a:moveTo>
                    <a:pt x="564" y="0"/>
                  </a:moveTo>
                  <a:lnTo>
                    <a:pt x="626" y="0"/>
                  </a:lnTo>
                  <a:lnTo>
                    <a:pt x="626" y="598"/>
                  </a:lnTo>
                  <a:lnTo>
                    <a:pt x="564" y="598"/>
                  </a:lnTo>
                  <a:lnTo>
                    <a:pt x="564" y="0"/>
                  </a:lnTo>
                  <a:close/>
                  <a:moveTo>
                    <a:pt x="1128" y="400"/>
                  </a:moveTo>
                  <a:lnTo>
                    <a:pt x="1190" y="400"/>
                  </a:lnTo>
                  <a:lnTo>
                    <a:pt x="1190" y="598"/>
                  </a:lnTo>
                  <a:lnTo>
                    <a:pt x="1128" y="598"/>
                  </a:lnTo>
                  <a:lnTo>
                    <a:pt x="1128" y="400"/>
                  </a:lnTo>
                  <a:close/>
                  <a:moveTo>
                    <a:pt x="1406" y="202"/>
                  </a:moveTo>
                  <a:lnTo>
                    <a:pt x="1472" y="202"/>
                  </a:lnTo>
                  <a:lnTo>
                    <a:pt x="1472" y="598"/>
                  </a:lnTo>
                  <a:lnTo>
                    <a:pt x="1406" y="598"/>
                  </a:lnTo>
                  <a:lnTo>
                    <a:pt x="1406" y="202"/>
                  </a:lnTo>
                  <a:close/>
                  <a:moveTo>
                    <a:pt x="1688" y="162"/>
                  </a:moveTo>
                  <a:lnTo>
                    <a:pt x="1753" y="162"/>
                  </a:lnTo>
                  <a:lnTo>
                    <a:pt x="1753" y="598"/>
                  </a:lnTo>
                  <a:lnTo>
                    <a:pt x="1688" y="598"/>
                  </a:lnTo>
                  <a:lnTo>
                    <a:pt x="1688" y="162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9" name="Freeform 233"/>
            <p:cNvSpPr>
              <a:spLocks noEditPoints="1"/>
            </p:cNvSpPr>
            <p:nvPr/>
          </p:nvSpPr>
          <p:spPr bwMode="auto">
            <a:xfrm>
              <a:off x="166688" y="6191250"/>
              <a:ext cx="41275" cy="250825"/>
            </a:xfrm>
            <a:custGeom>
              <a:avLst/>
              <a:gdLst>
                <a:gd name="T0" fmla="*/ 11 w 26"/>
                <a:gd name="T1" fmla="*/ 81 h 158"/>
                <a:gd name="T2" fmla="*/ 11 w 26"/>
                <a:gd name="T3" fmla="*/ 158 h 158"/>
                <a:gd name="T4" fmla="*/ 11 w 26"/>
                <a:gd name="T5" fmla="*/ 81 h 158"/>
                <a:gd name="T6" fmla="*/ 11 w 26"/>
                <a:gd name="T7" fmla="*/ 0 h 158"/>
                <a:gd name="T8" fmla="*/ 0 w 26"/>
                <a:gd name="T9" fmla="*/ 158 h 158"/>
                <a:gd name="T10" fmla="*/ 26 w 26"/>
                <a:gd name="T11" fmla="*/ 158 h 158"/>
                <a:gd name="T12" fmla="*/ 0 w 26"/>
                <a:gd name="T13" fmla="*/ 0 h 158"/>
                <a:gd name="T14" fmla="*/ 26 w 26"/>
                <a:gd name="T15" fmla="*/ 0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58">
                  <a:moveTo>
                    <a:pt x="11" y="81"/>
                  </a:moveTo>
                  <a:lnTo>
                    <a:pt x="11" y="158"/>
                  </a:lnTo>
                  <a:moveTo>
                    <a:pt x="11" y="81"/>
                  </a:moveTo>
                  <a:lnTo>
                    <a:pt x="11" y="0"/>
                  </a:lnTo>
                  <a:moveTo>
                    <a:pt x="0" y="158"/>
                  </a:moveTo>
                  <a:lnTo>
                    <a:pt x="26" y="158"/>
                  </a:lnTo>
                  <a:moveTo>
                    <a:pt x="0" y="0"/>
                  </a:moveTo>
                  <a:lnTo>
                    <a:pt x="26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0" name="Freeform 234"/>
            <p:cNvSpPr>
              <a:spLocks noEditPoints="1"/>
            </p:cNvSpPr>
            <p:nvPr/>
          </p:nvSpPr>
          <p:spPr bwMode="auto">
            <a:xfrm>
              <a:off x="609600" y="5935663"/>
              <a:ext cx="46038" cy="127000"/>
            </a:xfrm>
            <a:custGeom>
              <a:avLst/>
              <a:gdLst>
                <a:gd name="T0" fmla="*/ 14 w 29"/>
                <a:gd name="T1" fmla="*/ 40 h 80"/>
                <a:gd name="T2" fmla="*/ 14 w 29"/>
                <a:gd name="T3" fmla="*/ 80 h 80"/>
                <a:gd name="T4" fmla="*/ 14 w 29"/>
                <a:gd name="T5" fmla="*/ 40 h 80"/>
                <a:gd name="T6" fmla="*/ 14 w 29"/>
                <a:gd name="T7" fmla="*/ 0 h 80"/>
                <a:gd name="T8" fmla="*/ 0 w 29"/>
                <a:gd name="T9" fmla="*/ 80 h 80"/>
                <a:gd name="T10" fmla="*/ 29 w 29"/>
                <a:gd name="T11" fmla="*/ 80 h 80"/>
                <a:gd name="T12" fmla="*/ 0 w 29"/>
                <a:gd name="T13" fmla="*/ 0 h 80"/>
                <a:gd name="T14" fmla="*/ 29 w 29"/>
                <a:gd name="T15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9" h="80">
                  <a:moveTo>
                    <a:pt x="14" y="40"/>
                  </a:moveTo>
                  <a:lnTo>
                    <a:pt x="14" y="80"/>
                  </a:lnTo>
                  <a:moveTo>
                    <a:pt x="14" y="40"/>
                  </a:moveTo>
                  <a:lnTo>
                    <a:pt x="14" y="0"/>
                  </a:lnTo>
                  <a:moveTo>
                    <a:pt x="0" y="80"/>
                  </a:moveTo>
                  <a:lnTo>
                    <a:pt x="29" y="80"/>
                  </a:lnTo>
                  <a:moveTo>
                    <a:pt x="0" y="0"/>
                  </a:moveTo>
                  <a:lnTo>
                    <a:pt x="29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" name="Freeform 235"/>
            <p:cNvSpPr>
              <a:spLocks noEditPoints="1"/>
            </p:cNvSpPr>
            <p:nvPr/>
          </p:nvSpPr>
          <p:spPr bwMode="auto">
            <a:xfrm>
              <a:off x="1055688" y="5464175"/>
              <a:ext cx="47625" cy="442913"/>
            </a:xfrm>
            <a:custGeom>
              <a:avLst/>
              <a:gdLst>
                <a:gd name="T0" fmla="*/ 15 w 30"/>
                <a:gd name="T1" fmla="*/ 139 h 279"/>
                <a:gd name="T2" fmla="*/ 15 w 30"/>
                <a:gd name="T3" fmla="*/ 279 h 279"/>
                <a:gd name="T4" fmla="*/ 15 w 30"/>
                <a:gd name="T5" fmla="*/ 139 h 279"/>
                <a:gd name="T6" fmla="*/ 15 w 30"/>
                <a:gd name="T7" fmla="*/ 0 h 279"/>
                <a:gd name="T8" fmla="*/ 0 w 30"/>
                <a:gd name="T9" fmla="*/ 279 h 279"/>
                <a:gd name="T10" fmla="*/ 30 w 30"/>
                <a:gd name="T11" fmla="*/ 279 h 279"/>
                <a:gd name="T12" fmla="*/ 0 w 30"/>
                <a:gd name="T13" fmla="*/ 0 h 279"/>
                <a:gd name="T14" fmla="*/ 30 w 30"/>
                <a:gd name="T15" fmla="*/ 0 h 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0" h="279">
                  <a:moveTo>
                    <a:pt x="15" y="139"/>
                  </a:moveTo>
                  <a:lnTo>
                    <a:pt x="15" y="279"/>
                  </a:lnTo>
                  <a:moveTo>
                    <a:pt x="15" y="139"/>
                  </a:moveTo>
                  <a:lnTo>
                    <a:pt x="15" y="0"/>
                  </a:lnTo>
                  <a:moveTo>
                    <a:pt x="0" y="279"/>
                  </a:moveTo>
                  <a:lnTo>
                    <a:pt x="30" y="279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" name="Freeform 236"/>
            <p:cNvSpPr>
              <a:spLocks noEditPoints="1"/>
            </p:cNvSpPr>
            <p:nvPr/>
          </p:nvSpPr>
          <p:spPr bwMode="auto">
            <a:xfrm>
              <a:off x="1951038" y="6302375"/>
              <a:ext cx="41275" cy="28575"/>
            </a:xfrm>
            <a:custGeom>
              <a:avLst/>
              <a:gdLst>
                <a:gd name="T0" fmla="*/ 15 w 26"/>
                <a:gd name="T1" fmla="*/ 11 h 18"/>
                <a:gd name="T2" fmla="*/ 15 w 26"/>
                <a:gd name="T3" fmla="*/ 18 h 18"/>
                <a:gd name="T4" fmla="*/ 15 w 26"/>
                <a:gd name="T5" fmla="*/ 11 h 18"/>
                <a:gd name="T6" fmla="*/ 15 w 26"/>
                <a:gd name="T7" fmla="*/ 0 h 18"/>
                <a:gd name="T8" fmla="*/ 0 w 26"/>
                <a:gd name="T9" fmla="*/ 18 h 18"/>
                <a:gd name="T10" fmla="*/ 26 w 26"/>
                <a:gd name="T11" fmla="*/ 18 h 18"/>
                <a:gd name="T12" fmla="*/ 0 w 26"/>
                <a:gd name="T13" fmla="*/ 0 h 18"/>
                <a:gd name="T14" fmla="*/ 26 w 26"/>
                <a:gd name="T15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8">
                  <a:moveTo>
                    <a:pt x="15" y="11"/>
                  </a:moveTo>
                  <a:lnTo>
                    <a:pt x="15" y="18"/>
                  </a:lnTo>
                  <a:moveTo>
                    <a:pt x="15" y="11"/>
                  </a:moveTo>
                  <a:lnTo>
                    <a:pt x="15" y="0"/>
                  </a:lnTo>
                  <a:moveTo>
                    <a:pt x="0" y="18"/>
                  </a:moveTo>
                  <a:lnTo>
                    <a:pt x="26" y="18"/>
                  </a:lnTo>
                  <a:moveTo>
                    <a:pt x="0" y="0"/>
                  </a:moveTo>
                  <a:lnTo>
                    <a:pt x="26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3" name="Freeform 237"/>
            <p:cNvSpPr>
              <a:spLocks noEditPoints="1"/>
            </p:cNvSpPr>
            <p:nvPr/>
          </p:nvSpPr>
          <p:spPr bwMode="auto">
            <a:xfrm>
              <a:off x="2398713" y="5872163"/>
              <a:ext cx="39688" cy="255588"/>
            </a:xfrm>
            <a:custGeom>
              <a:avLst/>
              <a:gdLst>
                <a:gd name="T0" fmla="*/ 15 w 25"/>
                <a:gd name="T1" fmla="*/ 80 h 161"/>
                <a:gd name="T2" fmla="*/ 15 w 25"/>
                <a:gd name="T3" fmla="*/ 161 h 161"/>
                <a:gd name="T4" fmla="*/ 15 w 25"/>
                <a:gd name="T5" fmla="*/ 80 h 161"/>
                <a:gd name="T6" fmla="*/ 15 w 25"/>
                <a:gd name="T7" fmla="*/ 0 h 161"/>
                <a:gd name="T8" fmla="*/ 0 w 25"/>
                <a:gd name="T9" fmla="*/ 161 h 161"/>
                <a:gd name="T10" fmla="*/ 25 w 25"/>
                <a:gd name="T11" fmla="*/ 161 h 161"/>
                <a:gd name="T12" fmla="*/ 0 w 25"/>
                <a:gd name="T13" fmla="*/ 0 h 161"/>
                <a:gd name="T14" fmla="*/ 25 w 25"/>
                <a:gd name="T15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5" h="161">
                  <a:moveTo>
                    <a:pt x="15" y="80"/>
                  </a:moveTo>
                  <a:lnTo>
                    <a:pt x="15" y="161"/>
                  </a:lnTo>
                  <a:moveTo>
                    <a:pt x="15" y="80"/>
                  </a:moveTo>
                  <a:lnTo>
                    <a:pt x="15" y="0"/>
                  </a:lnTo>
                  <a:moveTo>
                    <a:pt x="0" y="161"/>
                  </a:moveTo>
                  <a:lnTo>
                    <a:pt x="25" y="161"/>
                  </a:lnTo>
                  <a:moveTo>
                    <a:pt x="0" y="0"/>
                  </a:moveTo>
                  <a:lnTo>
                    <a:pt x="25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4" name="Freeform 238"/>
            <p:cNvSpPr>
              <a:spLocks noEditPoints="1"/>
            </p:cNvSpPr>
            <p:nvPr/>
          </p:nvSpPr>
          <p:spPr bwMode="auto">
            <a:xfrm>
              <a:off x="2846388" y="5842000"/>
              <a:ext cx="39688" cy="192088"/>
            </a:xfrm>
            <a:custGeom>
              <a:avLst/>
              <a:gdLst>
                <a:gd name="T0" fmla="*/ 11 w 25"/>
                <a:gd name="T1" fmla="*/ 59 h 121"/>
                <a:gd name="T2" fmla="*/ 11 w 25"/>
                <a:gd name="T3" fmla="*/ 121 h 121"/>
                <a:gd name="T4" fmla="*/ 11 w 25"/>
                <a:gd name="T5" fmla="*/ 59 h 121"/>
                <a:gd name="T6" fmla="*/ 11 w 25"/>
                <a:gd name="T7" fmla="*/ 0 h 121"/>
                <a:gd name="T8" fmla="*/ 0 w 25"/>
                <a:gd name="T9" fmla="*/ 121 h 121"/>
                <a:gd name="T10" fmla="*/ 25 w 25"/>
                <a:gd name="T11" fmla="*/ 121 h 121"/>
                <a:gd name="T12" fmla="*/ 0 w 25"/>
                <a:gd name="T13" fmla="*/ 0 h 121"/>
                <a:gd name="T14" fmla="*/ 25 w 25"/>
                <a:gd name="T15" fmla="*/ 0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5" h="121">
                  <a:moveTo>
                    <a:pt x="11" y="59"/>
                  </a:moveTo>
                  <a:lnTo>
                    <a:pt x="11" y="121"/>
                  </a:lnTo>
                  <a:moveTo>
                    <a:pt x="11" y="59"/>
                  </a:moveTo>
                  <a:lnTo>
                    <a:pt x="11" y="0"/>
                  </a:lnTo>
                  <a:moveTo>
                    <a:pt x="0" y="121"/>
                  </a:moveTo>
                  <a:lnTo>
                    <a:pt x="25" y="121"/>
                  </a:lnTo>
                  <a:moveTo>
                    <a:pt x="0" y="0"/>
                  </a:moveTo>
                  <a:lnTo>
                    <a:pt x="25" y="0"/>
                  </a:lnTo>
                </a:path>
              </a:pathLst>
            </a:custGeom>
            <a:noFill/>
            <a:ln w="6350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5" name="Line 239"/>
            <p:cNvSpPr>
              <a:spLocks noChangeShapeType="1"/>
            </p:cNvSpPr>
            <p:nvPr/>
          </p:nvSpPr>
          <p:spPr bwMode="auto">
            <a:xfrm>
              <a:off x="-100013" y="6634163"/>
              <a:ext cx="3125788" cy="0"/>
            </a:xfrm>
            <a:prstGeom prst="line">
              <a:avLst/>
            </a:prstGeom>
            <a:noFill/>
            <a:ln w="6350" cap="flat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6" name="Rectangle 240"/>
            <p:cNvSpPr>
              <a:spLocks noChangeArrowheads="1"/>
            </p:cNvSpPr>
            <p:nvPr/>
          </p:nvSpPr>
          <p:spPr bwMode="auto">
            <a:xfrm>
              <a:off x="-222250" y="6578600"/>
              <a:ext cx="9366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242"/>
            <p:cNvSpPr>
              <a:spLocks noChangeArrowheads="1"/>
            </p:cNvSpPr>
            <p:nvPr/>
          </p:nvSpPr>
          <p:spPr bwMode="auto">
            <a:xfrm>
              <a:off x="-222250" y="6262688"/>
              <a:ext cx="93663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244"/>
            <p:cNvSpPr>
              <a:spLocks noChangeArrowheads="1"/>
            </p:cNvSpPr>
            <p:nvPr/>
          </p:nvSpPr>
          <p:spPr bwMode="auto">
            <a:xfrm>
              <a:off x="-222250" y="5943600"/>
              <a:ext cx="9366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246"/>
            <p:cNvSpPr>
              <a:spLocks noChangeArrowheads="1"/>
            </p:cNvSpPr>
            <p:nvPr/>
          </p:nvSpPr>
          <p:spPr bwMode="auto">
            <a:xfrm>
              <a:off x="-222250" y="5629275"/>
              <a:ext cx="93663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248"/>
            <p:cNvSpPr>
              <a:spLocks noChangeArrowheads="1"/>
            </p:cNvSpPr>
            <p:nvPr/>
          </p:nvSpPr>
          <p:spPr bwMode="auto">
            <a:xfrm>
              <a:off x="-222250" y="5310188"/>
              <a:ext cx="9366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249"/>
            <p:cNvSpPr>
              <a:spLocks noChangeArrowheads="1"/>
            </p:cNvSpPr>
            <p:nvPr/>
          </p:nvSpPr>
          <p:spPr bwMode="auto">
            <a:xfrm>
              <a:off x="26988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250"/>
            <p:cNvSpPr>
              <a:spLocks noChangeArrowheads="1"/>
            </p:cNvSpPr>
            <p:nvPr/>
          </p:nvSpPr>
          <p:spPr bwMode="auto">
            <a:xfrm>
              <a:off x="473075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251"/>
            <p:cNvSpPr>
              <a:spLocks noChangeArrowheads="1"/>
            </p:cNvSpPr>
            <p:nvPr/>
          </p:nvSpPr>
          <p:spPr bwMode="auto">
            <a:xfrm>
              <a:off x="919163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252"/>
            <p:cNvSpPr>
              <a:spLocks noChangeArrowheads="1"/>
            </p:cNvSpPr>
            <p:nvPr/>
          </p:nvSpPr>
          <p:spPr bwMode="auto">
            <a:xfrm>
              <a:off x="1812925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253"/>
            <p:cNvSpPr>
              <a:spLocks noChangeArrowheads="1"/>
            </p:cNvSpPr>
            <p:nvPr/>
          </p:nvSpPr>
          <p:spPr bwMode="auto">
            <a:xfrm>
              <a:off x="2259013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254"/>
            <p:cNvSpPr>
              <a:spLocks noChangeArrowheads="1"/>
            </p:cNvSpPr>
            <p:nvPr/>
          </p:nvSpPr>
          <p:spPr bwMode="auto">
            <a:xfrm>
              <a:off x="2705100" y="6692900"/>
              <a:ext cx="244475" cy="12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255"/>
            <p:cNvSpPr>
              <a:spLocks noChangeArrowheads="1"/>
            </p:cNvSpPr>
            <p:nvPr/>
          </p:nvSpPr>
          <p:spPr bwMode="auto">
            <a:xfrm>
              <a:off x="1106488" y="5081588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Csa7M02401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09" name="Group 108"/>
          <p:cNvGrpSpPr/>
          <p:nvPr/>
        </p:nvGrpSpPr>
        <p:grpSpPr>
          <a:xfrm>
            <a:off x="3721591" y="6226957"/>
            <a:ext cx="2857891" cy="1300214"/>
            <a:chOff x="4024313" y="5129213"/>
            <a:chExt cx="3248026" cy="1736725"/>
          </a:xfrm>
        </p:grpSpPr>
        <p:sp>
          <p:nvSpPr>
            <p:cNvPr id="111" name="Freeform 270"/>
            <p:cNvSpPr>
              <a:spLocks noEditPoints="1"/>
            </p:cNvSpPr>
            <p:nvPr/>
          </p:nvSpPr>
          <p:spPr bwMode="auto">
            <a:xfrm>
              <a:off x="4257676" y="6056313"/>
              <a:ext cx="2782888" cy="622300"/>
            </a:xfrm>
            <a:custGeom>
              <a:avLst/>
              <a:gdLst>
                <a:gd name="T0" fmla="*/ 0 w 1753"/>
                <a:gd name="T1" fmla="*/ 73 h 392"/>
                <a:gd name="T2" fmla="*/ 65 w 1753"/>
                <a:gd name="T3" fmla="*/ 73 h 392"/>
                <a:gd name="T4" fmla="*/ 65 w 1753"/>
                <a:gd name="T5" fmla="*/ 392 h 392"/>
                <a:gd name="T6" fmla="*/ 0 w 1753"/>
                <a:gd name="T7" fmla="*/ 392 h 392"/>
                <a:gd name="T8" fmla="*/ 0 w 1753"/>
                <a:gd name="T9" fmla="*/ 73 h 392"/>
                <a:gd name="T10" fmla="*/ 281 w 1753"/>
                <a:gd name="T11" fmla="*/ 0 h 392"/>
                <a:gd name="T12" fmla="*/ 344 w 1753"/>
                <a:gd name="T13" fmla="*/ 0 h 392"/>
                <a:gd name="T14" fmla="*/ 344 w 1753"/>
                <a:gd name="T15" fmla="*/ 392 h 392"/>
                <a:gd name="T16" fmla="*/ 281 w 1753"/>
                <a:gd name="T17" fmla="*/ 392 h 392"/>
                <a:gd name="T18" fmla="*/ 281 w 1753"/>
                <a:gd name="T19" fmla="*/ 0 h 392"/>
                <a:gd name="T20" fmla="*/ 563 w 1753"/>
                <a:gd name="T21" fmla="*/ 212 h 392"/>
                <a:gd name="T22" fmla="*/ 625 w 1753"/>
                <a:gd name="T23" fmla="*/ 212 h 392"/>
                <a:gd name="T24" fmla="*/ 625 w 1753"/>
                <a:gd name="T25" fmla="*/ 392 h 392"/>
                <a:gd name="T26" fmla="*/ 563 w 1753"/>
                <a:gd name="T27" fmla="*/ 392 h 392"/>
                <a:gd name="T28" fmla="*/ 563 w 1753"/>
                <a:gd name="T29" fmla="*/ 212 h 392"/>
                <a:gd name="T30" fmla="*/ 1127 w 1753"/>
                <a:gd name="T31" fmla="*/ 73 h 392"/>
                <a:gd name="T32" fmla="*/ 1189 w 1753"/>
                <a:gd name="T33" fmla="*/ 73 h 392"/>
                <a:gd name="T34" fmla="*/ 1189 w 1753"/>
                <a:gd name="T35" fmla="*/ 392 h 392"/>
                <a:gd name="T36" fmla="*/ 1127 w 1753"/>
                <a:gd name="T37" fmla="*/ 392 h 392"/>
                <a:gd name="T38" fmla="*/ 1127 w 1753"/>
                <a:gd name="T39" fmla="*/ 73 h 392"/>
                <a:gd name="T40" fmla="*/ 1409 w 1753"/>
                <a:gd name="T41" fmla="*/ 131 h 392"/>
                <a:gd name="T42" fmla="*/ 1471 w 1753"/>
                <a:gd name="T43" fmla="*/ 131 h 392"/>
                <a:gd name="T44" fmla="*/ 1471 w 1753"/>
                <a:gd name="T45" fmla="*/ 392 h 392"/>
                <a:gd name="T46" fmla="*/ 1409 w 1753"/>
                <a:gd name="T47" fmla="*/ 392 h 392"/>
                <a:gd name="T48" fmla="*/ 1409 w 1753"/>
                <a:gd name="T49" fmla="*/ 131 h 392"/>
                <a:gd name="T50" fmla="*/ 1687 w 1753"/>
                <a:gd name="T51" fmla="*/ 241 h 392"/>
                <a:gd name="T52" fmla="*/ 1753 w 1753"/>
                <a:gd name="T53" fmla="*/ 241 h 392"/>
                <a:gd name="T54" fmla="*/ 1753 w 1753"/>
                <a:gd name="T55" fmla="*/ 392 h 392"/>
                <a:gd name="T56" fmla="*/ 1687 w 1753"/>
                <a:gd name="T57" fmla="*/ 392 h 392"/>
                <a:gd name="T58" fmla="*/ 1687 w 1753"/>
                <a:gd name="T59" fmla="*/ 241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392">
                  <a:moveTo>
                    <a:pt x="0" y="73"/>
                  </a:moveTo>
                  <a:lnTo>
                    <a:pt x="65" y="73"/>
                  </a:lnTo>
                  <a:lnTo>
                    <a:pt x="65" y="392"/>
                  </a:lnTo>
                  <a:lnTo>
                    <a:pt x="0" y="392"/>
                  </a:lnTo>
                  <a:lnTo>
                    <a:pt x="0" y="73"/>
                  </a:lnTo>
                  <a:close/>
                  <a:moveTo>
                    <a:pt x="281" y="0"/>
                  </a:moveTo>
                  <a:lnTo>
                    <a:pt x="344" y="0"/>
                  </a:lnTo>
                  <a:lnTo>
                    <a:pt x="344" y="392"/>
                  </a:lnTo>
                  <a:lnTo>
                    <a:pt x="281" y="392"/>
                  </a:lnTo>
                  <a:lnTo>
                    <a:pt x="281" y="0"/>
                  </a:lnTo>
                  <a:close/>
                  <a:moveTo>
                    <a:pt x="563" y="212"/>
                  </a:moveTo>
                  <a:lnTo>
                    <a:pt x="625" y="212"/>
                  </a:lnTo>
                  <a:lnTo>
                    <a:pt x="625" y="392"/>
                  </a:lnTo>
                  <a:lnTo>
                    <a:pt x="563" y="392"/>
                  </a:lnTo>
                  <a:lnTo>
                    <a:pt x="563" y="212"/>
                  </a:lnTo>
                  <a:close/>
                  <a:moveTo>
                    <a:pt x="1127" y="73"/>
                  </a:moveTo>
                  <a:lnTo>
                    <a:pt x="1189" y="73"/>
                  </a:lnTo>
                  <a:lnTo>
                    <a:pt x="1189" y="392"/>
                  </a:lnTo>
                  <a:lnTo>
                    <a:pt x="1127" y="392"/>
                  </a:lnTo>
                  <a:lnTo>
                    <a:pt x="1127" y="73"/>
                  </a:lnTo>
                  <a:close/>
                  <a:moveTo>
                    <a:pt x="1409" y="131"/>
                  </a:moveTo>
                  <a:lnTo>
                    <a:pt x="1471" y="131"/>
                  </a:lnTo>
                  <a:lnTo>
                    <a:pt x="1471" y="392"/>
                  </a:lnTo>
                  <a:lnTo>
                    <a:pt x="1409" y="392"/>
                  </a:lnTo>
                  <a:lnTo>
                    <a:pt x="1409" y="131"/>
                  </a:lnTo>
                  <a:close/>
                  <a:moveTo>
                    <a:pt x="1687" y="241"/>
                  </a:moveTo>
                  <a:lnTo>
                    <a:pt x="1753" y="241"/>
                  </a:lnTo>
                  <a:lnTo>
                    <a:pt x="1753" y="392"/>
                  </a:lnTo>
                  <a:lnTo>
                    <a:pt x="1687" y="392"/>
                  </a:lnTo>
                  <a:lnTo>
                    <a:pt x="1687" y="241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" name="Freeform 271"/>
            <p:cNvSpPr>
              <a:spLocks noEditPoints="1"/>
            </p:cNvSpPr>
            <p:nvPr/>
          </p:nvSpPr>
          <p:spPr bwMode="auto">
            <a:xfrm>
              <a:off x="4384676" y="5665788"/>
              <a:ext cx="2782888" cy="1012825"/>
            </a:xfrm>
            <a:custGeom>
              <a:avLst/>
              <a:gdLst>
                <a:gd name="T0" fmla="*/ 0 w 1753"/>
                <a:gd name="T1" fmla="*/ 319 h 638"/>
                <a:gd name="T2" fmla="*/ 62 w 1753"/>
                <a:gd name="T3" fmla="*/ 319 h 638"/>
                <a:gd name="T4" fmla="*/ 62 w 1753"/>
                <a:gd name="T5" fmla="*/ 638 h 638"/>
                <a:gd name="T6" fmla="*/ 0 w 1753"/>
                <a:gd name="T7" fmla="*/ 638 h 638"/>
                <a:gd name="T8" fmla="*/ 0 w 1753"/>
                <a:gd name="T9" fmla="*/ 319 h 638"/>
                <a:gd name="T10" fmla="*/ 282 w 1753"/>
                <a:gd name="T11" fmla="*/ 0 h 638"/>
                <a:gd name="T12" fmla="*/ 344 w 1753"/>
                <a:gd name="T13" fmla="*/ 0 h 638"/>
                <a:gd name="T14" fmla="*/ 344 w 1753"/>
                <a:gd name="T15" fmla="*/ 638 h 638"/>
                <a:gd name="T16" fmla="*/ 282 w 1753"/>
                <a:gd name="T17" fmla="*/ 638 h 638"/>
                <a:gd name="T18" fmla="*/ 282 w 1753"/>
                <a:gd name="T19" fmla="*/ 0 h 638"/>
                <a:gd name="T20" fmla="*/ 564 w 1753"/>
                <a:gd name="T21" fmla="*/ 352 h 638"/>
                <a:gd name="T22" fmla="*/ 626 w 1753"/>
                <a:gd name="T23" fmla="*/ 352 h 638"/>
                <a:gd name="T24" fmla="*/ 626 w 1753"/>
                <a:gd name="T25" fmla="*/ 638 h 638"/>
                <a:gd name="T26" fmla="*/ 564 w 1753"/>
                <a:gd name="T27" fmla="*/ 638 h 638"/>
                <a:gd name="T28" fmla="*/ 564 w 1753"/>
                <a:gd name="T29" fmla="*/ 352 h 638"/>
                <a:gd name="T30" fmla="*/ 1127 w 1753"/>
                <a:gd name="T31" fmla="*/ 319 h 638"/>
                <a:gd name="T32" fmla="*/ 1190 w 1753"/>
                <a:gd name="T33" fmla="*/ 319 h 638"/>
                <a:gd name="T34" fmla="*/ 1190 w 1753"/>
                <a:gd name="T35" fmla="*/ 638 h 638"/>
                <a:gd name="T36" fmla="*/ 1127 w 1753"/>
                <a:gd name="T37" fmla="*/ 638 h 638"/>
                <a:gd name="T38" fmla="*/ 1127 w 1753"/>
                <a:gd name="T39" fmla="*/ 319 h 638"/>
                <a:gd name="T40" fmla="*/ 1406 w 1753"/>
                <a:gd name="T41" fmla="*/ 385 h 638"/>
                <a:gd name="T42" fmla="*/ 1471 w 1753"/>
                <a:gd name="T43" fmla="*/ 385 h 638"/>
                <a:gd name="T44" fmla="*/ 1471 w 1753"/>
                <a:gd name="T45" fmla="*/ 638 h 638"/>
                <a:gd name="T46" fmla="*/ 1406 w 1753"/>
                <a:gd name="T47" fmla="*/ 638 h 638"/>
                <a:gd name="T48" fmla="*/ 1406 w 1753"/>
                <a:gd name="T49" fmla="*/ 385 h 638"/>
                <a:gd name="T50" fmla="*/ 1687 w 1753"/>
                <a:gd name="T51" fmla="*/ 575 h 638"/>
                <a:gd name="T52" fmla="*/ 1753 w 1753"/>
                <a:gd name="T53" fmla="*/ 575 h 638"/>
                <a:gd name="T54" fmla="*/ 1753 w 1753"/>
                <a:gd name="T55" fmla="*/ 638 h 638"/>
                <a:gd name="T56" fmla="*/ 1687 w 1753"/>
                <a:gd name="T57" fmla="*/ 638 h 638"/>
                <a:gd name="T58" fmla="*/ 1687 w 1753"/>
                <a:gd name="T59" fmla="*/ 575 h 6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638">
                  <a:moveTo>
                    <a:pt x="0" y="319"/>
                  </a:moveTo>
                  <a:lnTo>
                    <a:pt x="62" y="319"/>
                  </a:lnTo>
                  <a:lnTo>
                    <a:pt x="62" y="638"/>
                  </a:lnTo>
                  <a:lnTo>
                    <a:pt x="0" y="638"/>
                  </a:lnTo>
                  <a:lnTo>
                    <a:pt x="0" y="319"/>
                  </a:lnTo>
                  <a:close/>
                  <a:moveTo>
                    <a:pt x="282" y="0"/>
                  </a:moveTo>
                  <a:lnTo>
                    <a:pt x="344" y="0"/>
                  </a:lnTo>
                  <a:lnTo>
                    <a:pt x="344" y="638"/>
                  </a:lnTo>
                  <a:lnTo>
                    <a:pt x="282" y="638"/>
                  </a:lnTo>
                  <a:lnTo>
                    <a:pt x="282" y="0"/>
                  </a:lnTo>
                  <a:close/>
                  <a:moveTo>
                    <a:pt x="564" y="352"/>
                  </a:moveTo>
                  <a:lnTo>
                    <a:pt x="626" y="352"/>
                  </a:lnTo>
                  <a:lnTo>
                    <a:pt x="626" y="638"/>
                  </a:lnTo>
                  <a:lnTo>
                    <a:pt x="564" y="638"/>
                  </a:lnTo>
                  <a:lnTo>
                    <a:pt x="564" y="352"/>
                  </a:lnTo>
                  <a:close/>
                  <a:moveTo>
                    <a:pt x="1127" y="319"/>
                  </a:moveTo>
                  <a:lnTo>
                    <a:pt x="1190" y="319"/>
                  </a:lnTo>
                  <a:lnTo>
                    <a:pt x="1190" y="638"/>
                  </a:lnTo>
                  <a:lnTo>
                    <a:pt x="1127" y="638"/>
                  </a:lnTo>
                  <a:lnTo>
                    <a:pt x="1127" y="319"/>
                  </a:lnTo>
                  <a:close/>
                  <a:moveTo>
                    <a:pt x="1406" y="385"/>
                  </a:moveTo>
                  <a:lnTo>
                    <a:pt x="1471" y="385"/>
                  </a:lnTo>
                  <a:lnTo>
                    <a:pt x="1471" y="638"/>
                  </a:lnTo>
                  <a:lnTo>
                    <a:pt x="1406" y="638"/>
                  </a:lnTo>
                  <a:lnTo>
                    <a:pt x="1406" y="385"/>
                  </a:lnTo>
                  <a:close/>
                  <a:moveTo>
                    <a:pt x="1687" y="575"/>
                  </a:moveTo>
                  <a:lnTo>
                    <a:pt x="1753" y="575"/>
                  </a:lnTo>
                  <a:lnTo>
                    <a:pt x="1753" y="638"/>
                  </a:lnTo>
                  <a:lnTo>
                    <a:pt x="1687" y="638"/>
                  </a:lnTo>
                  <a:lnTo>
                    <a:pt x="1687" y="575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" name="Line 272"/>
            <p:cNvSpPr>
              <a:spLocks noChangeShapeType="1"/>
            </p:cNvSpPr>
            <p:nvPr/>
          </p:nvSpPr>
          <p:spPr bwMode="auto">
            <a:xfrm>
              <a:off x="4430713" y="6172200"/>
              <a:ext cx="0" cy="2032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" name="Line 273"/>
            <p:cNvSpPr>
              <a:spLocks noChangeShapeType="1"/>
            </p:cNvSpPr>
            <p:nvPr/>
          </p:nvSpPr>
          <p:spPr bwMode="auto">
            <a:xfrm flipV="1">
              <a:off x="4430713" y="5969000"/>
              <a:ext cx="0" cy="2032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" name="Line 274"/>
            <p:cNvSpPr>
              <a:spLocks noChangeShapeType="1"/>
            </p:cNvSpPr>
            <p:nvPr/>
          </p:nvSpPr>
          <p:spPr bwMode="auto">
            <a:xfrm>
              <a:off x="4413251" y="63754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" name="Line 275"/>
            <p:cNvSpPr>
              <a:spLocks noChangeShapeType="1"/>
            </p:cNvSpPr>
            <p:nvPr/>
          </p:nvSpPr>
          <p:spPr bwMode="auto">
            <a:xfrm>
              <a:off x="4413251" y="59690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" name="Line 276"/>
            <p:cNvSpPr>
              <a:spLocks noChangeShapeType="1"/>
            </p:cNvSpPr>
            <p:nvPr/>
          </p:nvSpPr>
          <p:spPr bwMode="auto">
            <a:xfrm>
              <a:off x="4878388" y="5665788"/>
              <a:ext cx="0" cy="984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" name="Line 277"/>
            <p:cNvSpPr>
              <a:spLocks noChangeShapeType="1"/>
            </p:cNvSpPr>
            <p:nvPr/>
          </p:nvSpPr>
          <p:spPr bwMode="auto">
            <a:xfrm flipV="1">
              <a:off x="4878388" y="5561013"/>
              <a:ext cx="0" cy="1047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" name="Line 278"/>
            <p:cNvSpPr>
              <a:spLocks noChangeShapeType="1"/>
            </p:cNvSpPr>
            <p:nvPr/>
          </p:nvSpPr>
          <p:spPr bwMode="auto">
            <a:xfrm>
              <a:off x="4856163" y="576421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" name="Line 279"/>
            <p:cNvSpPr>
              <a:spLocks noChangeShapeType="1"/>
            </p:cNvSpPr>
            <p:nvPr/>
          </p:nvSpPr>
          <p:spPr bwMode="auto">
            <a:xfrm>
              <a:off x="4856163" y="556101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" name="Line 280"/>
            <p:cNvSpPr>
              <a:spLocks noChangeShapeType="1"/>
            </p:cNvSpPr>
            <p:nvPr/>
          </p:nvSpPr>
          <p:spPr bwMode="auto">
            <a:xfrm>
              <a:off x="5326063" y="6224588"/>
              <a:ext cx="0" cy="3540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" name="Line 281"/>
            <p:cNvSpPr>
              <a:spLocks noChangeShapeType="1"/>
            </p:cNvSpPr>
            <p:nvPr/>
          </p:nvSpPr>
          <p:spPr bwMode="auto">
            <a:xfrm flipV="1">
              <a:off x="5326063" y="5868988"/>
              <a:ext cx="0" cy="3556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" name="Line 282"/>
            <p:cNvSpPr>
              <a:spLocks noChangeShapeType="1"/>
            </p:cNvSpPr>
            <p:nvPr/>
          </p:nvSpPr>
          <p:spPr bwMode="auto">
            <a:xfrm>
              <a:off x="5302251" y="6578600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" name="Line 283"/>
            <p:cNvSpPr>
              <a:spLocks noChangeShapeType="1"/>
            </p:cNvSpPr>
            <p:nvPr/>
          </p:nvSpPr>
          <p:spPr bwMode="auto">
            <a:xfrm>
              <a:off x="5302251" y="5868988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" name="Line 284"/>
            <p:cNvSpPr>
              <a:spLocks noChangeShapeType="1"/>
            </p:cNvSpPr>
            <p:nvPr/>
          </p:nvSpPr>
          <p:spPr bwMode="auto">
            <a:xfrm>
              <a:off x="6221413" y="6172200"/>
              <a:ext cx="0" cy="222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" name="Line 285"/>
            <p:cNvSpPr>
              <a:spLocks noChangeShapeType="1"/>
            </p:cNvSpPr>
            <p:nvPr/>
          </p:nvSpPr>
          <p:spPr bwMode="auto">
            <a:xfrm flipV="1">
              <a:off x="6221413" y="6148388"/>
              <a:ext cx="0" cy="238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" name="Line 286"/>
            <p:cNvSpPr>
              <a:spLocks noChangeShapeType="1"/>
            </p:cNvSpPr>
            <p:nvPr/>
          </p:nvSpPr>
          <p:spPr bwMode="auto">
            <a:xfrm>
              <a:off x="6197601" y="6194425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8" name="Line 287"/>
            <p:cNvSpPr>
              <a:spLocks noChangeShapeType="1"/>
            </p:cNvSpPr>
            <p:nvPr/>
          </p:nvSpPr>
          <p:spPr bwMode="auto">
            <a:xfrm>
              <a:off x="6197601" y="6148388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9" name="Line 288"/>
            <p:cNvSpPr>
              <a:spLocks noChangeShapeType="1"/>
            </p:cNvSpPr>
            <p:nvPr/>
          </p:nvSpPr>
          <p:spPr bwMode="auto">
            <a:xfrm>
              <a:off x="6667501" y="6270625"/>
              <a:ext cx="0" cy="2032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0" name="Line 289"/>
            <p:cNvSpPr>
              <a:spLocks noChangeShapeType="1"/>
            </p:cNvSpPr>
            <p:nvPr/>
          </p:nvSpPr>
          <p:spPr bwMode="auto">
            <a:xfrm flipV="1">
              <a:off x="6667501" y="6067425"/>
              <a:ext cx="0" cy="2032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1" name="Line 290"/>
            <p:cNvSpPr>
              <a:spLocks noChangeShapeType="1"/>
            </p:cNvSpPr>
            <p:nvPr/>
          </p:nvSpPr>
          <p:spPr bwMode="auto">
            <a:xfrm>
              <a:off x="6645276" y="64738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2" name="Line 291"/>
            <p:cNvSpPr>
              <a:spLocks noChangeShapeType="1"/>
            </p:cNvSpPr>
            <p:nvPr/>
          </p:nvSpPr>
          <p:spPr bwMode="auto">
            <a:xfrm>
              <a:off x="6645276" y="60674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3" name="Line 292"/>
            <p:cNvSpPr>
              <a:spLocks noChangeShapeType="1"/>
            </p:cNvSpPr>
            <p:nvPr/>
          </p:nvSpPr>
          <p:spPr bwMode="auto">
            <a:xfrm>
              <a:off x="7110413" y="6578600"/>
              <a:ext cx="0" cy="1000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4" name="Line 293"/>
            <p:cNvSpPr>
              <a:spLocks noChangeShapeType="1"/>
            </p:cNvSpPr>
            <p:nvPr/>
          </p:nvSpPr>
          <p:spPr bwMode="auto">
            <a:xfrm flipV="1">
              <a:off x="7110413" y="6473825"/>
              <a:ext cx="0" cy="1047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5" name="Line 294"/>
            <p:cNvSpPr>
              <a:spLocks noChangeShapeType="1"/>
            </p:cNvSpPr>
            <p:nvPr/>
          </p:nvSpPr>
          <p:spPr bwMode="auto">
            <a:xfrm>
              <a:off x="7092951" y="6678613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6" name="Line 295"/>
            <p:cNvSpPr>
              <a:spLocks noChangeShapeType="1"/>
            </p:cNvSpPr>
            <p:nvPr/>
          </p:nvSpPr>
          <p:spPr bwMode="auto">
            <a:xfrm>
              <a:off x="7092951" y="64738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7" name="Line 296"/>
            <p:cNvSpPr>
              <a:spLocks noChangeShapeType="1"/>
            </p:cNvSpPr>
            <p:nvPr/>
          </p:nvSpPr>
          <p:spPr bwMode="auto">
            <a:xfrm>
              <a:off x="4146551" y="6678613"/>
              <a:ext cx="3125788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8" name="Rectangle 297"/>
            <p:cNvSpPr>
              <a:spLocks noChangeArrowheads="1"/>
            </p:cNvSpPr>
            <p:nvPr/>
          </p:nvSpPr>
          <p:spPr bwMode="auto">
            <a:xfrm>
              <a:off x="4024313" y="6619875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299"/>
            <p:cNvSpPr>
              <a:spLocks noChangeArrowheads="1"/>
            </p:cNvSpPr>
            <p:nvPr/>
          </p:nvSpPr>
          <p:spPr bwMode="auto">
            <a:xfrm>
              <a:off x="4024313" y="6113463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301"/>
            <p:cNvSpPr>
              <a:spLocks noChangeArrowheads="1"/>
            </p:cNvSpPr>
            <p:nvPr/>
          </p:nvSpPr>
          <p:spPr bwMode="auto">
            <a:xfrm>
              <a:off x="4024313" y="5608638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303"/>
            <p:cNvSpPr>
              <a:spLocks noChangeArrowheads="1"/>
            </p:cNvSpPr>
            <p:nvPr/>
          </p:nvSpPr>
          <p:spPr bwMode="auto">
            <a:xfrm>
              <a:off x="4275138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304"/>
            <p:cNvSpPr>
              <a:spLocks noChangeArrowheads="1"/>
            </p:cNvSpPr>
            <p:nvPr/>
          </p:nvSpPr>
          <p:spPr bwMode="auto">
            <a:xfrm>
              <a:off x="4721226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305"/>
            <p:cNvSpPr>
              <a:spLocks noChangeArrowheads="1"/>
            </p:cNvSpPr>
            <p:nvPr/>
          </p:nvSpPr>
          <p:spPr bwMode="auto">
            <a:xfrm>
              <a:off x="5168901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306"/>
            <p:cNvSpPr>
              <a:spLocks noChangeArrowheads="1"/>
            </p:cNvSpPr>
            <p:nvPr/>
          </p:nvSpPr>
          <p:spPr bwMode="auto">
            <a:xfrm>
              <a:off x="6057901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307"/>
            <p:cNvSpPr>
              <a:spLocks noChangeArrowheads="1"/>
            </p:cNvSpPr>
            <p:nvPr/>
          </p:nvSpPr>
          <p:spPr bwMode="auto">
            <a:xfrm>
              <a:off x="6505576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308"/>
            <p:cNvSpPr>
              <a:spLocks noChangeArrowheads="1"/>
            </p:cNvSpPr>
            <p:nvPr/>
          </p:nvSpPr>
          <p:spPr bwMode="auto">
            <a:xfrm>
              <a:off x="6953251" y="6737350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309"/>
            <p:cNvSpPr>
              <a:spLocks noChangeArrowheads="1"/>
            </p:cNvSpPr>
            <p:nvPr/>
          </p:nvSpPr>
          <p:spPr bwMode="auto">
            <a:xfrm>
              <a:off x="5354638" y="5129213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Csa7M03158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49" name="Group 148"/>
          <p:cNvGrpSpPr/>
          <p:nvPr/>
        </p:nvGrpSpPr>
        <p:grpSpPr>
          <a:xfrm>
            <a:off x="3721591" y="4445259"/>
            <a:ext cx="2857891" cy="1300214"/>
            <a:chOff x="3743325" y="2852738"/>
            <a:chExt cx="3248026" cy="1736725"/>
          </a:xfrm>
        </p:grpSpPr>
        <p:sp>
          <p:nvSpPr>
            <p:cNvPr id="151" name="Freeform 180"/>
            <p:cNvSpPr>
              <a:spLocks noEditPoints="1"/>
            </p:cNvSpPr>
            <p:nvPr/>
          </p:nvSpPr>
          <p:spPr bwMode="auto">
            <a:xfrm>
              <a:off x="3976688" y="3749675"/>
              <a:ext cx="2782888" cy="652463"/>
            </a:xfrm>
            <a:custGeom>
              <a:avLst/>
              <a:gdLst>
                <a:gd name="T0" fmla="*/ 0 w 1753"/>
                <a:gd name="T1" fmla="*/ 147 h 411"/>
                <a:gd name="T2" fmla="*/ 65 w 1753"/>
                <a:gd name="T3" fmla="*/ 147 h 411"/>
                <a:gd name="T4" fmla="*/ 65 w 1753"/>
                <a:gd name="T5" fmla="*/ 411 h 411"/>
                <a:gd name="T6" fmla="*/ 0 w 1753"/>
                <a:gd name="T7" fmla="*/ 411 h 411"/>
                <a:gd name="T8" fmla="*/ 0 w 1753"/>
                <a:gd name="T9" fmla="*/ 147 h 411"/>
                <a:gd name="T10" fmla="*/ 281 w 1753"/>
                <a:gd name="T11" fmla="*/ 106 h 411"/>
                <a:gd name="T12" fmla="*/ 344 w 1753"/>
                <a:gd name="T13" fmla="*/ 106 h 411"/>
                <a:gd name="T14" fmla="*/ 344 w 1753"/>
                <a:gd name="T15" fmla="*/ 411 h 411"/>
                <a:gd name="T16" fmla="*/ 281 w 1753"/>
                <a:gd name="T17" fmla="*/ 411 h 411"/>
                <a:gd name="T18" fmla="*/ 281 w 1753"/>
                <a:gd name="T19" fmla="*/ 106 h 411"/>
                <a:gd name="T20" fmla="*/ 563 w 1753"/>
                <a:gd name="T21" fmla="*/ 59 h 411"/>
                <a:gd name="T22" fmla="*/ 625 w 1753"/>
                <a:gd name="T23" fmla="*/ 59 h 411"/>
                <a:gd name="T24" fmla="*/ 625 w 1753"/>
                <a:gd name="T25" fmla="*/ 411 h 411"/>
                <a:gd name="T26" fmla="*/ 563 w 1753"/>
                <a:gd name="T27" fmla="*/ 411 h 411"/>
                <a:gd name="T28" fmla="*/ 563 w 1753"/>
                <a:gd name="T29" fmla="*/ 59 h 411"/>
                <a:gd name="T30" fmla="*/ 1127 w 1753"/>
                <a:gd name="T31" fmla="*/ 147 h 411"/>
                <a:gd name="T32" fmla="*/ 1189 w 1753"/>
                <a:gd name="T33" fmla="*/ 147 h 411"/>
                <a:gd name="T34" fmla="*/ 1189 w 1753"/>
                <a:gd name="T35" fmla="*/ 411 h 411"/>
                <a:gd name="T36" fmla="*/ 1127 w 1753"/>
                <a:gd name="T37" fmla="*/ 411 h 411"/>
                <a:gd name="T38" fmla="*/ 1127 w 1753"/>
                <a:gd name="T39" fmla="*/ 147 h 411"/>
                <a:gd name="T40" fmla="*/ 1409 w 1753"/>
                <a:gd name="T41" fmla="*/ 0 h 411"/>
                <a:gd name="T42" fmla="*/ 1471 w 1753"/>
                <a:gd name="T43" fmla="*/ 0 h 411"/>
                <a:gd name="T44" fmla="*/ 1471 w 1753"/>
                <a:gd name="T45" fmla="*/ 411 h 411"/>
                <a:gd name="T46" fmla="*/ 1409 w 1753"/>
                <a:gd name="T47" fmla="*/ 411 h 411"/>
                <a:gd name="T48" fmla="*/ 1409 w 1753"/>
                <a:gd name="T49" fmla="*/ 0 h 411"/>
                <a:gd name="T50" fmla="*/ 1687 w 1753"/>
                <a:gd name="T51" fmla="*/ 191 h 411"/>
                <a:gd name="T52" fmla="*/ 1753 w 1753"/>
                <a:gd name="T53" fmla="*/ 191 h 411"/>
                <a:gd name="T54" fmla="*/ 1753 w 1753"/>
                <a:gd name="T55" fmla="*/ 411 h 411"/>
                <a:gd name="T56" fmla="*/ 1687 w 1753"/>
                <a:gd name="T57" fmla="*/ 411 h 411"/>
                <a:gd name="T58" fmla="*/ 1687 w 1753"/>
                <a:gd name="T59" fmla="*/ 191 h 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411">
                  <a:moveTo>
                    <a:pt x="0" y="147"/>
                  </a:moveTo>
                  <a:lnTo>
                    <a:pt x="65" y="147"/>
                  </a:lnTo>
                  <a:lnTo>
                    <a:pt x="65" y="411"/>
                  </a:lnTo>
                  <a:lnTo>
                    <a:pt x="0" y="411"/>
                  </a:lnTo>
                  <a:lnTo>
                    <a:pt x="0" y="147"/>
                  </a:lnTo>
                  <a:close/>
                  <a:moveTo>
                    <a:pt x="281" y="106"/>
                  </a:moveTo>
                  <a:lnTo>
                    <a:pt x="344" y="106"/>
                  </a:lnTo>
                  <a:lnTo>
                    <a:pt x="344" y="411"/>
                  </a:lnTo>
                  <a:lnTo>
                    <a:pt x="281" y="411"/>
                  </a:lnTo>
                  <a:lnTo>
                    <a:pt x="281" y="106"/>
                  </a:lnTo>
                  <a:close/>
                  <a:moveTo>
                    <a:pt x="563" y="59"/>
                  </a:moveTo>
                  <a:lnTo>
                    <a:pt x="625" y="59"/>
                  </a:lnTo>
                  <a:lnTo>
                    <a:pt x="625" y="411"/>
                  </a:lnTo>
                  <a:lnTo>
                    <a:pt x="563" y="411"/>
                  </a:lnTo>
                  <a:lnTo>
                    <a:pt x="563" y="59"/>
                  </a:lnTo>
                  <a:close/>
                  <a:moveTo>
                    <a:pt x="1127" y="147"/>
                  </a:moveTo>
                  <a:lnTo>
                    <a:pt x="1189" y="147"/>
                  </a:lnTo>
                  <a:lnTo>
                    <a:pt x="1189" y="411"/>
                  </a:lnTo>
                  <a:lnTo>
                    <a:pt x="1127" y="411"/>
                  </a:lnTo>
                  <a:lnTo>
                    <a:pt x="1127" y="147"/>
                  </a:lnTo>
                  <a:close/>
                  <a:moveTo>
                    <a:pt x="1409" y="0"/>
                  </a:moveTo>
                  <a:lnTo>
                    <a:pt x="1471" y="0"/>
                  </a:lnTo>
                  <a:lnTo>
                    <a:pt x="1471" y="411"/>
                  </a:lnTo>
                  <a:lnTo>
                    <a:pt x="1409" y="411"/>
                  </a:lnTo>
                  <a:lnTo>
                    <a:pt x="1409" y="0"/>
                  </a:lnTo>
                  <a:close/>
                  <a:moveTo>
                    <a:pt x="1687" y="191"/>
                  </a:moveTo>
                  <a:lnTo>
                    <a:pt x="1753" y="191"/>
                  </a:lnTo>
                  <a:lnTo>
                    <a:pt x="1753" y="411"/>
                  </a:lnTo>
                  <a:lnTo>
                    <a:pt x="1687" y="411"/>
                  </a:lnTo>
                  <a:lnTo>
                    <a:pt x="1687" y="191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" name="Freeform 181"/>
            <p:cNvSpPr>
              <a:spLocks noEditPoints="1"/>
            </p:cNvSpPr>
            <p:nvPr/>
          </p:nvSpPr>
          <p:spPr bwMode="auto">
            <a:xfrm>
              <a:off x="4103688" y="3557588"/>
              <a:ext cx="2782888" cy="844550"/>
            </a:xfrm>
            <a:custGeom>
              <a:avLst/>
              <a:gdLst>
                <a:gd name="T0" fmla="*/ 0 w 1753"/>
                <a:gd name="T1" fmla="*/ 268 h 532"/>
                <a:gd name="T2" fmla="*/ 62 w 1753"/>
                <a:gd name="T3" fmla="*/ 268 h 532"/>
                <a:gd name="T4" fmla="*/ 62 w 1753"/>
                <a:gd name="T5" fmla="*/ 532 h 532"/>
                <a:gd name="T6" fmla="*/ 0 w 1753"/>
                <a:gd name="T7" fmla="*/ 532 h 532"/>
                <a:gd name="T8" fmla="*/ 0 w 1753"/>
                <a:gd name="T9" fmla="*/ 268 h 532"/>
                <a:gd name="T10" fmla="*/ 282 w 1753"/>
                <a:gd name="T11" fmla="*/ 162 h 532"/>
                <a:gd name="T12" fmla="*/ 344 w 1753"/>
                <a:gd name="T13" fmla="*/ 162 h 532"/>
                <a:gd name="T14" fmla="*/ 344 w 1753"/>
                <a:gd name="T15" fmla="*/ 532 h 532"/>
                <a:gd name="T16" fmla="*/ 282 w 1753"/>
                <a:gd name="T17" fmla="*/ 532 h 532"/>
                <a:gd name="T18" fmla="*/ 282 w 1753"/>
                <a:gd name="T19" fmla="*/ 162 h 532"/>
                <a:gd name="T20" fmla="*/ 564 w 1753"/>
                <a:gd name="T21" fmla="*/ 0 h 532"/>
                <a:gd name="T22" fmla="*/ 626 w 1753"/>
                <a:gd name="T23" fmla="*/ 0 h 532"/>
                <a:gd name="T24" fmla="*/ 626 w 1753"/>
                <a:gd name="T25" fmla="*/ 532 h 532"/>
                <a:gd name="T26" fmla="*/ 564 w 1753"/>
                <a:gd name="T27" fmla="*/ 532 h 532"/>
                <a:gd name="T28" fmla="*/ 564 w 1753"/>
                <a:gd name="T29" fmla="*/ 0 h 532"/>
                <a:gd name="T30" fmla="*/ 1127 w 1753"/>
                <a:gd name="T31" fmla="*/ 268 h 532"/>
                <a:gd name="T32" fmla="*/ 1190 w 1753"/>
                <a:gd name="T33" fmla="*/ 268 h 532"/>
                <a:gd name="T34" fmla="*/ 1190 w 1753"/>
                <a:gd name="T35" fmla="*/ 532 h 532"/>
                <a:gd name="T36" fmla="*/ 1127 w 1753"/>
                <a:gd name="T37" fmla="*/ 532 h 532"/>
                <a:gd name="T38" fmla="*/ 1127 w 1753"/>
                <a:gd name="T39" fmla="*/ 268 h 532"/>
                <a:gd name="T40" fmla="*/ 1406 w 1753"/>
                <a:gd name="T41" fmla="*/ 162 h 532"/>
                <a:gd name="T42" fmla="*/ 1471 w 1753"/>
                <a:gd name="T43" fmla="*/ 162 h 532"/>
                <a:gd name="T44" fmla="*/ 1471 w 1753"/>
                <a:gd name="T45" fmla="*/ 532 h 532"/>
                <a:gd name="T46" fmla="*/ 1406 w 1753"/>
                <a:gd name="T47" fmla="*/ 532 h 532"/>
                <a:gd name="T48" fmla="*/ 1406 w 1753"/>
                <a:gd name="T49" fmla="*/ 162 h 532"/>
                <a:gd name="T50" fmla="*/ 1687 w 1753"/>
                <a:gd name="T51" fmla="*/ 425 h 532"/>
                <a:gd name="T52" fmla="*/ 1753 w 1753"/>
                <a:gd name="T53" fmla="*/ 425 h 532"/>
                <a:gd name="T54" fmla="*/ 1753 w 1753"/>
                <a:gd name="T55" fmla="*/ 532 h 532"/>
                <a:gd name="T56" fmla="*/ 1687 w 1753"/>
                <a:gd name="T57" fmla="*/ 532 h 532"/>
                <a:gd name="T58" fmla="*/ 1687 w 1753"/>
                <a:gd name="T59" fmla="*/ 425 h 5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532">
                  <a:moveTo>
                    <a:pt x="0" y="268"/>
                  </a:moveTo>
                  <a:lnTo>
                    <a:pt x="62" y="268"/>
                  </a:lnTo>
                  <a:lnTo>
                    <a:pt x="62" y="532"/>
                  </a:lnTo>
                  <a:lnTo>
                    <a:pt x="0" y="532"/>
                  </a:lnTo>
                  <a:lnTo>
                    <a:pt x="0" y="268"/>
                  </a:lnTo>
                  <a:close/>
                  <a:moveTo>
                    <a:pt x="282" y="162"/>
                  </a:moveTo>
                  <a:lnTo>
                    <a:pt x="344" y="162"/>
                  </a:lnTo>
                  <a:lnTo>
                    <a:pt x="344" y="532"/>
                  </a:lnTo>
                  <a:lnTo>
                    <a:pt x="282" y="532"/>
                  </a:lnTo>
                  <a:lnTo>
                    <a:pt x="282" y="162"/>
                  </a:lnTo>
                  <a:close/>
                  <a:moveTo>
                    <a:pt x="564" y="0"/>
                  </a:moveTo>
                  <a:lnTo>
                    <a:pt x="626" y="0"/>
                  </a:lnTo>
                  <a:lnTo>
                    <a:pt x="626" y="532"/>
                  </a:lnTo>
                  <a:lnTo>
                    <a:pt x="564" y="532"/>
                  </a:lnTo>
                  <a:lnTo>
                    <a:pt x="564" y="0"/>
                  </a:lnTo>
                  <a:close/>
                  <a:moveTo>
                    <a:pt x="1127" y="268"/>
                  </a:moveTo>
                  <a:lnTo>
                    <a:pt x="1190" y="268"/>
                  </a:lnTo>
                  <a:lnTo>
                    <a:pt x="1190" y="532"/>
                  </a:lnTo>
                  <a:lnTo>
                    <a:pt x="1127" y="532"/>
                  </a:lnTo>
                  <a:lnTo>
                    <a:pt x="1127" y="268"/>
                  </a:lnTo>
                  <a:close/>
                  <a:moveTo>
                    <a:pt x="1406" y="162"/>
                  </a:moveTo>
                  <a:lnTo>
                    <a:pt x="1471" y="162"/>
                  </a:lnTo>
                  <a:lnTo>
                    <a:pt x="1471" y="532"/>
                  </a:lnTo>
                  <a:lnTo>
                    <a:pt x="1406" y="532"/>
                  </a:lnTo>
                  <a:lnTo>
                    <a:pt x="1406" y="162"/>
                  </a:lnTo>
                  <a:close/>
                  <a:moveTo>
                    <a:pt x="1687" y="425"/>
                  </a:moveTo>
                  <a:lnTo>
                    <a:pt x="1753" y="425"/>
                  </a:lnTo>
                  <a:lnTo>
                    <a:pt x="1753" y="532"/>
                  </a:lnTo>
                  <a:lnTo>
                    <a:pt x="1687" y="532"/>
                  </a:lnTo>
                  <a:lnTo>
                    <a:pt x="1687" y="425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" name="Line 182"/>
            <p:cNvSpPr>
              <a:spLocks noChangeShapeType="1"/>
            </p:cNvSpPr>
            <p:nvPr/>
          </p:nvSpPr>
          <p:spPr bwMode="auto">
            <a:xfrm>
              <a:off x="4149725" y="3976688"/>
              <a:ext cx="0" cy="168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" name="Line 183"/>
            <p:cNvSpPr>
              <a:spLocks noChangeShapeType="1"/>
            </p:cNvSpPr>
            <p:nvPr/>
          </p:nvSpPr>
          <p:spPr bwMode="auto">
            <a:xfrm flipV="1">
              <a:off x="4149725" y="3808413"/>
              <a:ext cx="0" cy="168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" name="Line 184"/>
            <p:cNvSpPr>
              <a:spLocks noChangeShapeType="1"/>
            </p:cNvSpPr>
            <p:nvPr/>
          </p:nvSpPr>
          <p:spPr bwMode="auto">
            <a:xfrm>
              <a:off x="4132263" y="414496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" name="Line 185"/>
            <p:cNvSpPr>
              <a:spLocks noChangeShapeType="1"/>
            </p:cNvSpPr>
            <p:nvPr/>
          </p:nvSpPr>
          <p:spPr bwMode="auto">
            <a:xfrm>
              <a:off x="4132263" y="380841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" name="Line 186"/>
            <p:cNvSpPr>
              <a:spLocks noChangeShapeType="1"/>
            </p:cNvSpPr>
            <p:nvPr/>
          </p:nvSpPr>
          <p:spPr bwMode="auto">
            <a:xfrm>
              <a:off x="4597400" y="3808413"/>
              <a:ext cx="0" cy="873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" name="Line 187"/>
            <p:cNvSpPr>
              <a:spLocks noChangeShapeType="1"/>
            </p:cNvSpPr>
            <p:nvPr/>
          </p:nvSpPr>
          <p:spPr bwMode="auto">
            <a:xfrm flipV="1">
              <a:off x="4597400" y="3727450"/>
              <a:ext cx="0" cy="809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" name="Line 188"/>
            <p:cNvSpPr>
              <a:spLocks noChangeShapeType="1"/>
            </p:cNvSpPr>
            <p:nvPr/>
          </p:nvSpPr>
          <p:spPr bwMode="auto">
            <a:xfrm>
              <a:off x="4575175" y="3895725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" name="Line 189"/>
            <p:cNvSpPr>
              <a:spLocks noChangeShapeType="1"/>
            </p:cNvSpPr>
            <p:nvPr/>
          </p:nvSpPr>
          <p:spPr bwMode="auto">
            <a:xfrm>
              <a:off x="4575175" y="3727450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" name="Line 190"/>
            <p:cNvSpPr>
              <a:spLocks noChangeShapeType="1"/>
            </p:cNvSpPr>
            <p:nvPr/>
          </p:nvSpPr>
          <p:spPr bwMode="auto">
            <a:xfrm>
              <a:off x="5045075" y="3557588"/>
              <a:ext cx="0" cy="2968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2" name="Line 191"/>
            <p:cNvSpPr>
              <a:spLocks noChangeShapeType="1"/>
            </p:cNvSpPr>
            <p:nvPr/>
          </p:nvSpPr>
          <p:spPr bwMode="auto">
            <a:xfrm flipV="1">
              <a:off x="5045075" y="3260725"/>
              <a:ext cx="0" cy="2968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3" name="Line 192"/>
            <p:cNvSpPr>
              <a:spLocks noChangeShapeType="1"/>
            </p:cNvSpPr>
            <p:nvPr/>
          </p:nvSpPr>
          <p:spPr bwMode="auto">
            <a:xfrm>
              <a:off x="5021263" y="3854450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4" name="Line 193"/>
            <p:cNvSpPr>
              <a:spLocks noChangeShapeType="1"/>
            </p:cNvSpPr>
            <p:nvPr/>
          </p:nvSpPr>
          <p:spPr bwMode="auto">
            <a:xfrm>
              <a:off x="5021263" y="326072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5" name="Line 194"/>
            <p:cNvSpPr>
              <a:spLocks noChangeShapeType="1"/>
            </p:cNvSpPr>
            <p:nvPr/>
          </p:nvSpPr>
          <p:spPr bwMode="auto">
            <a:xfrm>
              <a:off x="5940425" y="3976688"/>
              <a:ext cx="0" cy="238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6" name="Line 195"/>
            <p:cNvSpPr>
              <a:spLocks noChangeShapeType="1"/>
            </p:cNvSpPr>
            <p:nvPr/>
          </p:nvSpPr>
          <p:spPr bwMode="auto">
            <a:xfrm flipV="1">
              <a:off x="5940425" y="3959225"/>
              <a:ext cx="0" cy="1746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7" name="Line 196"/>
            <p:cNvSpPr>
              <a:spLocks noChangeShapeType="1"/>
            </p:cNvSpPr>
            <p:nvPr/>
          </p:nvSpPr>
          <p:spPr bwMode="auto">
            <a:xfrm>
              <a:off x="5916613" y="40005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8" name="Line 197"/>
            <p:cNvSpPr>
              <a:spLocks noChangeShapeType="1"/>
            </p:cNvSpPr>
            <p:nvPr/>
          </p:nvSpPr>
          <p:spPr bwMode="auto">
            <a:xfrm>
              <a:off x="5916613" y="3959225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9" name="Line 198"/>
            <p:cNvSpPr>
              <a:spLocks noChangeShapeType="1"/>
            </p:cNvSpPr>
            <p:nvPr/>
          </p:nvSpPr>
          <p:spPr bwMode="auto">
            <a:xfrm>
              <a:off x="6386513" y="3808413"/>
              <a:ext cx="0" cy="168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0" name="Line 199"/>
            <p:cNvSpPr>
              <a:spLocks noChangeShapeType="1"/>
            </p:cNvSpPr>
            <p:nvPr/>
          </p:nvSpPr>
          <p:spPr bwMode="auto">
            <a:xfrm flipV="1">
              <a:off x="6386513" y="3640138"/>
              <a:ext cx="0" cy="168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1" name="Line 200"/>
            <p:cNvSpPr>
              <a:spLocks noChangeShapeType="1"/>
            </p:cNvSpPr>
            <p:nvPr/>
          </p:nvSpPr>
          <p:spPr bwMode="auto">
            <a:xfrm>
              <a:off x="6364288" y="397668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2" name="Line 201"/>
            <p:cNvSpPr>
              <a:spLocks noChangeShapeType="1"/>
            </p:cNvSpPr>
            <p:nvPr/>
          </p:nvSpPr>
          <p:spPr bwMode="auto">
            <a:xfrm>
              <a:off x="6364288" y="364013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3" name="Line 202"/>
            <p:cNvSpPr>
              <a:spLocks noChangeShapeType="1"/>
            </p:cNvSpPr>
            <p:nvPr/>
          </p:nvSpPr>
          <p:spPr bwMode="auto">
            <a:xfrm>
              <a:off x="6829425" y="4232275"/>
              <a:ext cx="0" cy="12858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4" name="Line 203"/>
            <p:cNvSpPr>
              <a:spLocks noChangeShapeType="1"/>
            </p:cNvSpPr>
            <p:nvPr/>
          </p:nvSpPr>
          <p:spPr bwMode="auto">
            <a:xfrm flipV="1">
              <a:off x="6829425" y="4105275"/>
              <a:ext cx="0" cy="12700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5" name="Line 204"/>
            <p:cNvSpPr>
              <a:spLocks noChangeShapeType="1"/>
            </p:cNvSpPr>
            <p:nvPr/>
          </p:nvSpPr>
          <p:spPr bwMode="auto">
            <a:xfrm>
              <a:off x="6811963" y="4360863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6" name="Line 205"/>
            <p:cNvSpPr>
              <a:spLocks noChangeShapeType="1"/>
            </p:cNvSpPr>
            <p:nvPr/>
          </p:nvSpPr>
          <p:spPr bwMode="auto">
            <a:xfrm>
              <a:off x="6811963" y="410527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7" name="Line 206"/>
            <p:cNvSpPr>
              <a:spLocks noChangeShapeType="1"/>
            </p:cNvSpPr>
            <p:nvPr/>
          </p:nvSpPr>
          <p:spPr bwMode="auto">
            <a:xfrm>
              <a:off x="3865563" y="4402138"/>
              <a:ext cx="3125788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8" name="Rectangle 207"/>
            <p:cNvSpPr>
              <a:spLocks noChangeArrowheads="1"/>
            </p:cNvSpPr>
            <p:nvPr/>
          </p:nvSpPr>
          <p:spPr bwMode="auto">
            <a:xfrm>
              <a:off x="3743325" y="4343400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209"/>
            <p:cNvSpPr>
              <a:spLocks noChangeArrowheads="1"/>
            </p:cNvSpPr>
            <p:nvPr/>
          </p:nvSpPr>
          <p:spPr bwMode="auto">
            <a:xfrm>
              <a:off x="3743325" y="3924300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Rectangle 211"/>
            <p:cNvSpPr>
              <a:spLocks noChangeArrowheads="1"/>
            </p:cNvSpPr>
            <p:nvPr/>
          </p:nvSpPr>
          <p:spPr bwMode="auto">
            <a:xfrm>
              <a:off x="3743325" y="3500438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Rectangle 213"/>
            <p:cNvSpPr>
              <a:spLocks noChangeArrowheads="1"/>
            </p:cNvSpPr>
            <p:nvPr/>
          </p:nvSpPr>
          <p:spPr bwMode="auto">
            <a:xfrm>
              <a:off x="3743325" y="3081338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Rectangle 214"/>
            <p:cNvSpPr>
              <a:spLocks noChangeArrowheads="1"/>
            </p:cNvSpPr>
            <p:nvPr/>
          </p:nvSpPr>
          <p:spPr bwMode="auto">
            <a:xfrm>
              <a:off x="3994150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Rectangle 215"/>
            <p:cNvSpPr>
              <a:spLocks noChangeArrowheads="1"/>
            </p:cNvSpPr>
            <p:nvPr/>
          </p:nvSpPr>
          <p:spPr bwMode="auto">
            <a:xfrm>
              <a:off x="4440238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216"/>
            <p:cNvSpPr>
              <a:spLocks noChangeArrowheads="1"/>
            </p:cNvSpPr>
            <p:nvPr/>
          </p:nvSpPr>
          <p:spPr bwMode="auto">
            <a:xfrm>
              <a:off x="4887913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Rectangle 217"/>
            <p:cNvSpPr>
              <a:spLocks noChangeArrowheads="1"/>
            </p:cNvSpPr>
            <p:nvPr/>
          </p:nvSpPr>
          <p:spPr bwMode="auto">
            <a:xfrm>
              <a:off x="5776913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Rectangle 218"/>
            <p:cNvSpPr>
              <a:spLocks noChangeArrowheads="1"/>
            </p:cNvSpPr>
            <p:nvPr/>
          </p:nvSpPr>
          <p:spPr bwMode="auto">
            <a:xfrm>
              <a:off x="6224588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Rectangle 219"/>
            <p:cNvSpPr>
              <a:spLocks noChangeArrowheads="1"/>
            </p:cNvSpPr>
            <p:nvPr/>
          </p:nvSpPr>
          <p:spPr bwMode="auto">
            <a:xfrm>
              <a:off x="6672263" y="4460875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220"/>
            <p:cNvSpPr>
              <a:spLocks noChangeArrowheads="1"/>
            </p:cNvSpPr>
            <p:nvPr/>
          </p:nvSpPr>
          <p:spPr bwMode="auto">
            <a:xfrm>
              <a:off x="5073650" y="2852738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 smtClean="0">
                  <a:solidFill>
                    <a:srgbClr val="595959"/>
                  </a:solidFill>
                  <a:latin typeface="Calibri" panose="020F0502020204030204" pitchFamily="34" charset="0"/>
                </a:rPr>
                <a:t>Csa2M05505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90" name="Group 189"/>
          <p:cNvGrpSpPr/>
          <p:nvPr/>
        </p:nvGrpSpPr>
        <p:grpSpPr>
          <a:xfrm>
            <a:off x="3721591" y="2802661"/>
            <a:ext cx="2857891" cy="1301403"/>
            <a:chOff x="4313238" y="452438"/>
            <a:chExt cx="3248026" cy="1738313"/>
          </a:xfrm>
        </p:grpSpPr>
        <p:sp>
          <p:nvSpPr>
            <p:cNvPr id="192" name="Freeform 65"/>
            <p:cNvSpPr>
              <a:spLocks noEditPoints="1"/>
            </p:cNvSpPr>
            <p:nvPr/>
          </p:nvSpPr>
          <p:spPr bwMode="auto">
            <a:xfrm>
              <a:off x="4546601" y="1111250"/>
              <a:ext cx="2782888" cy="892175"/>
            </a:xfrm>
            <a:custGeom>
              <a:avLst/>
              <a:gdLst>
                <a:gd name="T0" fmla="*/ 0 w 1753"/>
                <a:gd name="T1" fmla="*/ 242 h 562"/>
                <a:gd name="T2" fmla="*/ 65 w 1753"/>
                <a:gd name="T3" fmla="*/ 242 h 562"/>
                <a:gd name="T4" fmla="*/ 65 w 1753"/>
                <a:gd name="T5" fmla="*/ 562 h 562"/>
                <a:gd name="T6" fmla="*/ 0 w 1753"/>
                <a:gd name="T7" fmla="*/ 562 h 562"/>
                <a:gd name="T8" fmla="*/ 0 w 1753"/>
                <a:gd name="T9" fmla="*/ 242 h 562"/>
                <a:gd name="T10" fmla="*/ 281 w 1753"/>
                <a:gd name="T11" fmla="*/ 235 h 562"/>
                <a:gd name="T12" fmla="*/ 344 w 1753"/>
                <a:gd name="T13" fmla="*/ 235 h 562"/>
                <a:gd name="T14" fmla="*/ 344 w 1753"/>
                <a:gd name="T15" fmla="*/ 562 h 562"/>
                <a:gd name="T16" fmla="*/ 281 w 1753"/>
                <a:gd name="T17" fmla="*/ 562 h 562"/>
                <a:gd name="T18" fmla="*/ 281 w 1753"/>
                <a:gd name="T19" fmla="*/ 235 h 562"/>
                <a:gd name="T20" fmla="*/ 563 w 1753"/>
                <a:gd name="T21" fmla="*/ 338 h 562"/>
                <a:gd name="T22" fmla="*/ 625 w 1753"/>
                <a:gd name="T23" fmla="*/ 338 h 562"/>
                <a:gd name="T24" fmla="*/ 625 w 1753"/>
                <a:gd name="T25" fmla="*/ 562 h 562"/>
                <a:gd name="T26" fmla="*/ 563 w 1753"/>
                <a:gd name="T27" fmla="*/ 562 h 562"/>
                <a:gd name="T28" fmla="*/ 563 w 1753"/>
                <a:gd name="T29" fmla="*/ 338 h 562"/>
                <a:gd name="T30" fmla="*/ 1127 w 1753"/>
                <a:gd name="T31" fmla="*/ 242 h 562"/>
                <a:gd name="T32" fmla="*/ 1189 w 1753"/>
                <a:gd name="T33" fmla="*/ 242 h 562"/>
                <a:gd name="T34" fmla="*/ 1189 w 1753"/>
                <a:gd name="T35" fmla="*/ 562 h 562"/>
                <a:gd name="T36" fmla="*/ 1127 w 1753"/>
                <a:gd name="T37" fmla="*/ 562 h 562"/>
                <a:gd name="T38" fmla="*/ 1127 w 1753"/>
                <a:gd name="T39" fmla="*/ 242 h 562"/>
                <a:gd name="T40" fmla="*/ 1409 w 1753"/>
                <a:gd name="T41" fmla="*/ 0 h 562"/>
                <a:gd name="T42" fmla="*/ 1471 w 1753"/>
                <a:gd name="T43" fmla="*/ 0 h 562"/>
                <a:gd name="T44" fmla="*/ 1471 w 1753"/>
                <a:gd name="T45" fmla="*/ 562 h 562"/>
                <a:gd name="T46" fmla="*/ 1409 w 1753"/>
                <a:gd name="T47" fmla="*/ 562 h 562"/>
                <a:gd name="T48" fmla="*/ 1409 w 1753"/>
                <a:gd name="T49" fmla="*/ 0 h 562"/>
                <a:gd name="T50" fmla="*/ 1687 w 1753"/>
                <a:gd name="T51" fmla="*/ 316 h 562"/>
                <a:gd name="T52" fmla="*/ 1753 w 1753"/>
                <a:gd name="T53" fmla="*/ 316 h 562"/>
                <a:gd name="T54" fmla="*/ 1753 w 1753"/>
                <a:gd name="T55" fmla="*/ 562 h 562"/>
                <a:gd name="T56" fmla="*/ 1687 w 1753"/>
                <a:gd name="T57" fmla="*/ 562 h 562"/>
                <a:gd name="T58" fmla="*/ 1687 w 1753"/>
                <a:gd name="T59" fmla="*/ 316 h 5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562">
                  <a:moveTo>
                    <a:pt x="0" y="242"/>
                  </a:moveTo>
                  <a:lnTo>
                    <a:pt x="65" y="242"/>
                  </a:lnTo>
                  <a:lnTo>
                    <a:pt x="65" y="562"/>
                  </a:lnTo>
                  <a:lnTo>
                    <a:pt x="0" y="562"/>
                  </a:lnTo>
                  <a:lnTo>
                    <a:pt x="0" y="242"/>
                  </a:lnTo>
                  <a:close/>
                  <a:moveTo>
                    <a:pt x="281" y="235"/>
                  </a:moveTo>
                  <a:lnTo>
                    <a:pt x="344" y="235"/>
                  </a:lnTo>
                  <a:lnTo>
                    <a:pt x="344" y="562"/>
                  </a:lnTo>
                  <a:lnTo>
                    <a:pt x="281" y="562"/>
                  </a:lnTo>
                  <a:lnTo>
                    <a:pt x="281" y="235"/>
                  </a:lnTo>
                  <a:close/>
                  <a:moveTo>
                    <a:pt x="563" y="338"/>
                  </a:moveTo>
                  <a:lnTo>
                    <a:pt x="625" y="338"/>
                  </a:lnTo>
                  <a:lnTo>
                    <a:pt x="625" y="562"/>
                  </a:lnTo>
                  <a:lnTo>
                    <a:pt x="563" y="562"/>
                  </a:lnTo>
                  <a:lnTo>
                    <a:pt x="563" y="338"/>
                  </a:lnTo>
                  <a:close/>
                  <a:moveTo>
                    <a:pt x="1127" y="242"/>
                  </a:moveTo>
                  <a:lnTo>
                    <a:pt x="1189" y="242"/>
                  </a:lnTo>
                  <a:lnTo>
                    <a:pt x="1189" y="562"/>
                  </a:lnTo>
                  <a:lnTo>
                    <a:pt x="1127" y="562"/>
                  </a:lnTo>
                  <a:lnTo>
                    <a:pt x="1127" y="242"/>
                  </a:lnTo>
                  <a:close/>
                  <a:moveTo>
                    <a:pt x="1409" y="0"/>
                  </a:moveTo>
                  <a:lnTo>
                    <a:pt x="1471" y="0"/>
                  </a:lnTo>
                  <a:lnTo>
                    <a:pt x="1471" y="562"/>
                  </a:lnTo>
                  <a:lnTo>
                    <a:pt x="1409" y="562"/>
                  </a:lnTo>
                  <a:lnTo>
                    <a:pt x="1409" y="0"/>
                  </a:lnTo>
                  <a:close/>
                  <a:moveTo>
                    <a:pt x="1687" y="316"/>
                  </a:moveTo>
                  <a:lnTo>
                    <a:pt x="1753" y="316"/>
                  </a:lnTo>
                  <a:lnTo>
                    <a:pt x="1753" y="562"/>
                  </a:lnTo>
                  <a:lnTo>
                    <a:pt x="1687" y="562"/>
                  </a:lnTo>
                  <a:lnTo>
                    <a:pt x="1687" y="316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3" name="Freeform 66"/>
            <p:cNvSpPr>
              <a:spLocks noEditPoints="1"/>
            </p:cNvSpPr>
            <p:nvPr/>
          </p:nvSpPr>
          <p:spPr bwMode="auto">
            <a:xfrm>
              <a:off x="4673601" y="989013"/>
              <a:ext cx="2782888" cy="1014413"/>
            </a:xfrm>
            <a:custGeom>
              <a:avLst/>
              <a:gdLst>
                <a:gd name="T0" fmla="*/ 0 w 1753"/>
                <a:gd name="T1" fmla="*/ 319 h 639"/>
                <a:gd name="T2" fmla="*/ 62 w 1753"/>
                <a:gd name="T3" fmla="*/ 319 h 639"/>
                <a:gd name="T4" fmla="*/ 62 w 1753"/>
                <a:gd name="T5" fmla="*/ 639 h 639"/>
                <a:gd name="T6" fmla="*/ 0 w 1753"/>
                <a:gd name="T7" fmla="*/ 639 h 639"/>
                <a:gd name="T8" fmla="*/ 0 w 1753"/>
                <a:gd name="T9" fmla="*/ 319 h 639"/>
                <a:gd name="T10" fmla="*/ 282 w 1753"/>
                <a:gd name="T11" fmla="*/ 162 h 639"/>
                <a:gd name="T12" fmla="*/ 344 w 1753"/>
                <a:gd name="T13" fmla="*/ 162 h 639"/>
                <a:gd name="T14" fmla="*/ 344 w 1753"/>
                <a:gd name="T15" fmla="*/ 639 h 639"/>
                <a:gd name="T16" fmla="*/ 282 w 1753"/>
                <a:gd name="T17" fmla="*/ 639 h 639"/>
                <a:gd name="T18" fmla="*/ 282 w 1753"/>
                <a:gd name="T19" fmla="*/ 162 h 639"/>
                <a:gd name="T20" fmla="*/ 564 w 1753"/>
                <a:gd name="T21" fmla="*/ 481 h 639"/>
                <a:gd name="T22" fmla="*/ 626 w 1753"/>
                <a:gd name="T23" fmla="*/ 481 h 639"/>
                <a:gd name="T24" fmla="*/ 626 w 1753"/>
                <a:gd name="T25" fmla="*/ 639 h 639"/>
                <a:gd name="T26" fmla="*/ 564 w 1753"/>
                <a:gd name="T27" fmla="*/ 639 h 639"/>
                <a:gd name="T28" fmla="*/ 564 w 1753"/>
                <a:gd name="T29" fmla="*/ 481 h 639"/>
                <a:gd name="T30" fmla="*/ 1127 w 1753"/>
                <a:gd name="T31" fmla="*/ 319 h 639"/>
                <a:gd name="T32" fmla="*/ 1190 w 1753"/>
                <a:gd name="T33" fmla="*/ 319 h 639"/>
                <a:gd name="T34" fmla="*/ 1190 w 1753"/>
                <a:gd name="T35" fmla="*/ 639 h 639"/>
                <a:gd name="T36" fmla="*/ 1127 w 1753"/>
                <a:gd name="T37" fmla="*/ 639 h 639"/>
                <a:gd name="T38" fmla="*/ 1127 w 1753"/>
                <a:gd name="T39" fmla="*/ 319 h 639"/>
                <a:gd name="T40" fmla="*/ 1406 w 1753"/>
                <a:gd name="T41" fmla="*/ 0 h 639"/>
                <a:gd name="T42" fmla="*/ 1471 w 1753"/>
                <a:gd name="T43" fmla="*/ 0 h 639"/>
                <a:gd name="T44" fmla="*/ 1471 w 1753"/>
                <a:gd name="T45" fmla="*/ 639 h 639"/>
                <a:gd name="T46" fmla="*/ 1406 w 1753"/>
                <a:gd name="T47" fmla="*/ 639 h 639"/>
                <a:gd name="T48" fmla="*/ 1406 w 1753"/>
                <a:gd name="T49" fmla="*/ 0 h 639"/>
                <a:gd name="T50" fmla="*/ 1687 w 1753"/>
                <a:gd name="T51" fmla="*/ 576 h 639"/>
                <a:gd name="T52" fmla="*/ 1753 w 1753"/>
                <a:gd name="T53" fmla="*/ 576 h 639"/>
                <a:gd name="T54" fmla="*/ 1753 w 1753"/>
                <a:gd name="T55" fmla="*/ 639 h 639"/>
                <a:gd name="T56" fmla="*/ 1687 w 1753"/>
                <a:gd name="T57" fmla="*/ 639 h 639"/>
                <a:gd name="T58" fmla="*/ 1687 w 1753"/>
                <a:gd name="T59" fmla="*/ 576 h 6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639">
                  <a:moveTo>
                    <a:pt x="0" y="319"/>
                  </a:moveTo>
                  <a:lnTo>
                    <a:pt x="62" y="319"/>
                  </a:lnTo>
                  <a:lnTo>
                    <a:pt x="62" y="639"/>
                  </a:lnTo>
                  <a:lnTo>
                    <a:pt x="0" y="639"/>
                  </a:lnTo>
                  <a:lnTo>
                    <a:pt x="0" y="319"/>
                  </a:lnTo>
                  <a:close/>
                  <a:moveTo>
                    <a:pt x="282" y="162"/>
                  </a:moveTo>
                  <a:lnTo>
                    <a:pt x="344" y="162"/>
                  </a:lnTo>
                  <a:lnTo>
                    <a:pt x="344" y="639"/>
                  </a:lnTo>
                  <a:lnTo>
                    <a:pt x="282" y="639"/>
                  </a:lnTo>
                  <a:lnTo>
                    <a:pt x="282" y="162"/>
                  </a:lnTo>
                  <a:close/>
                  <a:moveTo>
                    <a:pt x="564" y="481"/>
                  </a:moveTo>
                  <a:lnTo>
                    <a:pt x="626" y="481"/>
                  </a:lnTo>
                  <a:lnTo>
                    <a:pt x="626" y="639"/>
                  </a:lnTo>
                  <a:lnTo>
                    <a:pt x="564" y="639"/>
                  </a:lnTo>
                  <a:lnTo>
                    <a:pt x="564" y="481"/>
                  </a:lnTo>
                  <a:close/>
                  <a:moveTo>
                    <a:pt x="1127" y="319"/>
                  </a:moveTo>
                  <a:lnTo>
                    <a:pt x="1190" y="319"/>
                  </a:lnTo>
                  <a:lnTo>
                    <a:pt x="1190" y="639"/>
                  </a:lnTo>
                  <a:lnTo>
                    <a:pt x="1127" y="639"/>
                  </a:lnTo>
                  <a:lnTo>
                    <a:pt x="1127" y="319"/>
                  </a:lnTo>
                  <a:close/>
                  <a:moveTo>
                    <a:pt x="1406" y="0"/>
                  </a:moveTo>
                  <a:lnTo>
                    <a:pt x="1471" y="0"/>
                  </a:lnTo>
                  <a:lnTo>
                    <a:pt x="1471" y="639"/>
                  </a:lnTo>
                  <a:lnTo>
                    <a:pt x="1406" y="639"/>
                  </a:lnTo>
                  <a:lnTo>
                    <a:pt x="1406" y="0"/>
                  </a:lnTo>
                  <a:close/>
                  <a:moveTo>
                    <a:pt x="1687" y="576"/>
                  </a:moveTo>
                  <a:lnTo>
                    <a:pt x="1753" y="576"/>
                  </a:lnTo>
                  <a:lnTo>
                    <a:pt x="1753" y="639"/>
                  </a:lnTo>
                  <a:lnTo>
                    <a:pt x="1687" y="639"/>
                  </a:lnTo>
                  <a:lnTo>
                    <a:pt x="1687" y="576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4" name="Line 67"/>
            <p:cNvSpPr>
              <a:spLocks noChangeShapeType="1"/>
            </p:cNvSpPr>
            <p:nvPr/>
          </p:nvSpPr>
          <p:spPr bwMode="auto">
            <a:xfrm>
              <a:off x="4719638" y="1495425"/>
              <a:ext cx="0" cy="1000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5" name="Line 68"/>
            <p:cNvSpPr>
              <a:spLocks noChangeShapeType="1"/>
            </p:cNvSpPr>
            <p:nvPr/>
          </p:nvSpPr>
          <p:spPr bwMode="auto">
            <a:xfrm flipV="1">
              <a:off x="4719638" y="1390650"/>
              <a:ext cx="0" cy="1047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6" name="Line 69"/>
            <p:cNvSpPr>
              <a:spLocks noChangeShapeType="1"/>
            </p:cNvSpPr>
            <p:nvPr/>
          </p:nvSpPr>
          <p:spPr bwMode="auto">
            <a:xfrm>
              <a:off x="4702176" y="1595438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7" name="Line 70"/>
            <p:cNvSpPr>
              <a:spLocks noChangeShapeType="1"/>
            </p:cNvSpPr>
            <p:nvPr/>
          </p:nvSpPr>
          <p:spPr bwMode="auto">
            <a:xfrm>
              <a:off x="4702176" y="139065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8" name="Line 71"/>
            <p:cNvSpPr>
              <a:spLocks noChangeShapeType="1"/>
            </p:cNvSpPr>
            <p:nvPr/>
          </p:nvSpPr>
          <p:spPr bwMode="auto">
            <a:xfrm>
              <a:off x="5167313" y="1239838"/>
              <a:ext cx="0" cy="5238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9" name="Line 72"/>
            <p:cNvSpPr>
              <a:spLocks noChangeShapeType="1"/>
            </p:cNvSpPr>
            <p:nvPr/>
          </p:nvSpPr>
          <p:spPr bwMode="auto">
            <a:xfrm flipV="1">
              <a:off x="5167313" y="1193800"/>
              <a:ext cx="0" cy="4603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0" name="Line 73"/>
            <p:cNvSpPr>
              <a:spLocks noChangeShapeType="1"/>
            </p:cNvSpPr>
            <p:nvPr/>
          </p:nvSpPr>
          <p:spPr bwMode="auto">
            <a:xfrm>
              <a:off x="5145088" y="1292225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1" name="Line 74"/>
            <p:cNvSpPr>
              <a:spLocks noChangeShapeType="1"/>
            </p:cNvSpPr>
            <p:nvPr/>
          </p:nvSpPr>
          <p:spPr bwMode="auto">
            <a:xfrm>
              <a:off x="5145088" y="1193800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2" name="Line 75"/>
            <p:cNvSpPr>
              <a:spLocks noChangeShapeType="1"/>
            </p:cNvSpPr>
            <p:nvPr/>
          </p:nvSpPr>
          <p:spPr bwMode="auto">
            <a:xfrm>
              <a:off x="5614988" y="1746250"/>
              <a:ext cx="0" cy="41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3" name="Line 76"/>
            <p:cNvSpPr>
              <a:spLocks noChangeShapeType="1"/>
            </p:cNvSpPr>
            <p:nvPr/>
          </p:nvSpPr>
          <p:spPr bwMode="auto">
            <a:xfrm flipV="1">
              <a:off x="5614988" y="1704975"/>
              <a:ext cx="0" cy="41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4" name="Line 77"/>
            <p:cNvSpPr>
              <a:spLocks noChangeShapeType="1"/>
            </p:cNvSpPr>
            <p:nvPr/>
          </p:nvSpPr>
          <p:spPr bwMode="auto">
            <a:xfrm>
              <a:off x="5591176" y="178752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5" name="Line 78"/>
            <p:cNvSpPr>
              <a:spLocks noChangeShapeType="1"/>
            </p:cNvSpPr>
            <p:nvPr/>
          </p:nvSpPr>
          <p:spPr bwMode="auto">
            <a:xfrm>
              <a:off x="5591176" y="170497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6" name="Line 79"/>
            <p:cNvSpPr>
              <a:spLocks noChangeShapeType="1"/>
            </p:cNvSpPr>
            <p:nvPr/>
          </p:nvSpPr>
          <p:spPr bwMode="auto">
            <a:xfrm>
              <a:off x="6510338" y="1495425"/>
              <a:ext cx="0" cy="238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7" name="Line 80"/>
            <p:cNvSpPr>
              <a:spLocks noChangeShapeType="1"/>
            </p:cNvSpPr>
            <p:nvPr/>
          </p:nvSpPr>
          <p:spPr bwMode="auto">
            <a:xfrm flipV="1">
              <a:off x="6510338" y="1473200"/>
              <a:ext cx="0" cy="222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8" name="Line 81"/>
            <p:cNvSpPr>
              <a:spLocks noChangeShapeType="1"/>
            </p:cNvSpPr>
            <p:nvPr/>
          </p:nvSpPr>
          <p:spPr bwMode="auto">
            <a:xfrm>
              <a:off x="6486526" y="1519238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9" name="Line 82"/>
            <p:cNvSpPr>
              <a:spLocks noChangeShapeType="1"/>
            </p:cNvSpPr>
            <p:nvPr/>
          </p:nvSpPr>
          <p:spPr bwMode="auto">
            <a:xfrm>
              <a:off x="6486526" y="14732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0" name="Line 83"/>
            <p:cNvSpPr>
              <a:spLocks noChangeShapeType="1"/>
            </p:cNvSpPr>
            <p:nvPr/>
          </p:nvSpPr>
          <p:spPr bwMode="auto">
            <a:xfrm>
              <a:off x="6956426" y="989013"/>
              <a:ext cx="0" cy="100013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1" name="Line 84"/>
            <p:cNvSpPr>
              <a:spLocks noChangeShapeType="1"/>
            </p:cNvSpPr>
            <p:nvPr/>
          </p:nvSpPr>
          <p:spPr bwMode="auto">
            <a:xfrm flipV="1">
              <a:off x="6956426" y="884238"/>
              <a:ext cx="0" cy="1047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2" name="Line 85"/>
            <p:cNvSpPr>
              <a:spLocks noChangeShapeType="1"/>
            </p:cNvSpPr>
            <p:nvPr/>
          </p:nvSpPr>
          <p:spPr bwMode="auto">
            <a:xfrm>
              <a:off x="6934201" y="10890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3" name="Line 86"/>
            <p:cNvSpPr>
              <a:spLocks noChangeShapeType="1"/>
            </p:cNvSpPr>
            <p:nvPr/>
          </p:nvSpPr>
          <p:spPr bwMode="auto">
            <a:xfrm>
              <a:off x="6934201" y="88423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4" name="Line 87"/>
            <p:cNvSpPr>
              <a:spLocks noChangeShapeType="1"/>
            </p:cNvSpPr>
            <p:nvPr/>
          </p:nvSpPr>
          <p:spPr bwMode="auto">
            <a:xfrm>
              <a:off x="7399338" y="1903413"/>
              <a:ext cx="0" cy="476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5" name="Line 88"/>
            <p:cNvSpPr>
              <a:spLocks noChangeShapeType="1"/>
            </p:cNvSpPr>
            <p:nvPr/>
          </p:nvSpPr>
          <p:spPr bwMode="auto">
            <a:xfrm flipV="1">
              <a:off x="7399338" y="1851025"/>
              <a:ext cx="0" cy="52388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6" name="Line 89"/>
            <p:cNvSpPr>
              <a:spLocks noChangeShapeType="1"/>
            </p:cNvSpPr>
            <p:nvPr/>
          </p:nvSpPr>
          <p:spPr bwMode="auto">
            <a:xfrm>
              <a:off x="7381876" y="195103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7" name="Line 90"/>
            <p:cNvSpPr>
              <a:spLocks noChangeShapeType="1"/>
            </p:cNvSpPr>
            <p:nvPr/>
          </p:nvSpPr>
          <p:spPr bwMode="auto">
            <a:xfrm>
              <a:off x="7381876" y="1851025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8" name="Line 91"/>
            <p:cNvSpPr>
              <a:spLocks noChangeShapeType="1"/>
            </p:cNvSpPr>
            <p:nvPr/>
          </p:nvSpPr>
          <p:spPr bwMode="auto">
            <a:xfrm>
              <a:off x="4435476" y="2003425"/>
              <a:ext cx="3125788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9" name="Rectangle 92"/>
            <p:cNvSpPr>
              <a:spLocks noChangeArrowheads="1"/>
            </p:cNvSpPr>
            <p:nvPr/>
          </p:nvSpPr>
          <p:spPr bwMode="auto">
            <a:xfrm>
              <a:off x="4313238" y="1944688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94"/>
            <p:cNvSpPr>
              <a:spLocks noChangeArrowheads="1"/>
            </p:cNvSpPr>
            <p:nvPr/>
          </p:nvSpPr>
          <p:spPr bwMode="auto">
            <a:xfrm>
              <a:off x="4313238" y="1438275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96"/>
            <p:cNvSpPr>
              <a:spLocks noChangeArrowheads="1"/>
            </p:cNvSpPr>
            <p:nvPr/>
          </p:nvSpPr>
          <p:spPr bwMode="auto">
            <a:xfrm>
              <a:off x="4313238" y="931863"/>
              <a:ext cx="87313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Rectangle 98"/>
            <p:cNvSpPr>
              <a:spLocks noChangeArrowheads="1"/>
            </p:cNvSpPr>
            <p:nvPr/>
          </p:nvSpPr>
          <p:spPr bwMode="auto">
            <a:xfrm>
              <a:off x="4564063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99"/>
            <p:cNvSpPr>
              <a:spLocks noChangeArrowheads="1"/>
            </p:cNvSpPr>
            <p:nvPr/>
          </p:nvSpPr>
          <p:spPr bwMode="auto">
            <a:xfrm>
              <a:off x="5010151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100"/>
            <p:cNvSpPr>
              <a:spLocks noChangeArrowheads="1"/>
            </p:cNvSpPr>
            <p:nvPr/>
          </p:nvSpPr>
          <p:spPr bwMode="auto">
            <a:xfrm>
              <a:off x="5457826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Rectangle 101"/>
            <p:cNvSpPr>
              <a:spLocks noChangeArrowheads="1"/>
            </p:cNvSpPr>
            <p:nvPr/>
          </p:nvSpPr>
          <p:spPr bwMode="auto">
            <a:xfrm>
              <a:off x="6346826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Rectangle 102"/>
            <p:cNvSpPr>
              <a:spLocks noChangeArrowheads="1"/>
            </p:cNvSpPr>
            <p:nvPr/>
          </p:nvSpPr>
          <p:spPr bwMode="auto">
            <a:xfrm>
              <a:off x="6794501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Rectangle 103"/>
            <p:cNvSpPr>
              <a:spLocks noChangeArrowheads="1"/>
            </p:cNvSpPr>
            <p:nvPr/>
          </p:nvSpPr>
          <p:spPr bwMode="auto">
            <a:xfrm>
              <a:off x="7242176" y="2062163"/>
              <a:ext cx="238125" cy="128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8" name="Rectangle 104"/>
            <p:cNvSpPr>
              <a:spLocks noChangeArrowheads="1"/>
            </p:cNvSpPr>
            <p:nvPr/>
          </p:nvSpPr>
          <p:spPr bwMode="auto">
            <a:xfrm>
              <a:off x="5643563" y="452438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100" dirty="0" smtClean="0">
                  <a:solidFill>
                    <a:srgbClr val="595959"/>
                  </a:solidFill>
                  <a:latin typeface="Calibri" panose="020F0502020204030204" pitchFamily="34" charset="0"/>
                </a:rPr>
                <a:t>Csa1M58914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30" name="Group 229"/>
          <p:cNvGrpSpPr/>
          <p:nvPr/>
        </p:nvGrpSpPr>
        <p:grpSpPr>
          <a:xfrm>
            <a:off x="547647" y="8043854"/>
            <a:ext cx="2857891" cy="1300214"/>
            <a:chOff x="403225" y="7381875"/>
            <a:chExt cx="3248026" cy="1736725"/>
          </a:xfrm>
        </p:grpSpPr>
        <p:sp>
          <p:nvSpPr>
            <p:cNvPr id="232" name="Freeform 328"/>
            <p:cNvSpPr>
              <a:spLocks noEditPoints="1"/>
            </p:cNvSpPr>
            <p:nvPr/>
          </p:nvSpPr>
          <p:spPr bwMode="auto">
            <a:xfrm>
              <a:off x="636588" y="8180388"/>
              <a:ext cx="2782888" cy="750887"/>
            </a:xfrm>
            <a:custGeom>
              <a:avLst/>
              <a:gdLst>
                <a:gd name="T0" fmla="*/ 0 w 1753"/>
                <a:gd name="T1" fmla="*/ 297 h 473"/>
                <a:gd name="T2" fmla="*/ 65 w 1753"/>
                <a:gd name="T3" fmla="*/ 297 h 473"/>
                <a:gd name="T4" fmla="*/ 65 w 1753"/>
                <a:gd name="T5" fmla="*/ 473 h 473"/>
                <a:gd name="T6" fmla="*/ 0 w 1753"/>
                <a:gd name="T7" fmla="*/ 473 h 473"/>
                <a:gd name="T8" fmla="*/ 0 w 1753"/>
                <a:gd name="T9" fmla="*/ 297 h 473"/>
                <a:gd name="T10" fmla="*/ 281 w 1753"/>
                <a:gd name="T11" fmla="*/ 234 h 473"/>
                <a:gd name="T12" fmla="*/ 344 w 1753"/>
                <a:gd name="T13" fmla="*/ 234 h 473"/>
                <a:gd name="T14" fmla="*/ 344 w 1753"/>
                <a:gd name="T15" fmla="*/ 473 h 473"/>
                <a:gd name="T16" fmla="*/ 281 w 1753"/>
                <a:gd name="T17" fmla="*/ 473 h 473"/>
                <a:gd name="T18" fmla="*/ 281 w 1753"/>
                <a:gd name="T19" fmla="*/ 234 h 473"/>
                <a:gd name="T20" fmla="*/ 563 w 1753"/>
                <a:gd name="T21" fmla="*/ 278 h 473"/>
                <a:gd name="T22" fmla="*/ 625 w 1753"/>
                <a:gd name="T23" fmla="*/ 278 h 473"/>
                <a:gd name="T24" fmla="*/ 625 w 1753"/>
                <a:gd name="T25" fmla="*/ 473 h 473"/>
                <a:gd name="T26" fmla="*/ 563 w 1753"/>
                <a:gd name="T27" fmla="*/ 473 h 473"/>
                <a:gd name="T28" fmla="*/ 563 w 1753"/>
                <a:gd name="T29" fmla="*/ 278 h 473"/>
                <a:gd name="T30" fmla="*/ 1127 w 1753"/>
                <a:gd name="T31" fmla="*/ 297 h 473"/>
                <a:gd name="T32" fmla="*/ 1189 w 1753"/>
                <a:gd name="T33" fmla="*/ 297 h 473"/>
                <a:gd name="T34" fmla="*/ 1189 w 1753"/>
                <a:gd name="T35" fmla="*/ 473 h 473"/>
                <a:gd name="T36" fmla="*/ 1127 w 1753"/>
                <a:gd name="T37" fmla="*/ 473 h 473"/>
                <a:gd name="T38" fmla="*/ 1127 w 1753"/>
                <a:gd name="T39" fmla="*/ 297 h 473"/>
                <a:gd name="T40" fmla="*/ 1409 w 1753"/>
                <a:gd name="T41" fmla="*/ 0 h 473"/>
                <a:gd name="T42" fmla="*/ 1471 w 1753"/>
                <a:gd name="T43" fmla="*/ 0 h 473"/>
                <a:gd name="T44" fmla="*/ 1471 w 1753"/>
                <a:gd name="T45" fmla="*/ 473 h 473"/>
                <a:gd name="T46" fmla="*/ 1409 w 1753"/>
                <a:gd name="T47" fmla="*/ 473 h 473"/>
                <a:gd name="T48" fmla="*/ 1409 w 1753"/>
                <a:gd name="T49" fmla="*/ 0 h 473"/>
                <a:gd name="T50" fmla="*/ 1687 w 1753"/>
                <a:gd name="T51" fmla="*/ 55 h 473"/>
                <a:gd name="T52" fmla="*/ 1753 w 1753"/>
                <a:gd name="T53" fmla="*/ 55 h 473"/>
                <a:gd name="T54" fmla="*/ 1753 w 1753"/>
                <a:gd name="T55" fmla="*/ 473 h 473"/>
                <a:gd name="T56" fmla="*/ 1687 w 1753"/>
                <a:gd name="T57" fmla="*/ 473 h 473"/>
                <a:gd name="T58" fmla="*/ 1687 w 1753"/>
                <a:gd name="T59" fmla="*/ 55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473">
                  <a:moveTo>
                    <a:pt x="0" y="297"/>
                  </a:moveTo>
                  <a:lnTo>
                    <a:pt x="65" y="297"/>
                  </a:lnTo>
                  <a:lnTo>
                    <a:pt x="65" y="473"/>
                  </a:lnTo>
                  <a:lnTo>
                    <a:pt x="0" y="473"/>
                  </a:lnTo>
                  <a:lnTo>
                    <a:pt x="0" y="297"/>
                  </a:lnTo>
                  <a:close/>
                  <a:moveTo>
                    <a:pt x="281" y="234"/>
                  </a:moveTo>
                  <a:lnTo>
                    <a:pt x="344" y="234"/>
                  </a:lnTo>
                  <a:lnTo>
                    <a:pt x="344" y="473"/>
                  </a:lnTo>
                  <a:lnTo>
                    <a:pt x="281" y="473"/>
                  </a:lnTo>
                  <a:lnTo>
                    <a:pt x="281" y="234"/>
                  </a:lnTo>
                  <a:close/>
                  <a:moveTo>
                    <a:pt x="563" y="278"/>
                  </a:moveTo>
                  <a:lnTo>
                    <a:pt x="625" y="278"/>
                  </a:lnTo>
                  <a:lnTo>
                    <a:pt x="625" y="473"/>
                  </a:lnTo>
                  <a:lnTo>
                    <a:pt x="563" y="473"/>
                  </a:lnTo>
                  <a:lnTo>
                    <a:pt x="563" y="278"/>
                  </a:lnTo>
                  <a:close/>
                  <a:moveTo>
                    <a:pt x="1127" y="297"/>
                  </a:moveTo>
                  <a:lnTo>
                    <a:pt x="1189" y="297"/>
                  </a:lnTo>
                  <a:lnTo>
                    <a:pt x="1189" y="473"/>
                  </a:lnTo>
                  <a:lnTo>
                    <a:pt x="1127" y="473"/>
                  </a:lnTo>
                  <a:lnTo>
                    <a:pt x="1127" y="297"/>
                  </a:lnTo>
                  <a:close/>
                  <a:moveTo>
                    <a:pt x="1409" y="0"/>
                  </a:moveTo>
                  <a:lnTo>
                    <a:pt x="1471" y="0"/>
                  </a:lnTo>
                  <a:lnTo>
                    <a:pt x="1471" y="473"/>
                  </a:lnTo>
                  <a:lnTo>
                    <a:pt x="1409" y="473"/>
                  </a:lnTo>
                  <a:lnTo>
                    <a:pt x="1409" y="0"/>
                  </a:lnTo>
                  <a:close/>
                  <a:moveTo>
                    <a:pt x="1687" y="55"/>
                  </a:moveTo>
                  <a:lnTo>
                    <a:pt x="1753" y="55"/>
                  </a:lnTo>
                  <a:lnTo>
                    <a:pt x="1753" y="473"/>
                  </a:lnTo>
                  <a:lnTo>
                    <a:pt x="1687" y="473"/>
                  </a:lnTo>
                  <a:lnTo>
                    <a:pt x="1687" y="55"/>
                  </a:ln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3" name="Freeform 329"/>
            <p:cNvSpPr>
              <a:spLocks noEditPoints="1"/>
            </p:cNvSpPr>
            <p:nvPr/>
          </p:nvSpPr>
          <p:spPr bwMode="auto">
            <a:xfrm>
              <a:off x="763588" y="7866063"/>
              <a:ext cx="2782888" cy="1065212"/>
            </a:xfrm>
            <a:custGeom>
              <a:avLst/>
              <a:gdLst>
                <a:gd name="T0" fmla="*/ 0 w 1753"/>
                <a:gd name="T1" fmla="*/ 495 h 671"/>
                <a:gd name="T2" fmla="*/ 62 w 1753"/>
                <a:gd name="T3" fmla="*/ 495 h 671"/>
                <a:gd name="T4" fmla="*/ 62 w 1753"/>
                <a:gd name="T5" fmla="*/ 671 h 671"/>
                <a:gd name="T6" fmla="*/ 0 w 1753"/>
                <a:gd name="T7" fmla="*/ 671 h 671"/>
                <a:gd name="T8" fmla="*/ 0 w 1753"/>
                <a:gd name="T9" fmla="*/ 495 h 671"/>
                <a:gd name="T10" fmla="*/ 282 w 1753"/>
                <a:gd name="T11" fmla="*/ 158 h 671"/>
                <a:gd name="T12" fmla="*/ 344 w 1753"/>
                <a:gd name="T13" fmla="*/ 158 h 671"/>
                <a:gd name="T14" fmla="*/ 344 w 1753"/>
                <a:gd name="T15" fmla="*/ 671 h 671"/>
                <a:gd name="T16" fmla="*/ 282 w 1753"/>
                <a:gd name="T17" fmla="*/ 671 h 671"/>
                <a:gd name="T18" fmla="*/ 282 w 1753"/>
                <a:gd name="T19" fmla="*/ 158 h 671"/>
                <a:gd name="T20" fmla="*/ 564 w 1753"/>
                <a:gd name="T21" fmla="*/ 443 h 671"/>
                <a:gd name="T22" fmla="*/ 626 w 1753"/>
                <a:gd name="T23" fmla="*/ 443 h 671"/>
                <a:gd name="T24" fmla="*/ 626 w 1753"/>
                <a:gd name="T25" fmla="*/ 671 h 671"/>
                <a:gd name="T26" fmla="*/ 564 w 1753"/>
                <a:gd name="T27" fmla="*/ 671 h 671"/>
                <a:gd name="T28" fmla="*/ 564 w 1753"/>
                <a:gd name="T29" fmla="*/ 443 h 671"/>
                <a:gd name="T30" fmla="*/ 1127 w 1753"/>
                <a:gd name="T31" fmla="*/ 495 h 671"/>
                <a:gd name="T32" fmla="*/ 1190 w 1753"/>
                <a:gd name="T33" fmla="*/ 495 h 671"/>
                <a:gd name="T34" fmla="*/ 1190 w 1753"/>
                <a:gd name="T35" fmla="*/ 671 h 671"/>
                <a:gd name="T36" fmla="*/ 1127 w 1753"/>
                <a:gd name="T37" fmla="*/ 671 h 671"/>
                <a:gd name="T38" fmla="*/ 1127 w 1753"/>
                <a:gd name="T39" fmla="*/ 495 h 671"/>
                <a:gd name="T40" fmla="*/ 1406 w 1753"/>
                <a:gd name="T41" fmla="*/ 139 h 671"/>
                <a:gd name="T42" fmla="*/ 1471 w 1753"/>
                <a:gd name="T43" fmla="*/ 139 h 671"/>
                <a:gd name="T44" fmla="*/ 1471 w 1753"/>
                <a:gd name="T45" fmla="*/ 671 h 671"/>
                <a:gd name="T46" fmla="*/ 1406 w 1753"/>
                <a:gd name="T47" fmla="*/ 671 h 671"/>
                <a:gd name="T48" fmla="*/ 1406 w 1753"/>
                <a:gd name="T49" fmla="*/ 139 h 671"/>
                <a:gd name="T50" fmla="*/ 1687 w 1753"/>
                <a:gd name="T51" fmla="*/ 0 h 671"/>
                <a:gd name="T52" fmla="*/ 1753 w 1753"/>
                <a:gd name="T53" fmla="*/ 0 h 671"/>
                <a:gd name="T54" fmla="*/ 1753 w 1753"/>
                <a:gd name="T55" fmla="*/ 671 h 671"/>
                <a:gd name="T56" fmla="*/ 1687 w 1753"/>
                <a:gd name="T57" fmla="*/ 671 h 671"/>
                <a:gd name="T58" fmla="*/ 1687 w 1753"/>
                <a:gd name="T59" fmla="*/ 0 h 6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753" h="671">
                  <a:moveTo>
                    <a:pt x="0" y="495"/>
                  </a:moveTo>
                  <a:lnTo>
                    <a:pt x="62" y="495"/>
                  </a:lnTo>
                  <a:lnTo>
                    <a:pt x="62" y="671"/>
                  </a:lnTo>
                  <a:lnTo>
                    <a:pt x="0" y="671"/>
                  </a:lnTo>
                  <a:lnTo>
                    <a:pt x="0" y="495"/>
                  </a:lnTo>
                  <a:close/>
                  <a:moveTo>
                    <a:pt x="282" y="158"/>
                  </a:moveTo>
                  <a:lnTo>
                    <a:pt x="344" y="158"/>
                  </a:lnTo>
                  <a:lnTo>
                    <a:pt x="344" y="671"/>
                  </a:lnTo>
                  <a:lnTo>
                    <a:pt x="282" y="671"/>
                  </a:lnTo>
                  <a:lnTo>
                    <a:pt x="282" y="158"/>
                  </a:lnTo>
                  <a:close/>
                  <a:moveTo>
                    <a:pt x="564" y="443"/>
                  </a:moveTo>
                  <a:lnTo>
                    <a:pt x="626" y="443"/>
                  </a:lnTo>
                  <a:lnTo>
                    <a:pt x="626" y="671"/>
                  </a:lnTo>
                  <a:lnTo>
                    <a:pt x="564" y="671"/>
                  </a:lnTo>
                  <a:lnTo>
                    <a:pt x="564" y="443"/>
                  </a:lnTo>
                  <a:close/>
                  <a:moveTo>
                    <a:pt x="1127" y="495"/>
                  </a:moveTo>
                  <a:lnTo>
                    <a:pt x="1190" y="495"/>
                  </a:lnTo>
                  <a:lnTo>
                    <a:pt x="1190" y="671"/>
                  </a:lnTo>
                  <a:lnTo>
                    <a:pt x="1127" y="671"/>
                  </a:lnTo>
                  <a:lnTo>
                    <a:pt x="1127" y="495"/>
                  </a:lnTo>
                  <a:close/>
                  <a:moveTo>
                    <a:pt x="1406" y="139"/>
                  </a:moveTo>
                  <a:lnTo>
                    <a:pt x="1471" y="139"/>
                  </a:lnTo>
                  <a:lnTo>
                    <a:pt x="1471" y="671"/>
                  </a:lnTo>
                  <a:lnTo>
                    <a:pt x="1406" y="671"/>
                  </a:lnTo>
                  <a:lnTo>
                    <a:pt x="1406" y="139"/>
                  </a:lnTo>
                  <a:close/>
                  <a:moveTo>
                    <a:pt x="1687" y="0"/>
                  </a:moveTo>
                  <a:lnTo>
                    <a:pt x="1753" y="0"/>
                  </a:lnTo>
                  <a:lnTo>
                    <a:pt x="1753" y="671"/>
                  </a:lnTo>
                  <a:lnTo>
                    <a:pt x="1687" y="671"/>
                  </a:lnTo>
                  <a:lnTo>
                    <a:pt x="1687" y="0"/>
                  </a:lnTo>
                  <a:close/>
                </a:path>
              </a:pathLst>
            </a:custGeom>
            <a:solidFill>
              <a:schemeClr val="bg1">
                <a:lumMod val="5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4" name="Line 330"/>
            <p:cNvSpPr>
              <a:spLocks noChangeShapeType="1"/>
            </p:cNvSpPr>
            <p:nvPr/>
          </p:nvSpPr>
          <p:spPr bwMode="auto">
            <a:xfrm>
              <a:off x="809625" y="8651875"/>
              <a:ext cx="0" cy="10953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5" name="Line 331"/>
            <p:cNvSpPr>
              <a:spLocks noChangeShapeType="1"/>
            </p:cNvSpPr>
            <p:nvPr/>
          </p:nvSpPr>
          <p:spPr bwMode="auto">
            <a:xfrm flipV="1">
              <a:off x="809625" y="8534400"/>
              <a:ext cx="0" cy="1174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6" name="Line 332"/>
            <p:cNvSpPr>
              <a:spLocks noChangeShapeType="1"/>
            </p:cNvSpPr>
            <p:nvPr/>
          </p:nvSpPr>
          <p:spPr bwMode="auto">
            <a:xfrm>
              <a:off x="792163" y="876141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7" name="Line 333"/>
            <p:cNvSpPr>
              <a:spLocks noChangeShapeType="1"/>
            </p:cNvSpPr>
            <p:nvPr/>
          </p:nvSpPr>
          <p:spPr bwMode="auto">
            <a:xfrm>
              <a:off x="792163" y="8534400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8" name="Line 334"/>
            <p:cNvSpPr>
              <a:spLocks noChangeShapeType="1"/>
            </p:cNvSpPr>
            <p:nvPr/>
          </p:nvSpPr>
          <p:spPr bwMode="auto">
            <a:xfrm>
              <a:off x="1257300" y="8116888"/>
              <a:ext cx="0" cy="16827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9" name="Line 335"/>
            <p:cNvSpPr>
              <a:spLocks noChangeShapeType="1"/>
            </p:cNvSpPr>
            <p:nvPr/>
          </p:nvSpPr>
          <p:spPr bwMode="auto">
            <a:xfrm flipV="1">
              <a:off x="1257300" y="7947025"/>
              <a:ext cx="0" cy="16986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0" name="Line 336"/>
            <p:cNvSpPr>
              <a:spLocks noChangeShapeType="1"/>
            </p:cNvSpPr>
            <p:nvPr/>
          </p:nvSpPr>
          <p:spPr bwMode="auto">
            <a:xfrm>
              <a:off x="1235075" y="8285163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1" name="Line 337"/>
            <p:cNvSpPr>
              <a:spLocks noChangeShapeType="1"/>
            </p:cNvSpPr>
            <p:nvPr/>
          </p:nvSpPr>
          <p:spPr bwMode="auto">
            <a:xfrm>
              <a:off x="1235075" y="7947025"/>
              <a:ext cx="4603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2" name="Line 338"/>
            <p:cNvSpPr>
              <a:spLocks noChangeShapeType="1"/>
            </p:cNvSpPr>
            <p:nvPr/>
          </p:nvSpPr>
          <p:spPr bwMode="auto">
            <a:xfrm>
              <a:off x="1704975" y="8564563"/>
              <a:ext cx="0" cy="19685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3" name="Line 339"/>
            <p:cNvSpPr>
              <a:spLocks noChangeShapeType="1"/>
            </p:cNvSpPr>
            <p:nvPr/>
          </p:nvSpPr>
          <p:spPr bwMode="auto">
            <a:xfrm flipV="1">
              <a:off x="1704975" y="8366125"/>
              <a:ext cx="0" cy="19843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4" name="Line 340"/>
            <p:cNvSpPr>
              <a:spLocks noChangeShapeType="1"/>
            </p:cNvSpPr>
            <p:nvPr/>
          </p:nvSpPr>
          <p:spPr bwMode="auto">
            <a:xfrm>
              <a:off x="1681163" y="8761413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5" name="Line 341"/>
            <p:cNvSpPr>
              <a:spLocks noChangeShapeType="1"/>
            </p:cNvSpPr>
            <p:nvPr/>
          </p:nvSpPr>
          <p:spPr bwMode="auto">
            <a:xfrm>
              <a:off x="1681163" y="8366125"/>
              <a:ext cx="4762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6" name="Line 342"/>
            <p:cNvSpPr>
              <a:spLocks noChangeShapeType="1"/>
            </p:cNvSpPr>
            <p:nvPr/>
          </p:nvSpPr>
          <p:spPr bwMode="auto">
            <a:xfrm>
              <a:off x="2600325" y="8651875"/>
              <a:ext cx="0" cy="1111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7" name="Line 343"/>
            <p:cNvSpPr>
              <a:spLocks noChangeShapeType="1"/>
            </p:cNvSpPr>
            <p:nvPr/>
          </p:nvSpPr>
          <p:spPr bwMode="auto">
            <a:xfrm flipV="1">
              <a:off x="2600325" y="8634413"/>
              <a:ext cx="0" cy="17462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8" name="Line 344"/>
            <p:cNvSpPr>
              <a:spLocks noChangeShapeType="1"/>
            </p:cNvSpPr>
            <p:nvPr/>
          </p:nvSpPr>
          <p:spPr bwMode="auto">
            <a:xfrm>
              <a:off x="2576513" y="8662988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9" name="Line 345"/>
            <p:cNvSpPr>
              <a:spLocks noChangeShapeType="1"/>
            </p:cNvSpPr>
            <p:nvPr/>
          </p:nvSpPr>
          <p:spPr bwMode="auto">
            <a:xfrm>
              <a:off x="2576513" y="8634413"/>
              <a:ext cx="41275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0" name="Line 346"/>
            <p:cNvSpPr>
              <a:spLocks noChangeShapeType="1"/>
            </p:cNvSpPr>
            <p:nvPr/>
          </p:nvSpPr>
          <p:spPr bwMode="auto">
            <a:xfrm>
              <a:off x="3046413" y="8086725"/>
              <a:ext cx="0" cy="111125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1" name="Line 347"/>
            <p:cNvSpPr>
              <a:spLocks noChangeShapeType="1"/>
            </p:cNvSpPr>
            <p:nvPr/>
          </p:nvSpPr>
          <p:spPr bwMode="auto">
            <a:xfrm flipV="1">
              <a:off x="3046413" y="7977188"/>
              <a:ext cx="0" cy="10953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2" name="Line 348"/>
            <p:cNvSpPr>
              <a:spLocks noChangeShapeType="1"/>
            </p:cNvSpPr>
            <p:nvPr/>
          </p:nvSpPr>
          <p:spPr bwMode="auto">
            <a:xfrm>
              <a:off x="3024188" y="8197850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3" name="Line 349"/>
            <p:cNvSpPr>
              <a:spLocks noChangeShapeType="1"/>
            </p:cNvSpPr>
            <p:nvPr/>
          </p:nvSpPr>
          <p:spPr bwMode="auto">
            <a:xfrm>
              <a:off x="3024188" y="7977188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4" name="Line 350"/>
            <p:cNvSpPr>
              <a:spLocks noChangeShapeType="1"/>
            </p:cNvSpPr>
            <p:nvPr/>
          </p:nvSpPr>
          <p:spPr bwMode="auto">
            <a:xfrm>
              <a:off x="3489325" y="7859713"/>
              <a:ext cx="0" cy="58737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5" name="Line 351"/>
            <p:cNvSpPr>
              <a:spLocks noChangeShapeType="1"/>
            </p:cNvSpPr>
            <p:nvPr/>
          </p:nvSpPr>
          <p:spPr bwMode="auto">
            <a:xfrm flipV="1">
              <a:off x="3489325" y="7802563"/>
              <a:ext cx="0" cy="5715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6" name="Line 352"/>
            <p:cNvSpPr>
              <a:spLocks noChangeShapeType="1"/>
            </p:cNvSpPr>
            <p:nvPr/>
          </p:nvSpPr>
          <p:spPr bwMode="auto">
            <a:xfrm>
              <a:off x="3471863" y="7918450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7" name="Line 353"/>
            <p:cNvSpPr>
              <a:spLocks noChangeShapeType="1"/>
            </p:cNvSpPr>
            <p:nvPr/>
          </p:nvSpPr>
          <p:spPr bwMode="auto">
            <a:xfrm>
              <a:off x="3471863" y="7802563"/>
              <a:ext cx="39688" cy="0"/>
            </a:xfrm>
            <a:prstGeom prst="line">
              <a:avLst/>
            </a:prstGeom>
            <a:noFill/>
            <a:ln w="6350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8" name="Line 354"/>
            <p:cNvSpPr>
              <a:spLocks noChangeShapeType="1"/>
            </p:cNvSpPr>
            <p:nvPr/>
          </p:nvSpPr>
          <p:spPr bwMode="auto">
            <a:xfrm>
              <a:off x="525463" y="8931275"/>
              <a:ext cx="3125788" cy="0"/>
            </a:xfrm>
            <a:prstGeom prst="line">
              <a:avLst/>
            </a:prstGeom>
            <a:noFill/>
            <a:ln w="6350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9" name="Rectangle 355"/>
            <p:cNvSpPr>
              <a:spLocks noChangeArrowheads="1"/>
            </p:cNvSpPr>
            <p:nvPr/>
          </p:nvSpPr>
          <p:spPr bwMode="auto">
            <a:xfrm>
              <a:off x="403225" y="8872538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0" name="Rectangle 357"/>
            <p:cNvSpPr>
              <a:spLocks noChangeArrowheads="1"/>
            </p:cNvSpPr>
            <p:nvPr/>
          </p:nvSpPr>
          <p:spPr bwMode="auto">
            <a:xfrm>
              <a:off x="403225" y="8593138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1" name="Rectangle 359"/>
            <p:cNvSpPr>
              <a:spLocks noChangeArrowheads="1"/>
            </p:cNvSpPr>
            <p:nvPr/>
          </p:nvSpPr>
          <p:spPr bwMode="auto">
            <a:xfrm>
              <a:off x="403225" y="8313738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2" name="Rectangle 361"/>
            <p:cNvSpPr>
              <a:spLocks noChangeArrowheads="1"/>
            </p:cNvSpPr>
            <p:nvPr/>
          </p:nvSpPr>
          <p:spPr bwMode="auto">
            <a:xfrm>
              <a:off x="403225" y="8029575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3" name="Rectangle 363"/>
            <p:cNvSpPr>
              <a:spLocks noChangeArrowheads="1"/>
            </p:cNvSpPr>
            <p:nvPr/>
          </p:nvSpPr>
          <p:spPr bwMode="auto">
            <a:xfrm>
              <a:off x="403225" y="7750175"/>
              <a:ext cx="87313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4" name="Rectangle 365"/>
            <p:cNvSpPr>
              <a:spLocks noChangeArrowheads="1"/>
            </p:cNvSpPr>
            <p:nvPr/>
          </p:nvSpPr>
          <p:spPr bwMode="auto">
            <a:xfrm>
              <a:off x="654050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5" name="Rectangle 366"/>
            <p:cNvSpPr>
              <a:spLocks noChangeArrowheads="1"/>
            </p:cNvSpPr>
            <p:nvPr/>
          </p:nvSpPr>
          <p:spPr bwMode="auto">
            <a:xfrm>
              <a:off x="1100138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6" name="Rectangle 367"/>
            <p:cNvSpPr>
              <a:spLocks noChangeArrowheads="1"/>
            </p:cNvSpPr>
            <p:nvPr/>
          </p:nvSpPr>
          <p:spPr bwMode="auto">
            <a:xfrm>
              <a:off x="1547813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Rectangle 368"/>
            <p:cNvSpPr>
              <a:spLocks noChangeArrowheads="1"/>
            </p:cNvSpPr>
            <p:nvPr/>
          </p:nvSpPr>
          <p:spPr bwMode="auto">
            <a:xfrm>
              <a:off x="2436813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8" name="Rectangle 369"/>
            <p:cNvSpPr>
              <a:spLocks noChangeArrowheads="1"/>
            </p:cNvSpPr>
            <p:nvPr/>
          </p:nvSpPr>
          <p:spPr bwMode="auto">
            <a:xfrm>
              <a:off x="2884488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9" name="Rectangle 370"/>
            <p:cNvSpPr>
              <a:spLocks noChangeArrowheads="1"/>
            </p:cNvSpPr>
            <p:nvPr/>
          </p:nvSpPr>
          <p:spPr bwMode="auto">
            <a:xfrm>
              <a:off x="3332163" y="8990013"/>
              <a:ext cx="238125" cy="1285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Day 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0" name="Rectangle 371"/>
            <p:cNvSpPr>
              <a:spLocks noChangeArrowheads="1"/>
            </p:cNvSpPr>
            <p:nvPr/>
          </p:nvSpPr>
          <p:spPr bwMode="auto">
            <a:xfrm>
              <a:off x="1733550" y="7381875"/>
              <a:ext cx="82234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Csa7M06171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71" name="TextBox 270"/>
          <p:cNvSpPr txBox="1"/>
          <p:nvPr/>
        </p:nvSpPr>
        <p:spPr>
          <a:xfrm rot="16200000">
            <a:off x="-2090401" y="5188538"/>
            <a:ext cx="4692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Expression, fold induction relative to Day 0</a:t>
            </a:r>
            <a:endParaRPr lang="en-GB" sz="1400" dirty="0"/>
          </a:p>
        </p:txBody>
      </p:sp>
      <p:sp>
        <p:nvSpPr>
          <p:cNvPr id="274" name="TextBox 273"/>
          <p:cNvSpPr txBox="1"/>
          <p:nvPr/>
        </p:nvSpPr>
        <p:spPr>
          <a:xfrm>
            <a:off x="740295" y="9359935"/>
            <a:ext cx="2970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Genotype CL		      Genotype CO</a:t>
            </a:r>
            <a:endParaRPr lang="en-GB" sz="1200" dirty="0"/>
          </a:p>
        </p:txBody>
      </p:sp>
      <p:sp>
        <p:nvSpPr>
          <p:cNvPr id="275" name="TextBox 274"/>
          <p:cNvSpPr txBox="1"/>
          <p:nvPr/>
        </p:nvSpPr>
        <p:spPr>
          <a:xfrm>
            <a:off x="3871523" y="7550169"/>
            <a:ext cx="2970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Genotype CL		      Genotype CO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67153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8"/>
          <p:cNvSpPr txBox="1"/>
          <p:nvPr/>
        </p:nvSpPr>
        <p:spPr>
          <a:xfrm>
            <a:off x="293081" y="244018"/>
            <a:ext cx="622963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cs typeface="Times New Roman" panose="02020603050405020304" pitchFamily="18" charset="0"/>
              </a:rPr>
              <a:t>Supplemental Figure S4</a:t>
            </a:r>
          </a:p>
          <a:p>
            <a:endParaRPr lang="en-GB" sz="16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Enriched KEGG pathways for spider-mite infested Chinese long cucumber leaves. KEGG pathway enrichment analysis was performed using hypergeometric test [Rivals et al. (2007), corrected P ≤ 0.05]. For each KEGG pathway, the bars show DEGs as percentage of all genes annotated to that pathway after one, two or three days of spider-mite infestation.</a:t>
            </a:r>
            <a:endParaRPr lang="en-GB" sz="1200" dirty="0"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719" y="2054542"/>
            <a:ext cx="6218001" cy="35499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58271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9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275" y="3445827"/>
            <a:ext cx="5759450" cy="301434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88"/>
          <p:cNvSpPr txBox="1"/>
          <p:nvPr/>
        </p:nvSpPr>
        <p:spPr>
          <a:xfrm>
            <a:off x="293081" y="244018"/>
            <a:ext cx="584101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cs typeface="Times New Roman" panose="02020603050405020304" pitchFamily="18" charset="0"/>
              </a:rPr>
              <a:t>Supplemental Figure S5</a:t>
            </a:r>
          </a:p>
          <a:p>
            <a:endParaRPr lang="en-GB" sz="16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Transcription factor co-expressed with </a:t>
            </a:r>
            <a:r>
              <a:rPr lang="en-US" sz="1200" i="1" dirty="0">
                <a:cs typeface="Times New Roman" panose="02020603050405020304" pitchFamily="18" charset="0"/>
              </a:rPr>
              <a:t>Bi</a:t>
            </a:r>
            <a:r>
              <a:rPr lang="en-US" sz="1200" dirty="0">
                <a:cs typeface="Times New Roman" panose="02020603050405020304" pitchFamily="18" charset="0"/>
              </a:rPr>
              <a:t> (Bitter) and related genes. All the TFs in the collection of DEGs were clustered with the genes involved in biosynthesis of </a:t>
            </a:r>
            <a:r>
              <a:rPr lang="en-US" sz="1200" dirty="0" err="1">
                <a:cs typeface="Times New Roman" panose="02020603050405020304" pitchFamily="18" charset="0"/>
              </a:rPr>
              <a:t>cucurbitacin</a:t>
            </a:r>
            <a:r>
              <a:rPr lang="en-US" sz="1200" dirty="0">
                <a:cs typeface="Times New Roman" panose="02020603050405020304" pitchFamily="18" charset="0"/>
              </a:rPr>
              <a:t> C. The TF most closely correlated with Bi and related genes are shown. </a:t>
            </a:r>
            <a:r>
              <a:rPr lang="en-US" sz="1200" dirty="0" err="1">
                <a:cs typeface="Times New Roman" panose="02020603050405020304" pitchFamily="18" charset="0"/>
              </a:rPr>
              <a:t>Colour</a:t>
            </a:r>
            <a:r>
              <a:rPr lang="en-US" sz="1200" dirty="0">
                <a:cs typeface="Times New Roman" panose="02020603050405020304" pitchFamily="18" charset="0"/>
              </a:rPr>
              <a:t> coding green represents relative low expression level and red represents high expression level.</a:t>
            </a:r>
            <a:endParaRPr lang="en-GB" sz="12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7564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8</TotalTime>
  <Words>482</Words>
  <Application>Microsoft Office PowerPoint</Application>
  <PresentationFormat>A4 Paper (210x297 mm)</PresentationFormat>
  <Paragraphs>11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geningen University and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ppers, Iris</dc:creator>
  <cp:lastModifiedBy>Kappers, Iris</cp:lastModifiedBy>
  <cp:revision>69</cp:revision>
  <dcterms:created xsi:type="dcterms:W3CDTF">2018-04-24T07:29:04Z</dcterms:created>
  <dcterms:modified xsi:type="dcterms:W3CDTF">2019-05-14T15:24:49Z</dcterms:modified>
</cp:coreProperties>
</file>